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notesSlides/notesSlide2.xml" ContentType="application/vnd.openxmlformats-officedocument.presentationml.notesSlide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drawings/drawing2.xml" ContentType="application/vnd.openxmlformats-officedocument.drawingml.chartshapes+xml"/>
  <Override PartName="/ppt/charts/chart13.xml" ContentType="application/vnd.openxmlformats-officedocument.drawingml.chart+xml"/>
  <Override PartName="/ppt/drawings/drawing3.xml" ContentType="application/vnd.openxmlformats-officedocument.drawingml.chartshapes+xml"/>
  <Override PartName="/ppt/charts/chart14.xml" ContentType="application/vnd.openxmlformats-officedocument.drawingml.chart+xml"/>
  <Override PartName="/ppt/drawings/drawing4.xml" ContentType="application/vnd.openxmlformats-officedocument.drawingml.chartshapes+xml"/>
  <Override PartName="/ppt/charts/chart15.xml" ContentType="application/vnd.openxmlformats-officedocument.drawingml.chart+xml"/>
  <Override PartName="/ppt/drawings/drawing5.xml" ContentType="application/vnd.openxmlformats-officedocument.drawingml.chartshapes+xml"/>
  <Override PartName="/ppt/charts/chart16.xml" ContentType="application/vnd.openxmlformats-officedocument.drawingml.chart+xml"/>
  <Override PartName="/ppt/drawings/drawing6.xml" ContentType="application/vnd.openxmlformats-officedocument.drawingml.chartshapes+xml"/>
  <Override PartName="/ppt/charts/chart17.xml" ContentType="application/vnd.openxmlformats-officedocument.drawingml.chart+xml"/>
  <Override PartName="/ppt/drawings/drawing7.xml" ContentType="application/vnd.openxmlformats-officedocument.drawingml.chartshapes+xml"/>
  <Override PartName="/ppt/charts/chart18.xml" ContentType="application/vnd.openxmlformats-officedocument.drawingml.chart+xml"/>
  <Override PartName="/ppt/drawings/drawing8.xml" ContentType="application/vnd.openxmlformats-officedocument.drawingml.chartshapes+xml"/>
  <Override PartName="/ppt/charts/chart19.xml" ContentType="application/vnd.openxmlformats-officedocument.drawingml.chart+xml"/>
  <Override PartName="/ppt/drawings/drawing9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278" r:id="rId2"/>
    <p:sldId id="281" r:id="rId3"/>
    <p:sldId id="275" r:id="rId4"/>
    <p:sldId id="282" r:id="rId5"/>
  </p:sldIdLst>
  <p:sldSz cx="6858000" cy="9144000" type="screen4x3"/>
  <p:notesSz cx="6810375" cy="9942513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reetham Darren" initials="GD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42" autoAdjust="0"/>
    <p:restoredTop sz="93040" autoAdjust="0"/>
  </p:normalViewPr>
  <p:slideViewPr>
    <p:cSldViewPr>
      <p:cViewPr>
        <p:scale>
          <a:sx n="100" d="100"/>
          <a:sy n="100" d="100"/>
        </p:scale>
        <p:origin x="-372" y="8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8.xlsx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9.xlsx"/></Relationships>
</file>

<file path=ppt/charts/_rels/chart1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../embeddings/oleObject2.bin"/></Relationships>
</file>

<file path=ppt/charts/_rels/chart1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../embeddings/oleObject3.bin"/></Relationships>
</file>

<file path=ppt/charts/_rels/chart1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../embeddings/oleObject4.bin"/></Relationships>
</file>

<file path=ppt/charts/_rels/chart1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../embeddings/oleObject5.bin"/></Relationships>
</file>

<file path=ppt/charts/_rels/chart1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package" Target="../embeddings/Microsoft_Excel_Worksheet10.xlsx"/></Relationships>
</file>

<file path=ppt/charts/_rels/chart1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7.xml"/><Relationship Id="rId1" Type="http://schemas.openxmlformats.org/officeDocument/2006/relationships/package" Target="../embeddings/Microsoft_Excel_Worksheet11.xlsx"/></Relationships>
</file>

<file path=ppt/charts/_rels/chart1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8.xml"/><Relationship Id="rId1" Type="http://schemas.openxmlformats.org/officeDocument/2006/relationships/package" Target="../embeddings/Microsoft_Excel_Worksheet12.xlsx"/></Relationships>
</file>

<file path=ppt/charts/_rels/chart1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9.xml"/><Relationship Id="rId1" Type="http://schemas.openxmlformats.org/officeDocument/2006/relationships/package" Target="../embeddings/Microsoft_Excel_Worksheet13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bzdg1\Documents\parental%20paper\new%20parental%20figures\new%20data%20inhibitor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7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071153191751133"/>
          <c:y val="8.0325311542823449E-2"/>
          <c:w val="0.67011122090700759"/>
          <c:h val="0.79157646563602202"/>
        </c:manualLayout>
      </c:layout>
      <c:scatterChart>
        <c:scatterStyle val="lineMarker"/>
        <c:varyColors val="0"/>
        <c:ser>
          <c:idx val="0"/>
          <c:order val="0"/>
          <c:tx>
            <c:strRef>
              <c:f>'Sorbitol -1'!$F$1</c:f>
              <c:strCache>
                <c:ptCount val="1"/>
                <c:pt idx="0">
                  <c:v>10% Sorbitol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multiLvlStrRef>
              <c:f>'[figure 1A.xlsx]Sorbitol -1'!$D$2:$E$91</c:f>
              <c:multiLvlStrCache>
                <c:ptCount val="90"/>
                <c:lvl>
                  <c:pt idx="0">
                    <c:v>N-17</c:v>
                  </c:pt>
                  <c:pt idx="1">
                    <c:v>W303</c:v>
                  </c:pt>
                  <c:pt idx="2">
                    <c:v>ZP452</c:v>
                  </c:pt>
                  <c:pt idx="3">
                    <c:v>Q32.3</c:v>
                  </c:pt>
                  <c:pt idx="4">
                    <c:v>DBVPG1788</c:v>
                  </c:pt>
                  <c:pt idx="5">
                    <c:v>NBRC10990</c:v>
                  </c:pt>
                  <c:pt idx="6">
                    <c:v>LD7</c:v>
                  </c:pt>
                  <c:pt idx="7">
                    <c:v>Q62.5</c:v>
                  </c:pt>
                  <c:pt idx="8">
                    <c:v>DBVPG1853</c:v>
                  </c:pt>
                  <c:pt idx="9">
                    <c:v>L-1528</c:v>
                  </c:pt>
                  <c:pt idx="10">
                    <c:v>UWOPS83-787.3</c:v>
                  </c:pt>
                  <c:pt idx="11">
                    <c:v>Y8.5</c:v>
                  </c:pt>
                  <c:pt idx="12">
                    <c:v>322134S</c:v>
                  </c:pt>
                  <c:pt idx="13">
                    <c:v>YPS128</c:v>
                  </c:pt>
                  <c:pt idx="14">
                    <c:v>N-44</c:v>
                  </c:pt>
                  <c:pt idx="15">
                    <c:v>UWOPS91-917.1</c:v>
                  </c:pt>
                  <c:pt idx="16">
                    <c:v>Q59.1</c:v>
                  </c:pt>
                  <c:pt idx="17">
                    <c:v>Y6.5</c:v>
                  </c:pt>
                  <c:pt idx="18">
                    <c:v>322134S</c:v>
                  </c:pt>
                  <c:pt idx="19">
                    <c:v>Q31.4</c:v>
                  </c:pt>
                  <c:pt idx="20">
                    <c:v>RM11</c:v>
                  </c:pt>
                  <c:pt idx="21">
                    <c:v>IFO1803</c:v>
                  </c:pt>
                  <c:pt idx="22">
                    <c:v>S288C</c:v>
                  </c:pt>
                  <c:pt idx="23">
                    <c:v>YPS138</c:v>
                  </c:pt>
                  <c:pt idx="24">
                    <c:v>2.3319</c:v>
                  </c:pt>
                  <c:pt idx="25">
                    <c:v>2.3318</c:v>
                  </c:pt>
                  <c:pt idx="26">
                    <c:v>IFO1802</c:v>
                  </c:pt>
                  <c:pt idx="27">
                    <c:v>Y8.1</c:v>
                  </c:pt>
                  <c:pt idx="28">
                    <c:v>L-1764</c:v>
                  </c:pt>
                  <c:pt idx="29">
                    <c:v>YJM978</c:v>
                  </c:pt>
                  <c:pt idx="30">
                    <c:v>S36.7</c:v>
                  </c:pt>
                  <c:pt idx="31">
                    <c:v>Y7</c:v>
                  </c:pt>
                  <c:pt idx="32">
                    <c:v>IFO1816</c:v>
                  </c:pt>
                  <c:pt idx="33">
                    <c:v>YPS606</c:v>
                  </c:pt>
                  <c:pt idx="34">
                    <c:v>A12</c:v>
                  </c:pt>
                  <c:pt idx="35">
                    <c:v>ZP594</c:v>
                  </c:pt>
                  <c:pt idx="36">
                    <c:v>KPN3829</c:v>
                  </c:pt>
                  <c:pt idx="37">
                    <c:v>UWOPS87-2421</c:v>
                  </c:pt>
                  <c:pt idx="38">
                    <c:v>N-45</c:v>
                  </c:pt>
                  <c:pt idx="39">
                    <c:v>ZP555</c:v>
                  </c:pt>
                  <c:pt idx="40">
                    <c:v>A4</c:v>
                  </c:pt>
                  <c:pt idx="41">
                    <c:v>Y55</c:v>
                  </c:pt>
                  <c:pt idx="42">
                    <c:v>N-43</c:v>
                  </c:pt>
                  <c:pt idx="43">
                    <c:v>UFRJ50816</c:v>
                  </c:pt>
                  <c:pt idx="44">
                    <c:v>K11</c:v>
                  </c:pt>
                  <c:pt idx="45">
                    <c:v>UWOPS03-461.4</c:v>
                  </c:pt>
                  <c:pt idx="46">
                    <c:v>YIIc17_E5</c:v>
                  </c:pt>
                  <c:pt idx="47">
                    <c:v>NCYC361</c:v>
                  </c:pt>
                  <c:pt idx="48">
                    <c:v>Y9</c:v>
                  </c:pt>
                  <c:pt idx="49">
                    <c:v>CBS5829</c:v>
                  </c:pt>
                  <c:pt idx="50">
                    <c:v>L-1374</c:v>
                  </c:pt>
                  <c:pt idx="51">
                    <c:v>DBVPG4650</c:v>
                  </c:pt>
                  <c:pt idx="52">
                    <c:v>DBVPG6765</c:v>
                  </c:pt>
                  <c:pt idx="53">
                    <c:v>CBS432</c:v>
                  </c:pt>
                  <c:pt idx="54">
                    <c:v>DBVPG6044</c:v>
                  </c:pt>
                  <c:pt idx="55">
                    <c:v>BC187</c:v>
                  </c:pt>
                  <c:pt idx="56">
                    <c:v>DBVP1106</c:v>
                  </c:pt>
                  <c:pt idx="57">
                    <c:v>IFO1815</c:v>
                  </c:pt>
                  <c:pt idx="58">
                    <c:v>DBVPG1373</c:v>
                  </c:pt>
                  <c:pt idx="59">
                    <c:v>Z1</c:v>
                  </c:pt>
                  <c:pt idx="60">
                    <c:v>T21.4</c:v>
                  </c:pt>
                  <c:pt idx="61">
                    <c:v>UWOPS05-217.3</c:v>
                  </c:pt>
                  <c:pt idx="62">
                    <c:v>GL379</c:v>
                  </c:pt>
                  <c:pt idx="63">
                    <c:v>YS2</c:v>
                  </c:pt>
                  <c:pt idx="64">
                    <c:v>UWOPS05-227.2</c:v>
                  </c:pt>
                  <c:pt idx="65">
                    <c:v>Y9.6</c:v>
                  </c:pt>
                  <c:pt idx="66">
                    <c:v>Q95.3</c:v>
                  </c:pt>
                  <c:pt idx="67">
                    <c:v>273614N</c:v>
                  </c:pt>
                  <c:pt idx="68">
                    <c:v>IFO1804</c:v>
                  </c:pt>
                  <c:pt idx="69">
                    <c:v>NCYC110</c:v>
                  </c:pt>
                  <c:pt idx="70">
                    <c:v>YJM975</c:v>
                  </c:pt>
                  <c:pt idx="71">
                    <c:v>YJM981</c:v>
                  </c:pt>
                  <c:pt idx="72">
                    <c:v>Q89.8</c:v>
                  </c:pt>
                  <c:pt idx="73">
                    <c:v>YS9</c:v>
                  </c:pt>
                  <c:pt idx="74">
                    <c:v>YJM789</c:v>
                  </c:pt>
                  <c:pt idx="75">
                    <c:v>KPN3828</c:v>
                  </c:pt>
                  <c:pt idx="76">
                    <c:v>UFRJ50791</c:v>
                  </c:pt>
                  <c:pt idx="77">
                    <c:v>SK1</c:v>
                  </c:pt>
                  <c:pt idx="78">
                    <c:v>YS4</c:v>
                  </c:pt>
                  <c:pt idx="79">
                    <c:v>DBVPG6040</c:v>
                  </c:pt>
                  <c:pt idx="80">
                    <c:v>DBVPG6304</c:v>
                  </c:pt>
                  <c:pt idx="81">
                    <c:v>Y12</c:v>
                  </c:pt>
                  <c:pt idx="82">
                    <c:v>378604X</c:v>
                  </c:pt>
                  <c:pt idx="83">
                    <c:v>Z1.1</c:v>
                  </c:pt>
                  <c:pt idx="84">
                    <c:v>Q96.8</c:v>
                  </c:pt>
                  <c:pt idx="85">
                    <c:v>UWOPS99-807.1.1</c:v>
                  </c:pt>
                  <c:pt idx="86">
                    <c:v>2.3317</c:v>
                  </c:pt>
                  <c:pt idx="87">
                    <c:v>Q74.4</c:v>
                  </c:pt>
                  <c:pt idx="88">
                    <c:v>CBS4309</c:v>
                  </c:pt>
                  <c:pt idx="89">
                    <c:v>DBVPG6045</c:v>
                  </c:pt>
                </c:lvl>
                <c:lvl>
                  <c:pt idx="0">
                    <c:v>S. paradoxus</c:v>
                  </c:pt>
                  <c:pt idx="1">
                    <c:v>S. cerevisiae</c:v>
                  </c:pt>
                  <c:pt idx="2">
                    <c:v>S. kudriavzevii</c:v>
                  </c:pt>
                  <c:pt idx="3">
                    <c:v>S. paradoxus</c:v>
                  </c:pt>
                  <c:pt idx="4">
                    <c:v>S. cerevisiae</c:v>
                  </c:pt>
                  <c:pt idx="5">
                    <c:v>S. kudriavzevii</c:v>
                  </c:pt>
                  <c:pt idx="6">
                    <c:v>S. paradoxus</c:v>
                  </c:pt>
                  <c:pt idx="7">
                    <c:v>S. paradoxus</c:v>
                  </c:pt>
                  <c:pt idx="8">
                    <c:v>S. cerevisiae</c:v>
                  </c:pt>
                  <c:pt idx="9">
                    <c:v>S. cerevisiae</c:v>
                  </c:pt>
                  <c:pt idx="10">
                    <c:v>S. cerevisiae</c:v>
                  </c:pt>
                  <c:pt idx="11">
                    <c:v>S. paradoxus</c:v>
                  </c:pt>
                  <c:pt idx="12">
                    <c:v>S. cerevisiae</c:v>
                  </c:pt>
                  <c:pt idx="13">
                    <c:v>S. cerevisiae</c:v>
                  </c:pt>
                  <c:pt idx="14">
                    <c:v>S. paradoxus</c:v>
                  </c:pt>
                  <c:pt idx="15">
                    <c:v>S. paradoxus</c:v>
                  </c:pt>
                  <c:pt idx="16">
                    <c:v>S. paradoxus</c:v>
                  </c:pt>
                  <c:pt idx="17">
                    <c:v>S. paradoxus</c:v>
                  </c:pt>
                  <c:pt idx="18">
                    <c:v>S. cerevisiae</c:v>
                  </c:pt>
                  <c:pt idx="19">
                    <c:v>S. paradoxus</c:v>
                  </c:pt>
                  <c:pt idx="20">
                    <c:v>S. cerevisiae</c:v>
                  </c:pt>
                  <c:pt idx="21">
                    <c:v>S. kudriavzevii</c:v>
                  </c:pt>
                  <c:pt idx="22">
                    <c:v>S. cerevisiae</c:v>
                  </c:pt>
                  <c:pt idx="23">
                    <c:v>S. paradoxus</c:v>
                  </c:pt>
                  <c:pt idx="24">
                    <c:v>S. arboricolus</c:v>
                  </c:pt>
                  <c:pt idx="25">
                    <c:v>S. arboricolus</c:v>
                  </c:pt>
                  <c:pt idx="26">
                    <c:v>S. kudriavzevii</c:v>
                  </c:pt>
                  <c:pt idx="27">
                    <c:v>S. paradoxus</c:v>
                  </c:pt>
                  <c:pt idx="28">
                    <c:v>S. bayanus</c:v>
                  </c:pt>
                  <c:pt idx="29">
                    <c:v>S. cerevisiae</c:v>
                  </c:pt>
                  <c:pt idx="30">
                    <c:v>S. paradoxus</c:v>
                  </c:pt>
                  <c:pt idx="31">
                    <c:v>S. paradoxus</c:v>
                  </c:pt>
                  <c:pt idx="32">
                    <c:v>S. mikatae</c:v>
                  </c:pt>
                  <c:pt idx="33">
                    <c:v>S. cerevisiae</c:v>
                  </c:pt>
                  <c:pt idx="34">
                    <c:v>S. paradoxus</c:v>
                  </c:pt>
                  <c:pt idx="35">
                    <c:v>S. kudriavzevii</c:v>
                  </c:pt>
                  <c:pt idx="36">
                    <c:v>S. cerevisiae</c:v>
                  </c:pt>
                  <c:pt idx="37">
                    <c:v>S. cerevisiae</c:v>
                  </c:pt>
                  <c:pt idx="38">
                    <c:v>S. paradoxus</c:v>
                  </c:pt>
                  <c:pt idx="39">
                    <c:v>S. bayanus</c:v>
                  </c:pt>
                  <c:pt idx="40">
                    <c:v>S. paradoxus</c:v>
                  </c:pt>
                  <c:pt idx="41">
                    <c:v>S. cerevisiae</c:v>
                  </c:pt>
                  <c:pt idx="42">
                    <c:v>S. paradoxus</c:v>
                  </c:pt>
                  <c:pt idx="43">
                    <c:v>S. paradoxus</c:v>
                  </c:pt>
                  <c:pt idx="44">
                    <c:v>S. cerevisiae</c:v>
                  </c:pt>
                  <c:pt idx="45">
                    <c:v>S. cerevisiae</c:v>
                  </c:pt>
                  <c:pt idx="46">
                    <c:v>S. cerevisiae</c:v>
                  </c:pt>
                  <c:pt idx="47">
                    <c:v>S. cerevisiae</c:v>
                  </c:pt>
                  <c:pt idx="48">
                    <c:v>S. cerevisiae</c:v>
                  </c:pt>
                  <c:pt idx="49">
                    <c:v>S. paradoxus</c:v>
                  </c:pt>
                  <c:pt idx="50">
                    <c:v>S. cerevisiae</c:v>
                  </c:pt>
                  <c:pt idx="51">
                    <c:v>S. paradoxus</c:v>
                  </c:pt>
                  <c:pt idx="52">
                    <c:v>S. cerevisiae</c:v>
                  </c:pt>
                  <c:pt idx="53">
                    <c:v>S. paradoxus</c:v>
                  </c:pt>
                  <c:pt idx="54">
                    <c:v>S. cerevisiae</c:v>
                  </c:pt>
                  <c:pt idx="55">
                    <c:v>S. cerevisiae</c:v>
                  </c:pt>
                  <c:pt idx="56">
                    <c:v>S. cerevisiae</c:v>
                  </c:pt>
                  <c:pt idx="57">
                    <c:v>S. mikatae</c:v>
                  </c:pt>
                  <c:pt idx="58">
                    <c:v>S. cerevisiae</c:v>
                  </c:pt>
                  <c:pt idx="59">
                    <c:v>S. paradoxus</c:v>
                  </c:pt>
                  <c:pt idx="60">
                    <c:v>S. paradoxus</c:v>
                  </c:pt>
                  <c:pt idx="61">
                    <c:v>S. cerevisiae</c:v>
                  </c:pt>
                  <c:pt idx="62">
                    <c:v>S. paradoxus</c:v>
                  </c:pt>
                  <c:pt idx="63">
                    <c:v>S. cerevisiae</c:v>
                  </c:pt>
                  <c:pt idx="64">
                    <c:v>S. cerevisiae</c:v>
                  </c:pt>
                  <c:pt idx="65">
                    <c:v>S. paradoxus</c:v>
                  </c:pt>
                  <c:pt idx="66">
                    <c:v>S. paradoxus</c:v>
                  </c:pt>
                  <c:pt idx="67">
                    <c:v>S. cerevisiae</c:v>
                  </c:pt>
                  <c:pt idx="68">
                    <c:v>S. paradoxus</c:v>
                  </c:pt>
                  <c:pt idx="69">
                    <c:v>S. cerevisiae</c:v>
                  </c:pt>
                  <c:pt idx="70">
                    <c:v>S. cerevisiae</c:v>
                  </c:pt>
                  <c:pt idx="71">
                    <c:v>S. cerevisiae</c:v>
                  </c:pt>
                  <c:pt idx="72">
                    <c:v>S. paradoxus</c:v>
                  </c:pt>
                  <c:pt idx="73">
                    <c:v>S. cerevisiae</c:v>
                  </c:pt>
                  <c:pt idx="74">
                    <c:v>S. cerevisiae</c:v>
                  </c:pt>
                  <c:pt idx="75">
                    <c:v>S. cerevisiae</c:v>
                  </c:pt>
                  <c:pt idx="76">
                    <c:v>S. paradoxus</c:v>
                  </c:pt>
                  <c:pt idx="77">
                    <c:v>S. cerevisiae</c:v>
                  </c:pt>
                  <c:pt idx="78">
                    <c:v>S. cerevisiae</c:v>
                  </c:pt>
                  <c:pt idx="79">
                    <c:v>S. cerevisiae</c:v>
                  </c:pt>
                  <c:pt idx="80">
                    <c:v>S. paradoxus</c:v>
                  </c:pt>
                  <c:pt idx="81">
                    <c:v>S. cerevisiae</c:v>
                  </c:pt>
                  <c:pt idx="82">
                    <c:v>S. cerevisiae</c:v>
                  </c:pt>
                  <c:pt idx="83">
                    <c:v>S. paradoxus</c:v>
                  </c:pt>
                  <c:pt idx="84">
                    <c:v>S. paradoxus</c:v>
                  </c:pt>
                  <c:pt idx="85">
                    <c:v>S. bayanus</c:v>
                  </c:pt>
                  <c:pt idx="86">
                    <c:v>S. arboricolus</c:v>
                  </c:pt>
                  <c:pt idx="87">
                    <c:v>S. paradoxus</c:v>
                  </c:pt>
                  <c:pt idx="88">
                    <c:v>S. castelli</c:v>
                  </c:pt>
                  <c:pt idx="89">
                    <c:v>S. bayanus</c:v>
                  </c:pt>
                </c:lvl>
              </c:multiLvlStrCache>
            </c:multiLvlStrRef>
          </c:xVal>
          <c:yVal>
            <c:numRef>
              <c:f>'Sorbitol -1'!$F$2:$F$91</c:f>
              <c:numCache>
                <c:formatCode>0</c:formatCode>
                <c:ptCount val="90"/>
                <c:pt idx="0">
                  <c:v>2.7676749473713684</c:v>
                </c:pt>
                <c:pt idx="1">
                  <c:v>32.142857142857146</c:v>
                </c:pt>
                <c:pt idx="2">
                  <c:v>53.213837585924907</c:v>
                </c:pt>
                <c:pt idx="3">
                  <c:v>53.547942359506791</c:v>
                </c:pt>
                <c:pt idx="4">
                  <c:v>53.723404255319153</c:v>
                </c:pt>
                <c:pt idx="5">
                  <c:v>62.5</c:v>
                </c:pt>
                <c:pt idx="6">
                  <c:v>67.526809007031659</c:v>
                </c:pt>
                <c:pt idx="7">
                  <c:v>67.567567567567593</c:v>
                </c:pt>
                <c:pt idx="8">
                  <c:v>67.592592592592595</c:v>
                </c:pt>
                <c:pt idx="9">
                  <c:v>67.721518987341796</c:v>
                </c:pt>
                <c:pt idx="10">
                  <c:v>67.741935483870961</c:v>
                </c:pt>
                <c:pt idx="11">
                  <c:v>68.419678213964872</c:v>
                </c:pt>
                <c:pt idx="12">
                  <c:v>69.671625471739901</c:v>
                </c:pt>
                <c:pt idx="13">
                  <c:v>73.214285714285708</c:v>
                </c:pt>
                <c:pt idx="14">
                  <c:v>73.863286750776354</c:v>
                </c:pt>
                <c:pt idx="15">
                  <c:v>74.154469411060688</c:v>
                </c:pt>
                <c:pt idx="16">
                  <c:v>74.375660242716108</c:v>
                </c:pt>
                <c:pt idx="17">
                  <c:v>77.453273770000891</c:v>
                </c:pt>
                <c:pt idx="18">
                  <c:v>78.301886792452862</c:v>
                </c:pt>
                <c:pt idx="19">
                  <c:v>79.026560267267726</c:v>
                </c:pt>
                <c:pt idx="20">
                  <c:v>79.452054794520549</c:v>
                </c:pt>
                <c:pt idx="21">
                  <c:v>81.578947368421041</c:v>
                </c:pt>
                <c:pt idx="22">
                  <c:v>82.383419689119165</c:v>
                </c:pt>
                <c:pt idx="23">
                  <c:v>84.666666666666657</c:v>
                </c:pt>
                <c:pt idx="24">
                  <c:v>85.074626865671632</c:v>
                </c:pt>
                <c:pt idx="25">
                  <c:v>86.925976317411084</c:v>
                </c:pt>
                <c:pt idx="26">
                  <c:v>88.95348837209302</c:v>
                </c:pt>
                <c:pt idx="27">
                  <c:v>89.726027397260282</c:v>
                </c:pt>
                <c:pt idx="28">
                  <c:v>90.78947368421052</c:v>
                </c:pt>
                <c:pt idx="29">
                  <c:v>90.972222222222229</c:v>
                </c:pt>
                <c:pt idx="30">
                  <c:v>91.304347826086953</c:v>
                </c:pt>
                <c:pt idx="31">
                  <c:v>92.175796883306859</c:v>
                </c:pt>
                <c:pt idx="32">
                  <c:v>92.441860465116292</c:v>
                </c:pt>
                <c:pt idx="33">
                  <c:v>92.464266423381915</c:v>
                </c:pt>
                <c:pt idx="34">
                  <c:v>92.880527326557697</c:v>
                </c:pt>
                <c:pt idx="35">
                  <c:v>93.750000000000014</c:v>
                </c:pt>
                <c:pt idx="36">
                  <c:v>94.318052568582388</c:v>
                </c:pt>
                <c:pt idx="37">
                  <c:v>94.512195121951237</c:v>
                </c:pt>
                <c:pt idx="38">
                  <c:v>94.531249999999972</c:v>
                </c:pt>
                <c:pt idx="39">
                  <c:v>96.268656716417894</c:v>
                </c:pt>
                <c:pt idx="40">
                  <c:v>96.835443037974699</c:v>
                </c:pt>
                <c:pt idx="41">
                  <c:v>97.67441860465118</c:v>
                </c:pt>
                <c:pt idx="42">
                  <c:v>98.76692697131945</c:v>
                </c:pt>
                <c:pt idx="43">
                  <c:v>99.566129419727659</c:v>
                </c:pt>
                <c:pt idx="44">
                  <c:v>99.71880616571039</c:v>
                </c:pt>
                <c:pt idx="45">
                  <c:v>101.72926596743845</c:v>
                </c:pt>
                <c:pt idx="46">
                  <c:v>102.06185567010316</c:v>
                </c:pt>
                <c:pt idx="47">
                  <c:v>103.47222222222223</c:v>
                </c:pt>
                <c:pt idx="48">
                  <c:v>103.70370370370368</c:v>
                </c:pt>
                <c:pt idx="49">
                  <c:v>103.71529839444827</c:v>
                </c:pt>
                <c:pt idx="50">
                  <c:v>103.94736842105266</c:v>
                </c:pt>
                <c:pt idx="51">
                  <c:v>104.19161676646702</c:v>
                </c:pt>
                <c:pt idx="52">
                  <c:v>104.72972972972974</c:v>
                </c:pt>
                <c:pt idx="53">
                  <c:v>106.89448008940869</c:v>
                </c:pt>
                <c:pt idx="54">
                  <c:v>107.7586206896552</c:v>
                </c:pt>
                <c:pt idx="55">
                  <c:v>108.3333333333333</c:v>
                </c:pt>
                <c:pt idx="56">
                  <c:v>110.13513513513513</c:v>
                </c:pt>
                <c:pt idx="57">
                  <c:v>110.41666666666667</c:v>
                </c:pt>
                <c:pt idx="58">
                  <c:v>112.32876712328761</c:v>
                </c:pt>
                <c:pt idx="59">
                  <c:v>113.69863013698631</c:v>
                </c:pt>
                <c:pt idx="60">
                  <c:v>115.45454545454552</c:v>
                </c:pt>
                <c:pt idx="61">
                  <c:v>117.2924715894319</c:v>
                </c:pt>
                <c:pt idx="62">
                  <c:v>117.73409296467922</c:v>
                </c:pt>
                <c:pt idx="63">
                  <c:v>118.54838709677421</c:v>
                </c:pt>
                <c:pt idx="64">
                  <c:v>118.99241413160982</c:v>
                </c:pt>
                <c:pt idx="65">
                  <c:v>119.26829268292683</c:v>
                </c:pt>
                <c:pt idx="66">
                  <c:v>120.44440702428192</c:v>
                </c:pt>
                <c:pt idx="67">
                  <c:v>121.80736724398172</c:v>
                </c:pt>
                <c:pt idx="68">
                  <c:v>122.9971423036979</c:v>
                </c:pt>
                <c:pt idx="69">
                  <c:v>123.94366197183101</c:v>
                </c:pt>
                <c:pt idx="70">
                  <c:v>124.21845829905453</c:v>
                </c:pt>
                <c:pt idx="71">
                  <c:v>125.08347550034648</c:v>
                </c:pt>
                <c:pt idx="72">
                  <c:v>127.11864406779662</c:v>
                </c:pt>
                <c:pt idx="73">
                  <c:v>127.14285714285711</c:v>
                </c:pt>
                <c:pt idx="74">
                  <c:v>128.05694968892249</c:v>
                </c:pt>
                <c:pt idx="75">
                  <c:v>128.46153846153848</c:v>
                </c:pt>
                <c:pt idx="76">
                  <c:v>128.46153846153848</c:v>
                </c:pt>
                <c:pt idx="77">
                  <c:v>129.31034482758619</c:v>
                </c:pt>
                <c:pt idx="78">
                  <c:v>130.30303030303031</c:v>
                </c:pt>
                <c:pt idx="79">
                  <c:v>130.39215686274508</c:v>
                </c:pt>
                <c:pt idx="80">
                  <c:v>133.0985915492958</c:v>
                </c:pt>
                <c:pt idx="81">
                  <c:v>133.24468085106383</c:v>
                </c:pt>
                <c:pt idx="82">
                  <c:v>134.83346181832437</c:v>
                </c:pt>
                <c:pt idx="83">
                  <c:v>136.71874999999997</c:v>
                </c:pt>
                <c:pt idx="84">
                  <c:v>151.72413793103451</c:v>
                </c:pt>
                <c:pt idx="85">
                  <c:v>172.8896103896104</c:v>
                </c:pt>
                <c:pt idx="86">
                  <c:v>175.60975609756105</c:v>
                </c:pt>
                <c:pt idx="87">
                  <c:v>182.29166666666669</c:v>
                </c:pt>
                <c:pt idx="88">
                  <c:v>194.04761904761904</c:v>
                </c:pt>
                <c:pt idx="89">
                  <c:v>278.32512315270924</c:v>
                </c:pt>
              </c:numCache>
            </c:numRef>
          </c:yVal>
          <c:smooth val="0"/>
        </c:ser>
        <c:ser>
          <c:idx val="6"/>
          <c:order val="1"/>
          <c:tx>
            <c:strRef>
              <c:f>'Sorbitol -1'!$M$1</c:f>
              <c:strCache>
                <c:ptCount val="1"/>
                <c:pt idx="0">
                  <c:v>15% Sorbitol</c:v>
                </c:pt>
              </c:strCache>
            </c:strRef>
          </c:tx>
          <c:spPr>
            <a:ln w="28575">
              <a:noFill/>
            </a:ln>
          </c:spPr>
          <c:marker>
            <c:spPr>
              <a:ln>
                <a:solidFill>
                  <a:schemeClr val="tx1"/>
                </a:solidFill>
              </a:ln>
            </c:spPr>
          </c:marker>
          <c:xVal>
            <c:multiLvlStrRef>
              <c:f>'[figure 1A.xlsx]Sorbitol -1'!$D$2:$E$91</c:f>
              <c:multiLvlStrCache>
                <c:ptCount val="90"/>
                <c:lvl>
                  <c:pt idx="0">
                    <c:v>N-17</c:v>
                  </c:pt>
                  <c:pt idx="1">
                    <c:v>W303</c:v>
                  </c:pt>
                  <c:pt idx="2">
                    <c:v>ZP452</c:v>
                  </c:pt>
                  <c:pt idx="3">
                    <c:v>Q32.3</c:v>
                  </c:pt>
                  <c:pt idx="4">
                    <c:v>DBVPG1788</c:v>
                  </c:pt>
                  <c:pt idx="5">
                    <c:v>NBRC10990</c:v>
                  </c:pt>
                  <c:pt idx="6">
                    <c:v>LD7</c:v>
                  </c:pt>
                  <c:pt idx="7">
                    <c:v>Q62.5</c:v>
                  </c:pt>
                  <c:pt idx="8">
                    <c:v>DBVPG1853</c:v>
                  </c:pt>
                  <c:pt idx="9">
                    <c:v>L-1528</c:v>
                  </c:pt>
                  <c:pt idx="10">
                    <c:v>UWOPS83-787.3</c:v>
                  </c:pt>
                  <c:pt idx="11">
                    <c:v>Y8.5</c:v>
                  </c:pt>
                  <c:pt idx="12">
                    <c:v>322134S</c:v>
                  </c:pt>
                  <c:pt idx="13">
                    <c:v>YPS128</c:v>
                  </c:pt>
                  <c:pt idx="14">
                    <c:v>N-44</c:v>
                  </c:pt>
                  <c:pt idx="15">
                    <c:v>UWOPS91-917.1</c:v>
                  </c:pt>
                  <c:pt idx="16">
                    <c:v>Q59.1</c:v>
                  </c:pt>
                  <c:pt idx="17">
                    <c:v>Y6.5</c:v>
                  </c:pt>
                  <c:pt idx="18">
                    <c:v>322134S</c:v>
                  </c:pt>
                  <c:pt idx="19">
                    <c:v>Q31.4</c:v>
                  </c:pt>
                  <c:pt idx="20">
                    <c:v>RM11</c:v>
                  </c:pt>
                  <c:pt idx="21">
                    <c:v>IFO1803</c:v>
                  </c:pt>
                  <c:pt idx="22">
                    <c:v>S288C</c:v>
                  </c:pt>
                  <c:pt idx="23">
                    <c:v>YPS138</c:v>
                  </c:pt>
                  <c:pt idx="24">
                    <c:v>2.3319</c:v>
                  </c:pt>
                  <c:pt idx="25">
                    <c:v>2.3318</c:v>
                  </c:pt>
                  <c:pt idx="26">
                    <c:v>IFO1802</c:v>
                  </c:pt>
                  <c:pt idx="27">
                    <c:v>Y8.1</c:v>
                  </c:pt>
                  <c:pt idx="28">
                    <c:v>L-1764</c:v>
                  </c:pt>
                  <c:pt idx="29">
                    <c:v>YJM978</c:v>
                  </c:pt>
                  <c:pt idx="30">
                    <c:v>S36.7</c:v>
                  </c:pt>
                  <c:pt idx="31">
                    <c:v>Y7</c:v>
                  </c:pt>
                  <c:pt idx="32">
                    <c:v>IFO1816</c:v>
                  </c:pt>
                  <c:pt idx="33">
                    <c:v>YPS606</c:v>
                  </c:pt>
                  <c:pt idx="34">
                    <c:v>A12</c:v>
                  </c:pt>
                  <c:pt idx="35">
                    <c:v>ZP594</c:v>
                  </c:pt>
                  <c:pt idx="36">
                    <c:v>KPN3829</c:v>
                  </c:pt>
                  <c:pt idx="37">
                    <c:v>UWOPS87-2421</c:v>
                  </c:pt>
                  <c:pt idx="38">
                    <c:v>N-45</c:v>
                  </c:pt>
                  <c:pt idx="39">
                    <c:v>ZP555</c:v>
                  </c:pt>
                  <c:pt idx="40">
                    <c:v>A4</c:v>
                  </c:pt>
                  <c:pt idx="41">
                    <c:v>Y55</c:v>
                  </c:pt>
                  <c:pt idx="42">
                    <c:v>N-43</c:v>
                  </c:pt>
                  <c:pt idx="43">
                    <c:v>UFRJ50816</c:v>
                  </c:pt>
                  <c:pt idx="44">
                    <c:v>K11</c:v>
                  </c:pt>
                  <c:pt idx="45">
                    <c:v>UWOPS03-461.4</c:v>
                  </c:pt>
                  <c:pt idx="46">
                    <c:v>YIIc17_E5</c:v>
                  </c:pt>
                  <c:pt idx="47">
                    <c:v>NCYC361</c:v>
                  </c:pt>
                  <c:pt idx="48">
                    <c:v>Y9</c:v>
                  </c:pt>
                  <c:pt idx="49">
                    <c:v>CBS5829</c:v>
                  </c:pt>
                  <c:pt idx="50">
                    <c:v>L-1374</c:v>
                  </c:pt>
                  <c:pt idx="51">
                    <c:v>DBVPG4650</c:v>
                  </c:pt>
                  <c:pt idx="52">
                    <c:v>DBVPG6765</c:v>
                  </c:pt>
                  <c:pt idx="53">
                    <c:v>CBS432</c:v>
                  </c:pt>
                  <c:pt idx="54">
                    <c:v>DBVPG6044</c:v>
                  </c:pt>
                  <c:pt idx="55">
                    <c:v>BC187</c:v>
                  </c:pt>
                  <c:pt idx="56">
                    <c:v>DBVP1106</c:v>
                  </c:pt>
                  <c:pt idx="57">
                    <c:v>IFO1815</c:v>
                  </c:pt>
                  <c:pt idx="58">
                    <c:v>DBVPG1373</c:v>
                  </c:pt>
                  <c:pt idx="59">
                    <c:v>Z1</c:v>
                  </c:pt>
                  <c:pt idx="60">
                    <c:v>T21.4</c:v>
                  </c:pt>
                  <c:pt idx="61">
                    <c:v>UWOPS05-217.3</c:v>
                  </c:pt>
                  <c:pt idx="62">
                    <c:v>GL379</c:v>
                  </c:pt>
                  <c:pt idx="63">
                    <c:v>YS2</c:v>
                  </c:pt>
                  <c:pt idx="64">
                    <c:v>UWOPS05-227.2</c:v>
                  </c:pt>
                  <c:pt idx="65">
                    <c:v>Y9.6</c:v>
                  </c:pt>
                  <c:pt idx="66">
                    <c:v>Q95.3</c:v>
                  </c:pt>
                  <c:pt idx="67">
                    <c:v>273614N</c:v>
                  </c:pt>
                  <c:pt idx="68">
                    <c:v>IFO1804</c:v>
                  </c:pt>
                  <c:pt idx="69">
                    <c:v>NCYC110</c:v>
                  </c:pt>
                  <c:pt idx="70">
                    <c:v>YJM975</c:v>
                  </c:pt>
                  <c:pt idx="71">
                    <c:v>YJM981</c:v>
                  </c:pt>
                  <c:pt idx="72">
                    <c:v>Q89.8</c:v>
                  </c:pt>
                  <c:pt idx="73">
                    <c:v>YS9</c:v>
                  </c:pt>
                  <c:pt idx="74">
                    <c:v>YJM789</c:v>
                  </c:pt>
                  <c:pt idx="75">
                    <c:v>KPN3828</c:v>
                  </c:pt>
                  <c:pt idx="76">
                    <c:v>UFRJ50791</c:v>
                  </c:pt>
                  <c:pt idx="77">
                    <c:v>SK1</c:v>
                  </c:pt>
                  <c:pt idx="78">
                    <c:v>YS4</c:v>
                  </c:pt>
                  <c:pt idx="79">
                    <c:v>DBVPG6040</c:v>
                  </c:pt>
                  <c:pt idx="80">
                    <c:v>DBVPG6304</c:v>
                  </c:pt>
                  <c:pt idx="81">
                    <c:v>Y12</c:v>
                  </c:pt>
                  <c:pt idx="82">
                    <c:v>378604X</c:v>
                  </c:pt>
                  <c:pt idx="83">
                    <c:v>Z1.1</c:v>
                  </c:pt>
                  <c:pt idx="84">
                    <c:v>Q96.8</c:v>
                  </c:pt>
                  <c:pt idx="85">
                    <c:v>UWOPS99-807.1.1</c:v>
                  </c:pt>
                  <c:pt idx="86">
                    <c:v>2.3317</c:v>
                  </c:pt>
                  <c:pt idx="87">
                    <c:v>Q74.4</c:v>
                  </c:pt>
                  <c:pt idx="88">
                    <c:v>CBS4309</c:v>
                  </c:pt>
                  <c:pt idx="89">
                    <c:v>DBVPG6045</c:v>
                  </c:pt>
                </c:lvl>
                <c:lvl>
                  <c:pt idx="0">
                    <c:v>S. paradoxus</c:v>
                  </c:pt>
                  <c:pt idx="1">
                    <c:v>S. cerevisiae</c:v>
                  </c:pt>
                  <c:pt idx="2">
                    <c:v>S. kudriavzevii</c:v>
                  </c:pt>
                  <c:pt idx="3">
                    <c:v>S. paradoxus</c:v>
                  </c:pt>
                  <c:pt idx="4">
                    <c:v>S. cerevisiae</c:v>
                  </c:pt>
                  <c:pt idx="5">
                    <c:v>S. kudriavzevii</c:v>
                  </c:pt>
                  <c:pt idx="6">
                    <c:v>S. paradoxus</c:v>
                  </c:pt>
                  <c:pt idx="7">
                    <c:v>S. paradoxus</c:v>
                  </c:pt>
                  <c:pt idx="8">
                    <c:v>S. cerevisiae</c:v>
                  </c:pt>
                  <c:pt idx="9">
                    <c:v>S. cerevisiae</c:v>
                  </c:pt>
                  <c:pt idx="10">
                    <c:v>S. cerevisiae</c:v>
                  </c:pt>
                  <c:pt idx="11">
                    <c:v>S. paradoxus</c:v>
                  </c:pt>
                  <c:pt idx="12">
                    <c:v>S. cerevisiae</c:v>
                  </c:pt>
                  <c:pt idx="13">
                    <c:v>S. cerevisiae</c:v>
                  </c:pt>
                  <c:pt idx="14">
                    <c:v>S. paradoxus</c:v>
                  </c:pt>
                  <c:pt idx="15">
                    <c:v>S. paradoxus</c:v>
                  </c:pt>
                  <c:pt idx="16">
                    <c:v>S. paradoxus</c:v>
                  </c:pt>
                  <c:pt idx="17">
                    <c:v>S. paradoxus</c:v>
                  </c:pt>
                  <c:pt idx="18">
                    <c:v>S. cerevisiae</c:v>
                  </c:pt>
                  <c:pt idx="19">
                    <c:v>S. paradoxus</c:v>
                  </c:pt>
                  <c:pt idx="20">
                    <c:v>S. cerevisiae</c:v>
                  </c:pt>
                  <c:pt idx="21">
                    <c:v>S. kudriavzevii</c:v>
                  </c:pt>
                  <c:pt idx="22">
                    <c:v>S. cerevisiae</c:v>
                  </c:pt>
                  <c:pt idx="23">
                    <c:v>S. paradoxus</c:v>
                  </c:pt>
                  <c:pt idx="24">
                    <c:v>S. arboricolus</c:v>
                  </c:pt>
                  <c:pt idx="25">
                    <c:v>S. arboricolus</c:v>
                  </c:pt>
                  <c:pt idx="26">
                    <c:v>S. kudriavzevii</c:v>
                  </c:pt>
                  <c:pt idx="27">
                    <c:v>S. paradoxus</c:v>
                  </c:pt>
                  <c:pt idx="28">
                    <c:v>S. bayanus</c:v>
                  </c:pt>
                  <c:pt idx="29">
                    <c:v>S. cerevisiae</c:v>
                  </c:pt>
                  <c:pt idx="30">
                    <c:v>S. paradoxus</c:v>
                  </c:pt>
                  <c:pt idx="31">
                    <c:v>S. paradoxus</c:v>
                  </c:pt>
                  <c:pt idx="32">
                    <c:v>S. mikatae</c:v>
                  </c:pt>
                  <c:pt idx="33">
                    <c:v>S. cerevisiae</c:v>
                  </c:pt>
                  <c:pt idx="34">
                    <c:v>S. paradoxus</c:v>
                  </c:pt>
                  <c:pt idx="35">
                    <c:v>S. kudriavzevii</c:v>
                  </c:pt>
                  <c:pt idx="36">
                    <c:v>S. cerevisiae</c:v>
                  </c:pt>
                  <c:pt idx="37">
                    <c:v>S. cerevisiae</c:v>
                  </c:pt>
                  <c:pt idx="38">
                    <c:v>S. paradoxus</c:v>
                  </c:pt>
                  <c:pt idx="39">
                    <c:v>S. bayanus</c:v>
                  </c:pt>
                  <c:pt idx="40">
                    <c:v>S. paradoxus</c:v>
                  </c:pt>
                  <c:pt idx="41">
                    <c:v>S. cerevisiae</c:v>
                  </c:pt>
                  <c:pt idx="42">
                    <c:v>S. paradoxus</c:v>
                  </c:pt>
                  <c:pt idx="43">
                    <c:v>S. paradoxus</c:v>
                  </c:pt>
                  <c:pt idx="44">
                    <c:v>S. cerevisiae</c:v>
                  </c:pt>
                  <c:pt idx="45">
                    <c:v>S. cerevisiae</c:v>
                  </c:pt>
                  <c:pt idx="46">
                    <c:v>S. cerevisiae</c:v>
                  </c:pt>
                  <c:pt idx="47">
                    <c:v>S. cerevisiae</c:v>
                  </c:pt>
                  <c:pt idx="48">
                    <c:v>S. cerevisiae</c:v>
                  </c:pt>
                  <c:pt idx="49">
                    <c:v>S. paradoxus</c:v>
                  </c:pt>
                  <c:pt idx="50">
                    <c:v>S. cerevisiae</c:v>
                  </c:pt>
                  <c:pt idx="51">
                    <c:v>S. paradoxus</c:v>
                  </c:pt>
                  <c:pt idx="52">
                    <c:v>S. cerevisiae</c:v>
                  </c:pt>
                  <c:pt idx="53">
                    <c:v>S. paradoxus</c:v>
                  </c:pt>
                  <c:pt idx="54">
                    <c:v>S. cerevisiae</c:v>
                  </c:pt>
                  <c:pt idx="55">
                    <c:v>S. cerevisiae</c:v>
                  </c:pt>
                  <c:pt idx="56">
                    <c:v>S. cerevisiae</c:v>
                  </c:pt>
                  <c:pt idx="57">
                    <c:v>S. mikatae</c:v>
                  </c:pt>
                  <c:pt idx="58">
                    <c:v>S. cerevisiae</c:v>
                  </c:pt>
                  <c:pt idx="59">
                    <c:v>S. paradoxus</c:v>
                  </c:pt>
                  <c:pt idx="60">
                    <c:v>S. paradoxus</c:v>
                  </c:pt>
                  <c:pt idx="61">
                    <c:v>S. cerevisiae</c:v>
                  </c:pt>
                  <c:pt idx="62">
                    <c:v>S. paradoxus</c:v>
                  </c:pt>
                  <c:pt idx="63">
                    <c:v>S. cerevisiae</c:v>
                  </c:pt>
                  <c:pt idx="64">
                    <c:v>S. cerevisiae</c:v>
                  </c:pt>
                  <c:pt idx="65">
                    <c:v>S. paradoxus</c:v>
                  </c:pt>
                  <c:pt idx="66">
                    <c:v>S. paradoxus</c:v>
                  </c:pt>
                  <c:pt idx="67">
                    <c:v>S. cerevisiae</c:v>
                  </c:pt>
                  <c:pt idx="68">
                    <c:v>S. paradoxus</c:v>
                  </c:pt>
                  <c:pt idx="69">
                    <c:v>S. cerevisiae</c:v>
                  </c:pt>
                  <c:pt idx="70">
                    <c:v>S. cerevisiae</c:v>
                  </c:pt>
                  <c:pt idx="71">
                    <c:v>S. cerevisiae</c:v>
                  </c:pt>
                  <c:pt idx="72">
                    <c:v>S. paradoxus</c:v>
                  </c:pt>
                  <c:pt idx="73">
                    <c:v>S. cerevisiae</c:v>
                  </c:pt>
                  <c:pt idx="74">
                    <c:v>S. cerevisiae</c:v>
                  </c:pt>
                  <c:pt idx="75">
                    <c:v>S. cerevisiae</c:v>
                  </c:pt>
                  <c:pt idx="76">
                    <c:v>S. paradoxus</c:v>
                  </c:pt>
                  <c:pt idx="77">
                    <c:v>S. cerevisiae</c:v>
                  </c:pt>
                  <c:pt idx="78">
                    <c:v>S. cerevisiae</c:v>
                  </c:pt>
                  <c:pt idx="79">
                    <c:v>S. cerevisiae</c:v>
                  </c:pt>
                  <c:pt idx="80">
                    <c:v>S. paradoxus</c:v>
                  </c:pt>
                  <c:pt idx="81">
                    <c:v>S. cerevisiae</c:v>
                  </c:pt>
                  <c:pt idx="82">
                    <c:v>S. cerevisiae</c:v>
                  </c:pt>
                  <c:pt idx="83">
                    <c:v>S. paradoxus</c:v>
                  </c:pt>
                  <c:pt idx="84">
                    <c:v>S. paradoxus</c:v>
                  </c:pt>
                  <c:pt idx="85">
                    <c:v>S. bayanus</c:v>
                  </c:pt>
                  <c:pt idx="86">
                    <c:v>S. arboricolus</c:v>
                  </c:pt>
                  <c:pt idx="87">
                    <c:v>S. paradoxus</c:v>
                  </c:pt>
                  <c:pt idx="88">
                    <c:v>S. castelli</c:v>
                  </c:pt>
                  <c:pt idx="89">
                    <c:v>S. bayanus</c:v>
                  </c:pt>
                </c:lvl>
              </c:multiLvlStrCache>
            </c:multiLvlStrRef>
          </c:xVal>
          <c:yVal>
            <c:numRef>
              <c:f>'Sorbitol -1'!$M$2:$M$91</c:f>
              <c:numCache>
                <c:formatCode>0</c:formatCode>
                <c:ptCount val="90"/>
                <c:pt idx="0">
                  <c:v>6.919187368428406</c:v>
                </c:pt>
                <c:pt idx="1">
                  <c:v>33.928571428571431</c:v>
                </c:pt>
                <c:pt idx="2">
                  <c:v>41.48936170212766</c:v>
                </c:pt>
                <c:pt idx="3">
                  <c:v>42.463567366546158</c:v>
                </c:pt>
                <c:pt idx="4">
                  <c:v>42.551489910679521</c:v>
                </c:pt>
                <c:pt idx="5">
                  <c:v>45.081640011125842</c:v>
                </c:pt>
                <c:pt idx="6">
                  <c:v>46.428571428571431</c:v>
                </c:pt>
                <c:pt idx="7">
                  <c:v>46.700783799255504</c:v>
                </c:pt>
                <c:pt idx="8">
                  <c:v>47.311827956989269</c:v>
                </c:pt>
                <c:pt idx="9">
                  <c:v>48.611111111111121</c:v>
                </c:pt>
                <c:pt idx="10">
                  <c:v>48.734177215189867</c:v>
                </c:pt>
                <c:pt idx="11">
                  <c:v>51.875000000000014</c:v>
                </c:pt>
                <c:pt idx="12">
                  <c:v>53.416050875862666</c:v>
                </c:pt>
                <c:pt idx="13">
                  <c:v>54.716981132075503</c:v>
                </c:pt>
                <c:pt idx="14">
                  <c:v>54.861111111111128</c:v>
                </c:pt>
                <c:pt idx="15">
                  <c:v>56.081081081081095</c:v>
                </c:pt>
                <c:pt idx="16">
                  <c:v>56.422914666888069</c:v>
                </c:pt>
                <c:pt idx="17">
                  <c:v>56.578947368421026</c:v>
                </c:pt>
                <c:pt idx="18">
                  <c:v>60.273972602739747</c:v>
                </c:pt>
                <c:pt idx="19">
                  <c:v>60.817491745746544</c:v>
                </c:pt>
                <c:pt idx="20">
                  <c:v>61.184210526315788</c:v>
                </c:pt>
                <c:pt idx="21">
                  <c:v>63.083097653335308</c:v>
                </c:pt>
                <c:pt idx="22">
                  <c:v>63.698630136986303</c:v>
                </c:pt>
                <c:pt idx="23">
                  <c:v>64.128110380815613</c:v>
                </c:pt>
                <c:pt idx="24">
                  <c:v>64.49275362318842</c:v>
                </c:pt>
                <c:pt idx="25">
                  <c:v>66.550090042778663</c:v>
                </c:pt>
                <c:pt idx="26">
                  <c:v>66.874999999999986</c:v>
                </c:pt>
                <c:pt idx="27">
                  <c:v>67.164179104477611</c:v>
                </c:pt>
                <c:pt idx="28">
                  <c:v>67.784021205492891</c:v>
                </c:pt>
                <c:pt idx="29">
                  <c:v>70.348837209302332</c:v>
                </c:pt>
                <c:pt idx="30">
                  <c:v>71.5096172696651</c:v>
                </c:pt>
                <c:pt idx="31">
                  <c:v>72.355510199429432</c:v>
                </c:pt>
                <c:pt idx="32">
                  <c:v>72.538860103626959</c:v>
                </c:pt>
                <c:pt idx="33">
                  <c:v>72.67441860465118</c:v>
                </c:pt>
                <c:pt idx="34">
                  <c:v>73.358485331119638</c:v>
                </c:pt>
                <c:pt idx="35">
                  <c:v>73.373896048839001</c:v>
                </c:pt>
                <c:pt idx="36">
                  <c:v>73.417721518987335</c:v>
                </c:pt>
                <c:pt idx="37">
                  <c:v>74.892834967686824</c:v>
                </c:pt>
                <c:pt idx="38">
                  <c:v>75.686202620150922</c:v>
                </c:pt>
                <c:pt idx="39">
                  <c:v>75.694444444444429</c:v>
                </c:pt>
                <c:pt idx="40">
                  <c:v>76.000000000000014</c:v>
                </c:pt>
                <c:pt idx="41">
                  <c:v>76.5625</c:v>
                </c:pt>
                <c:pt idx="42">
                  <c:v>76.712328767123267</c:v>
                </c:pt>
                <c:pt idx="43">
                  <c:v>78.577002673314922</c:v>
                </c:pt>
                <c:pt idx="44">
                  <c:v>79.090909090909108</c:v>
                </c:pt>
                <c:pt idx="45">
                  <c:v>79.605263157894754</c:v>
                </c:pt>
                <c:pt idx="46">
                  <c:v>80.555555555555571</c:v>
                </c:pt>
                <c:pt idx="47">
                  <c:v>81.034482758620697</c:v>
                </c:pt>
                <c:pt idx="48">
                  <c:v>84.146341463414629</c:v>
                </c:pt>
                <c:pt idx="49">
                  <c:v>84.707372979474414</c:v>
                </c:pt>
                <c:pt idx="50">
                  <c:v>84.98188412370817</c:v>
                </c:pt>
                <c:pt idx="51">
                  <c:v>86.429415328706909</c:v>
                </c:pt>
                <c:pt idx="52">
                  <c:v>87.09677419354837</c:v>
                </c:pt>
                <c:pt idx="53">
                  <c:v>87.136803157544733</c:v>
                </c:pt>
                <c:pt idx="54">
                  <c:v>87.79069767441861</c:v>
                </c:pt>
                <c:pt idx="55">
                  <c:v>88.63636363636364</c:v>
                </c:pt>
                <c:pt idx="56">
                  <c:v>88.781904844309935</c:v>
                </c:pt>
                <c:pt idx="57">
                  <c:v>88.888888888888857</c:v>
                </c:pt>
                <c:pt idx="58">
                  <c:v>88.992328333651017</c:v>
                </c:pt>
                <c:pt idx="59">
                  <c:v>89.041095890410986</c:v>
                </c:pt>
                <c:pt idx="60">
                  <c:v>89.189189189189193</c:v>
                </c:pt>
                <c:pt idx="61">
                  <c:v>89.295689015862635</c:v>
                </c:pt>
                <c:pt idx="62">
                  <c:v>89.690721649484601</c:v>
                </c:pt>
                <c:pt idx="63">
                  <c:v>90.540540540540547</c:v>
                </c:pt>
                <c:pt idx="64">
                  <c:v>90.796019900497498</c:v>
                </c:pt>
                <c:pt idx="65">
                  <c:v>90.901439263608992</c:v>
                </c:pt>
                <c:pt idx="66">
                  <c:v>92.142857142857139</c:v>
                </c:pt>
                <c:pt idx="67">
                  <c:v>92.187499999999972</c:v>
                </c:pt>
                <c:pt idx="68">
                  <c:v>92.682926829268311</c:v>
                </c:pt>
                <c:pt idx="69">
                  <c:v>93.661971830985934</c:v>
                </c:pt>
                <c:pt idx="70">
                  <c:v>95.465510520100835</c:v>
                </c:pt>
                <c:pt idx="71">
                  <c:v>96.064814814814795</c:v>
                </c:pt>
                <c:pt idx="72">
                  <c:v>96.923076923076934</c:v>
                </c:pt>
                <c:pt idx="73">
                  <c:v>98.305084745762713</c:v>
                </c:pt>
                <c:pt idx="74">
                  <c:v>99.102730006044084</c:v>
                </c:pt>
                <c:pt idx="75">
                  <c:v>100</c:v>
                </c:pt>
                <c:pt idx="76">
                  <c:v>100.24350649350649</c:v>
                </c:pt>
                <c:pt idx="77">
                  <c:v>102.69461077844304</c:v>
                </c:pt>
                <c:pt idx="78">
                  <c:v>105.38461538461542</c:v>
                </c:pt>
                <c:pt idx="79">
                  <c:v>105.66197459646531</c:v>
                </c:pt>
                <c:pt idx="80">
                  <c:v>107.17531580430912</c:v>
                </c:pt>
                <c:pt idx="81">
                  <c:v>109.48275862068964</c:v>
                </c:pt>
                <c:pt idx="82">
                  <c:v>109.76309973336211</c:v>
                </c:pt>
                <c:pt idx="83">
                  <c:v>109.8591549295775</c:v>
                </c:pt>
                <c:pt idx="84">
                  <c:v>110.90425531914893</c:v>
                </c:pt>
                <c:pt idx="85">
                  <c:v>137.93103448275863</c:v>
                </c:pt>
                <c:pt idx="86">
                  <c:v>151.19047619047618</c:v>
                </c:pt>
                <c:pt idx="87">
                  <c:v>152.03252032520331</c:v>
                </c:pt>
                <c:pt idx="88">
                  <c:v>158.33333333333331</c:v>
                </c:pt>
                <c:pt idx="89">
                  <c:v>240.1477832512314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2919424"/>
        <c:axId val="82920000"/>
      </c:scatterChart>
      <c:valAx>
        <c:axId val="829194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1"/>
                </a:pPr>
                <a:r>
                  <a:rPr lang="en-US" b="1"/>
                  <a:t>Strains 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82920000"/>
        <c:crosses val="autoZero"/>
        <c:crossBetween val="midCat"/>
      </c:valAx>
      <c:valAx>
        <c:axId val="82920000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crossAx val="82919424"/>
        <c:crosses val="autoZero"/>
        <c:crossBetween val="midCat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49120440812310112"/>
          <c:y val="0.75065720658473556"/>
          <c:w val="0.42704233563819477"/>
          <c:h val="0.1129667551585045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928025663458733"/>
          <c:y val="3.1504094638262363E-2"/>
          <c:w val="0.765979002624672"/>
          <c:h val="0.84970893520644597"/>
        </c:manualLayout>
      </c:layout>
      <c:scatterChart>
        <c:scatterStyle val="lineMarker"/>
        <c:varyColors val="0"/>
        <c:ser>
          <c:idx val="4"/>
          <c:order val="0"/>
          <c:tx>
            <c:strRef>
              <c:f>'Sheet2 (2)'!$F$21:$F$22</c:f>
              <c:strCache>
                <c:ptCount val="1"/>
                <c:pt idx="0">
                  <c:v>YPS606 Control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2 (2)'!$V$5:$V$14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1.7589916367372142E-4</c:v>
                  </c:pt>
                  <c:pt idx="2">
                    <c:v>1.6341520915175906E-2</c:v>
                  </c:pt>
                  <c:pt idx="3">
                    <c:v>8.7627100042734288E-3</c:v>
                  </c:pt>
                  <c:pt idx="4">
                    <c:v>1.8097092290516596E-2</c:v>
                  </c:pt>
                  <c:pt idx="5">
                    <c:v>3.0682188843417529E-2</c:v>
                  </c:pt>
                  <c:pt idx="6">
                    <c:v>3.4012057733702338E-3</c:v>
                  </c:pt>
                  <c:pt idx="7">
                    <c:v>1.8567133947133394E-5</c:v>
                  </c:pt>
                  <c:pt idx="8">
                    <c:v>3.3792183779160424E-3</c:v>
                  </c:pt>
                  <c:pt idx="9">
                    <c:v>3.2253066096965123E-3</c:v>
                  </c:pt>
                </c:numCache>
              </c:numRef>
            </c:plus>
            <c:minus>
              <c:numRef>
                <c:f>'Sheet2 (2)'!$V$5:$V$14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1.7589916367372142E-4</c:v>
                  </c:pt>
                  <c:pt idx="2">
                    <c:v>1.6341520915175906E-2</c:v>
                  </c:pt>
                  <c:pt idx="3">
                    <c:v>8.7627100042734288E-3</c:v>
                  </c:pt>
                  <c:pt idx="4">
                    <c:v>1.8097092290516596E-2</c:v>
                  </c:pt>
                  <c:pt idx="5">
                    <c:v>3.0682188843417529E-2</c:v>
                  </c:pt>
                  <c:pt idx="6">
                    <c:v>3.4012057733702338E-3</c:v>
                  </c:pt>
                  <c:pt idx="7">
                    <c:v>1.8567133947133394E-5</c:v>
                  </c:pt>
                  <c:pt idx="8">
                    <c:v>3.3792183779160424E-3</c:v>
                  </c:pt>
                  <c:pt idx="9">
                    <c:v>3.2253066096965123E-3</c:v>
                  </c:pt>
                </c:numCache>
              </c:numRef>
            </c:minus>
          </c:errBars>
          <c:xVal>
            <c:numRef>
              <c:f>'Sheet2 (2)'!$A$23:$A$32</c:f>
              <c:numCache>
                <c:formatCode>General</c:formatCode>
                <c:ptCount val="10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2</c:v>
                </c:pt>
              </c:numCache>
            </c:numRef>
          </c:xVal>
          <c:yVal>
            <c:numRef>
              <c:f>'Sheet2 (2)'!$F$23:$F$32</c:f>
              <c:numCache>
                <c:formatCode>General</c:formatCode>
                <c:ptCount val="10"/>
                <c:pt idx="0">
                  <c:v>100</c:v>
                </c:pt>
                <c:pt idx="1">
                  <c:v>99.961605432984641</c:v>
                </c:pt>
                <c:pt idx="2">
                  <c:v>99.863258223598834</c:v>
                </c:pt>
                <c:pt idx="3">
                  <c:v>99.690467124593255</c:v>
                </c:pt>
                <c:pt idx="4">
                  <c:v>99.505716591986456</c:v>
                </c:pt>
                <c:pt idx="5">
                  <c:v>99.289778247397891</c:v>
                </c:pt>
                <c:pt idx="6">
                  <c:v>99.260920132390652</c:v>
                </c:pt>
                <c:pt idx="7">
                  <c:v>99.263312019110884</c:v>
                </c:pt>
                <c:pt idx="8">
                  <c:v>99.256120811513711</c:v>
                </c:pt>
                <c:pt idx="9">
                  <c:v>99.222525565375264</c:v>
                </c:pt>
              </c:numCache>
            </c:numRef>
          </c:yVal>
          <c:smooth val="0"/>
        </c:ser>
        <c:ser>
          <c:idx val="5"/>
          <c:order val="1"/>
          <c:tx>
            <c:strRef>
              <c:f>'Sheet2 (2)'!$G$21:$G$22</c:f>
              <c:strCache>
                <c:ptCount val="1"/>
                <c:pt idx="0">
                  <c:v>YPS606 Inhibitors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2 (2)'!$Z$5:$Z$14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9.8942241222372499E-3</c:v>
                  </c:pt>
                  <c:pt idx="2">
                    <c:v>6.3555193743327579E-3</c:v>
                  </c:pt>
                  <c:pt idx="3">
                    <c:v>6.6636011209325391E-4</c:v>
                  </c:pt>
                  <c:pt idx="4">
                    <c:v>1.5611148389138095E-2</c:v>
                  </c:pt>
                  <c:pt idx="5">
                    <c:v>1.854294464520253E-3</c:v>
                  </c:pt>
                  <c:pt idx="6">
                    <c:v>1.5270752569163809E-3</c:v>
                  </c:pt>
                  <c:pt idx="7">
                    <c:v>1.5363302584567632E-3</c:v>
                  </c:pt>
                  <c:pt idx="8">
                    <c:v>4.8714249721110974E-3</c:v>
                  </c:pt>
                  <c:pt idx="9">
                    <c:v>4.9269549814538764E-3</c:v>
                  </c:pt>
                </c:numCache>
              </c:numRef>
            </c:plus>
            <c:minus>
              <c:numRef>
                <c:f>'Sheet2 (2)'!$Z$5:$Z$14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9.8942241222372499E-3</c:v>
                  </c:pt>
                  <c:pt idx="2">
                    <c:v>6.3555193743327579E-3</c:v>
                  </c:pt>
                  <c:pt idx="3">
                    <c:v>6.6636011209325391E-4</c:v>
                  </c:pt>
                  <c:pt idx="4">
                    <c:v>1.5611148389138095E-2</c:v>
                  </c:pt>
                  <c:pt idx="5">
                    <c:v>1.854294464520253E-3</c:v>
                  </c:pt>
                  <c:pt idx="6">
                    <c:v>1.5270752569163809E-3</c:v>
                  </c:pt>
                  <c:pt idx="7">
                    <c:v>1.5363302584567632E-3</c:v>
                  </c:pt>
                  <c:pt idx="8">
                    <c:v>4.8714249721110974E-3</c:v>
                  </c:pt>
                  <c:pt idx="9">
                    <c:v>4.9269549814538764E-3</c:v>
                  </c:pt>
                </c:numCache>
              </c:numRef>
            </c:minus>
          </c:errBars>
          <c:xVal>
            <c:numRef>
              <c:f>'Sheet2 (2)'!$A$23:$A$32</c:f>
              <c:numCache>
                <c:formatCode>General</c:formatCode>
                <c:ptCount val="10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2</c:v>
                </c:pt>
              </c:numCache>
            </c:numRef>
          </c:xVal>
          <c:yVal>
            <c:numRef>
              <c:f>'Sheet2 (2)'!$G$23:$G$32</c:f>
              <c:numCache>
                <c:formatCode>General</c:formatCode>
                <c:ptCount val="10"/>
                <c:pt idx="0">
                  <c:v>100</c:v>
                </c:pt>
                <c:pt idx="1">
                  <c:v>99.950554901446083</c:v>
                </c:pt>
                <c:pt idx="2">
                  <c:v>99.844576811525798</c:v>
                </c:pt>
                <c:pt idx="3">
                  <c:v>99.660880583094041</c:v>
                </c:pt>
                <c:pt idx="4">
                  <c:v>99.470142271770342</c:v>
                </c:pt>
                <c:pt idx="5">
                  <c:v>99.248759563852474</c:v>
                </c:pt>
                <c:pt idx="6">
                  <c:v>99.222851336257179</c:v>
                </c:pt>
                <c:pt idx="7">
                  <c:v>99.218141344355715</c:v>
                </c:pt>
                <c:pt idx="8">
                  <c:v>99.215783076267797</c:v>
                </c:pt>
                <c:pt idx="9">
                  <c:v>99.18752312485895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0580736"/>
        <c:axId val="160583616"/>
      </c:scatterChart>
      <c:valAx>
        <c:axId val="160580736"/>
        <c:scaling>
          <c:orientation val="minMax"/>
          <c:max val="12"/>
        </c:scaling>
        <c:delete val="0"/>
        <c:axPos val="b"/>
        <c:title>
          <c:tx>
            <c:rich>
              <a:bodyPr/>
              <a:lstStyle/>
              <a:p>
                <a:pPr>
                  <a:defRPr b="1"/>
                </a:pPr>
                <a:r>
                  <a:rPr lang="en-US" b="1"/>
                  <a:t>Time (H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60583616"/>
        <c:crosses val="autoZero"/>
        <c:crossBetween val="midCat"/>
        <c:majorUnit val="2"/>
      </c:valAx>
      <c:valAx>
        <c:axId val="160583616"/>
        <c:scaling>
          <c:orientation val="minMax"/>
          <c:max val="100"/>
          <c:min val="99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 b="1"/>
                </a:pPr>
                <a:r>
                  <a:rPr lang="en-US" sz="1400" b="1"/>
                  <a:t>% weight los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60580736"/>
        <c:crosses val="autoZero"/>
        <c:crossBetween val="midCat"/>
        <c:majorUnit val="0.2"/>
      </c:valAx>
    </c:plotArea>
    <c:legend>
      <c:legendPos val="r"/>
      <c:layout>
        <c:manualLayout>
          <c:xMode val="edge"/>
          <c:yMode val="edge"/>
          <c:x val="0.50246689997083693"/>
          <c:y val="3.6653178769320505E-2"/>
          <c:w val="0.47808865558471852"/>
          <c:h val="0.11645853337786496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000" b="0"/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222543015456401"/>
          <c:y val="2.3858162420946863E-2"/>
          <c:w val="0.76451531058617672"/>
          <c:h val="0.85466558207740173"/>
        </c:manualLayout>
      </c:layout>
      <c:scatterChart>
        <c:scatterStyle val="lineMarker"/>
        <c:varyColors val="0"/>
        <c:ser>
          <c:idx val="8"/>
          <c:order val="0"/>
          <c:tx>
            <c:strRef>
              <c:f>'Sheet2 (2)'!$J$21:$J$22</c:f>
              <c:strCache>
                <c:ptCount val="1"/>
                <c:pt idx="0">
                  <c:v>DBVG1853 Control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2 (2)'!$AL$5:$AL$14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9.1682133115423715E-3</c:v>
                  </c:pt>
                  <c:pt idx="2">
                    <c:v>3.1213259379703293E-3</c:v>
                  </c:pt>
                  <c:pt idx="3">
                    <c:v>9.0575163923584199E-3</c:v>
                  </c:pt>
                  <c:pt idx="4">
                    <c:v>2.2199367389124894E-3</c:v>
                  </c:pt>
                  <c:pt idx="5">
                    <c:v>4.6438175555210673E-3</c:v>
                  </c:pt>
                  <c:pt idx="6">
                    <c:v>5.1711275104532016E-3</c:v>
                  </c:pt>
                  <c:pt idx="7">
                    <c:v>2.0998605733694463E-2</c:v>
                  </c:pt>
                  <c:pt idx="8">
                    <c:v>2.1968158060343922E-2</c:v>
                  </c:pt>
                  <c:pt idx="9">
                    <c:v>1.8617258708678218E-2</c:v>
                  </c:pt>
                </c:numCache>
              </c:numRef>
            </c:plus>
            <c:minus>
              <c:numRef>
                <c:f>'Sheet2 (2)'!$AL$5:$AL$14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9.1682133115423715E-3</c:v>
                  </c:pt>
                  <c:pt idx="2">
                    <c:v>3.1213259379703293E-3</c:v>
                  </c:pt>
                  <c:pt idx="3">
                    <c:v>9.0575163923584199E-3</c:v>
                  </c:pt>
                  <c:pt idx="4">
                    <c:v>2.2199367389124894E-3</c:v>
                  </c:pt>
                  <c:pt idx="5">
                    <c:v>4.6438175555210673E-3</c:v>
                  </c:pt>
                  <c:pt idx="6">
                    <c:v>5.1711275104532016E-3</c:v>
                  </c:pt>
                  <c:pt idx="7">
                    <c:v>2.0998605733694463E-2</c:v>
                  </c:pt>
                  <c:pt idx="8">
                    <c:v>2.1968158060343922E-2</c:v>
                  </c:pt>
                  <c:pt idx="9">
                    <c:v>1.8617258708678218E-2</c:v>
                  </c:pt>
                </c:numCache>
              </c:numRef>
            </c:minus>
          </c:errBars>
          <c:xVal>
            <c:numRef>
              <c:f>'Sheet2 (2)'!$A$23:$A$32</c:f>
              <c:numCache>
                <c:formatCode>General</c:formatCode>
                <c:ptCount val="10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2</c:v>
                </c:pt>
              </c:numCache>
            </c:numRef>
          </c:xVal>
          <c:yVal>
            <c:numRef>
              <c:f>'Sheet2 (2)'!$J$23:$J$32</c:f>
              <c:numCache>
                <c:formatCode>General</c:formatCode>
                <c:ptCount val="10"/>
                <c:pt idx="0">
                  <c:v>100</c:v>
                </c:pt>
                <c:pt idx="1">
                  <c:v>99.961389333794173</c:v>
                </c:pt>
                <c:pt idx="2">
                  <c:v>99.82980407303701</c:v>
                </c:pt>
                <c:pt idx="3">
                  <c:v>99.582515900335764</c:v>
                </c:pt>
                <c:pt idx="4">
                  <c:v>99.351813833216923</c:v>
                </c:pt>
                <c:pt idx="5">
                  <c:v>99.326405454108411</c:v>
                </c:pt>
                <c:pt idx="6">
                  <c:v>99.283382603880156</c:v>
                </c:pt>
                <c:pt idx="7">
                  <c:v>99.267451999390133</c:v>
                </c:pt>
                <c:pt idx="8">
                  <c:v>99.257288647746748</c:v>
                </c:pt>
                <c:pt idx="9">
                  <c:v>99.254919204092104</c:v>
                </c:pt>
              </c:numCache>
            </c:numRef>
          </c:yVal>
          <c:smooth val="0"/>
        </c:ser>
        <c:ser>
          <c:idx val="9"/>
          <c:order val="1"/>
          <c:tx>
            <c:strRef>
              <c:f>'Sheet2 (2)'!$K$21:$K$22</c:f>
              <c:strCache>
                <c:ptCount val="1"/>
                <c:pt idx="0">
                  <c:v>DBVG1853 Inhibitors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2 (2)'!$AP$5:$AP$14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1.9650656676442838E-2</c:v>
                  </c:pt>
                  <c:pt idx="2">
                    <c:v>5.0485112981777094E-3</c:v>
                  </c:pt>
                  <c:pt idx="3">
                    <c:v>1.9604048038030855E-2</c:v>
                  </c:pt>
                  <c:pt idx="4">
                    <c:v>1.2328553260214465E-2</c:v>
                  </c:pt>
                  <c:pt idx="5">
                    <c:v>7.5983448585576182E-3</c:v>
                  </c:pt>
                  <c:pt idx="6">
                    <c:v>3.0655979323948861E-2</c:v>
                  </c:pt>
                  <c:pt idx="7">
                    <c:v>6.2341895877352574E-3</c:v>
                  </c:pt>
                  <c:pt idx="8">
                    <c:v>1.6195933453034893E-2</c:v>
                  </c:pt>
                  <c:pt idx="9">
                    <c:v>1.6059517925961702E-2</c:v>
                  </c:pt>
                </c:numCache>
              </c:numRef>
            </c:plus>
            <c:minus>
              <c:numRef>
                <c:f>'Sheet2 (2)'!$AP$5:$AP$14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1.9650656676442838E-2</c:v>
                  </c:pt>
                  <c:pt idx="2">
                    <c:v>5.0485112981777094E-3</c:v>
                  </c:pt>
                  <c:pt idx="3">
                    <c:v>1.9604048038030855E-2</c:v>
                  </c:pt>
                  <c:pt idx="4">
                    <c:v>1.2328553260214465E-2</c:v>
                  </c:pt>
                  <c:pt idx="5">
                    <c:v>7.5983448585576182E-3</c:v>
                  </c:pt>
                  <c:pt idx="6">
                    <c:v>3.0655979323948861E-2</c:v>
                  </c:pt>
                  <c:pt idx="7">
                    <c:v>6.2341895877352574E-3</c:v>
                  </c:pt>
                  <c:pt idx="8">
                    <c:v>1.6195933453034893E-2</c:v>
                  </c:pt>
                  <c:pt idx="9">
                    <c:v>1.6059517925961702E-2</c:v>
                  </c:pt>
                </c:numCache>
              </c:numRef>
            </c:minus>
          </c:errBars>
          <c:xVal>
            <c:numRef>
              <c:f>'Sheet2 (2)'!$A$23:$A$32</c:f>
              <c:numCache>
                <c:formatCode>General</c:formatCode>
                <c:ptCount val="10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2</c:v>
                </c:pt>
              </c:numCache>
            </c:numRef>
          </c:xVal>
          <c:yVal>
            <c:numRef>
              <c:f>'Sheet2 (2)'!$K$23:$K$32</c:f>
              <c:numCache>
                <c:formatCode>General</c:formatCode>
                <c:ptCount val="10"/>
                <c:pt idx="0">
                  <c:v>100</c:v>
                </c:pt>
                <c:pt idx="1">
                  <c:v>99.928209388784325</c:v>
                </c:pt>
                <c:pt idx="2">
                  <c:v>99.915058715813473</c:v>
                </c:pt>
                <c:pt idx="3">
                  <c:v>99.809560037296066</c:v>
                </c:pt>
                <c:pt idx="4">
                  <c:v>99.60364453273138</c:v>
                </c:pt>
                <c:pt idx="5">
                  <c:v>99.462250548606164</c:v>
                </c:pt>
                <c:pt idx="6">
                  <c:v>99.359035568739131</c:v>
                </c:pt>
                <c:pt idx="7">
                  <c:v>99.318476405486308</c:v>
                </c:pt>
                <c:pt idx="8">
                  <c:v>99.29695851419045</c:v>
                </c:pt>
                <c:pt idx="9">
                  <c:v>99.2825810998784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0585344"/>
        <c:axId val="160585920"/>
      </c:scatterChart>
      <c:valAx>
        <c:axId val="160585344"/>
        <c:scaling>
          <c:orientation val="minMax"/>
          <c:max val="12"/>
        </c:scaling>
        <c:delete val="0"/>
        <c:axPos val="b"/>
        <c:title>
          <c:tx>
            <c:rich>
              <a:bodyPr/>
              <a:lstStyle/>
              <a:p>
                <a:pPr>
                  <a:defRPr b="1"/>
                </a:pPr>
                <a:r>
                  <a:rPr lang="en-US" b="1"/>
                  <a:t>Time (H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60585920"/>
        <c:crosses val="autoZero"/>
        <c:crossBetween val="midCat"/>
        <c:majorUnit val="2"/>
      </c:valAx>
      <c:valAx>
        <c:axId val="160585920"/>
        <c:scaling>
          <c:orientation val="minMax"/>
          <c:max val="100"/>
          <c:min val="99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 b="1"/>
                </a:pPr>
                <a:r>
                  <a:rPr lang="en-US" sz="1400" b="1"/>
                  <a:t>% weight los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60585344"/>
        <c:crosses val="autoZero"/>
        <c:crossBetween val="midCat"/>
        <c:majorUnit val="0.2"/>
      </c:valAx>
    </c:plotArea>
    <c:legend>
      <c:legendPos val="r"/>
      <c:layout>
        <c:manualLayout>
          <c:xMode val="edge"/>
          <c:yMode val="edge"/>
          <c:x val="0.51141586468358124"/>
          <c:y val="4.5912438028579763E-2"/>
          <c:w val="0.46913969087197432"/>
          <c:h val="0.11105272425478258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000" b="0"/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320751550221254"/>
          <c:y val="3.5592761161681835E-2"/>
          <c:w val="0.68577979357631624"/>
          <c:h val="0.809584236382025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Chart in Microsoft PowerPoint]Sorbitol'!$H$22</c:f>
              <c:strCache>
                <c:ptCount val="1"/>
                <c:pt idx="0">
                  <c:v>IFO1803 x Y55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[Chart in Microsoft PowerPoint]Sorbitol'!$B$23:$B$37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'[Chart in Microsoft PowerPoint]Sorbitol'!$H$23:$H$37</c:f>
              <c:numCache>
                <c:formatCode>General</c:formatCode>
                <c:ptCount val="15"/>
                <c:pt idx="0">
                  <c:v>0</c:v>
                </c:pt>
                <c:pt idx="1">
                  <c:v>7.6666666666666643</c:v>
                </c:pt>
                <c:pt idx="2">
                  <c:v>28.333333333333336</c:v>
                </c:pt>
                <c:pt idx="3">
                  <c:v>36.333333333333336</c:v>
                </c:pt>
                <c:pt idx="4">
                  <c:v>51.333333333333329</c:v>
                </c:pt>
                <c:pt idx="5">
                  <c:v>53</c:v>
                </c:pt>
                <c:pt idx="6">
                  <c:v>55</c:v>
                </c:pt>
                <c:pt idx="7">
                  <c:v>56.666666666666671</c:v>
                </c:pt>
                <c:pt idx="8">
                  <c:v>62.666666666666671</c:v>
                </c:pt>
                <c:pt idx="9">
                  <c:v>61.333333333333329</c:v>
                </c:pt>
                <c:pt idx="10">
                  <c:v>62</c:v>
                </c:pt>
                <c:pt idx="11">
                  <c:v>63.666666666666671</c:v>
                </c:pt>
                <c:pt idx="12">
                  <c:v>62.333333333333329</c:v>
                </c:pt>
                <c:pt idx="13">
                  <c:v>64</c:v>
                </c:pt>
                <c:pt idx="14">
                  <c:v>62.66666666666667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[Chart in Microsoft PowerPoint]Sorbitol'!$I$22</c:f>
              <c:strCache>
                <c:ptCount val="1"/>
                <c:pt idx="0">
                  <c:v>IF01803 (S.k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[Chart in Microsoft PowerPoint]Sorbitol'!$B$23:$B$37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'[Chart in Microsoft PowerPoint]Sorbitol'!$I$23:$I$37</c:f>
              <c:numCache>
                <c:formatCode>General</c:formatCode>
                <c:ptCount val="15"/>
                <c:pt idx="0">
                  <c:v>0</c:v>
                </c:pt>
                <c:pt idx="1">
                  <c:v>4.3333333333333321</c:v>
                </c:pt>
                <c:pt idx="2">
                  <c:v>13.666666666666668</c:v>
                </c:pt>
                <c:pt idx="3">
                  <c:v>25.333333333333332</c:v>
                </c:pt>
                <c:pt idx="4">
                  <c:v>21.666666666666668</c:v>
                </c:pt>
                <c:pt idx="5">
                  <c:v>26.666666666666668</c:v>
                </c:pt>
                <c:pt idx="6">
                  <c:v>30.999999999999996</c:v>
                </c:pt>
                <c:pt idx="7">
                  <c:v>34.333333333333329</c:v>
                </c:pt>
                <c:pt idx="8">
                  <c:v>37.666666666666671</c:v>
                </c:pt>
                <c:pt idx="9">
                  <c:v>38</c:v>
                </c:pt>
                <c:pt idx="10">
                  <c:v>38.333333333333329</c:v>
                </c:pt>
                <c:pt idx="11">
                  <c:v>38.333333333333329</c:v>
                </c:pt>
                <c:pt idx="12">
                  <c:v>37.333333333333329</c:v>
                </c:pt>
                <c:pt idx="13">
                  <c:v>39.333333333333329</c:v>
                </c:pt>
                <c:pt idx="14">
                  <c:v>38.66666666666667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[Chart in Microsoft PowerPoint]Sorbitol'!$J$22</c:f>
              <c:strCache>
                <c:ptCount val="1"/>
                <c:pt idx="0">
                  <c:v>Y55 (S.c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[Chart in Microsoft PowerPoint]Sorbitol'!$B$23:$B$37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'[Chart in Microsoft PowerPoint]Sorbitol'!$J$23:$J$37</c:f>
              <c:numCache>
                <c:formatCode>General</c:formatCode>
                <c:ptCount val="15"/>
                <c:pt idx="0">
                  <c:v>0</c:v>
                </c:pt>
                <c:pt idx="1">
                  <c:v>7.6666666666666679</c:v>
                </c:pt>
                <c:pt idx="2">
                  <c:v>21.333333333333332</c:v>
                </c:pt>
                <c:pt idx="3">
                  <c:v>54</c:v>
                </c:pt>
                <c:pt idx="4">
                  <c:v>65</c:v>
                </c:pt>
                <c:pt idx="5">
                  <c:v>65.666666666666671</c:v>
                </c:pt>
                <c:pt idx="6">
                  <c:v>67.333333333333343</c:v>
                </c:pt>
                <c:pt idx="7">
                  <c:v>69.333333333333343</c:v>
                </c:pt>
                <c:pt idx="8">
                  <c:v>72.333333333333343</c:v>
                </c:pt>
                <c:pt idx="9">
                  <c:v>73</c:v>
                </c:pt>
                <c:pt idx="10">
                  <c:v>72.666666666666671</c:v>
                </c:pt>
                <c:pt idx="11">
                  <c:v>74</c:v>
                </c:pt>
                <c:pt idx="12">
                  <c:v>72.333333333333343</c:v>
                </c:pt>
                <c:pt idx="13">
                  <c:v>75.666666666666671</c:v>
                </c:pt>
                <c:pt idx="14">
                  <c:v>7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093760"/>
        <c:axId val="87094336"/>
      </c:scatterChart>
      <c:valAx>
        <c:axId val="87093760"/>
        <c:scaling>
          <c:orientation val="minMax"/>
          <c:max val="72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rs)</a:t>
                </a:r>
              </a:p>
            </c:rich>
          </c:tx>
          <c:layout>
            <c:manualLayout>
              <c:xMode val="edge"/>
              <c:yMode val="edge"/>
              <c:x val="0.47183512889848961"/>
              <c:y val="0.9064343727889883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87094336"/>
        <c:crosses val="autoZero"/>
        <c:crossBetween val="midCat"/>
        <c:majorUnit val="12"/>
      </c:valAx>
      <c:valAx>
        <c:axId val="87094336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7093760"/>
        <c:crosses val="autoZero"/>
        <c:crossBetween val="midCat"/>
        <c:majorUnit val="20"/>
      </c:valAx>
    </c:plotArea>
    <c:legend>
      <c:legendPos val="t"/>
      <c:layout>
        <c:manualLayout>
          <c:xMode val="edge"/>
          <c:yMode val="edge"/>
          <c:x val="0.45822252388623486"/>
          <c:y val="0.66837133541972238"/>
          <c:w val="0.49857350919342286"/>
          <c:h val="0.15584711840388624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900" b="0">
          <a:latin typeface="Arial" panose="020B0604020202090204" pitchFamily="34" charset="0"/>
          <a:cs typeface="Arial" panose="020B060402020209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139202968849952"/>
          <c:y val="3.6449053942883995E-2"/>
          <c:w val="0.72863237181795459"/>
          <c:h val="0.80982305734656879"/>
        </c:manualLayout>
      </c:layout>
      <c:scatterChart>
        <c:scatterStyle val="lineMarker"/>
        <c:varyColors val="0"/>
        <c:ser>
          <c:idx val="0"/>
          <c:order val="0"/>
          <c:tx>
            <c:strRef>
              <c:f>'[Chart in Microsoft PowerPoint]Sorbitol'!$C$22</c:f>
              <c:strCache>
                <c:ptCount val="1"/>
                <c:pt idx="0">
                  <c:v>IFO1803 x Y55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[Chart in Microsoft PowerPoint]Sorbitol'!$B$23:$B$37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'[Chart in Microsoft PowerPoint]Sorbitol'!$C$23:$C$37</c:f>
              <c:numCache>
                <c:formatCode>General</c:formatCode>
                <c:ptCount val="15"/>
                <c:pt idx="0">
                  <c:v>0</c:v>
                </c:pt>
                <c:pt idx="1">
                  <c:v>8.2222222222222179</c:v>
                </c:pt>
                <c:pt idx="2">
                  <c:v>28.777777777777782</c:v>
                </c:pt>
                <c:pt idx="3">
                  <c:v>51.111111111111114</c:v>
                </c:pt>
                <c:pt idx="4">
                  <c:v>67.444444444444429</c:v>
                </c:pt>
                <c:pt idx="5">
                  <c:v>66.666666666666657</c:v>
                </c:pt>
                <c:pt idx="6">
                  <c:v>68.333333333333329</c:v>
                </c:pt>
                <c:pt idx="7">
                  <c:v>73.222222222222229</c:v>
                </c:pt>
                <c:pt idx="8">
                  <c:v>77.888888888888886</c:v>
                </c:pt>
                <c:pt idx="9">
                  <c:v>77.444444444444429</c:v>
                </c:pt>
                <c:pt idx="10">
                  <c:v>78</c:v>
                </c:pt>
                <c:pt idx="11">
                  <c:v>79.222222222222229</c:v>
                </c:pt>
                <c:pt idx="12">
                  <c:v>78.444444444444429</c:v>
                </c:pt>
                <c:pt idx="13">
                  <c:v>80.666666666666657</c:v>
                </c:pt>
                <c:pt idx="14">
                  <c:v>80.55555555555555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[Chart in Microsoft PowerPoint]Sorbitol'!$D$22</c:f>
              <c:strCache>
                <c:ptCount val="1"/>
                <c:pt idx="0">
                  <c:v>IF01803 (S.k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[Chart in Microsoft PowerPoint]Sorbitol'!$B$23:$B$37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'[Chart in Microsoft PowerPoint]Sorbitol'!$D$23:$D$37</c:f>
              <c:numCache>
                <c:formatCode>General</c:formatCode>
                <c:ptCount val="15"/>
                <c:pt idx="0">
                  <c:v>0</c:v>
                </c:pt>
                <c:pt idx="1">
                  <c:v>12.666666666666664</c:v>
                </c:pt>
                <c:pt idx="2">
                  <c:v>23</c:v>
                </c:pt>
                <c:pt idx="3">
                  <c:v>18</c:v>
                </c:pt>
                <c:pt idx="4">
                  <c:v>28</c:v>
                </c:pt>
                <c:pt idx="5">
                  <c:v>36.666666666666671</c:v>
                </c:pt>
                <c:pt idx="6">
                  <c:v>36.666666666666671</c:v>
                </c:pt>
                <c:pt idx="7">
                  <c:v>32</c:v>
                </c:pt>
                <c:pt idx="8">
                  <c:v>38</c:v>
                </c:pt>
                <c:pt idx="9">
                  <c:v>39</c:v>
                </c:pt>
                <c:pt idx="10">
                  <c:v>41.333333333333329</c:v>
                </c:pt>
                <c:pt idx="11">
                  <c:v>42</c:v>
                </c:pt>
                <c:pt idx="12">
                  <c:v>41.333333333333329</c:v>
                </c:pt>
                <c:pt idx="13">
                  <c:v>44.666666666666671</c:v>
                </c:pt>
                <c:pt idx="14">
                  <c:v>45.66666666666667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[Chart in Microsoft PowerPoint]Sorbitol'!$E$22</c:f>
              <c:strCache>
                <c:ptCount val="1"/>
                <c:pt idx="0">
                  <c:v>Y55 (S.c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[Chart in Microsoft PowerPoint]Sorbitol'!$B$23:$B$37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'[Chart in Microsoft PowerPoint]Sorbitol'!$E$23:$E$37</c:f>
              <c:numCache>
                <c:formatCode>General</c:formatCode>
                <c:ptCount val="15"/>
                <c:pt idx="0">
                  <c:v>0</c:v>
                </c:pt>
                <c:pt idx="1">
                  <c:v>1.6666666666666643</c:v>
                </c:pt>
                <c:pt idx="2">
                  <c:v>30.999999999999993</c:v>
                </c:pt>
                <c:pt idx="3">
                  <c:v>59.666666666666664</c:v>
                </c:pt>
                <c:pt idx="4">
                  <c:v>67.333333333333343</c:v>
                </c:pt>
                <c:pt idx="5">
                  <c:v>69.666666666666657</c:v>
                </c:pt>
                <c:pt idx="6">
                  <c:v>73</c:v>
                </c:pt>
                <c:pt idx="7">
                  <c:v>75.666666666666657</c:v>
                </c:pt>
                <c:pt idx="8">
                  <c:v>80.333333333333343</c:v>
                </c:pt>
                <c:pt idx="9">
                  <c:v>81.666666666666657</c:v>
                </c:pt>
                <c:pt idx="10">
                  <c:v>82.333333333333343</c:v>
                </c:pt>
                <c:pt idx="11">
                  <c:v>82</c:v>
                </c:pt>
                <c:pt idx="12">
                  <c:v>81.333333333333343</c:v>
                </c:pt>
                <c:pt idx="13">
                  <c:v>83.333333333333343</c:v>
                </c:pt>
                <c:pt idx="14">
                  <c:v>8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096064"/>
        <c:axId val="87096640"/>
      </c:scatterChart>
      <c:valAx>
        <c:axId val="87096064"/>
        <c:scaling>
          <c:orientation val="minMax"/>
          <c:max val="72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7096640"/>
        <c:crosses val="autoZero"/>
        <c:crossBetween val="midCat"/>
        <c:majorUnit val="12"/>
      </c:valAx>
      <c:valAx>
        <c:axId val="87096640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7096064"/>
        <c:crosses val="autoZero"/>
        <c:crossBetween val="midCat"/>
        <c:majorUnit val="20"/>
      </c:valAx>
    </c:plotArea>
    <c:legend>
      <c:legendPos val="t"/>
      <c:layout>
        <c:manualLayout>
          <c:xMode val="edge"/>
          <c:yMode val="edge"/>
          <c:x val="0.44733693490454446"/>
          <c:y val="0.67489989593848698"/>
          <c:w val="0.51545581960045717"/>
          <c:h val="0.1758238667925786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900" b="0">
          <a:latin typeface="Arial" panose="020B0604020202090204" pitchFamily="34" charset="0"/>
          <a:cs typeface="Arial" panose="020B060402020209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613548667596602"/>
          <c:y val="2.626892403797668E-2"/>
          <c:w val="0.69056719986956772"/>
          <c:h val="0.84545782523991631"/>
        </c:manualLayout>
      </c:layout>
      <c:scatterChart>
        <c:scatterStyle val="lineMarker"/>
        <c:varyColors val="0"/>
        <c:ser>
          <c:idx val="0"/>
          <c:order val="0"/>
          <c:tx>
            <c:strRef>
              <c:f>'[Chart in Microsoft PowerPoint]Sorbitol'!$C$61</c:f>
              <c:strCache>
                <c:ptCount val="1"/>
                <c:pt idx="0">
                  <c:v>YPS128 x Y12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[Chart in Microsoft PowerPoint]Sorbitol'!$B$62:$B$76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'[Chart in Microsoft PowerPoint]Sorbitol'!$C$62:$C$76</c:f>
              <c:numCache>
                <c:formatCode>General</c:formatCode>
                <c:ptCount val="15"/>
                <c:pt idx="0">
                  <c:v>0</c:v>
                </c:pt>
                <c:pt idx="1">
                  <c:v>6.9999999999999964</c:v>
                </c:pt>
                <c:pt idx="2">
                  <c:v>39.666666666666657</c:v>
                </c:pt>
                <c:pt idx="3">
                  <c:v>59</c:v>
                </c:pt>
                <c:pt idx="4">
                  <c:v>69</c:v>
                </c:pt>
                <c:pt idx="5">
                  <c:v>70</c:v>
                </c:pt>
                <c:pt idx="6">
                  <c:v>69.666666666666657</c:v>
                </c:pt>
                <c:pt idx="7">
                  <c:v>70.666666666666657</c:v>
                </c:pt>
                <c:pt idx="8">
                  <c:v>72</c:v>
                </c:pt>
                <c:pt idx="9">
                  <c:v>73</c:v>
                </c:pt>
                <c:pt idx="10">
                  <c:v>73.333333333333329</c:v>
                </c:pt>
                <c:pt idx="11">
                  <c:v>73.333333333333329</c:v>
                </c:pt>
                <c:pt idx="12">
                  <c:v>74.333333333333329</c:v>
                </c:pt>
                <c:pt idx="13">
                  <c:v>75.666666666666657</c:v>
                </c:pt>
                <c:pt idx="14">
                  <c:v>7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[Chart in Microsoft PowerPoint]Sorbitol'!$D$61</c:f>
              <c:strCache>
                <c:ptCount val="1"/>
                <c:pt idx="0">
                  <c:v>YPS128 (S.c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[Chart in Microsoft PowerPoint]Sorbitol'!$B$62:$B$76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'[Chart in Microsoft PowerPoint]Sorbitol'!$D$62:$D$76</c:f>
              <c:numCache>
                <c:formatCode>General</c:formatCode>
                <c:ptCount val="15"/>
                <c:pt idx="0">
                  <c:v>0</c:v>
                </c:pt>
                <c:pt idx="1">
                  <c:v>13</c:v>
                </c:pt>
                <c:pt idx="2">
                  <c:v>56</c:v>
                </c:pt>
                <c:pt idx="3">
                  <c:v>72</c:v>
                </c:pt>
                <c:pt idx="4">
                  <c:v>79.666666666666671</c:v>
                </c:pt>
                <c:pt idx="5">
                  <c:v>77.333333333333329</c:v>
                </c:pt>
                <c:pt idx="6">
                  <c:v>78</c:v>
                </c:pt>
                <c:pt idx="7">
                  <c:v>80.333333333333329</c:v>
                </c:pt>
                <c:pt idx="8">
                  <c:v>83.333333333333343</c:v>
                </c:pt>
                <c:pt idx="9">
                  <c:v>84.666666666666657</c:v>
                </c:pt>
                <c:pt idx="10">
                  <c:v>85</c:v>
                </c:pt>
                <c:pt idx="11">
                  <c:v>84.666666666666657</c:v>
                </c:pt>
                <c:pt idx="12">
                  <c:v>84.333333333333343</c:v>
                </c:pt>
                <c:pt idx="13">
                  <c:v>87</c:v>
                </c:pt>
                <c:pt idx="14">
                  <c:v>87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[Chart in Microsoft PowerPoint]Sorbitol'!$E$61</c:f>
              <c:strCache>
                <c:ptCount val="1"/>
                <c:pt idx="0">
                  <c:v>Y12 (S.c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[Chart in Microsoft PowerPoint]Sorbitol'!$B$62:$B$76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'[Chart in Microsoft PowerPoint]Sorbitol'!$E$62:$E$76</c:f>
              <c:numCache>
                <c:formatCode>General</c:formatCode>
                <c:ptCount val="15"/>
                <c:pt idx="0">
                  <c:v>0</c:v>
                </c:pt>
                <c:pt idx="1">
                  <c:v>-2</c:v>
                </c:pt>
                <c:pt idx="2">
                  <c:v>24.666666666666664</c:v>
                </c:pt>
                <c:pt idx="3">
                  <c:v>52.333333333333336</c:v>
                </c:pt>
                <c:pt idx="4">
                  <c:v>62.333333333333336</c:v>
                </c:pt>
                <c:pt idx="5">
                  <c:v>64.333333333333343</c:v>
                </c:pt>
                <c:pt idx="6">
                  <c:v>67.333333333333343</c:v>
                </c:pt>
                <c:pt idx="7">
                  <c:v>67.666666666666657</c:v>
                </c:pt>
                <c:pt idx="8">
                  <c:v>71</c:v>
                </c:pt>
                <c:pt idx="9">
                  <c:v>70.666666666666657</c:v>
                </c:pt>
                <c:pt idx="10">
                  <c:v>70.666666666666657</c:v>
                </c:pt>
                <c:pt idx="11">
                  <c:v>69.333333333333343</c:v>
                </c:pt>
                <c:pt idx="12">
                  <c:v>70</c:v>
                </c:pt>
                <c:pt idx="13">
                  <c:v>73.666666666666657</c:v>
                </c:pt>
                <c:pt idx="14">
                  <c:v>7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8287616"/>
        <c:axId val="98288192"/>
      </c:scatterChart>
      <c:valAx>
        <c:axId val="98287616"/>
        <c:scaling>
          <c:orientation val="minMax"/>
          <c:max val="72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8288192"/>
        <c:crosses val="autoZero"/>
        <c:crossBetween val="midCat"/>
        <c:majorUnit val="12"/>
      </c:valAx>
      <c:valAx>
        <c:axId val="98288192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8287616"/>
        <c:crosses val="autoZero"/>
        <c:crossBetween val="midCat"/>
        <c:majorUnit val="20"/>
      </c:valAx>
    </c:plotArea>
    <c:legend>
      <c:legendPos val="t"/>
      <c:layout>
        <c:manualLayout>
          <c:xMode val="edge"/>
          <c:yMode val="edge"/>
          <c:x val="0.46404901422205946"/>
          <c:y val="0.65671641791044777"/>
          <c:w val="0.51376243667216015"/>
          <c:h val="0.15636568596762085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900" b="0">
          <a:latin typeface="Arial" panose="020B0604020202090204" pitchFamily="34" charset="0"/>
          <a:cs typeface="Arial" panose="020B060402020209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130909138622154"/>
          <c:y val="2.5042254653755962E-2"/>
          <c:w val="0.70883814913870968"/>
          <c:h val="0.84592416707712681"/>
        </c:manualLayout>
      </c:layout>
      <c:scatterChart>
        <c:scatterStyle val="lineMarker"/>
        <c:varyColors val="0"/>
        <c:ser>
          <c:idx val="0"/>
          <c:order val="0"/>
          <c:tx>
            <c:strRef>
              <c:f>'[Chart in Microsoft PowerPoint]Sorbitol'!$H$61</c:f>
              <c:strCache>
                <c:ptCount val="1"/>
                <c:pt idx="0">
                  <c:v>YPS128 x Y12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[Chart in Microsoft PowerPoint]Sorbitol'!$B$62:$B$76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'[Chart in Microsoft PowerPoint]Sorbitol'!$H$62:$H$76</c:f>
              <c:numCache>
                <c:formatCode>General</c:formatCode>
                <c:ptCount val="15"/>
                <c:pt idx="0">
                  <c:v>0</c:v>
                </c:pt>
                <c:pt idx="1">
                  <c:v>3.6666666666666643</c:v>
                </c:pt>
                <c:pt idx="2">
                  <c:v>25.999999999999996</c:v>
                </c:pt>
                <c:pt idx="3">
                  <c:v>45.333333333333329</c:v>
                </c:pt>
                <c:pt idx="4">
                  <c:v>57.666666666666657</c:v>
                </c:pt>
                <c:pt idx="5">
                  <c:v>58.666666666666657</c:v>
                </c:pt>
                <c:pt idx="6">
                  <c:v>59.666666666666657</c:v>
                </c:pt>
                <c:pt idx="7">
                  <c:v>60.333333333333329</c:v>
                </c:pt>
                <c:pt idx="8">
                  <c:v>64.333333333333329</c:v>
                </c:pt>
                <c:pt idx="9">
                  <c:v>64</c:v>
                </c:pt>
                <c:pt idx="10">
                  <c:v>63.333333333333329</c:v>
                </c:pt>
                <c:pt idx="11">
                  <c:v>65</c:v>
                </c:pt>
                <c:pt idx="12">
                  <c:v>64.666666666666657</c:v>
                </c:pt>
                <c:pt idx="13">
                  <c:v>65.333333333333329</c:v>
                </c:pt>
                <c:pt idx="14">
                  <c:v>65.66666666666665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[Chart in Microsoft PowerPoint]Sorbitol'!$I$61</c:f>
              <c:strCache>
                <c:ptCount val="1"/>
                <c:pt idx="0">
                  <c:v>YPS128 (S.c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[Chart in Microsoft PowerPoint]Sorbitol'!$B$62:$B$76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'[Chart in Microsoft PowerPoint]Sorbitol'!$I$62:$I$76</c:f>
              <c:numCache>
                <c:formatCode>General</c:formatCode>
                <c:ptCount val="15"/>
                <c:pt idx="0">
                  <c:v>0</c:v>
                </c:pt>
                <c:pt idx="1">
                  <c:v>-5.3333333333333321</c:v>
                </c:pt>
                <c:pt idx="2">
                  <c:v>18.333333333333336</c:v>
                </c:pt>
                <c:pt idx="3">
                  <c:v>39.666666666666671</c:v>
                </c:pt>
                <c:pt idx="4">
                  <c:v>53.333333333333329</c:v>
                </c:pt>
                <c:pt idx="5">
                  <c:v>56.333333333333329</c:v>
                </c:pt>
                <c:pt idx="6">
                  <c:v>59</c:v>
                </c:pt>
                <c:pt idx="7">
                  <c:v>58.333333333333329</c:v>
                </c:pt>
                <c:pt idx="8">
                  <c:v>62.333333333333329</c:v>
                </c:pt>
                <c:pt idx="9">
                  <c:v>62</c:v>
                </c:pt>
                <c:pt idx="10">
                  <c:v>63</c:v>
                </c:pt>
                <c:pt idx="11">
                  <c:v>63.333333333333329</c:v>
                </c:pt>
                <c:pt idx="12">
                  <c:v>63</c:v>
                </c:pt>
                <c:pt idx="13">
                  <c:v>66.333333333333329</c:v>
                </c:pt>
                <c:pt idx="14">
                  <c:v>63.66666666666667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[Chart in Microsoft PowerPoint]Sorbitol'!$J$61</c:f>
              <c:strCache>
                <c:ptCount val="1"/>
                <c:pt idx="0">
                  <c:v>Y12 (S.c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[Chart in Microsoft PowerPoint]Sorbitol'!$B$62:$B$76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'[Chart in Microsoft PowerPoint]Sorbitol'!$J$62:$J$76</c:f>
              <c:numCache>
                <c:formatCode>General</c:formatCode>
                <c:ptCount val="15"/>
                <c:pt idx="0">
                  <c:v>0</c:v>
                </c:pt>
                <c:pt idx="1">
                  <c:v>6.3333333333333357</c:v>
                </c:pt>
                <c:pt idx="2">
                  <c:v>35.666666666666671</c:v>
                </c:pt>
                <c:pt idx="3">
                  <c:v>62</c:v>
                </c:pt>
                <c:pt idx="4">
                  <c:v>70</c:v>
                </c:pt>
                <c:pt idx="5">
                  <c:v>70.666666666666671</c:v>
                </c:pt>
                <c:pt idx="6">
                  <c:v>71.333333333333329</c:v>
                </c:pt>
                <c:pt idx="7">
                  <c:v>73.666666666666671</c:v>
                </c:pt>
                <c:pt idx="8">
                  <c:v>78</c:v>
                </c:pt>
                <c:pt idx="9">
                  <c:v>79</c:v>
                </c:pt>
                <c:pt idx="10">
                  <c:v>80.333333333333329</c:v>
                </c:pt>
                <c:pt idx="11">
                  <c:v>79</c:v>
                </c:pt>
                <c:pt idx="12">
                  <c:v>78.666666666666671</c:v>
                </c:pt>
                <c:pt idx="13">
                  <c:v>80.333333333333329</c:v>
                </c:pt>
                <c:pt idx="14">
                  <c:v>80.33333333333332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8289344"/>
        <c:axId val="98289920"/>
      </c:scatterChart>
      <c:valAx>
        <c:axId val="98289344"/>
        <c:scaling>
          <c:orientation val="minMax"/>
          <c:max val="72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8289920"/>
        <c:crosses val="autoZero"/>
        <c:crossBetween val="midCat"/>
        <c:majorUnit val="12"/>
      </c:valAx>
      <c:valAx>
        <c:axId val="98289920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8289344"/>
        <c:crosses val="autoZero"/>
        <c:crossBetween val="midCat"/>
        <c:majorUnit val="20"/>
      </c:valAx>
    </c:plotArea>
    <c:legend>
      <c:legendPos val="t"/>
      <c:layout>
        <c:manualLayout>
          <c:xMode val="edge"/>
          <c:yMode val="edge"/>
          <c:x val="0.4551268113066802"/>
          <c:y val="0.67537313432835822"/>
          <c:w val="0.49555287507737233"/>
          <c:h val="0.1692318112469755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900" b="0">
          <a:latin typeface="Arial" panose="020B0604020202090204" pitchFamily="34" charset="0"/>
          <a:cs typeface="Arial" panose="020B060402020209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3215476058215753"/>
          <c:y val="2.1996554435100485E-2"/>
          <c:w val="0.71042146110749604"/>
          <c:h val="0.82377644194372401"/>
        </c:manualLayout>
      </c:layout>
      <c:scatterChart>
        <c:scatterStyle val="lineMarker"/>
        <c:varyColors val="0"/>
        <c:ser>
          <c:idx val="2"/>
          <c:order val="0"/>
          <c:tx>
            <c:strRef>
              <c:f>Sheet1!$O$5</c:f>
              <c:strCache>
                <c:ptCount val="1"/>
                <c:pt idx="0">
                  <c:v>YPS128 x Y12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Sheet1!$A$6:$A$20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5</c:v>
                </c:pt>
                <c:pt idx="4">
                  <c:v>10</c:v>
                </c:pt>
                <c:pt idx="5">
                  <c:v>15</c:v>
                </c:pt>
                <c:pt idx="6">
                  <c:v>20</c:v>
                </c:pt>
                <c:pt idx="7">
                  <c:v>25</c:v>
                </c:pt>
                <c:pt idx="8">
                  <c:v>30</c:v>
                </c:pt>
                <c:pt idx="9">
                  <c:v>35</c:v>
                </c:pt>
                <c:pt idx="10">
                  <c:v>40</c:v>
                </c:pt>
                <c:pt idx="11">
                  <c:v>45</c:v>
                </c:pt>
                <c:pt idx="12">
                  <c:v>50</c:v>
                </c:pt>
                <c:pt idx="13">
                  <c:v>60</c:v>
                </c:pt>
                <c:pt idx="14">
                  <c:v>70</c:v>
                </c:pt>
              </c:numCache>
            </c:numRef>
          </c:xVal>
          <c:yVal>
            <c:numRef>
              <c:f>Sheet1!$O$6:$O$20</c:f>
              <c:numCache>
                <c:formatCode>General</c:formatCode>
                <c:ptCount val="15"/>
                <c:pt idx="0">
                  <c:v>0</c:v>
                </c:pt>
                <c:pt idx="1">
                  <c:v>1.3333333333333339</c:v>
                </c:pt>
                <c:pt idx="2">
                  <c:v>1.6666666666666661</c:v>
                </c:pt>
                <c:pt idx="3">
                  <c:v>6.0000000000000018</c:v>
                </c:pt>
                <c:pt idx="4">
                  <c:v>28.6666666666667</c:v>
                </c:pt>
                <c:pt idx="5">
                  <c:v>51.3333333333333</c:v>
                </c:pt>
                <c:pt idx="6">
                  <c:v>54</c:v>
                </c:pt>
                <c:pt idx="7">
                  <c:v>59</c:v>
                </c:pt>
                <c:pt idx="8">
                  <c:v>62</c:v>
                </c:pt>
                <c:pt idx="9">
                  <c:v>64</c:v>
                </c:pt>
                <c:pt idx="10">
                  <c:v>69.6666666666667</c:v>
                </c:pt>
                <c:pt idx="11">
                  <c:v>71</c:v>
                </c:pt>
                <c:pt idx="12">
                  <c:v>70.6666666666667</c:v>
                </c:pt>
                <c:pt idx="13">
                  <c:v>73.3333333333333</c:v>
                </c:pt>
                <c:pt idx="14">
                  <c:v>7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C$5</c:f>
              <c:strCache>
                <c:ptCount val="1"/>
                <c:pt idx="0">
                  <c:v>YPS128 (S.c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Sheet1!$A$6:$A$20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5</c:v>
                </c:pt>
                <c:pt idx="4">
                  <c:v>10</c:v>
                </c:pt>
                <c:pt idx="5">
                  <c:v>15</c:v>
                </c:pt>
                <c:pt idx="6">
                  <c:v>20</c:v>
                </c:pt>
                <c:pt idx="7">
                  <c:v>25</c:v>
                </c:pt>
                <c:pt idx="8">
                  <c:v>30</c:v>
                </c:pt>
                <c:pt idx="9">
                  <c:v>35</c:v>
                </c:pt>
                <c:pt idx="10">
                  <c:v>40</c:v>
                </c:pt>
                <c:pt idx="11">
                  <c:v>45</c:v>
                </c:pt>
                <c:pt idx="12">
                  <c:v>50</c:v>
                </c:pt>
                <c:pt idx="13">
                  <c:v>60</c:v>
                </c:pt>
                <c:pt idx="14">
                  <c:v>70</c:v>
                </c:pt>
              </c:numCache>
            </c:numRef>
          </c:xVal>
          <c:yVal>
            <c:numRef>
              <c:f>Sheet1!$C$6:$C$20</c:f>
              <c:numCache>
                <c:formatCode>General</c:formatCode>
                <c:ptCount val="15"/>
                <c:pt idx="0">
                  <c:v>0</c:v>
                </c:pt>
                <c:pt idx="1">
                  <c:v>3.3333333333333321</c:v>
                </c:pt>
                <c:pt idx="2">
                  <c:v>3.6666666666666679</c:v>
                </c:pt>
                <c:pt idx="3">
                  <c:v>7.9999999999999964</c:v>
                </c:pt>
                <c:pt idx="4">
                  <c:v>46</c:v>
                </c:pt>
                <c:pt idx="5">
                  <c:v>62</c:v>
                </c:pt>
                <c:pt idx="6">
                  <c:v>70</c:v>
                </c:pt>
                <c:pt idx="7">
                  <c:v>69</c:v>
                </c:pt>
                <c:pt idx="8">
                  <c:v>75</c:v>
                </c:pt>
                <c:pt idx="9">
                  <c:v>71.3333333333333</c:v>
                </c:pt>
                <c:pt idx="10">
                  <c:v>73.6666666666667</c:v>
                </c:pt>
                <c:pt idx="11">
                  <c:v>72.3333333333333</c:v>
                </c:pt>
                <c:pt idx="12">
                  <c:v>77.3333333333333</c:v>
                </c:pt>
                <c:pt idx="13">
                  <c:v>74</c:v>
                </c:pt>
                <c:pt idx="14">
                  <c:v>76.3333333333333</c:v>
                </c:pt>
              </c:numCache>
            </c:numRef>
          </c:yVal>
          <c:smooth val="0"/>
        </c:ser>
        <c:ser>
          <c:idx val="0"/>
          <c:order val="2"/>
          <c:tx>
            <c:strRef>
              <c:f>Sheet1!$I$5</c:f>
              <c:strCache>
                <c:ptCount val="1"/>
                <c:pt idx="0">
                  <c:v>Y12 (S.c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Sheet1!$A$6:$A$20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5</c:v>
                </c:pt>
                <c:pt idx="4">
                  <c:v>10</c:v>
                </c:pt>
                <c:pt idx="5">
                  <c:v>15</c:v>
                </c:pt>
                <c:pt idx="6">
                  <c:v>20</c:v>
                </c:pt>
                <c:pt idx="7">
                  <c:v>25</c:v>
                </c:pt>
                <c:pt idx="8">
                  <c:v>30</c:v>
                </c:pt>
                <c:pt idx="9">
                  <c:v>35</c:v>
                </c:pt>
                <c:pt idx="10">
                  <c:v>40</c:v>
                </c:pt>
                <c:pt idx="11">
                  <c:v>45</c:v>
                </c:pt>
                <c:pt idx="12">
                  <c:v>50</c:v>
                </c:pt>
                <c:pt idx="13">
                  <c:v>60</c:v>
                </c:pt>
                <c:pt idx="14">
                  <c:v>70</c:v>
                </c:pt>
              </c:numCache>
            </c:numRef>
          </c:xVal>
          <c:yVal>
            <c:numRef>
              <c:f>Sheet1!$I$6:$I$20</c:f>
              <c:numCache>
                <c:formatCode>General</c:formatCode>
                <c:ptCount val="15"/>
                <c:pt idx="0">
                  <c:v>0</c:v>
                </c:pt>
                <c:pt idx="1">
                  <c:v>1.8888888888888857</c:v>
                </c:pt>
                <c:pt idx="2">
                  <c:v>3.8888888888888857</c:v>
                </c:pt>
                <c:pt idx="3">
                  <c:v>2.8888888888888857</c:v>
                </c:pt>
                <c:pt idx="4">
                  <c:v>5.6666666666666643</c:v>
                </c:pt>
                <c:pt idx="5">
                  <c:v>7.55555555555555</c:v>
                </c:pt>
                <c:pt idx="6">
                  <c:v>7.3333333333333321</c:v>
                </c:pt>
                <c:pt idx="7">
                  <c:v>11.777777777777768</c:v>
                </c:pt>
                <c:pt idx="8">
                  <c:v>28.999999999999996</c:v>
                </c:pt>
                <c:pt idx="9">
                  <c:v>45.6666666666667</c:v>
                </c:pt>
                <c:pt idx="10">
                  <c:v>53.666666666666657</c:v>
                </c:pt>
                <c:pt idx="11">
                  <c:v>59.666666666666657</c:v>
                </c:pt>
                <c:pt idx="12">
                  <c:v>71.777777777777771</c:v>
                </c:pt>
                <c:pt idx="13">
                  <c:v>72.912300000000002</c:v>
                </c:pt>
                <c:pt idx="14">
                  <c:v>72.67400000000000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8291648"/>
        <c:axId val="98292224"/>
      </c:scatterChart>
      <c:valAx>
        <c:axId val="98291648"/>
        <c:scaling>
          <c:orientation val="minMax"/>
          <c:max val="72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Time (hrs)</a:t>
                </a:r>
              </a:p>
            </c:rich>
          </c:tx>
          <c:layout>
            <c:manualLayout>
              <c:xMode val="edge"/>
              <c:yMode val="edge"/>
              <c:x val="0.40954014412311424"/>
              <c:y val="0.9199618547016067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98292224"/>
        <c:crosses val="autoZero"/>
        <c:crossBetween val="midCat"/>
        <c:majorUnit val="12"/>
      </c:valAx>
      <c:valAx>
        <c:axId val="98292224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8291648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48534190645483838"/>
          <c:y val="0.66311457496658033"/>
          <c:w val="0.45598991532002481"/>
          <c:h val="0.15994964369618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900" b="0">
          <a:latin typeface="Arial" panose="020B0604020202090204" pitchFamily="34" charset="0"/>
          <a:cs typeface="Arial" panose="020B060402020209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717380952380952"/>
          <c:y val="3.7359846842941774E-2"/>
          <c:w val="0.62713253968253957"/>
          <c:h val="0.80600780234070224"/>
        </c:manualLayout>
      </c:layout>
      <c:scatterChart>
        <c:scatterStyle val="lineMarker"/>
        <c:varyColors val="0"/>
        <c:ser>
          <c:idx val="14"/>
          <c:order val="0"/>
          <c:tx>
            <c:strRef>
              <c:f>Sheet1!$P$5</c:f>
              <c:strCache>
                <c:ptCount val="1"/>
                <c:pt idx="0">
                  <c:v>IFO1803 x Y55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Sheet1!$A$6:$A$21</c:f>
              <c:numCache>
                <c:formatCode>General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5</c:v>
                </c:pt>
                <c:pt idx="4">
                  <c:v>10</c:v>
                </c:pt>
                <c:pt idx="5">
                  <c:v>15</c:v>
                </c:pt>
                <c:pt idx="6">
                  <c:v>20</c:v>
                </c:pt>
                <c:pt idx="7">
                  <c:v>25</c:v>
                </c:pt>
                <c:pt idx="8">
                  <c:v>30</c:v>
                </c:pt>
                <c:pt idx="9">
                  <c:v>35</c:v>
                </c:pt>
                <c:pt idx="10">
                  <c:v>40</c:v>
                </c:pt>
                <c:pt idx="11">
                  <c:v>45</c:v>
                </c:pt>
                <c:pt idx="12">
                  <c:v>50</c:v>
                </c:pt>
                <c:pt idx="13">
                  <c:v>60</c:v>
                </c:pt>
                <c:pt idx="14">
                  <c:v>70</c:v>
                </c:pt>
                <c:pt idx="15">
                  <c:v>80</c:v>
                </c:pt>
              </c:numCache>
            </c:numRef>
          </c:xVal>
          <c:yVal>
            <c:numRef>
              <c:f>Sheet1!$P$6:$P$21</c:f>
              <c:numCache>
                <c:formatCode>General</c:formatCode>
                <c:ptCount val="16"/>
                <c:pt idx="0">
                  <c:v>0</c:v>
                </c:pt>
                <c:pt idx="1">
                  <c:v>4.3333333333333357</c:v>
                </c:pt>
                <c:pt idx="2">
                  <c:v>2.6666666666666679</c:v>
                </c:pt>
                <c:pt idx="3">
                  <c:v>2.6666666666666679</c:v>
                </c:pt>
                <c:pt idx="4">
                  <c:v>2.6666666666666679</c:v>
                </c:pt>
                <c:pt idx="5">
                  <c:v>12</c:v>
                </c:pt>
                <c:pt idx="6">
                  <c:v>21.333333333333332</c:v>
                </c:pt>
                <c:pt idx="7">
                  <c:v>39.333333333333329</c:v>
                </c:pt>
                <c:pt idx="8">
                  <c:v>59.333333333333343</c:v>
                </c:pt>
                <c:pt idx="9">
                  <c:v>66.666666666666671</c:v>
                </c:pt>
                <c:pt idx="10">
                  <c:v>64.6666666666667</c:v>
                </c:pt>
                <c:pt idx="11">
                  <c:v>67.6666666666667</c:v>
                </c:pt>
                <c:pt idx="12">
                  <c:v>67.3333333333333</c:v>
                </c:pt>
                <c:pt idx="13">
                  <c:v>68.6666666666667</c:v>
                </c:pt>
                <c:pt idx="14">
                  <c:v>69</c:v>
                </c:pt>
                <c:pt idx="15">
                  <c:v>70.3333333333333</c:v>
                </c:pt>
              </c:numCache>
            </c:numRef>
          </c:yVal>
          <c:smooth val="0"/>
        </c:ser>
        <c:ser>
          <c:idx val="2"/>
          <c:order val="1"/>
          <c:tx>
            <c:strRef>
              <c:f>Sheet1!$D$5</c:f>
              <c:strCache>
                <c:ptCount val="1"/>
                <c:pt idx="0">
                  <c:v>IF01803 (S.k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Sheet1!$A$6:$A$21</c:f>
              <c:numCache>
                <c:formatCode>General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5</c:v>
                </c:pt>
                <c:pt idx="4">
                  <c:v>10</c:v>
                </c:pt>
                <c:pt idx="5">
                  <c:v>15</c:v>
                </c:pt>
                <c:pt idx="6">
                  <c:v>20</c:v>
                </c:pt>
                <c:pt idx="7">
                  <c:v>25</c:v>
                </c:pt>
                <c:pt idx="8">
                  <c:v>30</c:v>
                </c:pt>
                <c:pt idx="9">
                  <c:v>35</c:v>
                </c:pt>
                <c:pt idx="10">
                  <c:v>40</c:v>
                </c:pt>
                <c:pt idx="11">
                  <c:v>45</c:v>
                </c:pt>
                <c:pt idx="12">
                  <c:v>50</c:v>
                </c:pt>
                <c:pt idx="13">
                  <c:v>60</c:v>
                </c:pt>
                <c:pt idx="14">
                  <c:v>70</c:v>
                </c:pt>
                <c:pt idx="15">
                  <c:v>80</c:v>
                </c:pt>
              </c:numCache>
            </c:numRef>
          </c:xVal>
          <c:yVal>
            <c:numRef>
              <c:f>Sheet1!$D$6:$D$21</c:f>
              <c:numCache>
                <c:formatCode>General</c:formatCode>
                <c:ptCount val="16"/>
                <c:pt idx="0">
                  <c:v>0</c:v>
                </c:pt>
                <c:pt idx="1">
                  <c:v>3.3333333333333321</c:v>
                </c:pt>
                <c:pt idx="2">
                  <c:v>2.6666666666666679</c:v>
                </c:pt>
                <c:pt idx="3">
                  <c:v>4</c:v>
                </c:pt>
                <c:pt idx="4">
                  <c:v>3</c:v>
                </c:pt>
                <c:pt idx="5">
                  <c:v>7</c:v>
                </c:pt>
                <c:pt idx="6">
                  <c:v>18</c:v>
                </c:pt>
                <c:pt idx="7">
                  <c:v>21.6666666666666</c:v>
                </c:pt>
                <c:pt idx="8">
                  <c:v>28</c:v>
                </c:pt>
                <c:pt idx="9">
                  <c:v>28.6666666666666</c:v>
                </c:pt>
                <c:pt idx="10">
                  <c:v>28.3333333333333</c:v>
                </c:pt>
                <c:pt idx="11">
                  <c:v>30.6666666666666</c:v>
                </c:pt>
                <c:pt idx="12">
                  <c:v>33.3333333333333</c:v>
                </c:pt>
                <c:pt idx="13">
                  <c:v>31.3333333333333</c:v>
                </c:pt>
                <c:pt idx="14">
                  <c:v>29.6666666666666</c:v>
                </c:pt>
                <c:pt idx="15">
                  <c:v>31.6666666666667</c:v>
                </c:pt>
              </c:numCache>
            </c:numRef>
          </c:yVal>
          <c:smooth val="0"/>
        </c:ser>
        <c:ser>
          <c:idx val="8"/>
          <c:order val="2"/>
          <c:tx>
            <c:strRef>
              <c:f>Sheet1!$J$5</c:f>
              <c:strCache>
                <c:ptCount val="1"/>
                <c:pt idx="0">
                  <c:v>Y55 (S.c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Sheet1!$A$6:$A$21</c:f>
              <c:numCache>
                <c:formatCode>General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5</c:v>
                </c:pt>
                <c:pt idx="4">
                  <c:v>10</c:v>
                </c:pt>
                <c:pt idx="5">
                  <c:v>15</c:v>
                </c:pt>
                <c:pt idx="6">
                  <c:v>20</c:v>
                </c:pt>
                <c:pt idx="7">
                  <c:v>25</c:v>
                </c:pt>
                <c:pt idx="8">
                  <c:v>30</c:v>
                </c:pt>
                <c:pt idx="9">
                  <c:v>35</c:v>
                </c:pt>
                <c:pt idx="10">
                  <c:v>40</c:v>
                </c:pt>
                <c:pt idx="11">
                  <c:v>45</c:v>
                </c:pt>
                <c:pt idx="12">
                  <c:v>50</c:v>
                </c:pt>
                <c:pt idx="13">
                  <c:v>60</c:v>
                </c:pt>
                <c:pt idx="14">
                  <c:v>70</c:v>
                </c:pt>
                <c:pt idx="15">
                  <c:v>80</c:v>
                </c:pt>
              </c:numCache>
            </c:numRef>
          </c:xVal>
          <c:yVal>
            <c:numRef>
              <c:f>Sheet1!$J$6:$J$21</c:f>
              <c:numCache>
                <c:formatCode>General</c:formatCode>
                <c:ptCount val="16"/>
                <c:pt idx="0">
                  <c:v>0</c:v>
                </c:pt>
                <c:pt idx="1">
                  <c:v>3.3333333333333321</c:v>
                </c:pt>
                <c:pt idx="2">
                  <c:v>2</c:v>
                </c:pt>
                <c:pt idx="3">
                  <c:v>5.6666666666666643</c:v>
                </c:pt>
                <c:pt idx="4">
                  <c:v>13.666666666666668</c:v>
                </c:pt>
                <c:pt idx="5">
                  <c:v>40</c:v>
                </c:pt>
                <c:pt idx="6">
                  <c:v>55.666666666666657</c:v>
                </c:pt>
                <c:pt idx="7">
                  <c:v>62</c:v>
                </c:pt>
                <c:pt idx="8">
                  <c:v>66.3333333333333</c:v>
                </c:pt>
                <c:pt idx="9">
                  <c:v>67.6666666666667</c:v>
                </c:pt>
                <c:pt idx="10">
                  <c:v>70</c:v>
                </c:pt>
                <c:pt idx="11">
                  <c:v>68</c:v>
                </c:pt>
                <c:pt idx="12">
                  <c:v>70</c:v>
                </c:pt>
                <c:pt idx="13">
                  <c:v>70</c:v>
                </c:pt>
                <c:pt idx="14">
                  <c:v>71.3333333333333</c:v>
                </c:pt>
                <c:pt idx="15">
                  <c:v>7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8294528"/>
        <c:axId val="98295104"/>
      </c:scatterChart>
      <c:valAx>
        <c:axId val="98294528"/>
        <c:scaling>
          <c:orientation val="minMax"/>
          <c:max val="72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rs)</a:t>
                </a:r>
              </a:p>
            </c:rich>
          </c:tx>
          <c:layout>
            <c:manualLayout>
              <c:xMode val="edge"/>
              <c:yMode val="edge"/>
              <c:x val="0.41524126984126986"/>
              <c:y val="0.9175816356017916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98295104"/>
        <c:crosses val="autoZero"/>
        <c:crossBetween val="midCat"/>
        <c:majorUnit val="12"/>
      </c:valAx>
      <c:valAx>
        <c:axId val="98295104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dox signal intensity</a:t>
                </a:r>
              </a:p>
            </c:rich>
          </c:tx>
          <c:layout>
            <c:manualLayout>
              <c:xMode val="edge"/>
              <c:yMode val="edge"/>
              <c:x val="7.5222222222222166E-3"/>
              <c:y val="0.2303828926455714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98294528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40939404761904763"/>
          <c:y val="0.67815597457014876"/>
          <c:w val="0.59060593958503704"/>
          <c:h val="0.16434018664333627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900" b="0" i="0">
          <a:latin typeface="Arial" panose="020B0604020202090204" pitchFamily="34" charset="0"/>
          <a:cs typeface="Arial" panose="020B060402020209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120951995133473"/>
          <c:y val="2.4217795244972782E-2"/>
          <c:w val="0.70740908149481641"/>
          <c:h val="0.82399059861932344"/>
        </c:manualLayout>
      </c:layout>
      <c:scatterChart>
        <c:scatterStyle val="lineMarker"/>
        <c:varyColors val="0"/>
        <c:ser>
          <c:idx val="0"/>
          <c:order val="0"/>
          <c:tx>
            <c:strRef>
              <c:f>Temperature!$I$83:$I$85</c:f>
              <c:strCache>
                <c:ptCount val="1"/>
                <c:pt idx="0">
                  <c:v>YPS128xY12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Temperature!$H$86:$H$100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Temperature!$I$86:$I$100</c:f>
              <c:numCache>
                <c:formatCode>General</c:formatCode>
                <c:ptCount val="15"/>
                <c:pt idx="0">
                  <c:v>0</c:v>
                </c:pt>
                <c:pt idx="1">
                  <c:v>14.666666666666664</c:v>
                </c:pt>
                <c:pt idx="2">
                  <c:v>61.666666666666664</c:v>
                </c:pt>
                <c:pt idx="3">
                  <c:v>74.333333333333343</c:v>
                </c:pt>
                <c:pt idx="4">
                  <c:v>82.333333333333343</c:v>
                </c:pt>
                <c:pt idx="5">
                  <c:v>80</c:v>
                </c:pt>
                <c:pt idx="6">
                  <c:v>81.666666666666657</c:v>
                </c:pt>
                <c:pt idx="7">
                  <c:v>79.333333333333343</c:v>
                </c:pt>
                <c:pt idx="8">
                  <c:v>81.333333333333343</c:v>
                </c:pt>
                <c:pt idx="9">
                  <c:v>85</c:v>
                </c:pt>
                <c:pt idx="10">
                  <c:v>83.666666666666657</c:v>
                </c:pt>
                <c:pt idx="11">
                  <c:v>88.333333333333343</c:v>
                </c:pt>
                <c:pt idx="12">
                  <c:v>89.666666666666657</c:v>
                </c:pt>
                <c:pt idx="13">
                  <c:v>89.666666666666657</c:v>
                </c:pt>
                <c:pt idx="14">
                  <c:v>88.33333333333334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Temperature!$J$83:$J$85</c:f>
              <c:strCache>
                <c:ptCount val="1"/>
                <c:pt idx="0">
                  <c:v>YPS128 (S.c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Temperature!$H$86:$H$100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Temperature!$J$86:$J$100</c:f>
              <c:numCache>
                <c:formatCode>General</c:formatCode>
                <c:ptCount val="15"/>
                <c:pt idx="0">
                  <c:v>0</c:v>
                </c:pt>
                <c:pt idx="1">
                  <c:v>13.333333333333332</c:v>
                </c:pt>
                <c:pt idx="2">
                  <c:v>57.333333333333343</c:v>
                </c:pt>
                <c:pt idx="3">
                  <c:v>67</c:v>
                </c:pt>
                <c:pt idx="4">
                  <c:v>70</c:v>
                </c:pt>
                <c:pt idx="5">
                  <c:v>71</c:v>
                </c:pt>
                <c:pt idx="6">
                  <c:v>70.666666666666671</c:v>
                </c:pt>
                <c:pt idx="7">
                  <c:v>70.333333333333343</c:v>
                </c:pt>
                <c:pt idx="8">
                  <c:v>70.666666666666671</c:v>
                </c:pt>
                <c:pt idx="9">
                  <c:v>75.333333333333343</c:v>
                </c:pt>
                <c:pt idx="10">
                  <c:v>72.333333333333343</c:v>
                </c:pt>
                <c:pt idx="11">
                  <c:v>77</c:v>
                </c:pt>
                <c:pt idx="12">
                  <c:v>77.333333333333343</c:v>
                </c:pt>
                <c:pt idx="13">
                  <c:v>76.333333333333343</c:v>
                </c:pt>
                <c:pt idx="14">
                  <c:v>77.333333333333343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Temperature!$K$83:$K$85</c:f>
              <c:strCache>
                <c:ptCount val="1"/>
                <c:pt idx="0">
                  <c:v>Y12 (S.c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Temperature!$H$86:$H$100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Temperature!$K$86:$K$100</c:f>
              <c:numCache>
                <c:formatCode>General</c:formatCode>
                <c:ptCount val="15"/>
                <c:pt idx="0">
                  <c:v>0</c:v>
                </c:pt>
                <c:pt idx="1">
                  <c:v>14.000000000000004</c:v>
                </c:pt>
                <c:pt idx="2">
                  <c:v>55.333333333333343</c:v>
                </c:pt>
                <c:pt idx="3">
                  <c:v>73.333333333333343</c:v>
                </c:pt>
                <c:pt idx="4">
                  <c:v>78.333333333333343</c:v>
                </c:pt>
                <c:pt idx="5">
                  <c:v>79.666666666666671</c:v>
                </c:pt>
                <c:pt idx="6">
                  <c:v>80.333333333333343</c:v>
                </c:pt>
                <c:pt idx="7">
                  <c:v>78.333333333333343</c:v>
                </c:pt>
                <c:pt idx="8">
                  <c:v>78</c:v>
                </c:pt>
                <c:pt idx="9">
                  <c:v>80</c:v>
                </c:pt>
                <c:pt idx="10">
                  <c:v>78</c:v>
                </c:pt>
                <c:pt idx="11">
                  <c:v>83</c:v>
                </c:pt>
                <c:pt idx="12">
                  <c:v>83.666666666666671</c:v>
                </c:pt>
                <c:pt idx="13">
                  <c:v>83.333333333333343</c:v>
                </c:pt>
                <c:pt idx="14">
                  <c:v>84.66666666666667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2960960"/>
        <c:axId val="82961536"/>
      </c:scatterChart>
      <c:valAx>
        <c:axId val="82960960"/>
        <c:scaling>
          <c:orientation val="minMax"/>
          <c:max val="72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rs)</a:t>
                </a:r>
              </a:p>
            </c:rich>
          </c:tx>
          <c:layout>
            <c:manualLayout>
              <c:xMode val="edge"/>
              <c:yMode val="edge"/>
              <c:x val="0.4404186743051367"/>
              <c:y val="0.9200676284604527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82961536"/>
        <c:crosses val="autoZero"/>
        <c:crossBetween val="midCat"/>
        <c:majorUnit val="12"/>
      </c:valAx>
      <c:valAx>
        <c:axId val="829615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dox signal  inte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2960960"/>
        <c:crosses val="autoZero"/>
        <c:crossBetween val="midCat"/>
        <c:majorUnit val="20"/>
      </c:valAx>
    </c:plotArea>
    <c:legend>
      <c:legendPos val="t"/>
      <c:layout>
        <c:manualLayout>
          <c:xMode val="edge"/>
          <c:yMode val="edge"/>
          <c:x val="0.38837399846032206"/>
          <c:y val="0.62668661815353854"/>
          <c:w val="0.44257499854603299"/>
          <c:h val="0.1456497711080535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900" b="0">
          <a:latin typeface="Arial" panose="020B0604020202090204" pitchFamily="34" charset="0"/>
          <a:cs typeface="Arial" panose="020B060402020209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944328875528163"/>
          <c:y val="4.9820659567217117E-2"/>
          <c:w val="0.67819852407862935"/>
          <c:h val="0.78160144598944936"/>
        </c:manualLayout>
      </c:layout>
      <c:scatterChart>
        <c:scatterStyle val="lineMarker"/>
        <c:varyColors val="0"/>
        <c:ser>
          <c:idx val="0"/>
          <c:order val="0"/>
          <c:tx>
            <c:strRef>
              <c:f>Temperature!$AF$25</c:f>
              <c:strCache>
                <c:ptCount val="1"/>
                <c:pt idx="0">
                  <c:v>IFO1803xY55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Temperature!$AE$26:$AE$40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Temperature!$AF$26:$AF$40</c:f>
              <c:numCache>
                <c:formatCode>General</c:formatCode>
                <c:ptCount val="15"/>
                <c:pt idx="0">
                  <c:v>0</c:v>
                </c:pt>
                <c:pt idx="1">
                  <c:v>14.888888888888886</c:v>
                </c:pt>
                <c:pt idx="2">
                  <c:v>39.222222222222214</c:v>
                </c:pt>
                <c:pt idx="3">
                  <c:v>58.111111111111114</c:v>
                </c:pt>
                <c:pt idx="4">
                  <c:v>73.777777777777786</c:v>
                </c:pt>
                <c:pt idx="5">
                  <c:v>77.999999999999986</c:v>
                </c:pt>
                <c:pt idx="6">
                  <c:v>78.888888888888886</c:v>
                </c:pt>
                <c:pt idx="7">
                  <c:v>79.444444444444443</c:v>
                </c:pt>
                <c:pt idx="8">
                  <c:v>80.777777777777786</c:v>
                </c:pt>
                <c:pt idx="9">
                  <c:v>84.666666666666657</c:v>
                </c:pt>
                <c:pt idx="10">
                  <c:v>82.555555555555557</c:v>
                </c:pt>
                <c:pt idx="11">
                  <c:v>87.111111111111114</c:v>
                </c:pt>
                <c:pt idx="12">
                  <c:v>88.222222222222229</c:v>
                </c:pt>
                <c:pt idx="13">
                  <c:v>86.555555555555557</c:v>
                </c:pt>
                <c:pt idx="14">
                  <c:v>85.77777777777778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Temperature!$AG$25</c:f>
              <c:strCache>
                <c:ptCount val="1"/>
                <c:pt idx="0">
                  <c:v>IF01803 (S.k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Temperature!$AE$26:$AE$40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Temperature!$AG$26:$AG$40</c:f>
              <c:numCache>
                <c:formatCode>General</c:formatCode>
                <c:ptCount val="15"/>
                <c:pt idx="0">
                  <c:v>0</c:v>
                </c:pt>
                <c:pt idx="1">
                  <c:v>18.666666666666664</c:v>
                </c:pt>
                <c:pt idx="2">
                  <c:v>69.666666666666671</c:v>
                </c:pt>
                <c:pt idx="3">
                  <c:v>74.333333333333329</c:v>
                </c:pt>
                <c:pt idx="4">
                  <c:v>77.333333333333329</c:v>
                </c:pt>
                <c:pt idx="5">
                  <c:v>78.333333333333329</c:v>
                </c:pt>
                <c:pt idx="6">
                  <c:v>75.666666666666671</c:v>
                </c:pt>
                <c:pt idx="7">
                  <c:v>75</c:v>
                </c:pt>
                <c:pt idx="8">
                  <c:v>76.666666666666671</c:v>
                </c:pt>
                <c:pt idx="9">
                  <c:v>79.666666666666671</c:v>
                </c:pt>
                <c:pt idx="10">
                  <c:v>76.333333333333329</c:v>
                </c:pt>
                <c:pt idx="11">
                  <c:v>79</c:v>
                </c:pt>
                <c:pt idx="12">
                  <c:v>80</c:v>
                </c:pt>
                <c:pt idx="13">
                  <c:v>77.333333333333329</c:v>
                </c:pt>
                <c:pt idx="14">
                  <c:v>77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Temperature!$AH$25</c:f>
              <c:strCache>
                <c:ptCount val="1"/>
                <c:pt idx="0">
                  <c:v>Y55 (S.c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Temperature!$AE$26:$AE$40</c:f>
              <c:numCache>
                <c:formatCode>General</c:formatCode>
                <c:ptCount val="1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</c:numCache>
            </c:numRef>
          </c:xVal>
          <c:yVal>
            <c:numRef>
              <c:f>Temperature!$AH$26:$AH$40</c:f>
              <c:numCache>
                <c:formatCode>General</c:formatCode>
                <c:ptCount val="15"/>
                <c:pt idx="0">
                  <c:v>0</c:v>
                </c:pt>
                <c:pt idx="1">
                  <c:v>6.6666666666666679</c:v>
                </c:pt>
                <c:pt idx="2">
                  <c:v>44</c:v>
                </c:pt>
                <c:pt idx="3">
                  <c:v>61.333333333333329</c:v>
                </c:pt>
                <c:pt idx="4">
                  <c:v>64.666666666666671</c:v>
                </c:pt>
                <c:pt idx="5">
                  <c:v>69</c:v>
                </c:pt>
                <c:pt idx="6">
                  <c:v>71.666666666666671</c:v>
                </c:pt>
                <c:pt idx="7">
                  <c:v>72.666666666666671</c:v>
                </c:pt>
                <c:pt idx="8">
                  <c:v>72.666666666666671</c:v>
                </c:pt>
                <c:pt idx="9">
                  <c:v>75.666666666666671</c:v>
                </c:pt>
                <c:pt idx="10">
                  <c:v>71</c:v>
                </c:pt>
                <c:pt idx="11">
                  <c:v>74.666666666666671</c:v>
                </c:pt>
                <c:pt idx="12">
                  <c:v>73.666666666666671</c:v>
                </c:pt>
                <c:pt idx="13">
                  <c:v>72.666666666666671</c:v>
                </c:pt>
                <c:pt idx="14">
                  <c:v>7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2963264"/>
        <c:axId val="82963840"/>
      </c:scatterChart>
      <c:valAx>
        <c:axId val="82963264"/>
        <c:scaling>
          <c:orientation val="minMax"/>
          <c:max val="72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rs)</a:t>
                </a:r>
              </a:p>
            </c:rich>
          </c:tx>
          <c:layout>
            <c:manualLayout>
              <c:xMode val="edge"/>
              <c:yMode val="edge"/>
              <c:x val="0.45980436507936506"/>
              <c:y val="0.9330140153157058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82963840"/>
        <c:crosses val="autoZero"/>
        <c:crossBetween val="midCat"/>
        <c:majorUnit val="12"/>
      </c:valAx>
      <c:valAx>
        <c:axId val="82963840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dox signal intensity</a:t>
                </a:r>
              </a:p>
            </c:rich>
          </c:tx>
          <c:layout>
            <c:manualLayout>
              <c:xMode val="edge"/>
              <c:yMode val="edge"/>
              <c:x val="5.6310714285714283E-2"/>
              <c:y val="0.2270216109798310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82963264"/>
        <c:crosses val="autoZero"/>
        <c:crossBetween val="midCat"/>
        <c:majorUnit val="20"/>
      </c:valAx>
    </c:plotArea>
    <c:legend>
      <c:legendPos val="t"/>
      <c:layout>
        <c:manualLayout>
          <c:xMode val="edge"/>
          <c:yMode val="edge"/>
          <c:x val="0.42304960317460311"/>
          <c:y val="0.6755627799450945"/>
          <c:w val="0.56869837595142358"/>
          <c:h val="0.1555661594569756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900" b="0">
          <a:latin typeface="Arial" panose="020B0604020202090204" pitchFamily="34" charset="0"/>
          <a:cs typeface="Arial" panose="020B060402020209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3427671787769683"/>
          <c:y val="3.7719925140873453E-2"/>
          <c:w val="0.68266107687381139"/>
          <c:h val="0.79865487713691286"/>
        </c:manualLayout>
      </c:layout>
      <c:scatterChart>
        <c:scatterStyle val="lineMarker"/>
        <c:varyColors val="0"/>
        <c:ser>
          <c:idx val="0"/>
          <c:order val="0"/>
          <c:tx>
            <c:strRef>
              <c:f>'[Chart in Microsoft PowerPoint]ETOH-1'!$F$1</c:f>
              <c:strCache>
                <c:ptCount val="1"/>
                <c:pt idx="0">
                  <c:v>10%ETOH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noFill/>
              </a:ln>
            </c:spPr>
          </c:marker>
          <c:xVal>
            <c:multiLvlStrRef>
              <c:f>'[Chart in Microsoft PowerPoint]ETOH-1'!$A$2:$E$90</c:f>
              <c:multiLvlStrCache>
                <c:ptCount val="89"/>
                <c:lvl>
                  <c:pt idx="0">
                    <c:v>2.3318</c:v>
                  </c:pt>
                  <c:pt idx="1">
                    <c:v>2.3317</c:v>
                  </c:pt>
                  <c:pt idx="2">
                    <c:v>A12</c:v>
                  </c:pt>
                  <c:pt idx="3">
                    <c:v>UFRJ50816</c:v>
                  </c:pt>
                  <c:pt idx="4">
                    <c:v>LD7</c:v>
                  </c:pt>
                  <c:pt idx="5">
                    <c:v>Y9.6</c:v>
                  </c:pt>
                  <c:pt idx="6">
                    <c:v>Q59.1</c:v>
                  </c:pt>
                  <c:pt idx="7">
                    <c:v>N-43</c:v>
                  </c:pt>
                  <c:pt idx="8">
                    <c:v>UWOPS05-227.2</c:v>
                  </c:pt>
                  <c:pt idx="9">
                    <c:v>S288C</c:v>
                  </c:pt>
                  <c:pt idx="10">
                    <c:v>Q32.3</c:v>
                  </c:pt>
                  <c:pt idx="11">
                    <c:v>W303</c:v>
                  </c:pt>
                  <c:pt idx="12">
                    <c:v>ZP452</c:v>
                  </c:pt>
                  <c:pt idx="13">
                    <c:v>Q31.4</c:v>
                  </c:pt>
                  <c:pt idx="14">
                    <c:v>UWOPS03-461.4</c:v>
                  </c:pt>
                  <c:pt idx="15">
                    <c:v>K11</c:v>
                  </c:pt>
                  <c:pt idx="16">
                    <c:v>YPS128</c:v>
                  </c:pt>
                  <c:pt idx="17">
                    <c:v>273614N</c:v>
                  </c:pt>
                  <c:pt idx="18">
                    <c:v>Y7</c:v>
                  </c:pt>
                  <c:pt idx="19">
                    <c:v>DBVPG1853</c:v>
                  </c:pt>
                  <c:pt idx="20">
                    <c:v>ZP594</c:v>
                  </c:pt>
                  <c:pt idx="21">
                    <c:v>S36.7</c:v>
                  </c:pt>
                  <c:pt idx="22">
                    <c:v>UWOPS99-807.1.1</c:v>
                  </c:pt>
                  <c:pt idx="23">
                    <c:v>Z1.1</c:v>
                  </c:pt>
                  <c:pt idx="24">
                    <c:v>UWOPS83-787.3</c:v>
                  </c:pt>
                  <c:pt idx="25">
                    <c:v>Q95.3</c:v>
                  </c:pt>
                  <c:pt idx="26">
                    <c:v>UFRJ50791</c:v>
                  </c:pt>
                  <c:pt idx="27">
                    <c:v>DBVPG1788</c:v>
                  </c:pt>
                  <c:pt idx="28">
                    <c:v>UWOPS87-2421</c:v>
                  </c:pt>
                  <c:pt idx="29">
                    <c:v>Y8.5</c:v>
                  </c:pt>
                  <c:pt idx="30">
                    <c:v>IFO1815</c:v>
                  </c:pt>
                  <c:pt idx="31">
                    <c:v>UWOPS05-217.3</c:v>
                  </c:pt>
                  <c:pt idx="32">
                    <c:v>IFO1802</c:v>
                  </c:pt>
                  <c:pt idx="33">
                    <c:v>NBRC10990</c:v>
                  </c:pt>
                  <c:pt idx="34">
                    <c:v>YIIc17_E5</c:v>
                  </c:pt>
                  <c:pt idx="35">
                    <c:v>Y9</c:v>
                  </c:pt>
                  <c:pt idx="36">
                    <c:v>IFO1816</c:v>
                  </c:pt>
                  <c:pt idx="37">
                    <c:v>Q62.5</c:v>
                  </c:pt>
                  <c:pt idx="38">
                    <c:v>CBS5829</c:v>
                  </c:pt>
                  <c:pt idx="39">
                    <c:v>YS4</c:v>
                  </c:pt>
                  <c:pt idx="40">
                    <c:v>Y6.5</c:v>
                  </c:pt>
                  <c:pt idx="41">
                    <c:v>A4</c:v>
                  </c:pt>
                  <c:pt idx="42">
                    <c:v>Q89.8</c:v>
                  </c:pt>
                  <c:pt idx="43">
                    <c:v>L-1764</c:v>
                  </c:pt>
                  <c:pt idx="44">
                    <c:v>YJM978</c:v>
                  </c:pt>
                  <c:pt idx="45">
                    <c:v>DBVPG1373</c:v>
                  </c:pt>
                  <c:pt idx="46">
                    <c:v>Y55</c:v>
                  </c:pt>
                  <c:pt idx="47">
                    <c:v>CBS4309</c:v>
                  </c:pt>
                  <c:pt idx="48">
                    <c:v>DBVPG4650</c:v>
                  </c:pt>
                  <c:pt idx="49">
                    <c:v>BC187</c:v>
                  </c:pt>
                  <c:pt idx="50">
                    <c:v>NCYC361</c:v>
                  </c:pt>
                  <c:pt idx="51">
                    <c:v>GL379</c:v>
                  </c:pt>
                  <c:pt idx="52">
                    <c:v>L-1528</c:v>
                  </c:pt>
                  <c:pt idx="53">
                    <c:v>YPS138</c:v>
                  </c:pt>
                  <c:pt idx="54">
                    <c:v>KPN3829</c:v>
                  </c:pt>
                  <c:pt idx="55">
                    <c:v>YJM789</c:v>
                  </c:pt>
                  <c:pt idx="56">
                    <c:v>YJM981</c:v>
                  </c:pt>
                  <c:pt idx="57">
                    <c:v>Z1</c:v>
                  </c:pt>
                  <c:pt idx="58">
                    <c:v>RM11</c:v>
                  </c:pt>
                  <c:pt idx="59">
                    <c:v>2.3319</c:v>
                  </c:pt>
                  <c:pt idx="60">
                    <c:v>Y8.1</c:v>
                  </c:pt>
                  <c:pt idx="61">
                    <c:v>DBVPG6765</c:v>
                  </c:pt>
                  <c:pt idx="62">
                    <c:v>YS9</c:v>
                  </c:pt>
                  <c:pt idx="63">
                    <c:v>DBVPG6040</c:v>
                  </c:pt>
                  <c:pt idx="64">
                    <c:v>YS2</c:v>
                  </c:pt>
                  <c:pt idx="65">
                    <c:v>YPS606</c:v>
                  </c:pt>
                  <c:pt idx="66">
                    <c:v>L-1374</c:v>
                  </c:pt>
                  <c:pt idx="67">
                    <c:v>N-17</c:v>
                  </c:pt>
                  <c:pt idx="68">
                    <c:v>UWOPS91-917.1</c:v>
                  </c:pt>
                  <c:pt idx="69">
                    <c:v>DBVPG6304</c:v>
                  </c:pt>
                  <c:pt idx="70">
                    <c:v>ZP555</c:v>
                  </c:pt>
                  <c:pt idx="71">
                    <c:v>IFO1803</c:v>
                  </c:pt>
                  <c:pt idx="72">
                    <c:v>DBVP1106</c:v>
                  </c:pt>
                  <c:pt idx="73">
                    <c:v>KPN3828</c:v>
                  </c:pt>
                  <c:pt idx="74">
                    <c:v>DBVPG6044</c:v>
                  </c:pt>
                  <c:pt idx="75">
                    <c:v>Y12</c:v>
                  </c:pt>
                  <c:pt idx="76">
                    <c:v>SK1</c:v>
                  </c:pt>
                  <c:pt idx="77">
                    <c:v>T21.4</c:v>
                  </c:pt>
                  <c:pt idx="78">
                    <c:v>N-44</c:v>
                  </c:pt>
                  <c:pt idx="79">
                    <c:v>Q74.4</c:v>
                  </c:pt>
                  <c:pt idx="80">
                    <c:v>CBS432</c:v>
                  </c:pt>
                  <c:pt idx="81">
                    <c:v>N-45</c:v>
                  </c:pt>
                  <c:pt idx="82">
                    <c:v>322134S</c:v>
                  </c:pt>
                  <c:pt idx="83">
                    <c:v>IFO1804</c:v>
                  </c:pt>
                  <c:pt idx="84">
                    <c:v>322134S</c:v>
                  </c:pt>
                  <c:pt idx="85">
                    <c:v>YJM975</c:v>
                  </c:pt>
                  <c:pt idx="86">
                    <c:v>NCYC110</c:v>
                  </c:pt>
                  <c:pt idx="87">
                    <c:v>378604X</c:v>
                  </c:pt>
                  <c:pt idx="88">
                    <c:v>Q96.8</c:v>
                  </c:pt>
                </c:lvl>
                <c:lvl>
                  <c:pt idx="0">
                    <c:v>S. arboricolus</c:v>
                  </c:pt>
                  <c:pt idx="1">
                    <c:v>S. arboricolus</c:v>
                  </c:pt>
                  <c:pt idx="2">
                    <c:v>S. paradoxus</c:v>
                  </c:pt>
                  <c:pt idx="3">
                    <c:v>S. paradoxus</c:v>
                  </c:pt>
                  <c:pt idx="4">
                    <c:v>S. paradoxus</c:v>
                  </c:pt>
                  <c:pt idx="5">
                    <c:v>S. paradoxus</c:v>
                  </c:pt>
                  <c:pt idx="6">
                    <c:v>S. paradoxus</c:v>
                  </c:pt>
                  <c:pt idx="7">
                    <c:v>S. paradoxus</c:v>
                  </c:pt>
                  <c:pt idx="8">
                    <c:v>S. cerevisiae</c:v>
                  </c:pt>
                  <c:pt idx="9">
                    <c:v>S. cerevisiae</c:v>
                  </c:pt>
                  <c:pt idx="10">
                    <c:v>S. paradoxus</c:v>
                  </c:pt>
                  <c:pt idx="11">
                    <c:v>S. cerevisiae</c:v>
                  </c:pt>
                  <c:pt idx="12">
                    <c:v>S. kudriavzevii</c:v>
                  </c:pt>
                  <c:pt idx="13">
                    <c:v>S. paradoxus</c:v>
                  </c:pt>
                  <c:pt idx="14">
                    <c:v>S. cerevisiae</c:v>
                  </c:pt>
                  <c:pt idx="15">
                    <c:v>S. cerevisiae</c:v>
                  </c:pt>
                  <c:pt idx="16">
                    <c:v>S. cerevisiae</c:v>
                  </c:pt>
                  <c:pt idx="17">
                    <c:v>S. cerevisiae</c:v>
                  </c:pt>
                  <c:pt idx="18">
                    <c:v>S. paradoxus</c:v>
                  </c:pt>
                  <c:pt idx="19">
                    <c:v>S. cerevisiae</c:v>
                  </c:pt>
                  <c:pt idx="20">
                    <c:v>S. kudriavzevii</c:v>
                  </c:pt>
                  <c:pt idx="21">
                    <c:v>S. paradoxus</c:v>
                  </c:pt>
                  <c:pt idx="22">
                    <c:v>S. bayanus</c:v>
                  </c:pt>
                  <c:pt idx="23">
                    <c:v>S. paradoxus</c:v>
                  </c:pt>
                  <c:pt idx="24">
                    <c:v>S. cerevisiae</c:v>
                  </c:pt>
                  <c:pt idx="25">
                    <c:v>S. paradoxus</c:v>
                  </c:pt>
                  <c:pt idx="26">
                    <c:v>S. paradoxus</c:v>
                  </c:pt>
                  <c:pt idx="27">
                    <c:v>S. cerevisiae</c:v>
                  </c:pt>
                  <c:pt idx="28">
                    <c:v>S. cerevisiae</c:v>
                  </c:pt>
                  <c:pt idx="29">
                    <c:v>S. paradoxus</c:v>
                  </c:pt>
                  <c:pt idx="30">
                    <c:v>S. mikatae</c:v>
                  </c:pt>
                  <c:pt idx="31">
                    <c:v>S. cerevisiae</c:v>
                  </c:pt>
                  <c:pt idx="32">
                    <c:v>S. kudriavzevii</c:v>
                  </c:pt>
                  <c:pt idx="33">
                    <c:v>S. kudriavzevii</c:v>
                  </c:pt>
                  <c:pt idx="34">
                    <c:v>S. cerevisiae</c:v>
                  </c:pt>
                  <c:pt idx="35">
                    <c:v>S. cerevisiae</c:v>
                  </c:pt>
                  <c:pt idx="36">
                    <c:v>S. mikatae</c:v>
                  </c:pt>
                  <c:pt idx="37">
                    <c:v>S. paradoxus</c:v>
                  </c:pt>
                  <c:pt idx="38">
                    <c:v>S. paradoxus</c:v>
                  </c:pt>
                  <c:pt idx="39">
                    <c:v>S. cerevisiae</c:v>
                  </c:pt>
                  <c:pt idx="40">
                    <c:v>S. paradoxus</c:v>
                  </c:pt>
                  <c:pt idx="41">
                    <c:v>S. paradoxus</c:v>
                  </c:pt>
                  <c:pt idx="42">
                    <c:v>S. paradoxus</c:v>
                  </c:pt>
                  <c:pt idx="43">
                    <c:v>S. bayanus</c:v>
                  </c:pt>
                  <c:pt idx="44">
                    <c:v>S. cerevisiae</c:v>
                  </c:pt>
                  <c:pt idx="45">
                    <c:v>S. cerevisiae</c:v>
                  </c:pt>
                  <c:pt idx="46">
                    <c:v>S. cerevisiae</c:v>
                  </c:pt>
                  <c:pt idx="47">
                    <c:v>S. castelli</c:v>
                  </c:pt>
                  <c:pt idx="48">
                    <c:v>S. paradoxus</c:v>
                  </c:pt>
                  <c:pt idx="49">
                    <c:v>S. cerevisiae</c:v>
                  </c:pt>
                  <c:pt idx="50">
                    <c:v>S. cerevisiae</c:v>
                  </c:pt>
                  <c:pt idx="51">
                    <c:v>S. paradoxus</c:v>
                  </c:pt>
                  <c:pt idx="52">
                    <c:v>S. cerevisiae</c:v>
                  </c:pt>
                  <c:pt idx="53">
                    <c:v>S. paradoxus</c:v>
                  </c:pt>
                  <c:pt idx="54">
                    <c:v>S. cerevisiae</c:v>
                  </c:pt>
                  <c:pt idx="55">
                    <c:v>S. cerevisiae</c:v>
                  </c:pt>
                  <c:pt idx="56">
                    <c:v>S. cerevisiae</c:v>
                  </c:pt>
                  <c:pt idx="57">
                    <c:v>S. paradoxus</c:v>
                  </c:pt>
                  <c:pt idx="58">
                    <c:v>S. cerevisiae</c:v>
                  </c:pt>
                  <c:pt idx="59">
                    <c:v>S. arboricolus</c:v>
                  </c:pt>
                  <c:pt idx="60">
                    <c:v>S. paradoxus</c:v>
                  </c:pt>
                  <c:pt idx="61">
                    <c:v>S. cerevisiae</c:v>
                  </c:pt>
                  <c:pt idx="62">
                    <c:v>S. cerevisiae</c:v>
                  </c:pt>
                  <c:pt idx="63">
                    <c:v>S. cerevisiae</c:v>
                  </c:pt>
                  <c:pt idx="64">
                    <c:v>S. cerevisiae</c:v>
                  </c:pt>
                  <c:pt idx="65">
                    <c:v>S. cerevisiae</c:v>
                  </c:pt>
                  <c:pt idx="66">
                    <c:v>S. cerevisiae</c:v>
                  </c:pt>
                  <c:pt idx="67">
                    <c:v>S. paradoxus</c:v>
                  </c:pt>
                  <c:pt idx="68">
                    <c:v>S. paradoxus</c:v>
                  </c:pt>
                  <c:pt idx="69">
                    <c:v>S. paradoxus</c:v>
                  </c:pt>
                  <c:pt idx="70">
                    <c:v>S. bayanus</c:v>
                  </c:pt>
                  <c:pt idx="71">
                    <c:v>S. kudriavzevii</c:v>
                  </c:pt>
                  <c:pt idx="72">
                    <c:v>S. cerevisiae</c:v>
                  </c:pt>
                  <c:pt idx="73">
                    <c:v>S. cerevisiae</c:v>
                  </c:pt>
                  <c:pt idx="74">
                    <c:v>S. cerevisiae</c:v>
                  </c:pt>
                  <c:pt idx="75">
                    <c:v>S. cerevisiae</c:v>
                  </c:pt>
                  <c:pt idx="76">
                    <c:v>S. cerevisiae</c:v>
                  </c:pt>
                  <c:pt idx="77">
                    <c:v>S. paradoxus</c:v>
                  </c:pt>
                  <c:pt idx="78">
                    <c:v>S. paradoxus</c:v>
                  </c:pt>
                  <c:pt idx="79">
                    <c:v>S. paradoxus</c:v>
                  </c:pt>
                  <c:pt idx="80">
                    <c:v>S. paradoxus</c:v>
                  </c:pt>
                  <c:pt idx="81">
                    <c:v>S. paradoxus</c:v>
                  </c:pt>
                  <c:pt idx="82">
                    <c:v>S. cerevisiae</c:v>
                  </c:pt>
                  <c:pt idx="83">
                    <c:v>S. paradoxus</c:v>
                  </c:pt>
                  <c:pt idx="84">
                    <c:v>S. cerevisiae</c:v>
                  </c:pt>
                  <c:pt idx="85">
                    <c:v>S. cerevisiae</c:v>
                  </c:pt>
                  <c:pt idx="86">
                    <c:v>S. cerevisiae</c:v>
                  </c:pt>
                  <c:pt idx="87">
                    <c:v>S. cerevisiae</c:v>
                  </c:pt>
                  <c:pt idx="88">
                    <c:v>S. paradoxus</c:v>
                  </c:pt>
                </c:lvl>
                <c:lvl>
                  <c:pt idx="0">
                    <c:v>China</c:v>
                  </c:pt>
                  <c:pt idx="1">
                    <c:v>China</c:v>
                  </c:pt>
                  <c:pt idx="2">
                    <c:v>Montreal</c:v>
                  </c:pt>
                  <c:pt idx="3">
                    <c:v>Brazil</c:v>
                  </c:pt>
                  <c:pt idx="4">
                    <c:v>England</c:v>
                  </c:pt>
                  <c:pt idx="5">
                    <c:v>England</c:v>
                  </c:pt>
                  <c:pt idx="7">
                    <c:v>Russia</c:v>
                  </c:pt>
                  <c:pt idx="8">
                    <c:v>Malasian</c:v>
                  </c:pt>
                  <c:pt idx="9">
                    <c:v>Mostly European Mosaic</c:v>
                  </c:pt>
                  <c:pt idx="11">
                    <c:v>Mostly European Mosaic</c:v>
                  </c:pt>
                  <c:pt idx="12">
                    <c:v>Portugal</c:v>
                  </c:pt>
                  <c:pt idx="13">
                    <c:v>England</c:v>
                  </c:pt>
                  <c:pt idx="14">
                    <c:v>Malasian</c:v>
                  </c:pt>
                  <c:pt idx="15">
                    <c:v>Sake</c:v>
                  </c:pt>
                  <c:pt idx="16">
                    <c:v>North American</c:v>
                  </c:pt>
                  <c:pt idx="17">
                    <c:v>Mostly European Mosaic</c:v>
                  </c:pt>
                  <c:pt idx="19">
                    <c:v>Mostly European Mosaic</c:v>
                  </c:pt>
                  <c:pt idx="20">
                    <c:v>Portugal</c:v>
                  </c:pt>
                  <c:pt idx="22">
                    <c:v>Argentina</c:v>
                  </c:pt>
                  <c:pt idx="24">
                    <c:v>Mostly North American/Malasian Mosaic</c:v>
                  </c:pt>
                  <c:pt idx="26">
                    <c:v>Brazil</c:v>
                  </c:pt>
                  <c:pt idx="27">
                    <c:v>European</c:v>
                  </c:pt>
                  <c:pt idx="28">
                    <c:v>Mostly North American/Malasian Mosaic</c:v>
                  </c:pt>
                  <c:pt idx="29">
                    <c:v>England</c:v>
                  </c:pt>
                  <c:pt idx="30">
                    <c:v>Japan</c:v>
                  </c:pt>
                  <c:pt idx="31">
                    <c:v>Malasian</c:v>
                  </c:pt>
                  <c:pt idx="32">
                    <c:v>Japan</c:v>
                  </c:pt>
                  <c:pt idx="33">
                    <c:v>Japan</c:v>
                  </c:pt>
                  <c:pt idx="34">
                    <c:v>Mostly European Mosaic</c:v>
                  </c:pt>
                  <c:pt idx="35">
                    <c:v>Sake</c:v>
                  </c:pt>
                  <c:pt idx="36">
                    <c:v>Japan</c:v>
                  </c:pt>
                  <c:pt idx="39">
                    <c:v>Mostly European Mosaic</c:v>
                  </c:pt>
                  <c:pt idx="41">
                    <c:v>Montreal</c:v>
                  </c:pt>
                  <c:pt idx="43">
                    <c:v>Chile</c:v>
                  </c:pt>
                  <c:pt idx="44">
                    <c:v>European</c:v>
                  </c:pt>
                  <c:pt idx="45">
                    <c:v>European</c:v>
                  </c:pt>
                  <c:pt idx="46">
                    <c:v>Mostly African Mosaic</c:v>
                  </c:pt>
                  <c:pt idx="47">
                    <c:v>Finland</c:v>
                  </c:pt>
                  <c:pt idx="48">
                    <c:v>Italy</c:v>
                  </c:pt>
                  <c:pt idx="49">
                    <c:v>European</c:v>
                  </c:pt>
                  <c:pt idx="50">
                    <c:v>Mostly European Mosaic</c:v>
                  </c:pt>
                  <c:pt idx="51">
                    <c:v>North America</c:v>
                  </c:pt>
                  <c:pt idx="52">
                    <c:v>Mostly European Mosaic</c:v>
                  </c:pt>
                  <c:pt idx="53">
                    <c:v>Pennsylvania</c:v>
                  </c:pt>
                  <c:pt idx="54">
                    <c:v>Siberia</c:v>
                  </c:pt>
                  <c:pt idx="55">
                    <c:v>Mostly European Mosaic</c:v>
                  </c:pt>
                  <c:pt idx="56">
                    <c:v>European</c:v>
                  </c:pt>
                  <c:pt idx="57">
                    <c:v>England</c:v>
                  </c:pt>
                  <c:pt idx="58">
                    <c:v>European</c:v>
                  </c:pt>
                  <c:pt idx="59">
                    <c:v>China</c:v>
                  </c:pt>
                  <c:pt idx="60">
                    <c:v>England</c:v>
                  </c:pt>
                  <c:pt idx="61">
                    <c:v>European</c:v>
                  </c:pt>
                  <c:pt idx="62">
                    <c:v>Mostly European Mosaic</c:v>
                  </c:pt>
                  <c:pt idx="63">
                    <c:v>Mostly European Mosaic</c:v>
                  </c:pt>
                  <c:pt idx="64">
                    <c:v>Malasian</c:v>
                  </c:pt>
                  <c:pt idx="65">
                    <c:v>North American</c:v>
                  </c:pt>
                  <c:pt idx="66">
                    <c:v>Mostly European Mosaic</c:v>
                  </c:pt>
                  <c:pt idx="68">
                    <c:v>Hawaii</c:v>
                  </c:pt>
                  <c:pt idx="69">
                    <c:v>California</c:v>
                  </c:pt>
                  <c:pt idx="70">
                    <c:v>Canada</c:v>
                  </c:pt>
                  <c:pt idx="71">
                    <c:v>Japan</c:v>
                  </c:pt>
                  <c:pt idx="72">
                    <c:v>European</c:v>
                  </c:pt>
                  <c:pt idx="73">
                    <c:v>Siberia</c:v>
                  </c:pt>
                  <c:pt idx="74">
                    <c:v>African</c:v>
                  </c:pt>
                  <c:pt idx="75">
                    <c:v>Sake</c:v>
                  </c:pt>
                  <c:pt idx="76">
                    <c:v>Mostly African Mosaic</c:v>
                  </c:pt>
                  <c:pt idx="77">
                    <c:v>England</c:v>
                  </c:pt>
                  <c:pt idx="78">
                    <c:v>Russia</c:v>
                  </c:pt>
                  <c:pt idx="79">
                    <c:v>England</c:v>
                  </c:pt>
                  <c:pt idx="80">
                    <c:v>Russia</c:v>
                  </c:pt>
                  <c:pt idx="81">
                    <c:v>Russia</c:v>
                  </c:pt>
                  <c:pt idx="82">
                    <c:v>Mostly European Mosaic</c:v>
                  </c:pt>
                  <c:pt idx="83">
                    <c:v>Japan</c:v>
                  </c:pt>
                  <c:pt idx="84">
                    <c:v>Mostly European Mosaic</c:v>
                  </c:pt>
                  <c:pt idx="85">
                    <c:v>European</c:v>
                  </c:pt>
                  <c:pt idx="86">
                    <c:v>African</c:v>
                  </c:pt>
                  <c:pt idx="87">
                    <c:v>Mostly European Mosaic</c:v>
                  </c:pt>
                  <c:pt idx="88">
                    <c:v>England</c:v>
                  </c:pt>
                </c:lvl>
                <c:lvl>
                  <c:pt idx="0">
                    <c:v>¨Wild</c:v>
                  </c:pt>
                  <c:pt idx="1">
                    <c:v>¨Wild</c:v>
                  </c:pt>
                  <c:pt idx="2">
                    <c:v>¨Wild</c:v>
                  </c:pt>
                  <c:pt idx="3">
                    <c:v>¨Wild</c:v>
                  </c:pt>
                  <c:pt idx="4">
                    <c:v>¨Wild</c:v>
                  </c:pt>
                  <c:pt idx="5">
                    <c:v>¨Wild</c:v>
                  </c:pt>
                  <c:pt idx="6">
                    <c:v>¨Wild</c:v>
                  </c:pt>
                  <c:pt idx="7">
                    <c:v>¨Wild</c:v>
                  </c:pt>
                  <c:pt idx="8">
                    <c:v>¨Wild</c:v>
                  </c:pt>
                  <c:pt idx="9">
                    <c:v>¯Laboratory</c:v>
                  </c:pt>
                  <c:pt idx="10">
                    <c:v>¨Wild</c:v>
                  </c:pt>
                  <c:pt idx="11">
                    <c:v>¯Laboratory</c:v>
                  </c:pt>
                  <c:pt idx="12">
                    <c:v>¨Wild</c:v>
                  </c:pt>
                  <c:pt idx="13">
                    <c:v>¨Wild</c:v>
                  </c:pt>
                  <c:pt idx="14">
                    <c:v>¨Wild</c:v>
                  </c:pt>
                  <c:pt idx="15">
                    <c:v>£Fermentation</c:v>
                  </c:pt>
                  <c:pt idx="16">
                    <c:v>¨Wild</c:v>
                  </c:pt>
                  <c:pt idx="17">
                    <c:v>rClinical</c:v>
                  </c:pt>
                  <c:pt idx="18">
                    <c:v>¨Wild</c:v>
                  </c:pt>
                  <c:pt idx="19">
                    <c:v>¨Wild</c:v>
                  </c:pt>
                  <c:pt idx="20">
                    <c:v>¨Wild</c:v>
                  </c:pt>
                  <c:pt idx="21">
                    <c:v>¨Wild</c:v>
                  </c:pt>
                  <c:pt idx="22">
                    <c:v>¨Wild</c:v>
                  </c:pt>
                  <c:pt idx="23">
                    <c:v>¨Wild</c:v>
                  </c:pt>
                  <c:pt idx="24">
                    <c:v>¨Wild</c:v>
                  </c:pt>
                  <c:pt idx="25">
                    <c:v>¨Wild</c:v>
                  </c:pt>
                  <c:pt idx="26">
                    <c:v>¨Wild</c:v>
                  </c:pt>
                  <c:pt idx="27">
                    <c:v>¨Wild</c:v>
                  </c:pt>
                  <c:pt idx="28">
                    <c:v>¨Wild</c:v>
                  </c:pt>
                  <c:pt idx="29">
                    <c:v>¨Wild</c:v>
                  </c:pt>
                  <c:pt idx="30">
                    <c:v>¨Wild</c:v>
                  </c:pt>
                  <c:pt idx="31">
                    <c:v>¨Wild</c:v>
                  </c:pt>
                  <c:pt idx="32">
                    <c:v>¨Wild</c:v>
                  </c:pt>
                  <c:pt idx="33">
                    <c:v>¨Wild</c:v>
                  </c:pt>
                  <c:pt idx="34">
                    <c:v>£Fermentation</c:v>
                  </c:pt>
                  <c:pt idx="35">
                    <c:v>£Fermentation</c:v>
                  </c:pt>
                  <c:pt idx="36">
                    <c:v>¨Wild</c:v>
                  </c:pt>
                  <c:pt idx="37">
                    <c:v>¨Wild</c:v>
                  </c:pt>
                  <c:pt idx="38">
                    <c:v>¨Wild</c:v>
                  </c:pt>
                  <c:pt idx="39">
                    <c:v>¡Baking</c:v>
                  </c:pt>
                  <c:pt idx="40">
                    <c:v>¨Wild</c:v>
                  </c:pt>
                  <c:pt idx="41">
                    <c:v>¨Wild</c:v>
                  </c:pt>
                  <c:pt idx="42">
                    <c:v>¨Wild</c:v>
                  </c:pt>
                  <c:pt idx="43">
                    <c:v>¨Wild</c:v>
                  </c:pt>
                  <c:pt idx="44">
                    <c:v>rClinical</c:v>
                  </c:pt>
                  <c:pt idx="45">
                    <c:v>¨Wild</c:v>
                  </c:pt>
                  <c:pt idx="46">
                    <c:v>¯Laboratory</c:v>
                  </c:pt>
                  <c:pt idx="47">
                    <c:v>¨Wild</c:v>
                  </c:pt>
                  <c:pt idx="48">
                    <c:v>¨Wild</c:v>
                  </c:pt>
                  <c:pt idx="49">
                    <c:v>£Fermentation</c:v>
                  </c:pt>
                  <c:pt idx="50">
                    <c:v>£Fermentation</c:v>
                  </c:pt>
                  <c:pt idx="51">
                    <c:v>¨Wild</c:v>
                  </c:pt>
                  <c:pt idx="52">
                    <c:v>£Fermentation</c:v>
                  </c:pt>
                  <c:pt idx="53">
                    <c:v>¨Wild</c:v>
                  </c:pt>
                  <c:pt idx="54">
                    <c:v>¨Wild</c:v>
                  </c:pt>
                  <c:pt idx="55">
                    <c:v>rClinical</c:v>
                  </c:pt>
                  <c:pt idx="56">
                    <c:v>rClinical</c:v>
                  </c:pt>
                  <c:pt idx="57">
                    <c:v>¨Wild</c:v>
                  </c:pt>
                  <c:pt idx="58">
                    <c:v>£Fermentation</c:v>
                  </c:pt>
                  <c:pt idx="59">
                    <c:v>¨Wild</c:v>
                  </c:pt>
                  <c:pt idx="60">
                    <c:v>¨Wild</c:v>
                  </c:pt>
                  <c:pt idx="61">
                    <c:v>¨Wild</c:v>
                  </c:pt>
                  <c:pt idx="62">
                    <c:v>¡Baking</c:v>
                  </c:pt>
                  <c:pt idx="63">
                    <c:v>£Fermentation</c:v>
                  </c:pt>
                  <c:pt idx="64">
                    <c:v>¡Baking</c:v>
                  </c:pt>
                  <c:pt idx="65">
                    <c:v>¨Wild</c:v>
                  </c:pt>
                  <c:pt idx="66">
                    <c:v>£Fermentation</c:v>
                  </c:pt>
                  <c:pt idx="67">
                    <c:v>¨Wild</c:v>
                  </c:pt>
                  <c:pt idx="68">
                    <c:v>¨Wild</c:v>
                  </c:pt>
                  <c:pt idx="69">
                    <c:v>¨Wild</c:v>
                  </c:pt>
                  <c:pt idx="70">
                    <c:v>¨Wild</c:v>
                  </c:pt>
                  <c:pt idx="71">
                    <c:v>¨Wild</c:v>
                  </c:pt>
                  <c:pt idx="72">
                    <c:v>£Fermentation</c:v>
                  </c:pt>
                  <c:pt idx="73">
                    <c:v>¨Wild</c:v>
                  </c:pt>
                  <c:pt idx="74">
                    <c:v>£Fermentation</c:v>
                  </c:pt>
                  <c:pt idx="75">
                    <c:v>£Fermentation</c:v>
                  </c:pt>
                  <c:pt idx="76">
                    <c:v>¯Laboratory</c:v>
                  </c:pt>
                  <c:pt idx="77">
                    <c:v>¨Wild</c:v>
                  </c:pt>
                  <c:pt idx="78">
                    <c:v>¨Wild</c:v>
                  </c:pt>
                  <c:pt idx="79">
                    <c:v>¨Wild</c:v>
                  </c:pt>
                  <c:pt idx="80">
                    <c:v>¨Wild</c:v>
                  </c:pt>
                  <c:pt idx="81">
                    <c:v>¨Wild</c:v>
                  </c:pt>
                  <c:pt idx="82">
                    <c:v>rClinical</c:v>
                  </c:pt>
                  <c:pt idx="83">
                    <c:v>¨Wild</c:v>
                  </c:pt>
                  <c:pt idx="84">
                    <c:v>rClinical</c:v>
                  </c:pt>
                  <c:pt idx="85">
                    <c:v>rClinical</c:v>
                  </c:pt>
                  <c:pt idx="86">
                    <c:v>£Fermentation</c:v>
                  </c:pt>
                  <c:pt idx="87">
                    <c:v>rClinical</c:v>
                  </c:pt>
                  <c:pt idx="88">
                    <c:v>¨Wild</c:v>
                  </c:pt>
                </c:lvl>
                <c:lvl>
                  <c:pt idx="0">
                    <c:v>B07</c:v>
                  </c:pt>
                  <c:pt idx="1">
                    <c:v>A07</c:v>
                  </c:pt>
                  <c:pt idx="2">
                    <c:v>F10</c:v>
                  </c:pt>
                  <c:pt idx="3">
                    <c:v>F12</c:v>
                  </c:pt>
                  <c:pt idx="4">
                    <c:v>D10</c:v>
                  </c:pt>
                  <c:pt idx="5">
                    <c:v>C12</c:v>
                  </c:pt>
                  <c:pt idx="6">
                    <c:v>B11</c:v>
                  </c:pt>
                  <c:pt idx="7">
                    <c:v>G07</c:v>
                  </c:pt>
                  <c:pt idx="8">
                    <c:v>E03</c:v>
                  </c:pt>
                  <c:pt idx="9">
                    <c:v>A01</c:v>
                  </c:pt>
                  <c:pt idx="10">
                    <c:v>B10</c:v>
                  </c:pt>
                  <c:pt idx="11">
                    <c:v>A04</c:v>
                  </c:pt>
                  <c:pt idx="12">
                    <c:v>H02</c:v>
                  </c:pt>
                  <c:pt idx="13">
                    <c:v>D11</c:v>
                  </c:pt>
                  <c:pt idx="14">
                    <c:v>E01</c:v>
                  </c:pt>
                  <c:pt idx="15">
                    <c:v>E04</c:v>
                  </c:pt>
                  <c:pt idx="16">
                    <c:v>D02</c:v>
                  </c:pt>
                  <c:pt idx="17">
                    <c:v>B06</c:v>
                  </c:pt>
                  <c:pt idx="18">
                    <c:v>B08</c:v>
                  </c:pt>
                  <c:pt idx="19">
                    <c:v>F01</c:v>
                  </c:pt>
                  <c:pt idx="20">
                    <c:v>H05</c:v>
                  </c:pt>
                  <c:pt idx="21">
                    <c:v>C10</c:v>
                  </c:pt>
                  <c:pt idx="22">
                    <c:v>H11</c:v>
                  </c:pt>
                  <c:pt idx="23">
                    <c:v>C11</c:v>
                  </c:pt>
                  <c:pt idx="24">
                    <c:v>G05</c:v>
                  </c:pt>
                  <c:pt idx="25">
                    <c:v>C09</c:v>
                  </c:pt>
                  <c:pt idx="26">
                    <c:v>F11</c:v>
                  </c:pt>
                  <c:pt idx="27">
                    <c:v>C01</c:v>
                  </c:pt>
                  <c:pt idx="28">
                    <c:v>G03</c:v>
                  </c:pt>
                  <c:pt idx="29">
                    <c:v>D12</c:v>
                  </c:pt>
                  <c:pt idx="30">
                    <c:v>H03</c:v>
                  </c:pt>
                  <c:pt idx="31">
                    <c:v>E02</c:v>
                  </c:pt>
                  <c:pt idx="32">
                    <c:v>H06</c:v>
                  </c:pt>
                  <c:pt idx="33">
                    <c:v>H08</c:v>
                  </c:pt>
                  <c:pt idx="34">
                    <c:v>C03</c:v>
                  </c:pt>
                  <c:pt idx="35">
                    <c:v>E05</c:v>
                  </c:pt>
                  <c:pt idx="36">
                    <c:v>H04</c:v>
                  </c:pt>
                  <c:pt idx="37">
                    <c:v>B12</c:v>
                  </c:pt>
                  <c:pt idx="38">
                    <c:v>A10</c:v>
                  </c:pt>
                  <c:pt idx="39">
                    <c:v>D04</c:v>
                  </c:pt>
                  <c:pt idx="40">
                    <c:v>B09</c:v>
                  </c:pt>
                  <c:pt idx="41">
                    <c:v>F09</c:v>
                  </c:pt>
                  <c:pt idx="42">
                    <c:v>C08</c:v>
                  </c:pt>
                  <c:pt idx="43">
                    <c:v>H10</c:v>
                  </c:pt>
                  <c:pt idx="44">
                    <c:v>B01</c:v>
                  </c:pt>
                  <c:pt idx="45">
                    <c:v>C02</c:v>
                  </c:pt>
                  <c:pt idx="46">
                    <c:v>A02</c:v>
                  </c:pt>
                  <c:pt idx="47">
                    <c:v>H12</c:v>
                  </c:pt>
                  <c:pt idx="48">
                    <c:v>A11</c:v>
                  </c:pt>
                  <c:pt idx="49">
                    <c:v>D06</c:v>
                  </c:pt>
                  <c:pt idx="50">
                    <c:v>F06</c:v>
                  </c:pt>
                  <c:pt idx="51">
                    <c:v>D07</c:v>
                  </c:pt>
                  <c:pt idx="52">
                    <c:v>G02</c:v>
                  </c:pt>
                  <c:pt idx="53">
                    <c:v>F07</c:v>
                  </c:pt>
                  <c:pt idx="54">
                    <c:v>E12</c:v>
                  </c:pt>
                  <c:pt idx="55">
                    <c:v>H01</c:v>
                  </c:pt>
                  <c:pt idx="56">
                    <c:v>B02</c:v>
                  </c:pt>
                  <c:pt idx="57">
                    <c:v>E08</c:v>
                  </c:pt>
                  <c:pt idx="58">
                    <c:v>E07</c:v>
                  </c:pt>
                  <c:pt idx="59">
                    <c:v>C07</c:v>
                  </c:pt>
                  <c:pt idx="60">
                    <c:v>E09</c:v>
                  </c:pt>
                  <c:pt idx="61">
                    <c:v>F05</c:v>
                  </c:pt>
                  <c:pt idx="62">
                    <c:v>D05</c:v>
                  </c:pt>
                  <c:pt idx="63">
                    <c:v>C04</c:v>
                  </c:pt>
                  <c:pt idx="64">
                    <c:v>D03</c:v>
                  </c:pt>
                  <c:pt idx="65">
                    <c:v>D01</c:v>
                  </c:pt>
                  <c:pt idx="66">
                    <c:v>G01</c:v>
                  </c:pt>
                  <c:pt idx="67">
                    <c:v>A09</c:v>
                  </c:pt>
                  <c:pt idx="68">
                    <c:v>G12</c:v>
                  </c:pt>
                  <c:pt idx="69">
                    <c:v>F08</c:v>
                  </c:pt>
                  <c:pt idx="70">
                    <c:v>G06</c:v>
                  </c:pt>
                  <c:pt idx="71">
                    <c:v>H07</c:v>
                  </c:pt>
                  <c:pt idx="72">
                    <c:v>G04</c:v>
                  </c:pt>
                  <c:pt idx="73">
                    <c:v>E11</c:v>
                  </c:pt>
                  <c:pt idx="74">
                    <c:v>F04</c:v>
                  </c:pt>
                  <c:pt idx="75">
                    <c:v>F02</c:v>
                  </c:pt>
                  <c:pt idx="76">
                    <c:v>A03</c:v>
                  </c:pt>
                  <c:pt idx="77">
                    <c:v>A12</c:v>
                  </c:pt>
                  <c:pt idx="78">
                    <c:v>G08</c:v>
                  </c:pt>
                  <c:pt idx="79">
                    <c:v>D08</c:v>
                  </c:pt>
                  <c:pt idx="80">
                    <c:v>A08</c:v>
                  </c:pt>
                  <c:pt idx="81">
                    <c:v>G09</c:v>
                  </c:pt>
                  <c:pt idx="82">
                    <c:v>C05</c:v>
                  </c:pt>
                  <c:pt idx="83">
                    <c:v>G10</c:v>
                  </c:pt>
                  <c:pt idx="84">
                    <c:v>B04</c:v>
                  </c:pt>
                  <c:pt idx="85">
                    <c:v>B03</c:v>
                  </c:pt>
                  <c:pt idx="86">
                    <c:v>F03</c:v>
                  </c:pt>
                  <c:pt idx="87">
                    <c:v>B05</c:v>
                  </c:pt>
                  <c:pt idx="88">
                    <c:v>D09</c:v>
                  </c:pt>
                </c:lvl>
              </c:multiLvlStrCache>
            </c:multiLvlStrRef>
          </c:xVal>
          <c:yVal>
            <c:numRef>
              <c:f>'[Chart in Microsoft PowerPoint]ETOH-1'!$F$2:$F$90</c:f>
              <c:numCache>
                <c:formatCode>0</c:formatCode>
                <c:ptCount val="89"/>
                <c:pt idx="0">
                  <c:v>4.457742375251847</c:v>
                </c:pt>
                <c:pt idx="1">
                  <c:v>36.585365853658544</c:v>
                </c:pt>
                <c:pt idx="2">
                  <c:v>40.107500436468094</c:v>
                </c:pt>
                <c:pt idx="3">
                  <c:v>43.908044650935807</c:v>
                </c:pt>
                <c:pt idx="4">
                  <c:v>49.856242164070082</c:v>
                </c:pt>
                <c:pt idx="5">
                  <c:v>51.707317073170699</c:v>
                </c:pt>
                <c:pt idx="6">
                  <c:v>51.806494375960867</c:v>
                </c:pt>
                <c:pt idx="7">
                  <c:v>51.838994819200813</c:v>
                </c:pt>
                <c:pt idx="8">
                  <c:v>53.022526504240631</c:v>
                </c:pt>
                <c:pt idx="9">
                  <c:v>53.886010362694279</c:v>
                </c:pt>
                <c:pt idx="10">
                  <c:v>54.026048987716692</c:v>
                </c:pt>
                <c:pt idx="11">
                  <c:v>54.166666666666664</c:v>
                </c:pt>
                <c:pt idx="12">
                  <c:v>54.288864607862799</c:v>
                </c:pt>
                <c:pt idx="13">
                  <c:v>55.059488710801283</c:v>
                </c:pt>
                <c:pt idx="14">
                  <c:v>55.385933693383151</c:v>
                </c:pt>
                <c:pt idx="15">
                  <c:v>59.616834653908548</c:v>
                </c:pt>
                <c:pt idx="16">
                  <c:v>61.904761904761919</c:v>
                </c:pt>
                <c:pt idx="17">
                  <c:v>62.320048357386007</c:v>
                </c:pt>
                <c:pt idx="18">
                  <c:v>63.37086035727345</c:v>
                </c:pt>
                <c:pt idx="19">
                  <c:v>63.425925925925938</c:v>
                </c:pt>
                <c:pt idx="20">
                  <c:v>64.999999999999986</c:v>
                </c:pt>
                <c:pt idx="21">
                  <c:v>65.217391304347828</c:v>
                </c:pt>
                <c:pt idx="22">
                  <c:v>65.340909090909065</c:v>
                </c:pt>
                <c:pt idx="23">
                  <c:v>65.624999999999986</c:v>
                </c:pt>
                <c:pt idx="24">
                  <c:v>66.129032258064541</c:v>
                </c:pt>
                <c:pt idx="25">
                  <c:v>66.661055459979934</c:v>
                </c:pt>
                <c:pt idx="26">
                  <c:v>66.923076923076934</c:v>
                </c:pt>
                <c:pt idx="27">
                  <c:v>67.021276595744666</c:v>
                </c:pt>
                <c:pt idx="28">
                  <c:v>67.073170731707336</c:v>
                </c:pt>
                <c:pt idx="29">
                  <c:v>67.728570353217748</c:v>
                </c:pt>
                <c:pt idx="30">
                  <c:v>68.055555555555543</c:v>
                </c:pt>
                <c:pt idx="31">
                  <c:v>68.368339054802561</c:v>
                </c:pt>
                <c:pt idx="32">
                  <c:v>68.604651162790702</c:v>
                </c:pt>
                <c:pt idx="33">
                  <c:v>69.375000000000014</c:v>
                </c:pt>
                <c:pt idx="34">
                  <c:v>69.587628865979426</c:v>
                </c:pt>
                <c:pt idx="35">
                  <c:v>70.370370370370367</c:v>
                </c:pt>
                <c:pt idx="36">
                  <c:v>70.930232558139537</c:v>
                </c:pt>
                <c:pt idx="37">
                  <c:v>70.945945945945937</c:v>
                </c:pt>
                <c:pt idx="38">
                  <c:v>71.138057232089551</c:v>
                </c:pt>
                <c:pt idx="39">
                  <c:v>71.212121212121204</c:v>
                </c:pt>
                <c:pt idx="40">
                  <c:v>71.443968046466352</c:v>
                </c:pt>
                <c:pt idx="41">
                  <c:v>72.784810126582272</c:v>
                </c:pt>
                <c:pt idx="42">
                  <c:v>72.881355932203391</c:v>
                </c:pt>
                <c:pt idx="43">
                  <c:v>73.026315789473671</c:v>
                </c:pt>
                <c:pt idx="44">
                  <c:v>73.6111111111111</c:v>
                </c:pt>
                <c:pt idx="45">
                  <c:v>73.972602739725971</c:v>
                </c:pt>
                <c:pt idx="46">
                  <c:v>76.162790697674424</c:v>
                </c:pt>
                <c:pt idx="47">
                  <c:v>76.190476190476204</c:v>
                </c:pt>
                <c:pt idx="48">
                  <c:v>76.946107784431106</c:v>
                </c:pt>
                <c:pt idx="49">
                  <c:v>77.083333333333314</c:v>
                </c:pt>
                <c:pt idx="50">
                  <c:v>77.083333333333343</c:v>
                </c:pt>
                <c:pt idx="51">
                  <c:v>78.273765102891147</c:v>
                </c:pt>
                <c:pt idx="52">
                  <c:v>78.481012658227868</c:v>
                </c:pt>
                <c:pt idx="53">
                  <c:v>78.666666666666657</c:v>
                </c:pt>
                <c:pt idx="54">
                  <c:v>79.908350092826751</c:v>
                </c:pt>
                <c:pt idx="55">
                  <c:v>80.03559355557654</c:v>
                </c:pt>
                <c:pt idx="56">
                  <c:v>80.109641612581441</c:v>
                </c:pt>
                <c:pt idx="57">
                  <c:v>80.136986301369888</c:v>
                </c:pt>
                <c:pt idx="58">
                  <c:v>81.506849315068493</c:v>
                </c:pt>
                <c:pt idx="59">
                  <c:v>82.089552238805979</c:v>
                </c:pt>
                <c:pt idx="60">
                  <c:v>82.876712328767127</c:v>
                </c:pt>
                <c:pt idx="61">
                  <c:v>83.108108108108112</c:v>
                </c:pt>
                <c:pt idx="62">
                  <c:v>83.571428571428569</c:v>
                </c:pt>
                <c:pt idx="63">
                  <c:v>84.313725490196092</c:v>
                </c:pt>
                <c:pt idx="64">
                  <c:v>84.677419354838733</c:v>
                </c:pt>
                <c:pt idx="65">
                  <c:v>84.686898219546052</c:v>
                </c:pt>
                <c:pt idx="66">
                  <c:v>84.868421052631604</c:v>
                </c:pt>
                <c:pt idx="67">
                  <c:v>85.106004631669421</c:v>
                </c:pt>
                <c:pt idx="68">
                  <c:v>85.863069844386033</c:v>
                </c:pt>
                <c:pt idx="69">
                  <c:v>87.323943661971853</c:v>
                </c:pt>
                <c:pt idx="70">
                  <c:v>87.810945273631845</c:v>
                </c:pt>
                <c:pt idx="71">
                  <c:v>88.157894736842096</c:v>
                </c:pt>
                <c:pt idx="72">
                  <c:v>89.189189189189193</c:v>
                </c:pt>
                <c:pt idx="73">
                  <c:v>89.230769230769241</c:v>
                </c:pt>
                <c:pt idx="74">
                  <c:v>89.655172413793139</c:v>
                </c:pt>
                <c:pt idx="75">
                  <c:v>91.223404255319167</c:v>
                </c:pt>
                <c:pt idx="76">
                  <c:v>91.379310344827587</c:v>
                </c:pt>
                <c:pt idx="77">
                  <c:v>92.727272727272748</c:v>
                </c:pt>
                <c:pt idx="78">
                  <c:v>92.877598191570229</c:v>
                </c:pt>
                <c:pt idx="79">
                  <c:v>93.402777777777729</c:v>
                </c:pt>
                <c:pt idx="80">
                  <c:v>93.448633537281793</c:v>
                </c:pt>
                <c:pt idx="81">
                  <c:v>95.3125</c:v>
                </c:pt>
                <c:pt idx="82">
                  <c:v>97.169811320754761</c:v>
                </c:pt>
                <c:pt idx="83">
                  <c:v>99.058101184186214</c:v>
                </c:pt>
                <c:pt idx="84">
                  <c:v>100.40910729750756</c:v>
                </c:pt>
                <c:pt idx="85">
                  <c:v>101.04337279549955</c:v>
                </c:pt>
                <c:pt idx="86">
                  <c:v>101.40845070422537</c:v>
                </c:pt>
                <c:pt idx="87">
                  <c:v>103.71804755255721</c:v>
                </c:pt>
                <c:pt idx="88">
                  <c:v>119.5402298850574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[Chart in Microsoft PowerPoint]ETOH-1'!$M$1</c:f>
              <c:strCache>
                <c:ptCount val="1"/>
                <c:pt idx="0">
                  <c:v>15% ETOH</c:v>
                </c:pt>
              </c:strCache>
            </c:strRef>
          </c:tx>
          <c:spPr>
            <a:ln w="28575">
              <a:noFill/>
            </a:ln>
          </c:spPr>
          <c:marker>
            <c:symbol val="plus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multiLvlStrRef>
              <c:f>'[Chart in Microsoft PowerPoint]ETOH-1'!$A$2:$E$91</c:f>
              <c:multiLvlStrCache>
                <c:ptCount val="90"/>
                <c:lvl>
                  <c:pt idx="0">
                    <c:v>2.3318</c:v>
                  </c:pt>
                  <c:pt idx="1">
                    <c:v>2.3317</c:v>
                  </c:pt>
                  <c:pt idx="2">
                    <c:v>A12</c:v>
                  </c:pt>
                  <c:pt idx="3">
                    <c:v>UFRJ50816</c:v>
                  </c:pt>
                  <c:pt idx="4">
                    <c:v>LD7</c:v>
                  </c:pt>
                  <c:pt idx="5">
                    <c:v>Y9.6</c:v>
                  </c:pt>
                  <c:pt idx="6">
                    <c:v>Q59.1</c:v>
                  </c:pt>
                  <c:pt idx="7">
                    <c:v>N-43</c:v>
                  </c:pt>
                  <c:pt idx="8">
                    <c:v>UWOPS05-227.2</c:v>
                  </c:pt>
                  <c:pt idx="9">
                    <c:v>S288C</c:v>
                  </c:pt>
                  <c:pt idx="10">
                    <c:v>Q32.3</c:v>
                  </c:pt>
                  <c:pt idx="11">
                    <c:v>W303</c:v>
                  </c:pt>
                  <c:pt idx="12">
                    <c:v>ZP452</c:v>
                  </c:pt>
                  <c:pt idx="13">
                    <c:v>Q31.4</c:v>
                  </c:pt>
                  <c:pt idx="14">
                    <c:v>UWOPS03-461.4</c:v>
                  </c:pt>
                  <c:pt idx="15">
                    <c:v>K11</c:v>
                  </c:pt>
                  <c:pt idx="16">
                    <c:v>YPS128</c:v>
                  </c:pt>
                  <c:pt idx="17">
                    <c:v>273614N</c:v>
                  </c:pt>
                  <c:pt idx="18">
                    <c:v>Y7</c:v>
                  </c:pt>
                  <c:pt idx="19">
                    <c:v>DBVPG1853</c:v>
                  </c:pt>
                  <c:pt idx="20">
                    <c:v>ZP594</c:v>
                  </c:pt>
                  <c:pt idx="21">
                    <c:v>S36.7</c:v>
                  </c:pt>
                  <c:pt idx="22">
                    <c:v>UWOPS99-807.1.1</c:v>
                  </c:pt>
                  <c:pt idx="23">
                    <c:v>Z1.1</c:v>
                  </c:pt>
                  <c:pt idx="24">
                    <c:v>UWOPS83-787.3</c:v>
                  </c:pt>
                  <c:pt idx="25">
                    <c:v>Q95.3</c:v>
                  </c:pt>
                  <c:pt idx="26">
                    <c:v>UFRJ50791</c:v>
                  </c:pt>
                  <c:pt idx="27">
                    <c:v>DBVPG1788</c:v>
                  </c:pt>
                  <c:pt idx="28">
                    <c:v>UWOPS87-2421</c:v>
                  </c:pt>
                  <c:pt idx="29">
                    <c:v>Y8.5</c:v>
                  </c:pt>
                  <c:pt idx="30">
                    <c:v>IFO1815</c:v>
                  </c:pt>
                  <c:pt idx="31">
                    <c:v>UWOPS05-217.3</c:v>
                  </c:pt>
                  <c:pt idx="32">
                    <c:v>IFO1802</c:v>
                  </c:pt>
                  <c:pt idx="33">
                    <c:v>NBRC10990</c:v>
                  </c:pt>
                  <c:pt idx="34">
                    <c:v>YIIc17_E5</c:v>
                  </c:pt>
                  <c:pt idx="35">
                    <c:v>Y9</c:v>
                  </c:pt>
                  <c:pt idx="36">
                    <c:v>IFO1816</c:v>
                  </c:pt>
                  <c:pt idx="37">
                    <c:v>Q62.5</c:v>
                  </c:pt>
                  <c:pt idx="38">
                    <c:v>CBS5829</c:v>
                  </c:pt>
                  <c:pt idx="39">
                    <c:v>YS4</c:v>
                  </c:pt>
                  <c:pt idx="40">
                    <c:v>Y6.5</c:v>
                  </c:pt>
                  <c:pt idx="41">
                    <c:v>A4</c:v>
                  </c:pt>
                  <c:pt idx="42">
                    <c:v>Q89.8</c:v>
                  </c:pt>
                  <c:pt idx="43">
                    <c:v>L-1764</c:v>
                  </c:pt>
                  <c:pt idx="44">
                    <c:v>YJM978</c:v>
                  </c:pt>
                  <c:pt idx="45">
                    <c:v>DBVPG1373</c:v>
                  </c:pt>
                  <c:pt idx="46">
                    <c:v>Y55</c:v>
                  </c:pt>
                  <c:pt idx="47">
                    <c:v>CBS4309</c:v>
                  </c:pt>
                  <c:pt idx="48">
                    <c:v>DBVPG4650</c:v>
                  </c:pt>
                  <c:pt idx="49">
                    <c:v>BC187</c:v>
                  </c:pt>
                  <c:pt idx="50">
                    <c:v>NCYC361</c:v>
                  </c:pt>
                  <c:pt idx="51">
                    <c:v>GL379</c:v>
                  </c:pt>
                  <c:pt idx="52">
                    <c:v>L-1528</c:v>
                  </c:pt>
                  <c:pt idx="53">
                    <c:v>YPS138</c:v>
                  </c:pt>
                  <c:pt idx="54">
                    <c:v>KPN3829</c:v>
                  </c:pt>
                  <c:pt idx="55">
                    <c:v>YJM789</c:v>
                  </c:pt>
                  <c:pt idx="56">
                    <c:v>YJM981</c:v>
                  </c:pt>
                  <c:pt idx="57">
                    <c:v>Z1</c:v>
                  </c:pt>
                  <c:pt idx="58">
                    <c:v>RM11</c:v>
                  </c:pt>
                  <c:pt idx="59">
                    <c:v>2.3319</c:v>
                  </c:pt>
                  <c:pt idx="60">
                    <c:v>Y8.1</c:v>
                  </c:pt>
                  <c:pt idx="61">
                    <c:v>DBVPG6765</c:v>
                  </c:pt>
                  <c:pt idx="62">
                    <c:v>YS9</c:v>
                  </c:pt>
                  <c:pt idx="63">
                    <c:v>DBVPG6040</c:v>
                  </c:pt>
                  <c:pt idx="64">
                    <c:v>YS2</c:v>
                  </c:pt>
                  <c:pt idx="65">
                    <c:v>YPS606</c:v>
                  </c:pt>
                  <c:pt idx="66">
                    <c:v>L-1374</c:v>
                  </c:pt>
                  <c:pt idx="67">
                    <c:v>N-17</c:v>
                  </c:pt>
                  <c:pt idx="68">
                    <c:v>UWOPS91-917.1</c:v>
                  </c:pt>
                  <c:pt idx="69">
                    <c:v>DBVPG6304</c:v>
                  </c:pt>
                  <c:pt idx="70">
                    <c:v>ZP555</c:v>
                  </c:pt>
                  <c:pt idx="71">
                    <c:v>IFO1803</c:v>
                  </c:pt>
                  <c:pt idx="72">
                    <c:v>DBVP1106</c:v>
                  </c:pt>
                  <c:pt idx="73">
                    <c:v>KPN3828</c:v>
                  </c:pt>
                  <c:pt idx="74">
                    <c:v>DBVPG6044</c:v>
                  </c:pt>
                  <c:pt idx="75">
                    <c:v>Y12</c:v>
                  </c:pt>
                  <c:pt idx="76">
                    <c:v>SK1</c:v>
                  </c:pt>
                  <c:pt idx="77">
                    <c:v>T21.4</c:v>
                  </c:pt>
                  <c:pt idx="78">
                    <c:v>N-44</c:v>
                  </c:pt>
                  <c:pt idx="79">
                    <c:v>Q74.4</c:v>
                  </c:pt>
                  <c:pt idx="80">
                    <c:v>CBS432</c:v>
                  </c:pt>
                  <c:pt idx="81">
                    <c:v>N-45</c:v>
                  </c:pt>
                  <c:pt idx="82">
                    <c:v>322134S</c:v>
                  </c:pt>
                  <c:pt idx="83">
                    <c:v>IFO1804</c:v>
                  </c:pt>
                  <c:pt idx="84">
                    <c:v>322134S</c:v>
                  </c:pt>
                  <c:pt idx="85">
                    <c:v>YJM975</c:v>
                  </c:pt>
                  <c:pt idx="86">
                    <c:v>NCYC110</c:v>
                  </c:pt>
                  <c:pt idx="87">
                    <c:v>378604X</c:v>
                  </c:pt>
                  <c:pt idx="88">
                    <c:v>Q96.8</c:v>
                  </c:pt>
                  <c:pt idx="89">
                    <c:v>DBVPG6045</c:v>
                  </c:pt>
                </c:lvl>
                <c:lvl>
                  <c:pt idx="0">
                    <c:v>S. arboricolus</c:v>
                  </c:pt>
                  <c:pt idx="1">
                    <c:v>S. arboricolus</c:v>
                  </c:pt>
                  <c:pt idx="2">
                    <c:v>S. paradoxus</c:v>
                  </c:pt>
                  <c:pt idx="3">
                    <c:v>S. paradoxus</c:v>
                  </c:pt>
                  <c:pt idx="4">
                    <c:v>S. paradoxus</c:v>
                  </c:pt>
                  <c:pt idx="5">
                    <c:v>S. paradoxus</c:v>
                  </c:pt>
                  <c:pt idx="6">
                    <c:v>S. paradoxus</c:v>
                  </c:pt>
                  <c:pt idx="7">
                    <c:v>S. paradoxus</c:v>
                  </c:pt>
                  <c:pt idx="8">
                    <c:v>S. cerevisiae</c:v>
                  </c:pt>
                  <c:pt idx="9">
                    <c:v>S. cerevisiae</c:v>
                  </c:pt>
                  <c:pt idx="10">
                    <c:v>S. paradoxus</c:v>
                  </c:pt>
                  <c:pt idx="11">
                    <c:v>S. cerevisiae</c:v>
                  </c:pt>
                  <c:pt idx="12">
                    <c:v>S. kudriavzevii</c:v>
                  </c:pt>
                  <c:pt idx="13">
                    <c:v>S. paradoxus</c:v>
                  </c:pt>
                  <c:pt idx="14">
                    <c:v>S. cerevisiae</c:v>
                  </c:pt>
                  <c:pt idx="15">
                    <c:v>S. cerevisiae</c:v>
                  </c:pt>
                  <c:pt idx="16">
                    <c:v>S. cerevisiae</c:v>
                  </c:pt>
                  <c:pt idx="17">
                    <c:v>S. cerevisiae</c:v>
                  </c:pt>
                  <c:pt idx="18">
                    <c:v>S. paradoxus</c:v>
                  </c:pt>
                  <c:pt idx="19">
                    <c:v>S. cerevisiae</c:v>
                  </c:pt>
                  <c:pt idx="20">
                    <c:v>S. kudriavzevii</c:v>
                  </c:pt>
                  <c:pt idx="21">
                    <c:v>S. paradoxus</c:v>
                  </c:pt>
                  <c:pt idx="22">
                    <c:v>S. bayanus</c:v>
                  </c:pt>
                  <c:pt idx="23">
                    <c:v>S. paradoxus</c:v>
                  </c:pt>
                  <c:pt idx="24">
                    <c:v>S. cerevisiae</c:v>
                  </c:pt>
                  <c:pt idx="25">
                    <c:v>S. paradoxus</c:v>
                  </c:pt>
                  <c:pt idx="26">
                    <c:v>S. paradoxus</c:v>
                  </c:pt>
                  <c:pt idx="27">
                    <c:v>S. cerevisiae</c:v>
                  </c:pt>
                  <c:pt idx="28">
                    <c:v>S. cerevisiae</c:v>
                  </c:pt>
                  <c:pt idx="29">
                    <c:v>S. paradoxus</c:v>
                  </c:pt>
                  <c:pt idx="30">
                    <c:v>S. mikatae</c:v>
                  </c:pt>
                  <c:pt idx="31">
                    <c:v>S. cerevisiae</c:v>
                  </c:pt>
                  <c:pt idx="32">
                    <c:v>S. kudriavzevii</c:v>
                  </c:pt>
                  <c:pt idx="33">
                    <c:v>S. kudriavzevii</c:v>
                  </c:pt>
                  <c:pt idx="34">
                    <c:v>S. cerevisiae</c:v>
                  </c:pt>
                  <c:pt idx="35">
                    <c:v>S. cerevisiae</c:v>
                  </c:pt>
                  <c:pt idx="36">
                    <c:v>S. mikatae</c:v>
                  </c:pt>
                  <c:pt idx="37">
                    <c:v>S. paradoxus</c:v>
                  </c:pt>
                  <c:pt idx="38">
                    <c:v>S. paradoxus</c:v>
                  </c:pt>
                  <c:pt idx="39">
                    <c:v>S. cerevisiae</c:v>
                  </c:pt>
                  <c:pt idx="40">
                    <c:v>S. paradoxus</c:v>
                  </c:pt>
                  <c:pt idx="41">
                    <c:v>S. paradoxus</c:v>
                  </c:pt>
                  <c:pt idx="42">
                    <c:v>S. paradoxus</c:v>
                  </c:pt>
                  <c:pt idx="43">
                    <c:v>S. bayanus</c:v>
                  </c:pt>
                  <c:pt idx="44">
                    <c:v>S. cerevisiae</c:v>
                  </c:pt>
                  <c:pt idx="45">
                    <c:v>S. cerevisiae</c:v>
                  </c:pt>
                  <c:pt idx="46">
                    <c:v>S. cerevisiae</c:v>
                  </c:pt>
                  <c:pt idx="47">
                    <c:v>S. castelli</c:v>
                  </c:pt>
                  <c:pt idx="48">
                    <c:v>S. paradoxus</c:v>
                  </c:pt>
                  <c:pt idx="49">
                    <c:v>S. cerevisiae</c:v>
                  </c:pt>
                  <c:pt idx="50">
                    <c:v>S. cerevisiae</c:v>
                  </c:pt>
                  <c:pt idx="51">
                    <c:v>S. paradoxus</c:v>
                  </c:pt>
                  <c:pt idx="52">
                    <c:v>S. cerevisiae</c:v>
                  </c:pt>
                  <c:pt idx="53">
                    <c:v>S. paradoxus</c:v>
                  </c:pt>
                  <c:pt idx="54">
                    <c:v>S. cerevisiae</c:v>
                  </c:pt>
                  <c:pt idx="55">
                    <c:v>S. cerevisiae</c:v>
                  </c:pt>
                  <c:pt idx="56">
                    <c:v>S. cerevisiae</c:v>
                  </c:pt>
                  <c:pt idx="57">
                    <c:v>S. paradoxus</c:v>
                  </c:pt>
                  <c:pt idx="58">
                    <c:v>S. cerevisiae</c:v>
                  </c:pt>
                  <c:pt idx="59">
                    <c:v>S. arboricolus</c:v>
                  </c:pt>
                  <c:pt idx="60">
                    <c:v>S. paradoxus</c:v>
                  </c:pt>
                  <c:pt idx="61">
                    <c:v>S. cerevisiae</c:v>
                  </c:pt>
                  <c:pt idx="62">
                    <c:v>S. cerevisiae</c:v>
                  </c:pt>
                  <c:pt idx="63">
                    <c:v>S. cerevisiae</c:v>
                  </c:pt>
                  <c:pt idx="64">
                    <c:v>S. cerevisiae</c:v>
                  </c:pt>
                  <c:pt idx="65">
                    <c:v>S. cerevisiae</c:v>
                  </c:pt>
                  <c:pt idx="66">
                    <c:v>S. cerevisiae</c:v>
                  </c:pt>
                  <c:pt idx="67">
                    <c:v>S. paradoxus</c:v>
                  </c:pt>
                  <c:pt idx="68">
                    <c:v>S. paradoxus</c:v>
                  </c:pt>
                  <c:pt idx="69">
                    <c:v>S. paradoxus</c:v>
                  </c:pt>
                  <c:pt idx="70">
                    <c:v>S. bayanus</c:v>
                  </c:pt>
                  <c:pt idx="71">
                    <c:v>S. kudriavzevii</c:v>
                  </c:pt>
                  <c:pt idx="72">
                    <c:v>S. cerevisiae</c:v>
                  </c:pt>
                  <c:pt idx="73">
                    <c:v>S. cerevisiae</c:v>
                  </c:pt>
                  <c:pt idx="74">
                    <c:v>S. cerevisiae</c:v>
                  </c:pt>
                  <c:pt idx="75">
                    <c:v>S. cerevisiae</c:v>
                  </c:pt>
                  <c:pt idx="76">
                    <c:v>S. cerevisiae</c:v>
                  </c:pt>
                  <c:pt idx="77">
                    <c:v>S. paradoxus</c:v>
                  </c:pt>
                  <c:pt idx="78">
                    <c:v>S. paradoxus</c:v>
                  </c:pt>
                  <c:pt idx="79">
                    <c:v>S. paradoxus</c:v>
                  </c:pt>
                  <c:pt idx="80">
                    <c:v>S. paradoxus</c:v>
                  </c:pt>
                  <c:pt idx="81">
                    <c:v>S. paradoxus</c:v>
                  </c:pt>
                  <c:pt idx="82">
                    <c:v>S. cerevisiae</c:v>
                  </c:pt>
                  <c:pt idx="83">
                    <c:v>S. paradoxus</c:v>
                  </c:pt>
                  <c:pt idx="84">
                    <c:v>S. cerevisiae</c:v>
                  </c:pt>
                  <c:pt idx="85">
                    <c:v>S. cerevisiae</c:v>
                  </c:pt>
                  <c:pt idx="86">
                    <c:v>S. cerevisiae</c:v>
                  </c:pt>
                  <c:pt idx="87">
                    <c:v>S. cerevisiae</c:v>
                  </c:pt>
                  <c:pt idx="88">
                    <c:v>S. paradoxus</c:v>
                  </c:pt>
                  <c:pt idx="89">
                    <c:v>S. bayanus</c:v>
                  </c:pt>
                </c:lvl>
                <c:lvl>
                  <c:pt idx="0">
                    <c:v>China</c:v>
                  </c:pt>
                  <c:pt idx="1">
                    <c:v>China</c:v>
                  </c:pt>
                  <c:pt idx="2">
                    <c:v>Montreal</c:v>
                  </c:pt>
                  <c:pt idx="3">
                    <c:v>Brazil</c:v>
                  </c:pt>
                  <c:pt idx="4">
                    <c:v>England</c:v>
                  </c:pt>
                  <c:pt idx="5">
                    <c:v>England</c:v>
                  </c:pt>
                  <c:pt idx="7">
                    <c:v>Russia</c:v>
                  </c:pt>
                  <c:pt idx="8">
                    <c:v>Malasian</c:v>
                  </c:pt>
                  <c:pt idx="9">
                    <c:v>Mostly European Mosaic</c:v>
                  </c:pt>
                  <c:pt idx="11">
                    <c:v>Mostly European Mosaic</c:v>
                  </c:pt>
                  <c:pt idx="12">
                    <c:v>Portugal</c:v>
                  </c:pt>
                  <c:pt idx="13">
                    <c:v>England</c:v>
                  </c:pt>
                  <c:pt idx="14">
                    <c:v>Malasian</c:v>
                  </c:pt>
                  <c:pt idx="15">
                    <c:v>Sake</c:v>
                  </c:pt>
                  <c:pt idx="16">
                    <c:v>North American</c:v>
                  </c:pt>
                  <c:pt idx="17">
                    <c:v>Mostly European Mosaic</c:v>
                  </c:pt>
                  <c:pt idx="19">
                    <c:v>Mostly European Mosaic</c:v>
                  </c:pt>
                  <c:pt idx="20">
                    <c:v>Portugal</c:v>
                  </c:pt>
                  <c:pt idx="22">
                    <c:v>Argentina</c:v>
                  </c:pt>
                  <c:pt idx="24">
                    <c:v>Mostly North American/Malasian Mosaic</c:v>
                  </c:pt>
                  <c:pt idx="26">
                    <c:v>Brazil</c:v>
                  </c:pt>
                  <c:pt idx="27">
                    <c:v>European</c:v>
                  </c:pt>
                  <c:pt idx="28">
                    <c:v>Mostly North American/Malasian Mosaic</c:v>
                  </c:pt>
                  <c:pt idx="29">
                    <c:v>England</c:v>
                  </c:pt>
                  <c:pt idx="30">
                    <c:v>Japan</c:v>
                  </c:pt>
                  <c:pt idx="31">
                    <c:v>Malasian</c:v>
                  </c:pt>
                  <c:pt idx="32">
                    <c:v>Japan</c:v>
                  </c:pt>
                  <c:pt idx="33">
                    <c:v>Japan</c:v>
                  </c:pt>
                  <c:pt idx="34">
                    <c:v>Mostly European Mosaic</c:v>
                  </c:pt>
                  <c:pt idx="35">
                    <c:v>Sake</c:v>
                  </c:pt>
                  <c:pt idx="36">
                    <c:v>Japan</c:v>
                  </c:pt>
                  <c:pt idx="39">
                    <c:v>Mostly European Mosaic</c:v>
                  </c:pt>
                  <c:pt idx="41">
                    <c:v>Montreal</c:v>
                  </c:pt>
                  <c:pt idx="43">
                    <c:v>Chile</c:v>
                  </c:pt>
                  <c:pt idx="44">
                    <c:v>European</c:v>
                  </c:pt>
                  <c:pt idx="45">
                    <c:v>European</c:v>
                  </c:pt>
                  <c:pt idx="46">
                    <c:v>Mostly African Mosaic</c:v>
                  </c:pt>
                  <c:pt idx="47">
                    <c:v>Finland</c:v>
                  </c:pt>
                  <c:pt idx="48">
                    <c:v>Italy</c:v>
                  </c:pt>
                  <c:pt idx="49">
                    <c:v>European</c:v>
                  </c:pt>
                  <c:pt idx="50">
                    <c:v>Mostly European Mosaic</c:v>
                  </c:pt>
                  <c:pt idx="51">
                    <c:v>North America</c:v>
                  </c:pt>
                  <c:pt idx="52">
                    <c:v>Mostly European Mosaic</c:v>
                  </c:pt>
                  <c:pt idx="53">
                    <c:v>Pennsylvania</c:v>
                  </c:pt>
                  <c:pt idx="54">
                    <c:v>Siberia</c:v>
                  </c:pt>
                  <c:pt idx="55">
                    <c:v>Mostly European Mosaic</c:v>
                  </c:pt>
                  <c:pt idx="56">
                    <c:v>European</c:v>
                  </c:pt>
                  <c:pt idx="57">
                    <c:v>England</c:v>
                  </c:pt>
                  <c:pt idx="58">
                    <c:v>European</c:v>
                  </c:pt>
                  <c:pt idx="59">
                    <c:v>China</c:v>
                  </c:pt>
                  <c:pt idx="60">
                    <c:v>England</c:v>
                  </c:pt>
                  <c:pt idx="61">
                    <c:v>European</c:v>
                  </c:pt>
                  <c:pt idx="62">
                    <c:v>Mostly European Mosaic</c:v>
                  </c:pt>
                  <c:pt idx="63">
                    <c:v>Mostly European Mosaic</c:v>
                  </c:pt>
                  <c:pt idx="64">
                    <c:v>Malasian</c:v>
                  </c:pt>
                  <c:pt idx="65">
                    <c:v>North American</c:v>
                  </c:pt>
                  <c:pt idx="66">
                    <c:v>Mostly European Mosaic</c:v>
                  </c:pt>
                  <c:pt idx="68">
                    <c:v>Hawaii</c:v>
                  </c:pt>
                  <c:pt idx="69">
                    <c:v>California</c:v>
                  </c:pt>
                  <c:pt idx="70">
                    <c:v>Canada</c:v>
                  </c:pt>
                  <c:pt idx="71">
                    <c:v>Japan</c:v>
                  </c:pt>
                  <c:pt idx="72">
                    <c:v>European</c:v>
                  </c:pt>
                  <c:pt idx="73">
                    <c:v>Siberia</c:v>
                  </c:pt>
                  <c:pt idx="74">
                    <c:v>African</c:v>
                  </c:pt>
                  <c:pt idx="75">
                    <c:v>Sake</c:v>
                  </c:pt>
                  <c:pt idx="76">
                    <c:v>Mostly African Mosaic</c:v>
                  </c:pt>
                  <c:pt idx="77">
                    <c:v>England</c:v>
                  </c:pt>
                  <c:pt idx="78">
                    <c:v>Russia</c:v>
                  </c:pt>
                  <c:pt idx="79">
                    <c:v>England</c:v>
                  </c:pt>
                  <c:pt idx="80">
                    <c:v>Russia</c:v>
                  </c:pt>
                  <c:pt idx="81">
                    <c:v>Russia</c:v>
                  </c:pt>
                  <c:pt idx="82">
                    <c:v>Mostly European Mosaic</c:v>
                  </c:pt>
                  <c:pt idx="83">
                    <c:v>Japan</c:v>
                  </c:pt>
                  <c:pt idx="84">
                    <c:v>Mostly European Mosaic</c:v>
                  </c:pt>
                  <c:pt idx="85">
                    <c:v>European</c:v>
                  </c:pt>
                  <c:pt idx="86">
                    <c:v>African</c:v>
                  </c:pt>
                  <c:pt idx="87">
                    <c:v>Mostly European Mosaic</c:v>
                  </c:pt>
                  <c:pt idx="88">
                    <c:v>England</c:v>
                  </c:pt>
                  <c:pt idx="89">
                    <c:v>Netherlands</c:v>
                  </c:pt>
                </c:lvl>
                <c:lvl>
                  <c:pt idx="0">
                    <c:v>¨Wild</c:v>
                  </c:pt>
                  <c:pt idx="1">
                    <c:v>¨Wild</c:v>
                  </c:pt>
                  <c:pt idx="2">
                    <c:v>¨Wild</c:v>
                  </c:pt>
                  <c:pt idx="3">
                    <c:v>¨Wild</c:v>
                  </c:pt>
                  <c:pt idx="4">
                    <c:v>¨Wild</c:v>
                  </c:pt>
                  <c:pt idx="5">
                    <c:v>¨Wild</c:v>
                  </c:pt>
                  <c:pt idx="6">
                    <c:v>¨Wild</c:v>
                  </c:pt>
                  <c:pt idx="7">
                    <c:v>¨Wild</c:v>
                  </c:pt>
                  <c:pt idx="8">
                    <c:v>¨Wild</c:v>
                  </c:pt>
                  <c:pt idx="9">
                    <c:v>¯Laboratory</c:v>
                  </c:pt>
                  <c:pt idx="10">
                    <c:v>¨Wild</c:v>
                  </c:pt>
                  <c:pt idx="11">
                    <c:v>¯Laboratory</c:v>
                  </c:pt>
                  <c:pt idx="12">
                    <c:v>¨Wild</c:v>
                  </c:pt>
                  <c:pt idx="13">
                    <c:v>¨Wild</c:v>
                  </c:pt>
                  <c:pt idx="14">
                    <c:v>¨Wild</c:v>
                  </c:pt>
                  <c:pt idx="15">
                    <c:v>£Fermentation</c:v>
                  </c:pt>
                  <c:pt idx="16">
                    <c:v>¨Wild</c:v>
                  </c:pt>
                  <c:pt idx="17">
                    <c:v>rClinical</c:v>
                  </c:pt>
                  <c:pt idx="18">
                    <c:v>¨Wild</c:v>
                  </c:pt>
                  <c:pt idx="19">
                    <c:v>¨Wild</c:v>
                  </c:pt>
                  <c:pt idx="20">
                    <c:v>¨Wild</c:v>
                  </c:pt>
                  <c:pt idx="21">
                    <c:v>¨Wild</c:v>
                  </c:pt>
                  <c:pt idx="22">
                    <c:v>¨Wild</c:v>
                  </c:pt>
                  <c:pt idx="23">
                    <c:v>¨Wild</c:v>
                  </c:pt>
                  <c:pt idx="24">
                    <c:v>¨Wild</c:v>
                  </c:pt>
                  <c:pt idx="25">
                    <c:v>¨Wild</c:v>
                  </c:pt>
                  <c:pt idx="26">
                    <c:v>¨Wild</c:v>
                  </c:pt>
                  <c:pt idx="27">
                    <c:v>¨Wild</c:v>
                  </c:pt>
                  <c:pt idx="28">
                    <c:v>¨Wild</c:v>
                  </c:pt>
                  <c:pt idx="29">
                    <c:v>¨Wild</c:v>
                  </c:pt>
                  <c:pt idx="30">
                    <c:v>¨Wild</c:v>
                  </c:pt>
                  <c:pt idx="31">
                    <c:v>¨Wild</c:v>
                  </c:pt>
                  <c:pt idx="32">
                    <c:v>¨Wild</c:v>
                  </c:pt>
                  <c:pt idx="33">
                    <c:v>¨Wild</c:v>
                  </c:pt>
                  <c:pt idx="34">
                    <c:v>£Fermentation</c:v>
                  </c:pt>
                  <c:pt idx="35">
                    <c:v>£Fermentation</c:v>
                  </c:pt>
                  <c:pt idx="36">
                    <c:v>¨Wild</c:v>
                  </c:pt>
                  <c:pt idx="37">
                    <c:v>¨Wild</c:v>
                  </c:pt>
                  <c:pt idx="38">
                    <c:v>¨Wild</c:v>
                  </c:pt>
                  <c:pt idx="39">
                    <c:v>¡Baking</c:v>
                  </c:pt>
                  <c:pt idx="40">
                    <c:v>¨Wild</c:v>
                  </c:pt>
                  <c:pt idx="41">
                    <c:v>¨Wild</c:v>
                  </c:pt>
                  <c:pt idx="42">
                    <c:v>¨Wild</c:v>
                  </c:pt>
                  <c:pt idx="43">
                    <c:v>¨Wild</c:v>
                  </c:pt>
                  <c:pt idx="44">
                    <c:v>rClinical</c:v>
                  </c:pt>
                  <c:pt idx="45">
                    <c:v>¨Wild</c:v>
                  </c:pt>
                  <c:pt idx="46">
                    <c:v>¯Laboratory</c:v>
                  </c:pt>
                  <c:pt idx="47">
                    <c:v>¨Wild</c:v>
                  </c:pt>
                  <c:pt idx="48">
                    <c:v>¨Wild</c:v>
                  </c:pt>
                  <c:pt idx="49">
                    <c:v>£Fermentation</c:v>
                  </c:pt>
                  <c:pt idx="50">
                    <c:v>£Fermentation</c:v>
                  </c:pt>
                  <c:pt idx="51">
                    <c:v>¨Wild</c:v>
                  </c:pt>
                  <c:pt idx="52">
                    <c:v>£Fermentation</c:v>
                  </c:pt>
                  <c:pt idx="53">
                    <c:v>¨Wild</c:v>
                  </c:pt>
                  <c:pt idx="54">
                    <c:v>¨Wild</c:v>
                  </c:pt>
                  <c:pt idx="55">
                    <c:v>rClinical</c:v>
                  </c:pt>
                  <c:pt idx="56">
                    <c:v>rClinical</c:v>
                  </c:pt>
                  <c:pt idx="57">
                    <c:v>¨Wild</c:v>
                  </c:pt>
                  <c:pt idx="58">
                    <c:v>£Fermentation</c:v>
                  </c:pt>
                  <c:pt idx="59">
                    <c:v>¨Wild</c:v>
                  </c:pt>
                  <c:pt idx="60">
                    <c:v>¨Wild</c:v>
                  </c:pt>
                  <c:pt idx="61">
                    <c:v>¨Wild</c:v>
                  </c:pt>
                  <c:pt idx="62">
                    <c:v>¡Baking</c:v>
                  </c:pt>
                  <c:pt idx="63">
                    <c:v>£Fermentation</c:v>
                  </c:pt>
                  <c:pt idx="64">
                    <c:v>¡Baking</c:v>
                  </c:pt>
                  <c:pt idx="65">
                    <c:v>¨Wild</c:v>
                  </c:pt>
                  <c:pt idx="66">
                    <c:v>£Fermentation</c:v>
                  </c:pt>
                  <c:pt idx="67">
                    <c:v>¨Wild</c:v>
                  </c:pt>
                  <c:pt idx="68">
                    <c:v>¨Wild</c:v>
                  </c:pt>
                  <c:pt idx="69">
                    <c:v>¨Wild</c:v>
                  </c:pt>
                  <c:pt idx="70">
                    <c:v>¨Wild</c:v>
                  </c:pt>
                  <c:pt idx="71">
                    <c:v>¨Wild</c:v>
                  </c:pt>
                  <c:pt idx="72">
                    <c:v>£Fermentation</c:v>
                  </c:pt>
                  <c:pt idx="73">
                    <c:v>¨Wild</c:v>
                  </c:pt>
                  <c:pt idx="74">
                    <c:v>£Fermentation</c:v>
                  </c:pt>
                  <c:pt idx="75">
                    <c:v>£Fermentation</c:v>
                  </c:pt>
                  <c:pt idx="76">
                    <c:v>¯Laboratory</c:v>
                  </c:pt>
                  <c:pt idx="77">
                    <c:v>¨Wild</c:v>
                  </c:pt>
                  <c:pt idx="78">
                    <c:v>¨Wild</c:v>
                  </c:pt>
                  <c:pt idx="79">
                    <c:v>¨Wild</c:v>
                  </c:pt>
                  <c:pt idx="80">
                    <c:v>¨Wild</c:v>
                  </c:pt>
                  <c:pt idx="81">
                    <c:v>¨Wild</c:v>
                  </c:pt>
                  <c:pt idx="82">
                    <c:v>rClinical</c:v>
                  </c:pt>
                  <c:pt idx="83">
                    <c:v>¨Wild</c:v>
                  </c:pt>
                  <c:pt idx="84">
                    <c:v>rClinical</c:v>
                  </c:pt>
                  <c:pt idx="85">
                    <c:v>rClinical</c:v>
                  </c:pt>
                  <c:pt idx="86">
                    <c:v>£Fermentation</c:v>
                  </c:pt>
                  <c:pt idx="87">
                    <c:v>rClinical</c:v>
                  </c:pt>
                  <c:pt idx="88">
                    <c:v>¨Wild</c:v>
                  </c:pt>
                  <c:pt idx="89">
                    <c:v>¨Wild</c:v>
                  </c:pt>
                </c:lvl>
                <c:lvl>
                  <c:pt idx="0">
                    <c:v>B07</c:v>
                  </c:pt>
                  <c:pt idx="1">
                    <c:v>A07</c:v>
                  </c:pt>
                  <c:pt idx="2">
                    <c:v>F10</c:v>
                  </c:pt>
                  <c:pt idx="3">
                    <c:v>F12</c:v>
                  </c:pt>
                  <c:pt idx="4">
                    <c:v>D10</c:v>
                  </c:pt>
                  <c:pt idx="5">
                    <c:v>C12</c:v>
                  </c:pt>
                  <c:pt idx="6">
                    <c:v>B11</c:v>
                  </c:pt>
                  <c:pt idx="7">
                    <c:v>G07</c:v>
                  </c:pt>
                  <c:pt idx="8">
                    <c:v>E03</c:v>
                  </c:pt>
                  <c:pt idx="9">
                    <c:v>A01</c:v>
                  </c:pt>
                  <c:pt idx="10">
                    <c:v>B10</c:v>
                  </c:pt>
                  <c:pt idx="11">
                    <c:v>A04</c:v>
                  </c:pt>
                  <c:pt idx="12">
                    <c:v>H02</c:v>
                  </c:pt>
                  <c:pt idx="13">
                    <c:v>D11</c:v>
                  </c:pt>
                  <c:pt idx="14">
                    <c:v>E01</c:v>
                  </c:pt>
                  <c:pt idx="15">
                    <c:v>E04</c:v>
                  </c:pt>
                  <c:pt idx="16">
                    <c:v>D02</c:v>
                  </c:pt>
                  <c:pt idx="17">
                    <c:v>B06</c:v>
                  </c:pt>
                  <c:pt idx="18">
                    <c:v>B08</c:v>
                  </c:pt>
                  <c:pt idx="19">
                    <c:v>F01</c:v>
                  </c:pt>
                  <c:pt idx="20">
                    <c:v>H05</c:v>
                  </c:pt>
                  <c:pt idx="21">
                    <c:v>C10</c:v>
                  </c:pt>
                  <c:pt idx="22">
                    <c:v>H11</c:v>
                  </c:pt>
                  <c:pt idx="23">
                    <c:v>C11</c:v>
                  </c:pt>
                  <c:pt idx="24">
                    <c:v>G05</c:v>
                  </c:pt>
                  <c:pt idx="25">
                    <c:v>C09</c:v>
                  </c:pt>
                  <c:pt idx="26">
                    <c:v>F11</c:v>
                  </c:pt>
                  <c:pt idx="27">
                    <c:v>C01</c:v>
                  </c:pt>
                  <c:pt idx="28">
                    <c:v>G03</c:v>
                  </c:pt>
                  <c:pt idx="29">
                    <c:v>D12</c:v>
                  </c:pt>
                  <c:pt idx="30">
                    <c:v>H03</c:v>
                  </c:pt>
                  <c:pt idx="31">
                    <c:v>E02</c:v>
                  </c:pt>
                  <c:pt idx="32">
                    <c:v>H06</c:v>
                  </c:pt>
                  <c:pt idx="33">
                    <c:v>H08</c:v>
                  </c:pt>
                  <c:pt idx="34">
                    <c:v>C03</c:v>
                  </c:pt>
                  <c:pt idx="35">
                    <c:v>E05</c:v>
                  </c:pt>
                  <c:pt idx="36">
                    <c:v>H04</c:v>
                  </c:pt>
                  <c:pt idx="37">
                    <c:v>B12</c:v>
                  </c:pt>
                  <c:pt idx="38">
                    <c:v>A10</c:v>
                  </c:pt>
                  <c:pt idx="39">
                    <c:v>D04</c:v>
                  </c:pt>
                  <c:pt idx="40">
                    <c:v>B09</c:v>
                  </c:pt>
                  <c:pt idx="41">
                    <c:v>F09</c:v>
                  </c:pt>
                  <c:pt idx="42">
                    <c:v>C08</c:v>
                  </c:pt>
                  <c:pt idx="43">
                    <c:v>H10</c:v>
                  </c:pt>
                  <c:pt idx="44">
                    <c:v>B01</c:v>
                  </c:pt>
                  <c:pt idx="45">
                    <c:v>C02</c:v>
                  </c:pt>
                  <c:pt idx="46">
                    <c:v>A02</c:v>
                  </c:pt>
                  <c:pt idx="47">
                    <c:v>H12</c:v>
                  </c:pt>
                  <c:pt idx="48">
                    <c:v>A11</c:v>
                  </c:pt>
                  <c:pt idx="49">
                    <c:v>D06</c:v>
                  </c:pt>
                  <c:pt idx="50">
                    <c:v>F06</c:v>
                  </c:pt>
                  <c:pt idx="51">
                    <c:v>D07</c:v>
                  </c:pt>
                  <c:pt idx="52">
                    <c:v>G02</c:v>
                  </c:pt>
                  <c:pt idx="53">
                    <c:v>F07</c:v>
                  </c:pt>
                  <c:pt idx="54">
                    <c:v>E12</c:v>
                  </c:pt>
                  <c:pt idx="55">
                    <c:v>H01</c:v>
                  </c:pt>
                  <c:pt idx="56">
                    <c:v>B02</c:v>
                  </c:pt>
                  <c:pt idx="57">
                    <c:v>E08</c:v>
                  </c:pt>
                  <c:pt idx="58">
                    <c:v>E07</c:v>
                  </c:pt>
                  <c:pt idx="59">
                    <c:v>C07</c:v>
                  </c:pt>
                  <c:pt idx="60">
                    <c:v>E09</c:v>
                  </c:pt>
                  <c:pt idx="61">
                    <c:v>F05</c:v>
                  </c:pt>
                  <c:pt idx="62">
                    <c:v>D05</c:v>
                  </c:pt>
                  <c:pt idx="63">
                    <c:v>C04</c:v>
                  </c:pt>
                  <c:pt idx="64">
                    <c:v>D03</c:v>
                  </c:pt>
                  <c:pt idx="65">
                    <c:v>D01</c:v>
                  </c:pt>
                  <c:pt idx="66">
                    <c:v>G01</c:v>
                  </c:pt>
                  <c:pt idx="67">
                    <c:v>A09</c:v>
                  </c:pt>
                  <c:pt idx="68">
                    <c:v>G12</c:v>
                  </c:pt>
                  <c:pt idx="69">
                    <c:v>F08</c:v>
                  </c:pt>
                  <c:pt idx="70">
                    <c:v>G06</c:v>
                  </c:pt>
                  <c:pt idx="71">
                    <c:v>H07</c:v>
                  </c:pt>
                  <c:pt idx="72">
                    <c:v>G04</c:v>
                  </c:pt>
                  <c:pt idx="73">
                    <c:v>E11</c:v>
                  </c:pt>
                  <c:pt idx="74">
                    <c:v>F04</c:v>
                  </c:pt>
                  <c:pt idx="75">
                    <c:v>F02</c:v>
                  </c:pt>
                  <c:pt idx="76">
                    <c:v>A03</c:v>
                  </c:pt>
                  <c:pt idx="77">
                    <c:v>A12</c:v>
                  </c:pt>
                  <c:pt idx="78">
                    <c:v>G08</c:v>
                  </c:pt>
                  <c:pt idx="79">
                    <c:v>D08</c:v>
                  </c:pt>
                  <c:pt idx="80">
                    <c:v>A08</c:v>
                  </c:pt>
                  <c:pt idx="81">
                    <c:v>G09</c:v>
                  </c:pt>
                  <c:pt idx="82">
                    <c:v>C05</c:v>
                  </c:pt>
                  <c:pt idx="83">
                    <c:v>G10</c:v>
                  </c:pt>
                  <c:pt idx="84">
                    <c:v>B04</c:v>
                  </c:pt>
                  <c:pt idx="85">
                    <c:v>B03</c:v>
                  </c:pt>
                  <c:pt idx="86">
                    <c:v>F03</c:v>
                  </c:pt>
                  <c:pt idx="87">
                    <c:v>B05</c:v>
                  </c:pt>
                  <c:pt idx="88">
                    <c:v>D09</c:v>
                  </c:pt>
                  <c:pt idx="89">
                    <c:v>H09</c:v>
                  </c:pt>
                </c:lvl>
              </c:multiLvlStrCache>
            </c:multiLvlStrRef>
          </c:xVal>
          <c:yVal>
            <c:numRef>
              <c:f>'[Chart in Microsoft PowerPoint]ETOH-1'!$M$2:$M$91</c:f>
              <c:numCache>
                <c:formatCode>0</c:formatCode>
                <c:ptCount val="90"/>
                <c:pt idx="0">
                  <c:v>2.2288711876259235</c:v>
                </c:pt>
                <c:pt idx="1">
                  <c:v>5.3783386208507462</c:v>
                </c:pt>
                <c:pt idx="2">
                  <c:v>12.430772333456932</c:v>
                </c:pt>
                <c:pt idx="3">
                  <c:v>17.073170731707325</c:v>
                </c:pt>
                <c:pt idx="4">
                  <c:v>18.301658515924473</c:v>
                </c:pt>
                <c:pt idx="5">
                  <c:v>20.348837209302324</c:v>
                </c:pt>
                <c:pt idx="6">
                  <c:v>23.500080235712115</c:v>
                </c:pt>
                <c:pt idx="7">
                  <c:v>23.84615384615384</c:v>
                </c:pt>
                <c:pt idx="8">
                  <c:v>24.725621504571162</c:v>
                </c:pt>
                <c:pt idx="9">
                  <c:v>25.100986965086712</c:v>
                </c:pt>
                <c:pt idx="10">
                  <c:v>26.744186046511636</c:v>
                </c:pt>
                <c:pt idx="11">
                  <c:v>27.185586157682433</c:v>
                </c:pt>
                <c:pt idx="12">
                  <c:v>28.225461077670765</c:v>
                </c:pt>
                <c:pt idx="13">
                  <c:v>30.263157894736832</c:v>
                </c:pt>
                <c:pt idx="14">
                  <c:v>32.367456492588303</c:v>
                </c:pt>
                <c:pt idx="15">
                  <c:v>32.387934535765453</c:v>
                </c:pt>
                <c:pt idx="16">
                  <c:v>32.894736842105274</c:v>
                </c:pt>
                <c:pt idx="17">
                  <c:v>33.13953488372092</c:v>
                </c:pt>
                <c:pt idx="18">
                  <c:v>33.333333333333343</c:v>
                </c:pt>
                <c:pt idx="19">
                  <c:v>33.582089552238806</c:v>
                </c:pt>
                <c:pt idx="20">
                  <c:v>33.864285176608881</c:v>
                </c:pt>
                <c:pt idx="21">
                  <c:v>34.571766131482782</c:v>
                </c:pt>
                <c:pt idx="22">
                  <c:v>34.720433069310737</c:v>
                </c:pt>
                <c:pt idx="23">
                  <c:v>35.616438356164387</c:v>
                </c:pt>
                <c:pt idx="24">
                  <c:v>36.875</c:v>
                </c:pt>
                <c:pt idx="25">
                  <c:v>38.157894736842117</c:v>
                </c:pt>
                <c:pt idx="26">
                  <c:v>38.793103448275836</c:v>
                </c:pt>
                <c:pt idx="27">
                  <c:v>39.686801435868233</c:v>
                </c:pt>
                <c:pt idx="28">
                  <c:v>39.726027397260289</c:v>
                </c:pt>
                <c:pt idx="29">
                  <c:v>39.864864864864863</c:v>
                </c:pt>
                <c:pt idx="30">
                  <c:v>39.893617021276597</c:v>
                </c:pt>
                <c:pt idx="31">
                  <c:v>41.274208826744271</c:v>
                </c:pt>
                <c:pt idx="32">
                  <c:v>42.372881355932215</c:v>
                </c:pt>
                <c:pt idx="33">
                  <c:v>42.490942061854078</c:v>
                </c:pt>
                <c:pt idx="34">
                  <c:v>42.613636363636374</c:v>
                </c:pt>
                <c:pt idx="35">
                  <c:v>42.857142857142875</c:v>
                </c:pt>
                <c:pt idx="36">
                  <c:v>43.055555555555564</c:v>
                </c:pt>
                <c:pt idx="37">
                  <c:v>44.531249999999979</c:v>
                </c:pt>
                <c:pt idx="38">
                  <c:v>45.161290322580641</c:v>
                </c:pt>
                <c:pt idx="39">
                  <c:v>45.312499999999986</c:v>
                </c:pt>
                <c:pt idx="40">
                  <c:v>45.84905333194979</c:v>
                </c:pt>
                <c:pt idx="41">
                  <c:v>46.053828371079788</c:v>
                </c:pt>
                <c:pt idx="42">
                  <c:v>46.908494862763277</c:v>
                </c:pt>
                <c:pt idx="43">
                  <c:v>47.826086956521742</c:v>
                </c:pt>
                <c:pt idx="44">
                  <c:v>53.378378378378379</c:v>
                </c:pt>
                <c:pt idx="45">
                  <c:v>54.861111111111086</c:v>
                </c:pt>
                <c:pt idx="46">
                  <c:v>55.000000000000007</c:v>
                </c:pt>
                <c:pt idx="47">
                  <c:v>55.357142857142868</c:v>
                </c:pt>
                <c:pt idx="48">
                  <c:v>55.913978494623649</c:v>
                </c:pt>
                <c:pt idx="49">
                  <c:v>57.338313545283491</c:v>
                </c:pt>
                <c:pt idx="50">
                  <c:v>57.499999999999993</c:v>
                </c:pt>
                <c:pt idx="51">
                  <c:v>58.490566037735867</c:v>
                </c:pt>
                <c:pt idx="52">
                  <c:v>59.146341463414629</c:v>
                </c:pt>
                <c:pt idx="53">
                  <c:v>59.730873132187931</c:v>
                </c:pt>
                <c:pt idx="54">
                  <c:v>59.999999999999986</c:v>
                </c:pt>
                <c:pt idx="55">
                  <c:v>60.126582278481024</c:v>
                </c:pt>
                <c:pt idx="56">
                  <c:v>60.2172561037195</c:v>
                </c:pt>
                <c:pt idx="57">
                  <c:v>60.62176165803109</c:v>
                </c:pt>
                <c:pt idx="58">
                  <c:v>61.580767579012843</c:v>
                </c:pt>
                <c:pt idx="59">
                  <c:v>63.636363636363633</c:v>
                </c:pt>
                <c:pt idx="60">
                  <c:v>64.81481481481481</c:v>
                </c:pt>
                <c:pt idx="61">
                  <c:v>66.455696202531641</c:v>
                </c:pt>
                <c:pt idx="62">
                  <c:v>66.6666666666667</c:v>
                </c:pt>
                <c:pt idx="63">
                  <c:v>67.281409713578441</c:v>
                </c:pt>
                <c:pt idx="64">
                  <c:v>69.161676646706567</c:v>
                </c:pt>
                <c:pt idx="65">
                  <c:v>69.863013698630112</c:v>
                </c:pt>
                <c:pt idx="66">
                  <c:v>70.452259930807031</c:v>
                </c:pt>
                <c:pt idx="67">
                  <c:v>71.206127423160353</c:v>
                </c:pt>
                <c:pt idx="68">
                  <c:v>71.707317073170742</c:v>
                </c:pt>
                <c:pt idx="69">
                  <c:v>72.054879293932657</c:v>
                </c:pt>
                <c:pt idx="70">
                  <c:v>73.636363636363654</c:v>
                </c:pt>
                <c:pt idx="71">
                  <c:v>73.943661971831006</c:v>
                </c:pt>
                <c:pt idx="72">
                  <c:v>74.615384615384627</c:v>
                </c:pt>
                <c:pt idx="73">
                  <c:v>75</c:v>
                </c:pt>
                <c:pt idx="74">
                  <c:v>75.342465753424634</c:v>
                </c:pt>
                <c:pt idx="75">
                  <c:v>76.333093240835993</c:v>
                </c:pt>
                <c:pt idx="76">
                  <c:v>78.169014084507054</c:v>
                </c:pt>
                <c:pt idx="77">
                  <c:v>79.054054054054063</c:v>
                </c:pt>
                <c:pt idx="78">
                  <c:v>79.166666666666657</c:v>
                </c:pt>
                <c:pt idx="79">
                  <c:v>81.944444444444457</c:v>
                </c:pt>
                <c:pt idx="80">
                  <c:v>85.294117647058826</c:v>
                </c:pt>
                <c:pt idx="81">
                  <c:v>88.059701492537329</c:v>
                </c:pt>
                <c:pt idx="82">
                  <c:v>90.753291608487558</c:v>
                </c:pt>
                <c:pt idx="83">
                  <c:v>91.237113402061894</c:v>
                </c:pt>
                <c:pt idx="84">
                  <c:v>94.192570468678767</c:v>
                </c:pt>
                <c:pt idx="85">
                  <c:v>97.290640394088669</c:v>
                </c:pt>
                <c:pt idx="86">
                  <c:v>98.936170212765958</c:v>
                </c:pt>
                <c:pt idx="87">
                  <c:v>99.384524569981934</c:v>
                </c:pt>
                <c:pt idx="88">
                  <c:v>103.12500000000004</c:v>
                </c:pt>
                <c:pt idx="89">
                  <c:v>106.0344827586207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2921728"/>
        <c:axId val="82922304"/>
      </c:scatterChart>
      <c:valAx>
        <c:axId val="829217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Strains </a:t>
                </a:r>
              </a:p>
            </c:rich>
          </c:tx>
          <c:layout>
            <c:manualLayout>
              <c:xMode val="edge"/>
              <c:yMode val="edge"/>
              <c:x val="0.45069268632579762"/>
              <c:y val="0.89581895441285553"/>
            </c:manualLayout>
          </c:layout>
          <c:overlay val="0"/>
        </c:title>
        <c:majorTickMark val="out"/>
        <c:minorTickMark val="none"/>
        <c:tickLblPos val="nextTo"/>
        <c:crossAx val="82922304"/>
        <c:crosses val="autoZero"/>
        <c:crossBetween val="midCat"/>
      </c:valAx>
      <c:valAx>
        <c:axId val="82922304"/>
        <c:scaling>
          <c:orientation val="minMax"/>
          <c:max val="120"/>
        </c:scaling>
        <c:delete val="0"/>
        <c:axPos val="l"/>
        <c:numFmt formatCode="0" sourceLinked="1"/>
        <c:majorTickMark val="out"/>
        <c:minorTickMark val="none"/>
        <c:tickLblPos val="nextTo"/>
        <c:crossAx val="82921728"/>
        <c:crosses val="autoZero"/>
        <c:crossBetween val="midCat"/>
      </c:valAx>
    </c:plotArea>
    <c:legend>
      <c:legendPos val="t"/>
      <c:layout>
        <c:manualLayout>
          <c:xMode val="edge"/>
          <c:yMode val="edge"/>
          <c:x val="0.23635364044517929"/>
          <c:y val="1.2599985514977282E-2"/>
          <c:w val="0.40676526137618702"/>
          <c:h val="0.13135865213887235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474779768602984"/>
          <c:y val="3.0833756579181481E-2"/>
          <c:w val="0.65411716305839873"/>
          <c:h val="0.77543340914016934"/>
        </c:manualLayout>
      </c:layout>
      <c:scatterChart>
        <c:scatterStyle val="lineMarker"/>
        <c:varyColors val="0"/>
        <c:ser>
          <c:idx val="3"/>
          <c:order val="0"/>
          <c:tx>
            <c:strRef>
              <c:f>'TEMP-1'!$F$1</c:f>
              <c:strCache>
                <c:ptCount val="1"/>
                <c:pt idx="0">
                  <c:v>35'C</c:v>
                </c:pt>
              </c:strCache>
            </c:strRef>
          </c:tx>
          <c:spPr>
            <a:ln w="28575">
              <a:noFill/>
            </a:ln>
          </c:spPr>
          <c:marker>
            <c:symbol val="plus"/>
            <c:size val="5"/>
            <c:spPr>
              <a:ln>
                <a:solidFill>
                  <a:schemeClr val="tx1"/>
                </a:solidFill>
              </a:ln>
            </c:spPr>
          </c:marker>
          <c:xVal>
            <c:multiLvlStrRef>
              <c:f>'[Final Analysis 30 May- New data.xlsx]TEMP-1'!$A$2:$C$89</c:f>
              <c:multiLvlStrCache>
                <c:ptCount val="88"/>
                <c:lvl>
                  <c:pt idx="0">
                    <c:v>Mostly European Mosaic</c:v>
                  </c:pt>
                  <c:pt idx="1">
                    <c:v>Mostly North American/Malasian Mosaic</c:v>
                  </c:pt>
                  <c:pt idx="2">
                    <c:v>Malasian</c:v>
                  </c:pt>
                  <c:pt idx="3">
                    <c:v>Sake</c:v>
                  </c:pt>
                  <c:pt idx="6">
                    <c:v>Mostly European Mosaic</c:v>
                  </c:pt>
                  <c:pt idx="7">
                    <c:v>England</c:v>
                  </c:pt>
                  <c:pt idx="8">
                    <c:v>Malasian</c:v>
                  </c:pt>
                  <c:pt idx="9">
                    <c:v>England</c:v>
                  </c:pt>
                  <c:pt idx="10">
                    <c:v>North American</c:v>
                  </c:pt>
                  <c:pt idx="11">
                    <c:v>Portugal</c:v>
                  </c:pt>
                  <c:pt idx="12">
                    <c:v>Brazil</c:v>
                  </c:pt>
                  <c:pt idx="13">
                    <c:v>European</c:v>
                  </c:pt>
                  <c:pt idx="14">
                    <c:v>California</c:v>
                  </c:pt>
                  <c:pt idx="15">
                    <c:v>Mostly European Mosaic</c:v>
                  </c:pt>
                  <c:pt idx="16">
                    <c:v>North America</c:v>
                  </c:pt>
                  <c:pt idx="17">
                    <c:v>England</c:v>
                  </c:pt>
                  <c:pt idx="18">
                    <c:v>Mostly European Mosaic</c:v>
                  </c:pt>
                  <c:pt idx="20">
                    <c:v>Siberia</c:v>
                  </c:pt>
                  <c:pt idx="21">
                    <c:v>Japan</c:v>
                  </c:pt>
                  <c:pt idx="22">
                    <c:v>Sake</c:v>
                  </c:pt>
                  <c:pt idx="23">
                    <c:v>Montreal</c:v>
                  </c:pt>
                  <c:pt idx="24">
                    <c:v>Sake</c:v>
                  </c:pt>
                  <c:pt idx="25">
                    <c:v>Pennsylvania</c:v>
                  </c:pt>
                  <c:pt idx="26">
                    <c:v>Chile</c:v>
                  </c:pt>
                  <c:pt idx="28">
                    <c:v>Mostly European Mosaic</c:v>
                  </c:pt>
                  <c:pt idx="29">
                    <c:v>Mostly European Mosaic</c:v>
                  </c:pt>
                  <c:pt idx="30">
                    <c:v>Portugal</c:v>
                  </c:pt>
                  <c:pt idx="32">
                    <c:v>Russia</c:v>
                  </c:pt>
                  <c:pt idx="34">
                    <c:v>China</c:v>
                  </c:pt>
                  <c:pt idx="35">
                    <c:v>Malasian</c:v>
                  </c:pt>
                  <c:pt idx="36">
                    <c:v>Mostly European Mosaic</c:v>
                  </c:pt>
                  <c:pt idx="37">
                    <c:v>Mostly North American/Malasian Mosaic</c:v>
                  </c:pt>
                  <c:pt idx="38">
                    <c:v>Japan</c:v>
                  </c:pt>
                  <c:pt idx="40">
                    <c:v>Siberia</c:v>
                  </c:pt>
                  <c:pt idx="41">
                    <c:v>England</c:v>
                  </c:pt>
                  <c:pt idx="42">
                    <c:v>African</c:v>
                  </c:pt>
                  <c:pt idx="43">
                    <c:v>European</c:v>
                  </c:pt>
                  <c:pt idx="44">
                    <c:v>England</c:v>
                  </c:pt>
                  <c:pt idx="45">
                    <c:v>European</c:v>
                  </c:pt>
                  <c:pt idx="46">
                    <c:v>Russia</c:v>
                  </c:pt>
                  <c:pt idx="48">
                    <c:v>Japan</c:v>
                  </c:pt>
                  <c:pt idx="49">
                    <c:v>Mostly African Mosaic</c:v>
                  </c:pt>
                  <c:pt idx="50">
                    <c:v>Mostly European Mosaic</c:v>
                  </c:pt>
                  <c:pt idx="51">
                    <c:v>European</c:v>
                  </c:pt>
                  <c:pt idx="52">
                    <c:v>Brazil</c:v>
                  </c:pt>
                  <c:pt idx="53">
                    <c:v>England</c:v>
                  </c:pt>
                  <c:pt idx="55">
                    <c:v>African</c:v>
                  </c:pt>
                  <c:pt idx="56">
                    <c:v>Russia</c:v>
                  </c:pt>
                  <c:pt idx="57">
                    <c:v>European</c:v>
                  </c:pt>
                  <c:pt idx="58">
                    <c:v>Mostly European Mosaic</c:v>
                  </c:pt>
                  <c:pt idx="59">
                    <c:v>Montreal</c:v>
                  </c:pt>
                  <c:pt idx="60">
                    <c:v>Canada</c:v>
                  </c:pt>
                  <c:pt idx="61">
                    <c:v>Japan</c:v>
                  </c:pt>
                  <c:pt idx="62">
                    <c:v>Mostly European Mosaic</c:v>
                  </c:pt>
                  <c:pt idx="63">
                    <c:v>Mostly African Mosaic</c:v>
                  </c:pt>
                  <c:pt idx="64">
                    <c:v>England</c:v>
                  </c:pt>
                  <c:pt idx="65">
                    <c:v>European</c:v>
                  </c:pt>
                  <c:pt idx="67">
                    <c:v>China</c:v>
                  </c:pt>
                  <c:pt idx="68">
                    <c:v>European</c:v>
                  </c:pt>
                  <c:pt idx="69">
                    <c:v>Hawaii</c:v>
                  </c:pt>
                  <c:pt idx="70">
                    <c:v>Mostly European Mosaic</c:v>
                  </c:pt>
                  <c:pt idx="71">
                    <c:v>Malasian</c:v>
                  </c:pt>
                  <c:pt idx="72">
                    <c:v>North American</c:v>
                  </c:pt>
                  <c:pt idx="73">
                    <c:v>Mostly European Mosaic</c:v>
                  </c:pt>
                  <c:pt idx="74">
                    <c:v>Italy</c:v>
                  </c:pt>
                  <c:pt idx="76">
                    <c:v>England</c:v>
                  </c:pt>
                  <c:pt idx="77">
                    <c:v>European</c:v>
                  </c:pt>
                  <c:pt idx="78">
                    <c:v>Japan</c:v>
                  </c:pt>
                  <c:pt idx="79">
                    <c:v>Mostly European Mosaic</c:v>
                  </c:pt>
                  <c:pt idx="80">
                    <c:v>England</c:v>
                  </c:pt>
                  <c:pt idx="81">
                    <c:v>Mostly European Mosaic</c:v>
                  </c:pt>
                  <c:pt idx="82">
                    <c:v>Japan</c:v>
                  </c:pt>
                  <c:pt idx="83">
                    <c:v>China</c:v>
                  </c:pt>
                  <c:pt idx="84">
                    <c:v>Mostly European Mosaic</c:v>
                  </c:pt>
                  <c:pt idx="85">
                    <c:v>Russia</c:v>
                  </c:pt>
                  <c:pt idx="86">
                    <c:v>Argentina</c:v>
                  </c:pt>
                  <c:pt idx="87">
                    <c:v>Finland</c:v>
                  </c:pt>
                </c:lvl>
                <c:lvl>
                  <c:pt idx="0">
                    <c:v>¨Wild</c:v>
                  </c:pt>
                  <c:pt idx="1">
                    <c:v>¨Wild</c:v>
                  </c:pt>
                  <c:pt idx="2">
                    <c:v>¨Wild</c:v>
                  </c:pt>
                  <c:pt idx="3">
                    <c:v>£Fermentation</c:v>
                  </c:pt>
                  <c:pt idx="4">
                    <c:v>¨Wild</c:v>
                  </c:pt>
                  <c:pt idx="5">
                    <c:v>¨Wild</c:v>
                  </c:pt>
                  <c:pt idx="6">
                    <c:v>£Fermentation</c:v>
                  </c:pt>
                  <c:pt idx="7">
                    <c:v>¨Wild</c:v>
                  </c:pt>
                  <c:pt idx="8">
                    <c:v>¨Wild</c:v>
                  </c:pt>
                  <c:pt idx="9">
                    <c:v>¨Wild</c:v>
                  </c:pt>
                  <c:pt idx="10">
                    <c:v>¨Wild</c:v>
                  </c:pt>
                  <c:pt idx="11">
                    <c:v>¨Wild</c:v>
                  </c:pt>
                  <c:pt idx="12">
                    <c:v>¨Wild</c:v>
                  </c:pt>
                  <c:pt idx="13">
                    <c:v>£Fermentation</c:v>
                  </c:pt>
                  <c:pt idx="14">
                    <c:v>¨Wild</c:v>
                  </c:pt>
                  <c:pt idx="15">
                    <c:v>¡Baking</c:v>
                  </c:pt>
                  <c:pt idx="16">
                    <c:v>¨Wild</c:v>
                  </c:pt>
                  <c:pt idx="17">
                    <c:v>¨Wild</c:v>
                  </c:pt>
                  <c:pt idx="18">
                    <c:v>£Fermentation</c:v>
                  </c:pt>
                  <c:pt idx="19">
                    <c:v>¨Wild</c:v>
                  </c:pt>
                  <c:pt idx="20">
                    <c:v>¨Wild</c:v>
                  </c:pt>
                  <c:pt idx="21">
                    <c:v>¨Wild</c:v>
                  </c:pt>
                  <c:pt idx="22">
                    <c:v>£Fermentation</c:v>
                  </c:pt>
                  <c:pt idx="23">
                    <c:v>¨Wild</c:v>
                  </c:pt>
                  <c:pt idx="24">
                    <c:v>£Fermentation</c:v>
                  </c:pt>
                  <c:pt idx="25">
                    <c:v>¨Wild</c:v>
                  </c:pt>
                  <c:pt idx="26">
                    <c:v>¨Wild</c:v>
                  </c:pt>
                  <c:pt idx="27">
                    <c:v>¨Wild</c:v>
                  </c:pt>
                  <c:pt idx="28">
                    <c:v>rClinical</c:v>
                  </c:pt>
                  <c:pt idx="29">
                    <c:v>£Fermentation</c:v>
                  </c:pt>
                  <c:pt idx="30">
                    <c:v>¨Wild</c:v>
                  </c:pt>
                  <c:pt idx="31">
                    <c:v>¨Wild</c:v>
                  </c:pt>
                  <c:pt idx="32">
                    <c:v>¨Wild</c:v>
                  </c:pt>
                  <c:pt idx="33">
                    <c:v>¨Wild</c:v>
                  </c:pt>
                  <c:pt idx="34">
                    <c:v>¨Wild</c:v>
                  </c:pt>
                  <c:pt idx="35">
                    <c:v>¨Wild</c:v>
                  </c:pt>
                  <c:pt idx="36">
                    <c:v>¡Baking</c:v>
                  </c:pt>
                  <c:pt idx="37">
                    <c:v>¨Wild</c:v>
                  </c:pt>
                  <c:pt idx="38">
                    <c:v>¨Wild</c:v>
                  </c:pt>
                  <c:pt idx="39">
                    <c:v>¨Wild</c:v>
                  </c:pt>
                  <c:pt idx="40">
                    <c:v>¨Wild</c:v>
                  </c:pt>
                  <c:pt idx="41">
                    <c:v>¨Wild</c:v>
                  </c:pt>
                  <c:pt idx="42">
                    <c:v>£Fermentation</c:v>
                  </c:pt>
                  <c:pt idx="43">
                    <c:v>£Fermentation</c:v>
                  </c:pt>
                  <c:pt idx="44">
                    <c:v>¨Wild</c:v>
                  </c:pt>
                  <c:pt idx="45">
                    <c:v>rClinical</c:v>
                  </c:pt>
                  <c:pt idx="46">
                    <c:v>¨Wild</c:v>
                  </c:pt>
                  <c:pt idx="47">
                    <c:v>¨Wild</c:v>
                  </c:pt>
                  <c:pt idx="48">
                    <c:v>¨Wild</c:v>
                  </c:pt>
                  <c:pt idx="49">
                    <c:v>¯Laboratory</c:v>
                  </c:pt>
                  <c:pt idx="50">
                    <c:v>¯Laboratory</c:v>
                  </c:pt>
                  <c:pt idx="51">
                    <c:v>¨Wild</c:v>
                  </c:pt>
                  <c:pt idx="52">
                    <c:v>¨Wild</c:v>
                  </c:pt>
                  <c:pt idx="53">
                    <c:v>¨Wild</c:v>
                  </c:pt>
                  <c:pt idx="54">
                    <c:v>¨Wild</c:v>
                  </c:pt>
                  <c:pt idx="55">
                    <c:v>£Fermentation</c:v>
                  </c:pt>
                  <c:pt idx="56">
                    <c:v>¨Wild</c:v>
                  </c:pt>
                  <c:pt idx="57">
                    <c:v>¨Wild</c:v>
                  </c:pt>
                  <c:pt idx="58">
                    <c:v>rClinical</c:v>
                  </c:pt>
                  <c:pt idx="59">
                    <c:v>¨Wild</c:v>
                  </c:pt>
                  <c:pt idx="60">
                    <c:v>¨Wild</c:v>
                  </c:pt>
                  <c:pt idx="61">
                    <c:v>¨Wild</c:v>
                  </c:pt>
                  <c:pt idx="62">
                    <c:v>¯Laboratory</c:v>
                  </c:pt>
                  <c:pt idx="63">
                    <c:v>¯Laboratory</c:v>
                  </c:pt>
                  <c:pt idx="64">
                    <c:v>¨Wild</c:v>
                  </c:pt>
                  <c:pt idx="65">
                    <c:v>rClinical</c:v>
                  </c:pt>
                  <c:pt idx="66">
                    <c:v>¨Wild</c:v>
                  </c:pt>
                  <c:pt idx="67">
                    <c:v>¨Wild</c:v>
                  </c:pt>
                  <c:pt idx="68">
                    <c:v>£Fermentation</c:v>
                  </c:pt>
                  <c:pt idx="69">
                    <c:v>¨Wild</c:v>
                  </c:pt>
                  <c:pt idx="70">
                    <c:v>rClinical</c:v>
                  </c:pt>
                  <c:pt idx="71">
                    <c:v>¡Baking</c:v>
                  </c:pt>
                  <c:pt idx="72">
                    <c:v>¨Wild</c:v>
                  </c:pt>
                  <c:pt idx="73">
                    <c:v>£Fermentation</c:v>
                  </c:pt>
                  <c:pt idx="74">
                    <c:v>¨Wild</c:v>
                  </c:pt>
                  <c:pt idx="75">
                    <c:v>¨Wild</c:v>
                  </c:pt>
                  <c:pt idx="76">
                    <c:v>¨Wild</c:v>
                  </c:pt>
                  <c:pt idx="77">
                    <c:v>¨Wild</c:v>
                  </c:pt>
                  <c:pt idx="78">
                    <c:v>¨Wild</c:v>
                  </c:pt>
                  <c:pt idx="79">
                    <c:v>£Fermentation</c:v>
                  </c:pt>
                  <c:pt idx="80">
                    <c:v>¨Wild</c:v>
                  </c:pt>
                  <c:pt idx="81">
                    <c:v>rClinical</c:v>
                  </c:pt>
                  <c:pt idx="82">
                    <c:v>¨Wild</c:v>
                  </c:pt>
                  <c:pt idx="83">
                    <c:v>¨Wild</c:v>
                  </c:pt>
                  <c:pt idx="84">
                    <c:v>rClinical</c:v>
                  </c:pt>
                  <c:pt idx="85">
                    <c:v>¨Wild</c:v>
                  </c:pt>
                  <c:pt idx="86">
                    <c:v>¨Wild</c:v>
                  </c:pt>
                  <c:pt idx="87">
                    <c:v>¨Wild</c:v>
                  </c:pt>
                </c:lvl>
                <c:lvl>
                  <c:pt idx="0">
                    <c:v>F01</c:v>
                  </c:pt>
                  <c:pt idx="1">
                    <c:v>G05</c:v>
                  </c:pt>
                  <c:pt idx="2">
                    <c:v>E01</c:v>
                  </c:pt>
                  <c:pt idx="3">
                    <c:v>E05</c:v>
                  </c:pt>
                  <c:pt idx="4">
                    <c:v>B08</c:v>
                  </c:pt>
                  <c:pt idx="5">
                    <c:v>B10</c:v>
                  </c:pt>
                  <c:pt idx="6">
                    <c:v>G02</c:v>
                  </c:pt>
                  <c:pt idx="7">
                    <c:v>D11</c:v>
                  </c:pt>
                  <c:pt idx="8">
                    <c:v>E03</c:v>
                  </c:pt>
                  <c:pt idx="9">
                    <c:v>D10</c:v>
                  </c:pt>
                  <c:pt idx="10">
                    <c:v>D02</c:v>
                  </c:pt>
                  <c:pt idx="11">
                    <c:v>H02</c:v>
                  </c:pt>
                  <c:pt idx="12">
                    <c:v>F12</c:v>
                  </c:pt>
                  <c:pt idx="13">
                    <c:v>E07</c:v>
                  </c:pt>
                  <c:pt idx="14">
                    <c:v>F08</c:v>
                  </c:pt>
                  <c:pt idx="15">
                    <c:v>D05</c:v>
                  </c:pt>
                  <c:pt idx="16">
                    <c:v>D07</c:v>
                  </c:pt>
                  <c:pt idx="17">
                    <c:v>E09</c:v>
                  </c:pt>
                  <c:pt idx="18">
                    <c:v>F06</c:v>
                  </c:pt>
                  <c:pt idx="19">
                    <c:v>C11</c:v>
                  </c:pt>
                  <c:pt idx="20">
                    <c:v>E11</c:v>
                  </c:pt>
                  <c:pt idx="21">
                    <c:v>H08</c:v>
                  </c:pt>
                  <c:pt idx="22">
                    <c:v>E04</c:v>
                  </c:pt>
                  <c:pt idx="23">
                    <c:v>F09</c:v>
                  </c:pt>
                  <c:pt idx="24">
                    <c:v>F02</c:v>
                  </c:pt>
                  <c:pt idx="25">
                    <c:v>F07</c:v>
                  </c:pt>
                  <c:pt idx="26">
                    <c:v>H10</c:v>
                  </c:pt>
                  <c:pt idx="27">
                    <c:v>C10</c:v>
                  </c:pt>
                  <c:pt idx="28">
                    <c:v>B06</c:v>
                  </c:pt>
                  <c:pt idx="29">
                    <c:v>G01</c:v>
                  </c:pt>
                  <c:pt idx="30">
                    <c:v>H05</c:v>
                  </c:pt>
                  <c:pt idx="31">
                    <c:v>A10</c:v>
                  </c:pt>
                  <c:pt idx="32">
                    <c:v>G07</c:v>
                  </c:pt>
                  <c:pt idx="33">
                    <c:v>B11</c:v>
                  </c:pt>
                  <c:pt idx="34">
                    <c:v>B07</c:v>
                  </c:pt>
                  <c:pt idx="35">
                    <c:v>E02</c:v>
                  </c:pt>
                  <c:pt idx="36">
                    <c:v>D04</c:v>
                  </c:pt>
                  <c:pt idx="37">
                    <c:v>G03</c:v>
                  </c:pt>
                  <c:pt idx="38">
                    <c:v>H06</c:v>
                  </c:pt>
                  <c:pt idx="39">
                    <c:v>B09</c:v>
                  </c:pt>
                  <c:pt idx="40">
                    <c:v>E12</c:v>
                  </c:pt>
                  <c:pt idx="41">
                    <c:v>D12</c:v>
                  </c:pt>
                  <c:pt idx="42">
                    <c:v>F03</c:v>
                  </c:pt>
                  <c:pt idx="43">
                    <c:v>D06</c:v>
                  </c:pt>
                  <c:pt idx="44">
                    <c:v>E08</c:v>
                  </c:pt>
                  <c:pt idx="45">
                    <c:v>B02</c:v>
                  </c:pt>
                  <c:pt idx="46">
                    <c:v>A08</c:v>
                  </c:pt>
                  <c:pt idx="47">
                    <c:v>C09</c:v>
                  </c:pt>
                  <c:pt idx="48">
                    <c:v>H04</c:v>
                  </c:pt>
                  <c:pt idx="49">
                    <c:v>A02</c:v>
                  </c:pt>
                  <c:pt idx="50">
                    <c:v>A04</c:v>
                  </c:pt>
                  <c:pt idx="51">
                    <c:v>F05</c:v>
                  </c:pt>
                  <c:pt idx="52">
                    <c:v>F11</c:v>
                  </c:pt>
                  <c:pt idx="53">
                    <c:v>C12</c:v>
                  </c:pt>
                  <c:pt idx="54">
                    <c:v>B12</c:v>
                  </c:pt>
                  <c:pt idx="55">
                    <c:v>F04</c:v>
                  </c:pt>
                  <c:pt idx="56">
                    <c:v>G08</c:v>
                  </c:pt>
                  <c:pt idx="57">
                    <c:v>C01</c:v>
                  </c:pt>
                  <c:pt idx="58">
                    <c:v>H01</c:v>
                  </c:pt>
                  <c:pt idx="59">
                    <c:v>F10</c:v>
                  </c:pt>
                  <c:pt idx="60">
                    <c:v>G06</c:v>
                  </c:pt>
                  <c:pt idx="61">
                    <c:v>H03</c:v>
                  </c:pt>
                  <c:pt idx="62">
                    <c:v>A01</c:v>
                  </c:pt>
                  <c:pt idx="63">
                    <c:v>A03</c:v>
                  </c:pt>
                  <c:pt idx="64">
                    <c:v>D08</c:v>
                  </c:pt>
                  <c:pt idx="65">
                    <c:v>B01</c:v>
                  </c:pt>
                  <c:pt idx="66">
                    <c:v>A09</c:v>
                  </c:pt>
                  <c:pt idx="67">
                    <c:v>C07</c:v>
                  </c:pt>
                  <c:pt idx="68">
                    <c:v>G04</c:v>
                  </c:pt>
                  <c:pt idx="69">
                    <c:v>G12</c:v>
                  </c:pt>
                  <c:pt idx="70">
                    <c:v>B04</c:v>
                  </c:pt>
                  <c:pt idx="71">
                    <c:v>D03</c:v>
                  </c:pt>
                  <c:pt idx="72">
                    <c:v>D01</c:v>
                  </c:pt>
                  <c:pt idx="73">
                    <c:v>C03</c:v>
                  </c:pt>
                  <c:pt idx="74">
                    <c:v>A11</c:v>
                  </c:pt>
                  <c:pt idx="75">
                    <c:v>C08</c:v>
                  </c:pt>
                  <c:pt idx="76">
                    <c:v>A12</c:v>
                  </c:pt>
                  <c:pt idx="77">
                    <c:v>C02</c:v>
                  </c:pt>
                  <c:pt idx="78">
                    <c:v>H07</c:v>
                  </c:pt>
                  <c:pt idx="79">
                    <c:v>C04</c:v>
                  </c:pt>
                  <c:pt idx="80">
                    <c:v>D09</c:v>
                  </c:pt>
                  <c:pt idx="81">
                    <c:v>B05</c:v>
                  </c:pt>
                  <c:pt idx="82">
                    <c:v>G10</c:v>
                  </c:pt>
                  <c:pt idx="83">
                    <c:v>A07</c:v>
                  </c:pt>
                  <c:pt idx="84">
                    <c:v>C05</c:v>
                  </c:pt>
                  <c:pt idx="85">
                    <c:v>G09</c:v>
                  </c:pt>
                  <c:pt idx="86">
                    <c:v>H11</c:v>
                  </c:pt>
                  <c:pt idx="87">
                    <c:v>H12</c:v>
                  </c:pt>
                </c:lvl>
              </c:multiLvlStrCache>
            </c:multiLvlStrRef>
          </c:xVal>
          <c:yVal>
            <c:numRef>
              <c:f>'TEMP-1'!$F$2:$F$89</c:f>
              <c:numCache>
                <c:formatCode>0</c:formatCode>
                <c:ptCount val="88"/>
                <c:pt idx="0">
                  <c:v>56.481481481481474</c:v>
                </c:pt>
                <c:pt idx="1">
                  <c:v>56.98924731182796</c:v>
                </c:pt>
                <c:pt idx="2">
                  <c:v>61.037559580463075</c:v>
                </c:pt>
                <c:pt idx="3">
                  <c:v>61.728395061728378</c:v>
                </c:pt>
                <c:pt idx="4">
                  <c:v>62.730750656694958</c:v>
                </c:pt>
                <c:pt idx="5">
                  <c:v>63.58818155191431</c:v>
                </c:pt>
                <c:pt idx="6">
                  <c:v>65.189873417721543</c:v>
                </c:pt>
                <c:pt idx="7">
                  <c:v>66.71914514367684</c:v>
                </c:pt>
                <c:pt idx="8">
                  <c:v>67.202969639095684</c:v>
                </c:pt>
                <c:pt idx="9">
                  <c:v>68.157900679994569</c:v>
                </c:pt>
                <c:pt idx="10">
                  <c:v>70.238095238095227</c:v>
                </c:pt>
                <c:pt idx="11">
                  <c:v>70.951783447899871</c:v>
                </c:pt>
                <c:pt idx="12">
                  <c:v>71.118663871234034</c:v>
                </c:pt>
                <c:pt idx="13">
                  <c:v>71.232876712328746</c:v>
                </c:pt>
                <c:pt idx="14">
                  <c:v>71.83098591549296</c:v>
                </c:pt>
                <c:pt idx="15">
                  <c:v>72.142857142857125</c:v>
                </c:pt>
                <c:pt idx="16">
                  <c:v>72.451749516725656</c:v>
                </c:pt>
                <c:pt idx="17">
                  <c:v>72.602739726027394</c:v>
                </c:pt>
                <c:pt idx="18">
                  <c:v>74.305555555555571</c:v>
                </c:pt>
                <c:pt idx="19">
                  <c:v>74.999999999999986</c:v>
                </c:pt>
                <c:pt idx="20">
                  <c:v>75.384615384615401</c:v>
                </c:pt>
                <c:pt idx="21">
                  <c:v>75.625</c:v>
                </c:pt>
                <c:pt idx="22">
                  <c:v>75.914962113250482</c:v>
                </c:pt>
                <c:pt idx="23">
                  <c:v>77.848101265822777</c:v>
                </c:pt>
                <c:pt idx="24">
                  <c:v>78.989361702127667</c:v>
                </c:pt>
                <c:pt idx="25">
                  <c:v>80.666666666666671</c:v>
                </c:pt>
                <c:pt idx="26">
                  <c:v>80.921052631578931</c:v>
                </c:pt>
                <c:pt idx="27">
                  <c:v>81.159420289855063</c:v>
                </c:pt>
                <c:pt idx="28">
                  <c:v>81.44097228522034</c:v>
                </c:pt>
                <c:pt idx="29">
                  <c:v>82.894736842105274</c:v>
                </c:pt>
                <c:pt idx="30">
                  <c:v>84.375000000000028</c:v>
                </c:pt>
                <c:pt idx="31">
                  <c:v>84.434890359582894</c:v>
                </c:pt>
                <c:pt idx="32">
                  <c:v>84.579412599748679</c:v>
                </c:pt>
                <c:pt idx="33">
                  <c:v>84.634372000332121</c:v>
                </c:pt>
                <c:pt idx="34">
                  <c:v>85.811540723598128</c:v>
                </c:pt>
                <c:pt idx="35">
                  <c:v>86.558080638190376</c:v>
                </c:pt>
                <c:pt idx="36">
                  <c:v>87.121212121212139</c:v>
                </c:pt>
                <c:pt idx="37">
                  <c:v>87.195121951219519</c:v>
                </c:pt>
                <c:pt idx="38">
                  <c:v>87.209302325581405</c:v>
                </c:pt>
                <c:pt idx="39">
                  <c:v>87.468783309225145</c:v>
                </c:pt>
                <c:pt idx="40">
                  <c:v>88.423174283045981</c:v>
                </c:pt>
                <c:pt idx="41">
                  <c:v>88.461806175631338</c:v>
                </c:pt>
                <c:pt idx="42">
                  <c:v>88.73239436619717</c:v>
                </c:pt>
                <c:pt idx="43">
                  <c:v>90.277777777777743</c:v>
                </c:pt>
                <c:pt idx="44">
                  <c:v>91.09589041095893</c:v>
                </c:pt>
                <c:pt idx="45">
                  <c:v>92.758532393515367</c:v>
                </c:pt>
                <c:pt idx="46">
                  <c:v>93.448633537281808</c:v>
                </c:pt>
                <c:pt idx="47">
                  <c:v>94.688999232926037</c:v>
                </c:pt>
                <c:pt idx="48">
                  <c:v>96.511627906976756</c:v>
                </c:pt>
                <c:pt idx="49">
                  <c:v>98.255813953488371</c:v>
                </c:pt>
                <c:pt idx="50">
                  <c:v>100.00000000000003</c:v>
                </c:pt>
                <c:pt idx="51">
                  <c:v>100.67567567567571</c:v>
                </c:pt>
                <c:pt idx="52">
                  <c:v>100.76923076923077</c:v>
                </c:pt>
                <c:pt idx="53">
                  <c:v>102.68292682926831</c:v>
                </c:pt>
                <c:pt idx="54">
                  <c:v>102.70270270270269</c:v>
                </c:pt>
                <c:pt idx="55">
                  <c:v>103.44827586206897</c:v>
                </c:pt>
                <c:pt idx="56">
                  <c:v>105.31003259516625</c:v>
                </c:pt>
                <c:pt idx="57">
                  <c:v>106.38297872340425</c:v>
                </c:pt>
                <c:pt idx="58">
                  <c:v>106.71412474076871</c:v>
                </c:pt>
                <c:pt idx="59">
                  <c:v>107.18788128342642</c:v>
                </c:pt>
                <c:pt idx="60">
                  <c:v>107.46268656716418</c:v>
                </c:pt>
                <c:pt idx="61">
                  <c:v>107.63888888888889</c:v>
                </c:pt>
                <c:pt idx="62">
                  <c:v>108.29015544041454</c:v>
                </c:pt>
                <c:pt idx="63">
                  <c:v>109.48275862068965</c:v>
                </c:pt>
                <c:pt idx="64">
                  <c:v>111.45833333333334</c:v>
                </c:pt>
                <c:pt idx="65">
                  <c:v>111.80555555555556</c:v>
                </c:pt>
                <c:pt idx="66">
                  <c:v>114.16659157906875</c:v>
                </c:pt>
                <c:pt idx="67">
                  <c:v>114.1791044776119</c:v>
                </c:pt>
                <c:pt idx="68">
                  <c:v>114.18918918918921</c:v>
                </c:pt>
                <c:pt idx="69">
                  <c:v>116.30543097103201</c:v>
                </c:pt>
                <c:pt idx="70">
                  <c:v>118.85159639296812</c:v>
                </c:pt>
                <c:pt idx="71">
                  <c:v>120.16129032258067</c:v>
                </c:pt>
                <c:pt idx="72">
                  <c:v>124.14984058715766</c:v>
                </c:pt>
                <c:pt idx="73">
                  <c:v>126.03092783505163</c:v>
                </c:pt>
                <c:pt idx="74">
                  <c:v>127.54491017964065</c:v>
                </c:pt>
                <c:pt idx="75">
                  <c:v>129.66101694915255</c:v>
                </c:pt>
                <c:pt idx="76">
                  <c:v>130.90909090909096</c:v>
                </c:pt>
                <c:pt idx="77">
                  <c:v>131.50684931506845</c:v>
                </c:pt>
                <c:pt idx="78">
                  <c:v>131.57894736842104</c:v>
                </c:pt>
                <c:pt idx="79">
                  <c:v>132.35294117647058</c:v>
                </c:pt>
                <c:pt idx="80">
                  <c:v>136.7816091954023</c:v>
                </c:pt>
                <c:pt idx="81">
                  <c:v>139.15504713301425</c:v>
                </c:pt>
                <c:pt idx="82">
                  <c:v>142.80876254053513</c:v>
                </c:pt>
                <c:pt idx="83">
                  <c:v>150.40650406504074</c:v>
                </c:pt>
                <c:pt idx="84">
                  <c:v>150.9433962264151</c:v>
                </c:pt>
                <c:pt idx="85">
                  <c:v>151.56249999999994</c:v>
                </c:pt>
                <c:pt idx="86">
                  <c:v>172.8896103896104</c:v>
                </c:pt>
                <c:pt idx="87">
                  <c:v>176.19047619047618</c:v>
                </c:pt>
              </c:numCache>
            </c:numRef>
          </c:yVal>
          <c:smooth val="0"/>
        </c:ser>
        <c:ser>
          <c:idx val="4"/>
          <c:order val="1"/>
          <c:tx>
            <c:strRef>
              <c:f>'TEMP-1'!$M$1</c:f>
              <c:strCache>
                <c:ptCount val="1"/>
                <c:pt idx="0">
                  <c:v>40'C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multiLvlStrRef>
              <c:f>'[Final Analysis 30 May- New data.xlsx]TEMP-1'!$A$2:$C$91</c:f>
              <c:multiLvlStrCache>
                <c:ptCount val="90"/>
                <c:lvl>
                  <c:pt idx="0">
                    <c:v>Mostly European Mosaic</c:v>
                  </c:pt>
                  <c:pt idx="1">
                    <c:v>Mostly North American/Malasian Mosaic</c:v>
                  </c:pt>
                  <c:pt idx="2">
                    <c:v>Malasian</c:v>
                  </c:pt>
                  <c:pt idx="3">
                    <c:v>Sake</c:v>
                  </c:pt>
                  <c:pt idx="6">
                    <c:v>Mostly European Mosaic</c:v>
                  </c:pt>
                  <c:pt idx="7">
                    <c:v>England</c:v>
                  </c:pt>
                  <c:pt idx="8">
                    <c:v>Malasian</c:v>
                  </c:pt>
                  <c:pt idx="9">
                    <c:v>England</c:v>
                  </c:pt>
                  <c:pt idx="10">
                    <c:v>North American</c:v>
                  </c:pt>
                  <c:pt idx="11">
                    <c:v>Portugal</c:v>
                  </c:pt>
                  <c:pt idx="12">
                    <c:v>Brazil</c:v>
                  </c:pt>
                  <c:pt idx="13">
                    <c:v>European</c:v>
                  </c:pt>
                  <c:pt idx="14">
                    <c:v>California</c:v>
                  </c:pt>
                  <c:pt idx="15">
                    <c:v>Mostly European Mosaic</c:v>
                  </c:pt>
                  <c:pt idx="16">
                    <c:v>North America</c:v>
                  </c:pt>
                  <c:pt idx="17">
                    <c:v>England</c:v>
                  </c:pt>
                  <c:pt idx="18">
                    <c:v>Mostly European Mosaic</c:v>
                  </c:pt>
                  <c:pt idx="20">
                    <c:v>Siberia</c:v>
                  </c:pt>
                  <c:pt idx="21">
                    <c:v>Japan</c:v>
                  </c:pt>
                  <c:pt idx="22">
                    <c:v>Sake</c:v>
                  </c:pt>
                  <c:pt idx="23">
                    <c:v>Montreal</c:v>
                  </c:pt>
                  <c:pt idx="24">
                    <c:v>Sake</c:v>
                  </c:pt>
                  <c:pt idx="25">
                    <c:v>Pennsylvania</c:v>
                  </c:pt>
                  <c:pt idx="26">
                    <c:v>Chile</c:v>
                  </c:pt>
                  <c:pt idx="28">
                    <c:v>Mostly European Mosaic</c:v>
                  </c:pt>
                  <c:pt idx="29">
                    <c:v>Mostly European Mosaic</c:v>
                  </c:pt>
                  <c:pt idx="30">
                    <c:v>Portugal</c:v>
                  </c:pt>
                  <c:pt idx="32">
                    <c:v>Russia</c:v>
                  </c:pt>
                  <c:pt idx="34">
                    <c:v>China</c:v>
                  </c:pt>
                  <c:pt idx="35">
                    <c:v>Malasian</c:v>
                  </c:pt>
                  <c:pt idx="36">
                    <c:v>Mostly European Mosaic</c:v>
                  </c:pt>
                  <c:pt idx="37">
                    <c:v>Mostly North American/Malasian Mosaic</c:v>
                  </c:pt>
                  <c:pt idx="38">
                    <c:v>Japan</c:v>
                  </c:pt>
                  <c:pt idx="40">
                    <c:v>Siberia</c:v>
                  </c:pt>
                  <c:pt idx="41">
                    <c:v>England</c:v>
                  </c:pt>
                  <c:pt idx="42">
                    <c:v>African</c:v>
                  </c:pt>
                  <c:pt idx="43">
                    <c:v>European</c:v>
                  </c:pt>
                  <c:pt idx="44">
                    <c:v>England</c:v>
                  </c:pt>
                  <c:pt idx="45">
                    <c:v>European</c:v>
                  </c:pt>
                  <c:pt idx="46">
                    <c:v>Russia</c:v>
                  </c:pt>
                  <c:pt idx="48">
                    <c:v>Japan</c:v>
                  </c:pt>
                  <c:pt idx="49">
                    <c:v>Mostly African Mosaic</c:v>
                  </c:pt>
                  <c:pt idx="50">
                    <c:v>Mostly European Mosaic</c:v>
                  </c:pt>
                  <c:pt idx="51">
                    <c:v>European</c:v>
                  </c:pt>
                  <c:pt idx="52">
                    <c:v>Brazil</c:v>
                  </c:pt>
                  <c:pt idx="53">
                    <c:v>England</c:v>
                  </c:pt>
                  <c:pt idx="55">
                    <c:v>African</c:v>
                  </c:pt>
                  <c:pt idx="56">
                    <c:v>Russia</c:v>
                  </c:pt>
                  <c:pt idx="57">
                    <c:v>European</c:v>
                  </c:pt>
                  <c:pt idx="58">
                    <c:v>Mostly European Mosaic</c:v>
                  </c:pt>
                  <c:pt idx="59">
                    <c:v>Montreal</c:v>
                  </c:pt>
                  <c:pt idx="60">
                    <c:v>Canada</c:v>
                  </c:pt>
                  <c:pt idx="61">
                    <c:v>Japan</c:v>
                  </c:pt>
                  <c:pt idx="62">
                    <c:v>Mostly European Mosaic</c:v>
                  </c:pt>
                  <c:pt idx="63">
                    <c:v>Mostly African Mosaic</c:v>
                  </c:pt>
                  <c:pt idx="64">
                    <c:v>England</c:v>
                  </c:pt>
                  <c:pt idx="65">
                    <c:v>European</c:v>
                  </c:pt>
                  <c:pt idx="67">
                    <c:v>China</c:v>
                  </c:pt>
                  <c:pt idx="68">
                    <c:v>European</c:v>
                  </c:pt>
                  <c:pt idx="69">
                    <c:v>Hawaii</c:v>
                  </c:pt>
                  <c:pt idx="70">
                    <c:v>Mostly European Mosaic</c:v>
                  </c:pt>
                  <c:pt idx="71">
                    <c:v>Malasian</c:v>
                  </c:pt>
                  <c:pt idx="72">
                    <c:v>North American</c:v>
                  </c:pt>
                  <c:pt idx="73">
                    <c:v>Mostly European Mosaic</c:v>
                  </c:pt>
                  <c:pt idx="74">
                    <c:v>Italy</c:v>
                  </c:pt>
                  <c:pt idx="76">
                    <c:v>England</c:v>
                  </c:pt>
                  <c:pt idx="77">
                    <c:v>European</c:v>
                  </c:pt>
                  <c:pt idx="78">
                    <c:v>Japan</c:v>
                  </c:pt>
                  <c:pt idx="79">
                    <c:v>Mostly European Mosaic</c:v>
                  </c:pt>
                  <c:pt idx="80">
                    <c:v>England</c:v>
                  </c:pt>
                  <c:pt idx="81">
                    <c:v>Mostly European Mosaic</c:v>
                  </c:pt>
                  <c:pt idx="82">
                    <c:v>Japan</c:v>
                  </c:pt>
                  <c:pt idx="83">
                    <c:v>China</c:v>
                  </c:pt>
                  <c:pt idx="84">
                    <c:v>Mostly European Mosaic</c:v>
                  </c:pt>
                  <c:pt idx="85">
                    <c:v>Russia</c:v>
                  </c:pt>
                  <c:pt idx="86">
                    <c:v>Argentina</c:v>
                  </c:pt>
                  <c:pt idx="87">
                    <c:v>Finland</c:v>
                  </c:pt>
                  <c:pt idx="88">
                    <c:v>European</c:v>
                  </c:pt>
                  <c:pt idx="89">
                    <c:v>Netherlands</c:v>
                  </c:pt>
                </c:lvl>
                <c:lvl>
                  <c:pt idx="0">
                    <c:v>¨Wild</c:v>
                  </c:pt>
                  <c:pt idx="1">
                    <c:v>¨Wild</c:v>
                  </c:pt>
                  <c:pt idx="2">
                    <c:v>¨Wild</c:v>
                  </c:pt>
                  <c:pt idx="3">
                    <c:v>£Fermentation</c:v>
                  </c:pt>
                  <c:pt idx="4">
                    <c:v>¨Wild</c:v>
                  </c:pt>
                  <c:pt idx="5">
                    <c:v>¨Wild</c:v>
                  </c:pt>
                  <c:pt idx="6">
                    <c:v>£Fermentation</c:v>
                  </c:pt>
                  <c:pt idx="7">
                    <c:v>¨Wild</c:v>
                  </c:pt>
                  <c:pt idx="8">
                    <c:v>¨Wild</c:v>
                  </c:pt>
                  <c:pt idx="9">
                    <c:v>¨Wild</c:v>
                  </c:pt>
                  <c:pt idx="10">
                    <c:v>¨Wild</c:v>
                  </c:pt>
                  <c:pt idx="11">
                    <c:v>¨Wild</c:v>
                  </c:pt>
                  <c:pt idx="12">
                    <c:v>¨Wild</c:v>
                  </c:pt>
                  <c:pt idx="13">
                    <c:v>£Fermentation</c:v>
                  </c:pt>
                  <c:pt idx="14">
                    <c:v>¨Wild</c:v>
                  </c:pt>
                  <c:pt idx="15">
                    <c:v>¡Baking</c:v>
                  </c:pt>
                  <c:pt idx="16">
                    <c:v>¨Wild</c:v>
                  </c:pt>
                  <c:pt idx="17">
                    <c:v>¨Wild</c:v>
                  </c:pt>
                  <c:pt idx="18">
                    <c:v>£Fermentation</c:v>
                  </c:pt>
                  <c:pt idx="19">
                    <c:v>¨Wild</c:v>
                  </c:pt>
                  <c:pt idx="20">
                    <c:v>¨Wild</c:v>
                  </c:pt>
                  <c:pt idx="21">
                    <c:v>¨Wild</c:v>
                  </c:pt>
                  <c:pt idx="22">
                    <c:v>£Fermentation</c:v>
                  </c:pt>
                  <c:pt idx="23">
                    <c:v>¨Wild</c:v>
                  </c:pt>
                  <c:pt idx="24">
                    <c:v>£Fermentation</c:v>
                  </c:pt>
                  <c:pt idx="25">
                    <c:v>¨Wild</c:v>
                  </c:pt>
                  <c:pt idx="26">
                    <c:v>¨Wild</c:v>
                  </c:pt>
                  <c:pt idx="27">
                    <c:v>¨Wild</c:v>
                  </c:pt>
                  <c:pt idx="28">
                    <c:v>rClinical</c:v>
                  </c:pt>
                  <c:pt idx="29">
                    <c:v>£Fermentation</c:v>
                  </c:pt>
                  <c:pt idx="30">
                    <c:v>¨Wild</c:v>
                  </c:pt>
                  <c:pt idx="31">
                    <c:v>¨Wild</c:v>
                  </c:pt>
                  <c:pt idx="32">
                    <c:v>¨Wild</c:v>
                  </c:pt>
                  <c:pt idx="33">
                    <c:v>¨Wild</c:v>
                  </c:pt>
                  <c:pt idx="34">
                    <c:v>¨Wild</c:v>
                  </c:pt>
                  <c:pt idx="35">
                    <c:v>¨Wild</c:v>
                  </c:pt>
                  <c:pt idx="36">
                    <c:v>¡Baking</c:v>
                  </c:pt>
                  <c:pt idx="37">
                    <c:v>¨Wild</c:v>
                  </c:pt>
                  <c:pt idx="38">
                    <c:v>¨Wild</c:v>
                  </c:pt>
                  <c:pt idx="39">
                    <c:v>¨Wild</c:v>
                  </c:pt>
                  <c:pt idx="40">
                    <c:v>¨Wild</c:v>
                  </c:pt>
                  <c:pt idx="41">
                    <c:v>¨Wild</c:v>
                  </c:pt>
                  <c:pt idx="42">
                    <c:v>£Fermentation</c:v>
                  </c:pt>
                  <c:pt idx="43">
                    <c:v>£Fermentation</c:v>
                  </c:pt>
                  <c:pt idx="44">
                    <c:v>¨Wild</c:v>
                  </c:pt>
                  <c:pt idx="45">
                    <c:v>rClinical</c:v>
                  </c:pt>
                  <c:pt idx="46">
                    <c:v>¨Wild</c:v>
                  </c:pt>
                  <c:pt idx="47">
                    <c:v>¨Wild</c:v>
                  </c:pt>
                  <c:pt idx="48">
                    <c:v>¨Wild</c:v>
                  </c:pt>
                  <c:pt idx="49">
                    <c:v>¯Laboratory</c:v>
                  </c:pt>
                  <c:pt idx="50">
                    <c:v>¯Laboratory</c:v>
                  </c:pt>
                  <c:pt idx="51">
                    <c:v>¨Wild</c:v>
                  </c:pt>
                  <c:pt idx="52">
                    <c:v>¨Wild</c:v>
                  </c:pt>
                  <c:pt idx="53">
                    <c:v>¨Wild</c:v>
                  </c:pt>
                  <c:pt idx="54">
                    <c:v>¨Wild</c:v>
                  </c:pt>
                  <c:pt idx="55">
                    <c:v>£Fermentation</c:v>
                  </c:pt>
                  <c:pt idx="56">
                    <c:v>¨Wild</c:v>
                  </c:pt>
                  <c:pt idx="57">
                    <c:v>¨Wild</c:v>
                  </c:pt>
                  <c:pt idx="58">
                    <c:v>rClinical</c:v>
                  </c:pt>
                  <c:pt idx="59">
                    <c:v>¨Wild</c:v>
                  </c:pt>
                  <c:pt idx="60">
                    <c:v>¨Wild</c:v>
                  </c:pt>
                  <c:pt idx="61">
                    <c:v>¨Wild</c:v>
                  </c:pt>
                  <c:pt idx="62">
                    <c:v>¯Laboratory</c:v>
                  </c:pt>
                  <c:pt idx="63">
                    <c:v>¯Laboratory</c:v>
                  </c:pt>
                  <c:pt idx="64">
                    <c:v>¨Wild</c:v>
                  </c:pt>
                  <c:pt idx="65">
                    <c:v>rClinical</c:v>
                  </c:pt>
                  <c:pt idx="66">
                    <c:v>¨Wild</c:v>
                  </c:pt>
                  <c:pt idx="67">
                    <c:v>¨Wild</c:v>
                  </c:pt>
                  <c:pt idx="68">
                    <c:v>£Fermentation</c:v>
                  </c:pt>
                  <c:pt idx="69">
                    <c:v>¨Wild</c:v>
                  </c:pt>
                  <c:pt idx="70">
                    <c:v>rClinical</c:v>
                  </c:pt>
                  <c:pt idx="71">
                    <c:v>¡Baking</c:v>
                  </c:pt>
                  <c:pt idx="72">
                    <c:v>¨Wild</c:v>
                  </c:pt>
                  <c:pt idx="73">
                    <c:v>£Fermentation</c:v>
                  </c:pt>
                  <c:pt idx="74">
                    <c:v>¨Wild</c:v>
                  </c:pt>
                  <c:pt idx="75">
                    <c:v>¨Wild</c:v>
                  </c:pt>
                  <c:pt idx="76">
                    <c:v>¨Wild</c:v>
                  </c:pt>
                  <c:pt idx="77">
                    <c:v>¨Wild</c:v>
                  </c:pt>
                  <c:pt idx="78">
                    <c:v>¨Wild</c:v>
                  </c:pt>
                  <c:pt idx="79">
                    <c:v>£Fermentation</c:v>
                  </c:pt>
                  <c:pt idx="80">
                    <c:v>¨Wild</c:v>
                  </c:pt>
                  <c:pt idx="81">
                    <c:v>rClinical</c:v>
                  </c:pt>
                  <c:pt idx="82">
                    <c:v>¨Wild</c:v>
                  </c:pt>
                  <c:pt idx="83">
                    <c:v>¨Wild</c:v>
                  </c:pt>
                  <c:pt idx="84">
                    <c:v>rClinical</c:v>
                  </c:pt>
                  <c:pt idx="85">
                    <c:v>¨Wild</c:v>
                  </c:pt>
                  <c:pt idx="86">
                    <c:v>¨Wild</c:v>
                  </c:pt>
                  <c:pt idx="87">
                    <c:v>¨Wild</c:v>
                  </c:pt>
                  <c:pt idx="88">
                    <c:v>rClinical</c:v>
                  </c:pt>
                  <c:pt idx="89">
                    <c:v>¨Wild</c:v>
                  </c:pt>
                </c:lvl>
                <c:lvl>
                  <c:pt idx="0">
                    <c:v>F01</c:v>
                  </c:pt>
                  <c:pt idx="1">
                    <c:v>G05</c:v>
                  </c:pt>
                  <c:pt idx="2">
                    <c:v>E01</c:v>
                  </c:pt>
                  <c:pt idx="3">
                    <c:v>E05</c:v>
                  </c:pt>
                  <c:pt idx="4">
                    <c:v>B08</c:v>
                  </c:pt>
                  <c:pt idx="5">
                    <c:v>B10</c:v>
                  </c:pt>
                  <c:pt idx="6">
                    <c:v>G02</c:v>
                  </c:pt>
                  <c:pt idx="7">
                    <c:v>D11</c:v>
                  </c:pt>
                  <c:pt idx="8">
                    <c:v>E03</c:v>
                  </c:pt>
                  <c:pt idx="9">
                    <c:v>D10</c:v>
                  </c:pt>
                  <c:pt idx="10">
                    <c:v>D02</c:v>
                  </c:pt>
                  <c:pt idx="11">
                    <c:v>H02</c:v>
                  </c:pt>
                  <c:pt idx="12">
                    <c:v>F12</c:v>
                  </c:pt>
                  <c:pt idx="13">
                    <c:v>E07</c:v>
                  </c:pt>
                  <c:pt idx="14">
                    <c:v>F08</c:v>
                  </c:pt>
                  <c:pt idx="15">
                    <c:v>D05</c:v>
                  </c:pt>
                  <c:pt idx="16">
                    <c:v>D07</c:v>
                  </c:pt>
                  <c:pt idx="17">
                    <c:v>E09</c:v>
                  </c:pt>
                  <c:pt idx="18">
                    <c:v>F06</c:v>
                  </c:pt>
                  <c:pt idx="19">
                    <c:v>C11</c:v>
                  </c:pt>
                  <c:pt idx="20">
                    <c:v>E11</c:v>
                  </c:pt>
                  <c:pt idx="21">
                    <c:v>H08</c:v>
                  </c:pt>
                  <c:pt idx="22">
                    <c:v>E04</c:v>
                  </c:pt>
                  <c:pt idx="23">
                    <c:v>F09</c:v>
                  </c:pt>
                  <c:pt idx="24">
                    <c:v>F02</c:v>
                  </c:pt>
                  <c:pt idx="25">
                    <c:v>F07</c:v>
                  </c:pt>
                  <c:pt idx="26">
                    <c:v>H10</c:v>
                  </c:pt>
                  <c:pt idx="27">
                    <c:v>C10</c:v>
                  </c:pt>
                  <c:pt idx="28">
                    <c:v>B06</c:v>
                  </c:pt>
                  <c:pt idx="29">
                    <c:v>G01</c:v>
                  </c:pt>
                  <c:pt idx="30">
                    <c:v>H05</c:v>
                  </c:pt>
                  <c:pt idx="31">
                    <c:v>A10</c:v>
                  </c:pt>
                  <c:pt idx="32">
                    <c:v>G07</c:v>
                  </c:pt>
                  <c:pt idx="33">
                    <c:v>B11</c:v>
                  </c:pt>
                  <c:pt idx="34">
                    <c:v>B07</c:v>
                  </c:pt>
                  <c:pt idx="35">
                    <c:v>E02</c:v>
                  </c:pt>
                  <c:pt idx="36">
                    <c:v>D04</c:v>
                  </c:pt>
                  <c:pt idx="37">
                    <c:v>G03</c:v>
                  </c:pt>
                  <c:pt idx="38">
                    <c:v>H06</c:v>
                  </c:pt>
                  <c:pt idx="39">
                    <c:v>B09</c:v>
                  </c:pt>
                  <c:pt idx="40">
                    <c:v>E12</c:v>
                  </c:pt>
                  <c:pt idx="41">
                    <c:v>D12</c:v>
                  </c:pt>
                  <c:pt idx="42">
                    <c:v>F03</c:v>
                  </c:pt>
                  <c:pt idx="43">
                    <c:v>D06</c:v>
                  </c:pt>
                  <c:pt idx="44">
                    <c:v>E08</c:v>
                  </c:pt>
                  <c:pt idx="45">
                    <c:v>B02</c:v>
                  </c:pt>
                  <c:pt idx="46">
                    <c:v>A08</c:v>
                  </c:pt>
                  <c:pt idx="47">
                    <c:v>C09</c:v>
                  </c:pt>
                  <c:pt idx="48">
                    <c:v>H04</c:v>
                  </c:pt>
                  <c:pt idx="49">
                    <c:v>A02</c:v>
                  </c:pt>
                  <c:pt idx="50">
                    <c:v>A04</c:v>
                  </c:pt>
                  <c:pt idx="51">
                    <c:v>F05</c:v>
                  </c:pt>
                  <c:pt idx="52">
                    <c:v>F11</c:v>
                  </c:pt>
                  <c:pt idx="53">
                    <c:v>C12</c:v>
                  </c:pt>
                  <c:pt idx="54">
                    <c:v>B12</c:v>
                  </c:pt>
                  <c:pt idx="55">
                    <c:v>F04</c:v>
                  </c:pt>
                  <c:pt idx="56">
                    <c:v>G08</c:v>
                  </c:pt>
                  <c:pt idx="57">
                    <c:v>C01</c:v>
                  </c:pt>
                  <c:pt idx="58">
                    <c:v>H01</c:v>
                  </c:pt>
                  <c:pt idx="59">
                    <c:v>F10</c:v>
                  </c:pt>
                  <c:pt idx="60">
                    <c:v>G06</c:v>
                  </c:pt>
                  <c:pt idx="61">
                    <c:v>H03</c:v>
                  </c:pt>
                  <c:pt idx="62">
                    <c:v>A01</c:v>
                  </c:pt>
                  <c:pt idx="63">
                    <c:v>A03</c:v>
                  </c:pt>
                  <c:pt idx="64">
                    <c:v>D08</c:v>
                  </c:pt>
                  <c:pt idx="65">
                    <c:v>B01</c:v>
                  </c:pt>
                  <c:pt idx="66">
                    <c:v>A09</c:v>
                  </c:pt>
                  <c:pt idx="67">
                    <c:v>C07</c:v>
                  </c:pt>
                  <c:pt idx="68">
                    <c:v>G04</c:v>
                  </c:pt>
                  <c:pt idx="69">
                    <c:v>G12</c:v>
                  </c:pt>
                  <c:pt idx="70">
                    <c:v>B04</c:v>
                  </c:pt>
                  <c:pt idx="71">
                    <c:v>D03</c:v>
                  </c:pt>
                  <c:pt idx="72">
                    <c:v>D01</c:v>
                  </c:pt>
                  <c:pt idx="73">
                    <c:v>C03</c:v>
                  </c:pt>
                  <c:pt idx="74">
                    <c:v>A11</c:v>
                  </c:pt>
                  <c:pt idx="75">
                    <c:v>C08</c:v>
                  </c:pt>
                  <c:pt idx="76">
                    <c:v>A12</c:v>
                  </c:pt>
                  <c:pt idx="77">
                    <c:v>C02</c:v>
                  </c:pt>
                  <c:pt idx="78">
                    <c:v>H07</c:v>
                  </c:pt>
                  <c:pt idx="79">
                    <c:v>C04</c:v>
                  </c:pt>
                  <c:pt idx="80">
                    <c:v>D09</c:v>
                  </c:pt>
                  <c:pt idx="81">
                    <c:v>B05</c:v>
                  </c:pt>
                  <c:pt idx="82">
                    <c:v>G10</c:v>
                  </c:pt>
                  <c:pt idx="83">
                    <c:v>A07</c:v>
                  </c:pt>
                  <c:pt idx="84">
                    <c:v>C05</c:v>
                  </c:pt>
                  <c:pt idx="85">
                    <c:v>G09</c:v>
                  </c:pt>
                  <c:pt idx="86">
                    <c:v>H11</c:v>
                  </c:pt>
                  <c:pt idx="87">
                    <c:v>H12</c:v>
                  </c:pt>
                  <c:pt idx="88">
                    <c:v>B03</c:v>
                  </c:pt>
                  <c:pt idx="89">
                    <c:v>H09</c:v>
                  </c:pt>
                </c:lvl>
              </c:multiLvlStrCache>
            </c:multiLvlStrRef>
          </c:xVal>
          <c:yVal>
            <c:numRef>
              <c:f>'TEMP-1'!$M$2:$M$91</c:f>
              <c:numCache>
                <c:formatCode>0</c:formatCode>
                <c:ptCount val="90"/>
                <c:pt idx="0">
                  <c:v>12.77355422452054</c:v>
                </c:pt>
                <c:pt idx="1">
                  <c:v>25.624999999999996</c:v>
                </c:pt>
                <c:pt idx="2">
                  <c:v>27.093596059113306</c:v>
                </c:pt>
                <c:pt idx="3">
                  <c:v>32.52032520325205</c:v>
                </c:pt>
                <c:pt idx="4">
                  <c:v>45.39473684210526</c:v>
                </c:pt>
                <c:pt idx="5">
                  <c:v>51.806494375960874</c:v>
                </c:pt>
                <c:pt idx="6">
                  <c:v>54.255608515967154</c:v>
                </c:pt>
                <c:pt idx="7">
                  <c:v>57.894736842105267</c:v>
                </c:pt>
                <c:pt idx="8">
                  <c:v>61.115446523689378</c:v>
                </c:pt>
                <c:pt idx="9">
                  <c:v>61.830274042844167</c:v>
                </c:pt>
                <c:pt idx="10">
                  <c:v>62.730750656694958</c:v>
                </c:pt>
                <c:pt idx="11">
                  <c:v>63.281250000000021</c:v>
                </c:pt>
                <c:pt idx="12">
                  <c:v>64.54439480833409</c:v>
                </c:pt>
                <c:pt idx="13">
                  <c:v>65.152777828176269</c:v>
                </c:pt>
                <c:pt idx="14">
                  <c:v>66.21621621621621</c:v>
                </c:pt>
                <c:pt idx="15">
                  <c:v>67.741935483870989</c:v>
                </c:pt>
                <c:pt idx="16">
                  <c:v>69.19187368428409</c:v>
                </c:pt>
                <c:pt idx="17">
                  <c:v>69.565217391304344</c:v>
                </c:pt>
                <c:pt idx="18">
                  <c:v>72.656249999999972</c:v>
                </c:pt>
                <c:pt idx="19">
                  <c:v>73.148148148148167</c:v>
                </c:pt>
                <c:pt idx="20">
                  <c:v>73.255813953488385</c:v>
                </c:pt>
                <c:pt idx="21">
                  <c:v>73.639351002744576</c:v>
                </c:pt>
                <c:pt idx="22">
                  <c:v>76.435525504406471</c:v>
                </c:pt>
                <c:pt idx="23">
                  <c:v>78.01049156690739</c:v>
                </c:pt>
                <c:pt idx="24">
                  <c:v>78.08219178082193</c:v>
                </c:pt>
                <c:pt idx="25">
                  <c:v>79.713844117174474</c:v>
                </c:pt>
                <c:pt idx="26">
                  <c:v>80.487804878048792</c:v>
                </c:pt>
                <c:pt idx="27">
                  <c:v>81.282051282051299</c:v>
                </c:pt>
                <c:pt idx="28">
                  <c:v>82.528295997509588</c:v>
                </c:pt>
                <c:pt idx="29">
                  <c:v>82.548417653488528</c:v>
                </c:pt>
                <c:pt idx="30">
                  <c:v>85.465116279069761</c:v>
                </c:pt>
                <c:pt idx="31">
                  <c:v>86.133382037328587</c:v>
                </c:pt>
                <c:pt idx="32">
                  <c:v>86.184210526315823</c:v>
                </c:pt>
                <c:pt idx="33">
                  <c:v>87.197666137773908</c:v>
                </c:pt>
                <c:pt idx="34">
                  <c:v>87.209302325581405</c:v>
                </c:pt>
                <c:pt idx="35">
                  <c:v>88.194444444444429</c:v>
                </c:pt>
                <c:pt idx="36">
                  <c:v>89.182518533356699</c:v>
                </c:pt>
                <c:pt idx="37">
                  <c:v>89.333333333333329</c:v>
                </c:pt>
                <c:pt idx="38">
                  <c:v>89.506172839506135</c:v>
                </c:pt>
                <c:pt idx="39">
                  <c:v>90.321475448546479</c:v>
                </c:pt>
                <c:pt idx="40">
                  <c:v>91.226237618619848</c:v>
                </c:pt>
                <c:pt idx="41">
                  <c:v>92.17688696802314</c:v>
                </c:pt>
                <c:pt idx="42">
                  <c:v>93.401567598511051</c:v>
                </c:pt>
                <c:pt idx="43">
                  <c:v>93.714232891216028</c:v>
                </c:pt>
                <c:pt idx="44">
                  <c:v>93.749999999999986</c:v>
                </c:pt>
                <c:pt idx="45">
                  <c:v>94.642857142857153</c:v>
                </c:pt>
                <c:pt idx="46">
                  <c:v>95.833333333333286</c:v>
                </c:pt>
                <c:pt idx="47">
                  <c:v>96.428571428571459</c:v>
                </c:pt>
                <c:pt idx="48">
                  <c:v>98.327374344127705</c:v>
                </c:pt>
                <c:pt idx="49">
                  <c:v>100</c:v>
                </c:pt>
                <c:pt idx="50">
                  <c:v>100.00000000000003</c:v>
                </c:pt>
                <c:pt idx="51">
                  <c:v>100.90909090909095</c:v>
                </c:pt>
                <c:pt idx="52">
                  <c:v>102.08333333333333</c:v>
                </c:pt>
                <c:pt idx="53">
                  <c:v>102.38095238095238</c:v>
                </c:pt>
                <c:pt idx="54">
                  <c:v>105</c:v>
                </c:pt>
                <c:pt idx="55">
                  <c:v>105.63380281690141</c:v>
                </c:pt>
                <c:pt idx="56">
                  <c:v>106.05167914087714</c:v>
                </c:pt>
                <c:pt idx="57">
                  <c:v>106.11013932894559</c:v>
                </c:pt>
                <c:pt idx="58">
                  <c:v>106.16438356164379</c:v>
                </c:pt>
                <c:pt idx="59">
                  <c:v>106.91489361702126</c:v>
                </c:pt>
                <c:pt idx="60">
                  <c:v>108.90410958904111</c:v>
                </c:pt>
                <c:pt idx="61">
                  <c:v>109.58083832335326</c:v>
                </c:pt>
                <c:pt idx="62">
                  <c:v>109.58904109589041</c:v>
                </c:pt>
                <c:pt idx="63">
                  <c:v>110.44776119402984</c:v>
                </c:pt>
                <c:pt idx="64">
                  <c:v>112.02531645569623</c:v>
                </c:pt>
                <c:pt idx="65">
                  <c:v>112.17616580310879</c:v>
                </c:pt>
                <c:pt idx="66">
                  <c:v>114.18918918918919</c:v>
                </c:pt>
                <c:pt idx="67">
                  <c:v>116.19718309859157</c:v>
                </c:pt>
                <c:pt idx="68">
                  <c:v>116.44583171608762</c:v>
                </c:pt>
                <c:pt idx="69">
                  <c:v>116.75257731958769</c:v>
                </c:pt>
                <c:pt idx="70">
                  <c:v>119.82758620689653</c:v>
                </c:pt>
                <c:pt idx="71">
                  <c:v>120.14925373134329</c:v>
                </c:pt>
                <c:pt idx="72">
                  <c:v>125.28735632183907</c:v>
                </c:pt>
                <c:pt idx="73">
                  <c:v>128.03030303030303</c:v>
                </c:pt>
                <c:pt idx="74">
                  <c:v>130.05319148936172</c:v>
                </c:pt>
                <c:pt idx="75">
                  <c:v>130.24390243902445</c:v>
                </c:pt>
                <c:pt idx="76">
                  <c:v>130.55555555555557</c:v>
                </c:pt>
                <c:pt idx="77">
                  <c:v>130.7692307692308</c:v>
                </c:pt>
                <c:pt idx="78">
                  <c:v>131.42857142857142</c:v>
                </c:pt>
                <c:pt idx="79">
                  <c:v>135.48387096774195</c:v>
                </c:pt>
                <c:pt idx="80">
                  <c:v>136.44067796610173</c:v>
                </c:pt>
                <c:pt idx="81">
                  <c:v>139.72263183768274</c:v>
                </c:pt>
                <c:pt idx="82">
                  <c:v>150.17455406303606</c:v>
                </c:pt>
                <c:pt idx="83">
                  <c:v>152.58620689655174</c:v>
                </c:pt>
                <c:pt idx="84">
                  <c:v>159.00397216731093</c:v>
                </c:pt>
                <c:pt idx="85">
                  <c:v>162.26415094339626</c:v>
                </c:pt>
                <c:pt idx="86">
                  <c:v>165.08455902115355</c:v>
                </c:pt>
                <c:pt idx="87">
                  <c:v>170.83333333333331</c:v>
                </c:pt>
                <c:pt idx="88">
                  <c:v>173.52941176470588</c:v>
                </c:pt>
                <c:pt idx="89">
                  <c:v>175.2036464068753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2924032"/>
        <c:axId val="82924608"/>
      </c:scatterChart>
      <c:valAx>
        <c:axId val="82924032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 sz="1200" b="1"/>
                </a:pPr>
                <a:r>
                  <a:rPr lang="en-US" sz="1200" b="1"/>
                  <a:t>Strains</a:t>
                </a:r>
              </a:p>
            </c:rich>
          </c:tx>
          <c:layout>
            <c:manualLayout>
              <c:xMode val="edge"/>
              <c:yMode val="edge"/>
              <c:x val="0.44932269070176917"/>
              <c:y val="0.86492429110544666"/>
            </c:manualLayout>
          </c:layout>
          <c:overlay val="0"/>
        </c:title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82924608"/>
        <c:crosses val="autoZero"/>
        <c:crossBetween val="midCat"/>
        <c:majorUnit val="50"/>
        <c:minorUnit val="2"/>
      </c:valAx>
      <c:valAx>
        <c:axId val="82924608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82924032"/>
        <c:crosses val="autoZero"/>
        <c:crossBetween val="midCat"/>
        <c:majorUnit val="50"/>
      </c:valAx>
    </c:plotArea>
    <c:legend>
      <c:legendPos val="t"/>
      <c:layout>
        <c:manualLayout>
          <c:xMode val="edge"/>
          <c:yMode val="edge"/>
          <c:x val="0.36426119824477565"/>
          <c:y val="3.67488536198139E-2"/>
          <c:w val="0.42420206036970115"/>
          <c:h val="4.6368161352503823E-2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8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565080177006445"/>
          <c:y val="2.8498661311914322E-2"/>
          <c:w val="0.7409680642406079"/>
          <c:h val="0.81444678714859442"/>
        </c:manualLayout>
      </c:layout>
      <c:scatterChart>
        <c:scatterStyle val="lineMarker"/>
        <c:varyColors val="0"/>
        <c:ser>
          <c:idx val="0"/>
          <c:order val="0"/>
          <c:tx>
            <c:strRef>
              <c:f>'acetic acid'!$J$3</c:f>
              <c:strCache>
                <c:ptCount val="1"/>
                <c:pt idx="0">
                  <c:v>Acetic acid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acetic acid'!$B$4:$B$93</c:f>
              <c:strCache>
                <c:ptCount val="90"/>
                <c:pt idx="0">
                  <c:v>DBVPG6045</c:v>
                </c:pt>
                <c:pt idx="1">
                  <c:v>L-1764</c:v>
                </c:pt>
                <c:pt idx="2">
                  <c:v>IFO1803</c:v>
                </c:pt>
                <c:pt idx="3">
                  <c:v>UWOPS99-807.1.1</c:v>
                </c:pt>
                <c:pt idx="4">
                  <c:v>IFO1816</c:v>
                </c:pt>
                <c:pt idx="5">
                  <c:v>A4</c:v>
                </c:pt>
                <c:pt idx="6">
                  <c:v>2.3317</c:v>
                </c:pt>
                <c:pt idx="7">
                  <c:v>UFRJ50816</c:v>
                </c:pt>
                <c:pt idx="8">
                  <c:v>Q31.4</c:v>
                </c:pt>
                <c:pt idx="9">
                  <c:v>S288C</c:v>
                </c:pt>
                <c:pt idx="10">
                  <c:v>N-43</c:v>
                </c:pt>
                <c:pt idx="11">
                  <c:v>NCYC110</c:v>
                </c:pt>
                <c:pt idx="12">
                  <c:v>DBVPG1853</c:v>
                </c:pt>
                <c:pt idx="13">
                  <c:v>Y9</c:v>
                </c:pt>
                <c:pt idx="14">
                  <c:v>NCYC361</c:v>
                </c:pt>
                <c:pt idx="15">
                  <c:v>Q32.3</c:v>
                </c:pt>
                <c:pt idx="16">
                  <c:v>IFO1802</c:v>
                </c:pt>
                <c:pt idx="17">
                  <c:v>DBVPG6044</c:v>
                </c:pt>
                <c:pt idx="18">
                  <c:v>L-1528</c:v>
                </c:pt>
                <c:pt idx="19">
                  <c:v>N-17</c:v>
                </c:pt>
                <c:pt idx="20">
                  <c:v>DBVPG6765</c:v>
                </c:pt>
                <c:pt idx="21">
                  <c:v>UWOPS05-227.2</c:v>
                </c:pt>
                <c:pt idx="22">
                  <c:v>GL379</c:v>
                </c:pt>
                <c:pt idx="23">
                  <c:v>ZP594</c:v>
                </c:pt>
                <c:pt idx="24">
                  <c:v>DBVPG6040</c:v>
                </c:pt>
                <c:pt idx="25">
                  <c:v>RM11</c:v>
                </c:pt>
                <c:pt idx="26">
                  <c:v>YJM981</c:v>
                </c:pt>
                <c:pt idx="27">
                  <c:v>Z1</c:v>
                </c:pt>
                <c:pt idx="28">
                  <c:v>LD7</c:v>
                </c:pt>
                <c:pt idx="29">
                  <c:v>YPS138</c:v>
                </c:pt>
                <c:pt idx="30">
                  <c:v>378604X</c:v>
                </c:pt>
                <c:pt idx="31">
                  <c:v>Y8.1</c:v>
                </c:pt>
                <c:pt idx="32">
                  <c:v>YJM978</c:v>
                </c:pt>
                <c:pt idx="33">
                  <c:v>Q96.8</c:v>
                </c:pt>
                <c:pt idx="34">
                  <c:v>Y12</c:v>
                </c:pt>
                <c:pt idx="35">
                  <c:v>2.3318</c:v>
                </c:pt>
                <c:pt idx="36">
                  <c:v>Q74.4</c:v>
                </c:pt>
                <c:pt idx="37">
                  <c:v>SK1</c:v>
                </c:pt>
                <c:pt idx="38">
                  <c:v>UWOPS83-787.3</c:v>
                </c:pt>
                <c:pt idx="39">
                  <c:v>YJM789</c:v>
                </c:pt>
                <c:pt idx="40">
                  <c:v>DBVP1106</c:v>
                </c:pt>
                <c:pt idx="41">
                  <c:v>NBRC10990</c:v>
                </c:pt>
                <c:pt idx="42">
                  <c:v>DBVPG4650</c:v>
                </c:pt>
                <c:pt idx="43">
                  <c:v>W303</c:v>
                </c:pt>
                <c:pt idx="44">
                  <c:v>K11</c:v>
                </c:pt>
                <c:pt idx="45">
                  <c:v>DBVPG6304</c:v>
                </c:pt>
                <c:pt idx="46">
                  <c:v>YS4</c:v>
                </c:pt>
                <c:pt idx="47">
                  <c:v>KPN3829</c:v>
                </c:pt>
                <c:pt idx="48">
                  <c:v>2.3319</c:v>
                </c:pt>
                <c:pt idx="49">
                  <c:v>Y55</c:v>
                </c:pt>
                <c:pt idx="50">
                  <c:v>YIIc17_E5</c:v>
                </c:pt>
                <c:pt idx="51">
                  <c:v>UFRJ50791</c:v>
                </c:pt>
                <c:pt idx="52">
                  <c:v>UWOPS03-461.4</c:v>
                </c:pt>
                <c:pt idx="53">
                  <c:v>CBS432</c:v>
                </c:pt>
                <c:pt idx="54">
                  <c:v>Y8.5</c:v>
                </c:pt>
                <c:pt idx="55">
                  <c:v>L-1374</c:v>
                </c:pt>
                <c:pt idx="56">
                  <c:v>ZP452</c:v>
                </c:pt>
                <c:pt idx="57">
                  <c:v>Q59.1</c:v>
                </c:pt>
                <c:pt idx="58">
                  <c:v>A12</c:v>
                </c:pt>
                <c:pt idx="59">
                  <c:v>ZP555</c:v>
                </c:pt>
                <c:pt idx="60">
                  <c:v>N-45</c:v>
                </c:pt>
                <c:pt idx="61">
                  <c:v>CBS5829</c:v>
                </c:pt>
                <c:pt idx="62">
                  <c:v>IFO1815</c:v>
                </c:pt>
                <c:pt idx="63">
                  <c:v>S36.7</c:v>
                </c:pt>
                <c:pt idx="64">
                  <c:v>UWOPS05-217.3</c:v>
                </c:pt>
                <c:pt idx="65">
                  <c:v>Y7</c:v>
                </c:pt>
                <c:pt idx="66">
                  <c:v>Y6.5</c:v>
                </c:pt>
                <c:pt idx="67">
                  <c:v>T21.4</c:v>
                </c:pt>
                <c:pt idx="68">
                  <c:v>KPN3828</c:v>
                </c:pt>
                <c:pt idx="69">
                  <c:v>N-44</c:v>
                </c:pt>
                <c:pt idx="70">
                  <c:v>BC187</c:v>
                </c:pt>
                <c:pt idx="71">
                  <c:v>CBS4309</c:v>
                </c:pt>
                <c:pt idx="72">
                  <c:v>322134S</c:v>
                </c:pt>
                <c:pt idx="73">
                  <c:v>DBVPG1788</c:v>
                </c:pt>
                <c:pt idx="74">
                  <c:v>Y9.6</c:v>
                </c:pt>
                <c:pt idx="75">
                  <c:v>273614N</c:v>
                </c:pt>
                <c:pt idx="76">
                  <c:v>UWOPS87-2421</c:v>
                </c:pt>
                <c:pt idx="77">
                  <c:v>322134S</c:v>
                </c:pt>
                <c:pt idx="78">
                  <c:v>Q89.8</c:v>
                </c:pt>
                <c:pt idx="79">
                  <c:v>YJM975</c:v>
                </c:pt>
                <c:pt idx="80">
                  <c:v>YPS606</c:v>
                </c:pt>
                <c:pt idx="81">
                  <c:v>YPS128</c:v>
                </c:pt>
                <c:pt idx="82">
                  <c:v>YS9</c:v>
                </c:pt>
                <c:pt idx="83">
                  <c:v>DBVPG1373</c:v>
                </c:pt>
                <c:pt idx="84">
                  <c:v>YS2</c:v>
                </c:pt>
                <c:pt idx="85">
                  <c:v>UWOPS91-917.1</c:v>
                </c:pt>
                <c:pt idx="86">
                  <c:v>Z1.1</c:v>
                </c:pt>
                <c:pt idx="87">
                  <c:v>IFO1804</c:v>
                </c:pt>
                <c:pt idx="88">
                  <c:v>Q62.5</c:v>
                </c:pt>
                <c:pt idx="89">
                  <c:v>Q95.3</c:v>
                </c:pt>
              </c:strCache>
            </c:strRef>
          </c:xVal>
          <c:yVal>
            <c:numRef>
              <c:f>'acetic acid'!$J$4:$J$93</c:f>
              <c:numCache>
                <c:formatCode>General</c:formatCode>
                <c:ptCount val="90"/>
                <c:pt idx="0">
                  <c:v>26.737967914438489</c:v>
                </c:pt>
                <c:pt idx="1">
                  <c:v>30.68783068783069</c:v>
                </c:pt>
                <c:pt idx="2">
                  <c:v>49.646028735914186</c:v>
                </c:pt>
                <c:pt idx="3">
                  <c:v>56.095736724008951</c:v>
                </c:pt>
                <c:pt idx="4">
                  <c:v>60.661931100022507</c:v>
                </c:pt>
                <c:pt idx="5">
                  <c:v>66.731520953358427</c:v>
                </c:pt>
                <c:pt idx="6">
                  <c:v>69.072164948453675</c:v>
                </c:pt>
                <c:pt idx="7">
                  <c:v>69.183768067601264</c:v>
                </c:pt>
                <c:pt idx="8">
                  <c:v>69.24630483211935</c:v>
                </c:pt>
                <c:pt idx="9">
                  <c:v>69.823903212781175</c:v>
                </c:pt>
                <c:pt idx="10">
                  <c:v>70.808138643123584</c:v>
                </c:pt>
                <c:pt idx="11">
                  <c:v>70.977462452922353</c:v>
                </c:pt>
                <c:pt idx="12">
                  <c:v>71.270180251139266</c:v>
                </c:pt>
                <c:pt idx="13">
                  <c:v>71.698113207547181</c:v>
                </c:pt>
                <c:pt idx="14">
                  <c:v>73.256541434073824</c:v>
                </c:pt>
                <c:pt idx="15">
                  <c:v>73.456790123456784</c:v>
                </c:pt>
                <c:pt idx="16">
                  <c:v>73.489143328382099</c:v>
                </c:pt>
                <c:pt idx="17">
                  <c:v>74.653163301264101</c:v>
                </c:pt>
                <c:pt idx="18">
                  <c:v>74.908944624316078</c:v>
                </c:pt>
                <c:pt idx="19">
                  <c:v>75.483870967741922</c:v>
                </c:pt>
                <c:pt idx="20">
                  <c:v>75.666654855574762</c:v>
                </c:pt>
                <c:pt idx="21">
                  <c:v>76.136363636363626</c:v>
                </c:pt>
                <c:pt idx="22">
                  <c:v>76.21325082243078</c:v>
                </c:pt>
                <c:pt idx="23">
                  <c:v>76.381388660863465</c:v>
                </c:pt>
                <c:pt idx="24">
                  <c:v>77.999999999999972</c:v>
                </c:pt>
                <c:pt idx="25">
                  <c:v>78.034682080924838</c:v>
                </c:pt>
                <c:pt idx="26">
                  <c:v>78.205128205128204</c:v>
                </c:pt>
                <c:pt idx="27">
                  <c:v>78.343949044585997</c:v>
                </c:pt>
                <c:pt idx="28">
                  <c:v>78.51480997113876</c:v>
                </c:pt>
                <c:pt idx="29">
                  <c:v>78.577590011402236</c:v>
                </c:pt>
                <c:pt idx="30">
                  <c:v>78.740157480314963</c:v>
                </c:pt>
                <c:pt idx="31">
                  <c:v>79.194630872483245</c:v>
                </c:pt>
                <c:pt idx="32">
                  <c:v>79.268292682926813</c:v>
                </c:pt>
                <c:pt idx="33">
                  <c:v>79.312053592106338</c:v>
                </c:pt>
                <c:pt idx="34">
                  <c:v>79.365948636410025</c:v>
                </c:pt>
                <c:pt idx="35">
                  <c:v>79.616306954436482</c:v>
                </c:pt>
                <c:pt idx="36">
                  <c:v>79.882568540024621</c:v>
                </c:pt>
                <c:pt idx="37">
                  <c:v>80.644011744034856</c:v>
                </c:pt>
                <c:pt idx="38">
                  <c:v>80.647835547341799</c:v>
                </c:pt>
                <c:pt idx="39">
                  <c:v>80.839112802687112</c:v>
                </c:pt>
                <c:pt idx="40">
                  <c:v>80.92536419004665</c:v>
                </c:pt>
                <c:pt idx="41">
                  <c:v>81.000552388803015</c:v>
                </c:pt>
                <c:pt idx="42">
                  <c:v>81.632653061224474</c:v>
                </c:pt>
                <c:pt idx="43">
                  <c:v>81.745872109868827</c:v>
                </c:pt>
                <c:pt idx="44">
                  <c:v>81.818181818181799</c:v>
                </c:pt>
                <c:pt idx="45">
                  <c:v>81.872861048245809</c:v>
                </c:pt>
                <c:pt idx="46">
                  <c:v>82.16009042654197</c:v>
                </c:pt>
                <c:pt idx="47">
                  <c:v>82.961222408664142</c:v>
                </c:pt>
                <c:pt idx="48">
                  <c:v>82.993197278911595</c:v>
                </c:pt>
                <c:pt idx="49">
                  <c:v>82.999036837290447</c:v>
                </c:pt>
                <c:pt idx="50">
                  <c:v>83.300589390962671</c:v>
                </c:pt>
                <c:pt idx="51">
                  <c:v>83.372859121563991</c:v>
                </c:pt>
                <c:pt idx="52">
                  <c:v>83.854166666666671</c:v>
                </c:pt>
                <c:pt idx="53">
                  <c:v>83.892617449664499</c:v>
                </c:pt>
                <c:pt idx="54">
                  <c:v>84.707690129690576</c:v>
                </c:pt>
                <c:pt idx="55">
                  <c:v>85.062177477534078</c:v>
                </c:pt>
                <c:pt idx="56">
                  <c:v>85.260457611514326</c:v>
                </c:pt>
                <c:pt idx="57">
                  <c:v>85.430463576158928</c:v>
                </c:pt>
                <c:pt idx="58">
                  <c:v>85.693826160629442</c:v>
                </c:pt>
                <c:pt idx="59">
                  <c:v>85.833165715362185</c:v>
                </c:pt>
                <c:pt idx="60">
                  <c:v>86.776717459598729</c:v>
                </c:pt>
                <c:pt idx="61">
                  <c:v>86.956521739130494</c:v>
                </c:pt>
                <c:pt idx="62">
                  <c:v>87.049605326260846</c:v>
                </c:pt>
                <c:pt idx="63">
                  <c:v>87.837837837837824</c:v>
                </c:pt>
                <c:pt idx="64">
                  <c:v>87.861271676300561</c:v>
                </c:pt>
                <c:pt idx="65">
                  <c:v>89.256198347107457</c:v>
                </c:pt>
                <c:pt idx="66">
                  <c:v>89.65517241379311</c:v>
                </c:pt>
                <c:pt idx="67">
                  <c:v>89.915966386554601</c:v>
                </c:pt>
                <c:pt idx="68">
                  <c:v>90.500533520566563</c:v>
                </c:pt>
                <c:pt idx="69">
                  <c:v>90.772085075229029</c:v>
                </c:pt>
                <c:pt idx="70">
                  <c:v>90.81581388941936</c:v>
                </c:pt>
                <c:pt idx="71">
                  <c:v>91.386554621848759</c:v>
                </c:pt>
                <c:pt idx="72">
                  <c:v>91.603053435114518</c:v>
                </c:pt>
                <c:pt idx="73">
                  <c:v>92.405063291139257</c:v>
                </c:pt>
                <c:pt idx="74">
                  <c:v>93.331375209747179</c:v>
                </c:pt>
                <c:pt idx="75">
                  <c:v>93.548387096774178</c:v>
                </c:pt>
                <c:pt idx="76">
                  <c:v>93.711715132385038</c:v>
                </c:pt>
                <c:pt idx="77">
                  <c:v>93.750000000000014</c:v>
                </c:pt>
                <c:pt idx="78">
                  <c:v>94.488188976377927</c:v>
                </c:pt>
                <c:pt idx="79">
                  <c:v>94.656488549618331</c:v>
                </c:pt>
                <c:pt idx="80">
                  <c:v>95.174464310527611</c:v>
                </c:pt>
                <c:pt idx="81">
                  <c:v>96.057806145405308</c:v>
                </c:pt>
                <c:pt idx="82">
                  <c:v>96.487215542396953</c:v>
                </c:pt>
                <c:pt idx="83">
                  <c:v>97.297297297297305</c:v>
                </c:pt>
                <c:pt idx="84">
                  <c:v>97.899948210927377</c:v>
                </c:pt>
                <c:pt idx="85">
                  <c:v>98.61980077130184</c:v>
                </c:pt>
                <c:pt idx="86">
                  <c:v>99.196636266701248</c:v>
                </c:pt>
                <c:pt idx="87">
                  <c:v>105.81649697947087</c:v>
                </c:pt>
                <c:pt idx="88">
                  <c:v>106.71641791044777</c:v>
                </c:pt>
                <c:pt idx="89">
                  <c:v>109.0909090909091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2926912"/>
        <c:axId val="94183424"/>
      </c:scatterChart>
      <c:valAx>
        <c:axId val="82926912"/>
        <c:scaling>
          <c:orientation val="minMax"/>
          <c:max val="100"/>
          <c:min val="0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94183424"/>
        <c:crosses val="autoZero"/>
        <c:crossBetween val="midCat"/>
        <c:majorUnit val="50"/>
      </c:valAx>
      <c:valAx>
        <c:axId val="941834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8292691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5772779201786218"/>
          <c:y val="0.72223293172690761"/>
          <c:w val="0.5079704769421628"/>
          <c:h val="0.12426848114846224"/>
        </c:manualLayout>
      </c:layout>
      <c:overlay val="0"/>
      <c:txPr>
        <a:bodyPr/>
        <a:lstStyle/>
        <a:p>
          <a:pPr>
            <a:defRPr sz="120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667396408635814"/>
          <c:y val="5.1400554097404488E-2"/>
          <c:w val="0.71948143403526388"/>
          <c:h val="0.81783032128514077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mic acid'!$K$3</c:f>
              <c:strCache>
                <c:ptCount val="1"/>
                <c:pt idx="0">
                  <c:v>Formic acid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formic acid'!$B$4:$B$93</c:f>
              <c:strCache>
                <c:ptCount val="90"/>
                <c:pt idx="0">
                  <c:v>IFO1803</c:v>
                </c:pt>
                <c:pt idx="1">
                  <c:v>S288C</c:v>
                </c:pt>
                <c:pt idx="2">
                  <c:v>CBS4309</c:v>
                </c:pt>
                <c:pt idx="3">
                  <c:v>A4</c:v>
                </c:pt>
                <c:pt idx="4">
                  <c:v>DBVPG1853</c:v>
                </c:pt>
                <c:pt idx="5">
                  <c:v>Q31.4</c:v>
                </c:pt>
                <c:pt idx="6">
                  <c:v>UFRJ50816</c:v>
                </c:pt>
                <c:pt idx="7">
                  <c:v>SK1</c:v>
                </c:pt>
                <c:pt idx="8">
                  <c:v>N-43</c:v>
                </c:pt>
                <c:pt idx="9">
                  <c:v>GL379</c:v>
                </c:pt>
                <c:pt idx="10">
                  <c:v>A12</c:v>
                </c:pt>
                <c:pt idx="11">
                  <c:v>YPS138</c:v>
                </c:pt>
                <c:pt idx="12">
                  <c:v>CBS5829</c:v>
                </c:pt>
                <c:pt idx="13">
                  <c:v>DBVPG4650</c:v>
                </c:pt>
                <c:pt idx="14">
                  <c:v>UWOPS83-787.3</c:v>
                </c:pt>
                <c:pt idx="15">
                  <c:v>273614N</c:v>
                </c:pt>
                <c:pt idx="16">
                  <c:v>ZP452</c:v>
                </c:pt>
                <c:pt idx="17">
                  <c:v>IFO1802</c:v>
                </c:pt>
                <c:pt idx="18">
                  <c:v>Q32.3</c:v>
                </c:pt>
                <c:pt idx="19">
                  <c:v>IFO1816</c:v>
                </c:pt>
                <c:pt idx="20">
                  <c:v>UWOPS05-227.2</c:v>
                </c:pt>
                <c:pt idx="21">
                  <c:v>IFO1815</c:v>
                </c:pt>
                <c:pt idx="22">
                  <c:v>UFRJ50791</c:v>
                </c:pt>
                <c:pt idx="23">
                  <c:v>DBVPG6765</c:v>
                </c:pt>
                <c:pt idx="24">
                  <c:v>LD7</c:v>
                </c:pt>
                <c:pt idx="25">
                  <c:v>L-1374</c:v>
                </c:pt>
                <c:pt idx="26">
                  <c:v>DBVPG6045</c:v>
                </c:pt>
                <c:pt idx="27">
                  <c:v>N-17</c:v>
                </c:pt>
                <c:pt idx="28">
                  <c:v>KPN3829</c:v>
                </c:pt>
                <c:pt idx="29">
                  <c:v>DBVP1106</c:v>
                </c:pt>
                <c:pt idx="30">
                  <c:v>N-44</c:v>
                </c:pt>
                <c:pt idx="31">
                  <c:v>2.3318</c:v>
                </c:pt>
                <c:pt idx="32">
                  <c:v>Z1</c:v>
                </c:pt>
                <c:pt idx="33">
                  <c:v>NCYC361</c:v>
                </c:pt>
                <c:pt idx="34">
                  <c:v>RM11</c:v>
                </c:pt>
                <c:pt idx="35">
                  <c:v>N-45</c:v>
                </c:pt>
                <c:pt idx="36">
                  <c:v>ZP555</c:v>
                </c:pt>
                <c:pt idx="37">
                  <c:v>YIIc17_E5</c:v>
                </c:pt>
                <c:pt idx="38">
                  <c:v>YJM981</c:v>
                </c:pt>
                <c:pt idx="39">
                  <c:v>UWOPS03-461.4</c:v>
                </c:pt>
                <c:pt idx="40">
                  <c:v>DBVPG6040</c:v>
                </c:pt>
                <c:pt idx="41">
                  <c:v>Y12</c:v>
                </c:pt>
                <c:pt idx="42">
                  <c:v>DBVPG6304</c:v>
                </c:pt>
                <c:pt idx="43">
                  <c:v>Q96.8</c:v>
                </c:pt>
                <c:pt idx="44">
                  <c:v>YJM978</c:v>
                </c:pt>
                <c:pt idx="45">
                  <c:v>YJM789</c:v>
                </c:pt>
                <c:pt idx="46">
                  <c:v>L-1528</c:v>
                </c:pt>
                <c:pt idx="47">
                  <c:v>2.3317</c:v>
                </c:pt>
                <c:pt idx="48">
                  <c:v>NBRC10990</c:v>
                </c:pt>
                <c:pt idx="49">
                  <c:v>BC187</c:v>
                </c:pt>
                <c:pt idx="50">
                  <c:v>ZP594</c:v>
                </c:pt>
                <c:pt idx="51">
                  <c:v>Q74.4</c:v>
                </c:pt>
                <c:pt idx="52">
                  <c:v>Y8.1</c:v>
                </c:pt>
                <c:pt idx="53">
                  <c:v>Y55</c:v>
                </c:pt>
                <c:pt idx="54">
                  <c:v>UWOPS87-2421</c:v>
                </c:pt>
                <c:pt idx="55">
                  <c:v>K11</c:v>
                </c:pt>
                <c:pt idx="56">
                  <c:v>NCYC110</c:v>
                </c:pt>
                <c:pt idx="57">
                  <c:v>DBVPG6044</c:v>
                </c:pt>
                <c:pt idx="58">
                  <c:v>W303</c:v>
                </c:pt>
                <c:pt idx="59">
                  <c:v>Z1.1</c:v>
                </c:pt>
                <c:pt idx="60">
                  <c:v>Y9</c:v>
                </c:pt>
                <c:pt idx="61">
                  <c:v>S36.7</c:v>
                </c:pt>
                <c:pt idx="62">
                  <c:v>KPN3828</c:v>
                </c:pt>
                <c:pt idx="63">
                  <c:v>YS4</c:v>
                </c:pt>
                <c:pt idx="64">
                  <c:v>Y9.6</c:v>
                </c:pt>
                <c:pt idx="65">
                  <c:v>DBVPG1373</c:v>
                </c:pt>
                <c:pt idx="66">
                  <c:v>UWOPS05-217.3</c:v>
                </c:pt>
                <c:pt idx="67">
                  <c:v>Q59.1</c:v>
                </c:pt>
                <c:pt idx="68">
                  <c:v>Y8.5</c:v>
                </c:pt>
                <c:pt idx="69">
                  <c:v>CBS432</c:v>
                </c:pt>
                <c:pt idx="70">
                  <c:v>YS9</c:v>
                </c:pt>
                <c:pt idx="71">
                  <c:v>Q89.8</c:v>
                </c:pt>
                <c:pt idx="72">
                  <c:v>IFO1804</c:v>
                </c:pt>
                <c:pt idx="73">
                  <c:v>322134S</c:v>
                </c:pt>
                <c:pt idx="74">
                  <c:v>Y7</c:v>
                </c:pt>
                <c:pt idx="75">
                  <c:v>YJM975</c:v>
                </c:pt>
                <c:pt idx="76">
                  <c:v>378604X</c:v>
                </c:pt>
                <c:pt idx="77">
                  <c:v>T21.4</c:v>
                </c:pt>
                <c:pt idx="78">
                  <c:v>DBVPG1788</c:v>
                </c:pt>
                <c:pt idx="79">
                  <c:v>322134S</c:v>
                </c:pt>
                <c:pt idx="80">
                  <c:v>2.3319</c:v>
                </c:pt>
                <c:pt idx="81">
                  <c:v>Q62.5</c:v>
                </c:pt>
                <c:pt idx="82">
                  <c:v>Y6.5</c:v>
                </c:pt>
                <c:pt idx="83">
                  <c:v>YS2</c:v>
                </c:pt>
                <c:pt idx="84">
                  <c:v>YPS128</c:v>
                </c:pt>
                <c:pt idx="85">
                  <c:v>YPS606</c:v>
                </c:pt>
                <c:pt idx="86">
                  <c:v>UWOPS91-917.1</c:v>
                </c:pt>
                <c:pt idx="87">
                  <c:v>L-1764</c:v>
                </c:pt>
                <c:pt idx="88">
                  <c:v>UWOPS99-807.1.1</c:v>
                </c:pt>
                <c:pt idx="89">
                  <c:v>Q95.3</c:v>
                </c:pt>
              </c:strCache>
            </c:strRef>
          </c:xVal>
          <c:yVal>
            <c:numRef>
              <c:f>'formic acid'!$K$4:$K$93</c:f>
              <c:numCache>
                <c:formatCode>General</c:formatCode>
                <c:ptCount val="90"/>
                <c:pt idx="0">
                  <c:v>55.930336170840036</c:v>
                </c:pt>
                <c:pt idx="1">
                  <c:v>76.171530777579406</c:v>
                </c:pt>
                <c:pt idx="2">
                  <c:v>76.680672268907472</c:v>
                </c:pt>
                <c:pt idx="3">
                  <c:v>77.124134872324106</c:v>
                </c:pt>
                <c:pt idx="4">
                  <c:v>77.467587229499202</c:v>
                </c:pt>
                <c:pt idx="5">
                  <c:v>81.185322906622702</c:v>
                </c:pt>
                <c:pt idx="6">
                  <c:v>83.265419975166111</c:v>
                </c:pt>
                <c:pt idx="7">
                  <c:v>83.550102257333407</c:v>
                </c:pt>
                <c:pt idx="8">
                  <c:v>83.738320482302669</c:v>
                </c:pt>
                <c:pt idx="9">
                  <c:v>84.268309852443778</c:v>
                </c:pt>
                <c:pt idx="10">
                  <c:v>84.648779500133955</c:v>
                </c:pt>
                <c:pt idx="11">
                  <c:v>86.306533291212304</c:v>
                </c:pt>
                <c:pt idx="12">
                  <c:v>86.335403726708066</c:v>
                </c:pt>
                <c:pt idx="13">
                  <c:v>86.394557823129261</c:v>
                </c:pt>
                <c:pt idx="14">
                  <c:v>86.658854345901446</c:v>
                </c:pt>
                <c:pt idx="15">
                  <c:v>87.09677419354837</c:v>
                </c:pt>
                <c:pt idx="16">
                  <c:v>87.243258951316989</c:v>
                </c:pt>
                <c:pt idx="17">
                  <c:v>87.343653955863971</c:v>
                </c:pt>
                <c:pt idx="18">
                  <c:v>88.271604938271608</c:v>
                </c:pt>
                <c:pt idx="19">
                  <c:v>88.290137343597081</c:v>
                </c:pt>
                <c:pt idx="20">
                  <c:v>88.63636363636364</c:v>
                </c:pt>
                <c:pt idx="21">
                  <c:v>88.651745301590807</c:v>
                </c:pt>
                <c:pt idx="22">
                  <c:v>89.057372243488814</c:v>
                </c:pt>
                <c:pt idx="23">
                  <c:v>89.26300689993586</c:v>
                </c:pt>
                <c:pt idx="24">
                  <c:v>89.565042485595299</c:v>
                </c:pt>
                <c:pt idx="25">
                  <c:v>89.820900693060452</c:v>
                </c:pt>
                <c:pt idx="26">
                  <c:v>90.90909090909085</c:v>
                </c:pt>
                <c:pt idx="27">
                  <c:v>90.967741935483886</c:v>
                </c:pt>
                <c:pt idx="28">
                  <c:v>91.317028982198678</c:v>
                </c:pt>
                <c:pt idx="29">
                  <c:v>91.987104618901924</c:v>
                </c:pt>
                <c:pt idx="30">
                  <c:v>92.42248662205138</c:v>
                </c:pt>
                <c:pt idx="31">
                  <c:v>92.805755395683448</c:v>
                </c:pt>
                <c:pt idx="32">
                  <c:v>92.99363057324841</c:v>
                </c:pt>
                <c:pt idx="33">
                  <c:v>93.636180780395108</c:v>
                </c:pt>
                <c:pt idx="34">
                  <c:v>93.641618497109803</c:v>
                </c:pt>
                <c:pt idx="35">
                  <c:v>94.614614520465707</c:v>
                </c:pt>
                <c:pt idx="36">
                  <c:v>94.836644636553999</c:v>
                </c:pt>
                <c:pt idx="37">
                  <c:v>95.481335952848724</c:v>
                </c:pt>
                <c:pt idx="38">
                  <c:v>95.512820512820511</c:v>
                </c:pt>
                <c:pt idx="39">
                  <c:v>95.833333333333343</c:v>
                </c:pt>
                <c:pt idx="40">
                  <c:v>96.666666666666657</c:v>
                </c:pt>
                <c:pt idx="41">
                  <c:v>97.350350790473399</c:v>
                </c:pt>
                <c:pt idx="42">
                  <c:v>97.379084731625696</c:v>
                </c:pt>
                <c:pt idx="43">
                  <c:v>97.524451083627056</c:v>
                </c:pt>
                <c:pt idx="44">
                  <c:v>97.560975609756099</c:v>
                </c:pt>
                <c:pt idx="45">
                  <c:v>97.709884170204433</c:v>
                </c:pt>
                <c:pt idx="46">
                  <c:v>97.732763689537379</c:v>
                </c:pt>
                <c:pt idx="47">
                  <c:v>97.938144329896929</c:v>
                </c:pt>
                <c:pt idx="48">
                  <c:v>98.482685997897192</c:v>
                </c:pt>
                <c:pt idx="49">
                  <c:v>98.712841184151472</c:v>
                </c:pt>
                <c:pt idx="50">
                  <c:v>98.948617128845811</c:v>
                </c:pt>
                <c:pt idx="51">
                  <c:v>99.102434654917758</c:v>
                </c:pt>
                <c:pt idx="52">
                  <c:v>99.328859060402706</c:v>
                </c:pt>
                <c:pt idx="53">
                  <c:v>99.347331971908261</c:v>
                </c:pt>
                <c:pt idx="54">
                  <c:v>99.470535615380754</c:v>
                </c:pt>
                <c:pt idx="55">
                  <c:v>99.604743083003953</c:v>
                </c:pt>
                <c:pt idx="56">
                  <c:v>99.735572239882273</c:v>
                </c:pt>
                <c:pt idx="57">
                  <c:v>99.959320352540075</c:v>
                </c:pt>
                <c:pt idx="58">
                  <c:v>100.32447940756622</c:v>
                </c:pt>
                <c:pt idx="59">
                  <c:v>101.79001237824899</c:v>
                </c:pt>
                <c:pt idx="60">
                  <c:v>101.88679245283021</c:v>
                </c:pt>
                <c:pt idx="61">
                  <c:v>102.02702702702702</c:v>
                </c:pt>
                <c:pt idx="62">
                  <c:v>102.4534341742263</c:v>
                </c:pt>
                <c:pt idx="63">
                  <c:v>102.54088805173068</c:v>
                </c:pt>
                <c:pt idx="64">
                  <c:v>102.73165760497352</c:v>
                </c:pt>
                <c:pt idx="65">
                  <c:v>103.3783783783784</c:v>
                </c:pt>
                <c:pt idx="66">
                  <c:v>103.46820809248554</c:v>
                </c:pt>
                <c:pt idx="67">
                  <c:v>104.63576158940397</c:v>
                </c:pt>
                <c:pt idx="68">
                  <c:v>105.08848775487927</c:v>
                </c:pt>
                <c:pt idx="69">
                  <c:v>105.36912751677852</c:v>
                </c:pt>
                <c:pt idx="70">
                  <c:v>105.67647416548238</c:v>
                </c:pt>
                <c:pt idx="71">
                  <c:v>107.87401574803148</c:v>
                </c:pt>
                <c:pt idx="72">
                  <c:v>108.10030626679759</c:v>
                </c:pt>
                <c:pt idx="73">
                  <c:v>109.02777777777779</c:v>
                </c:pt>
                <c:pt idx="74">
                  <c:v>109.91735537190084</c:v>
                </c:pt>
                <c:pt idx="75">
                  <c:v>109.92366412213744</c:v>
                </c:pt>
                <c:pt idx="76">
                  <c:v>111.0236220472441</c:v>
                </c:pt>
                <c:pt idx="77">
                  <c:v>111.76470588235294</c:v>
                </c:pt>
                <c:pt idx="78">
                  <c:v>112.02531645569624</c:v>
                </c:pt>
                <c:pt idx="79">
                  <c:v>113.74045801526718</c:v>
                </c:pt>
                <c:pt idx="80">
                  <c:v>117.00680272108839</c:v>
                </c:pt>
                <c:pt idx="81">
                  <c:v>119.40298507462686</c:v>
                </c:pt>
                <c:pt idx="82">
                  <c:v>120.68965517241379</c:v>
                </c:pt>
                <c:pt idx="83">
                  <c:v>121.9983970013095</c:v>
                </c:pt>
                <c:pt idx="84">
                  <c:v>123.50289361552113</c:v>
                </c:pt>
                <c:pt idx="85">
                  <c:v>124.32700292816672</c:v>
                </c:pt>
                <c:pt idx="86">
                  <c:v>124.5344929447826</c:v>
                </c:pt>
                <c:pt idx="87">
                  <c:v>127.77777777777783</c:v>
                </c:pt>
                <c:pt idx="88">
                  <c:v>132.38593866866103</c:v>
                </c:pt>
                <c:pt idx="89">
                  <c:v>137.2727272727272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4185152"/>
        <c:axId val="94185728"/>
      </c:scatterChart>
      <c:valAx>
        <c:axId val="94185152"/>
        <c:scaling>
          <c:orientation val="minMax"/>
          <c:max val="100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94185728"/>
        <c:crosses val="autoZero"/>
        <c:crossBetween val="midCat"/>
        <c:majorUnit val="50"/>
      </c:valAx>
      <c:valAx>
        <c:axId val="94185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418515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7538679386418115"/>
          <c:y val="0.76563888888888887"/>
          <c:w val="0.52461320613581885"/>
          <c:h val="8.3717191601049873E-2"/>
        </c:manualLayout>
      </c:layout>
      <c:overlay val="0"/>
      <c:txPr>
        <a:bodyPr/>
        <a:lstStyle/>
        <a:p>
          <a:pPr>
            <a:defRPr sz="120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665058302293115"/>
          <c:y val="7.2652275769745658E-2"/>
          <c:w val="0.66750006920609839"/>
          <c:h val="0.82468775100401603"/>
        </c:manualLayout>
      </c:layout>
      <c:scatterChart>
        <c:scatterStyle val="lineMarker"/>
        <c:varyColors val="0"/>
        <c:ser>
          <c:idx val="0"/>
          <c:order val="0"/>
          <c:tx>
            <c:strRef>
              <c:f>'lvl acid'!$L$3</c:f>
              <c:strCache>
                <c:ptCount val="1"/>
                <c:pt idx="0">
                  <c:v>Levulinic acid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lvl acid'!$B$4:$B$93</c:f>
              <c:strCache>
                <c:ptCount val="90"/>
                <c:pt idx="0">
                  <c:v>CBS5829</c:v>
                </c:pt>
                <c:pt idx="1">
                  <c:v>L-1764</c:v>
                </c:pt>
                <c:pt idx="2">
                  <c:v>IFO1816</c:v>
                </c:pt>
                <c:pt idx="3">
                  <c:v>CBS4309</c:v>
                </c:pt>
                <c:pt idx="4">
                  <c:v>NCYC361</c:v>
                </c:pt>
                <c:pt idx="5">
                  <c:v>N-43</c:v>
                </c:pt>
                <c:pt idx="6">
                  <c:v>2.3317</c:v>
                </c:pt>
                <c:pt idx="7">
                  <c:v>IFO1803</c:v>
                </c:pt>
                <c:pt idx="8">
                  <c:v>S288C</c:v>
                </c:pt>
                <c:pt idx="9">
                  <c:v>A12</c:v>
                </c:pt>
                <c:pt idx="10">
                  <c:v>ZP555</c:v>
                </c:pt>
                <c:pt idx="11">
                  <c:v>A4</c:v>
                </c:pt>
                <c:pt idx="12">
                  <c:v>YPS138</c:v>
                </c:pt>
                <c:pt idx="13">
                  <c:v>UWOPS87-2421</c:v>
                </c:pt>
                <c:pt idx="14">
                  <c:v>GL379</c:v>
                </c:pt>
                <c:pt idx="15">
                  <c:v>Q31.4</c:v>
                </c:pt>
                <c:pt idx="16">
                  <c:v>DBVPG1853</c:v>
                </c:pt>
                <c:pt idx="17">
                  <c:v>UFRJ50816</c:v>
                </c:pt>
                <c:pt idx="18">
                  <c:v>KPN3829</c:v>
                </c:pt>
                <c:pt idx="19">
                  <c:v>Y12</c:v>
                </c:pt>
                <c:pt idx="20">
                  <c:v>DBVPG6044</c:v>
                </c:pt>
                <c:pt idx="21">
                  <c:v>YIIc17_E5</c:v>
                </c:pt>
                <c:pt idx="22">
                  <c:v>YJM789</c:v>
                </c:pt>
                <c:pt idx="23">
                  <c:v>DBVPG6304</c:v>
                </c:pt>
                <c:pt idx="24">
                  <c:v>DBVP1106</c:v>
                </c:pt>
                <c:pt idx="25">
                  <c:v>L-1374</c:v>
                </c:pt>
                <c:pt idx="26">
                  <c:v>UFRJ50791</c:v>
                </c:pt>
                <c:pt idx="27">
                  <c:v>Q74.4</c:v>
                </c:pt>
                <c:pt idx="28">
                  <c:v>KPN3828</c:v>
                </c:pt>
                <c:pt idx="29">
                  <c:v>DBVPG6040</c:v>
                </c:pt>
                <c:pt idx="30">
                  <c:v>Q96.8</c:v>
                </c:pt>
                <c:pt idx="31">
                  <c:v>UWOPS83-787.3</c:v>
                </c:pt>
                <c:pt idx="32">
                  <c:v>DBVPG4650</c:v>
                </c:pt>
                <c:pt idx="33">
                  <c:v>CBS432</c:v>
                </c:pt>
                <c:pt idx="34">
                  <c:v>UWOPS05-227.2</c:v>
                </c:pt>
                <c:pt idx="35">
                  <c:v>Z1</c:v>
                </c:pt>
                <c:pt idx="36">
                  <c:v>IFO1815</c:v>
                </c:pt>
                <c:pt idx="37">
                  <c:v>Y8.1</c:v>
                </c:pt>
                <c:pt idx="38">
                  <c:v>YJM978</c:v>
                </c:pt>
                <c:pt idx="39">
                  <c:v>RM11</c:v>
                </c:pt>
                <c:pt idx="40">
                  <c:v>UWOPS03-461.4</c:v>
                </c:pt>
                <c:pt idx="41">
                  <c:v>S36.7</c:v>
                </c:pt>
                <c:pt idx="42">
                  <c:v>Y55</c:v>
                </c:pt>
                <c:pt idx="43">
                  <c:v>Q32.3</c:v>
                </c:pt>
                <c:pt idx="44">
                  <c:v>ZP594</c:v>
                </c:pt>
                <c:pt idx="45">
                  <c:v>BC187</c:v>
                </c:pt>
                <c:pt idx="46">
                  <c:v>L-1528</c:v>
                </c:pt>
                <c:pt idx="47">
                  <c:v>2.3318</c:v>
                </c:pt>
                <c:pt idx="48">
                  <c:v>DBVPG6765</c:v>
                </c:pt>
                <c:pt idx="49">
                  <c:v>K11</c:v>
                </c:pt>
                <c:pt idx="50">
                  <c:v>ZP452</c:v>
                </c:pt>
                <c:pt idx="51">
                  <c:v>IFO1802</c:v>
                </c:pt>
                <c:pt idx="52">
                  <c:v>DBVPG1788</c:v>
                </c:pt>
                <c:pt idx="53">
                  <c:v>Q59.1</c:v>
                </c:pt>
                <c:pt idx="54">
                  <c:v>LD7</c:v>
                </c:pt>
                <c:pt idx="55">
                  <c:v>Y8.5</c:v>
                </c:pt>
                <c:pt idx="56">
                  <c:v>N-45</c:v>
                </c:pt>
                <c:pt idx="57">
                  <c:v>DBVPG6045</c:v>
                </c:pt>
                <c:pt idx="58">
                  <c:v>YJM981</c:v>
                </c:pt>
                <c:pt idx="59">
                  <c:v>273614N</c:v>
                </c:pt>
                <c:pt idx="60">
                  <c:v>378604X</c:v>
                </c:pt>
                <c:pt idx="61">
                  <c:v>NCYC110</c:v>
                </c:pt>
                <c:pt idx="62">
                  <c:v>UWOPS05-217.3</c:v>
                </c:pt>
                <c:pt idx="63">
                  <c:v>322134S</c:v>
                </c:pt>
                <c:pt idx="64">
                  <c:v>SK1</c:v>
                </c:pt>
                <c:pt idx="65">
                  <c:v>2.3319</c:v>
                </c:pt>
                <c:pt idx="66">
                  <c:v>W303</c:v>
                </c:pt>
                <c:pt idx="67">
                  <c:v>YS4</c:v>
                </c:pt>
                <c:pt idx="68">
                  <c:v>UWOPS91-917.1</c:v>
                </c:pt>
                <c:pt idx="69">
                  <c:v>YS9</c:v>
                </c:pt>
                <c:pt idx="70">
                  <c:v>N-17</c:v>
                </c:pt>
                <c:pt idx="71">
                  <c:v>T21.4</c:v>
                </c:pt>
                <c:pt idx="72">
                  <c:v>Z1.1</c:v>
                </c:pt>
                <c:pt idx="73">
                  <c:v>N-44</c:v>
                </c:pt>
                <c:pt idx="74">
                  <c:v>NBRC10990</c:v>
                </c:pt>
                <c:pt idx="75">
                  <c:v>Y7</c:v>
                </c:pt>
                <c:pt idx="76">
                  <c:v>Y9.6</c:v>
                </c:pt>
                <c:pt idx="77">
                  <c:v>Q62.5</c:v>
                </c:pt>
                <c:pt idx="78">
                  <c:v>322134S</c:v>
                </c:pt>
                <c:pt idx="79">
                  <c:v>YPS128</c:v>
                </c:pt>
                <c:pt idx="80">
                  <c:v>Y9</c:v>
                </c:pt>
                <c:pt idx="81">
                  <c:v>Q95.3</c:v>
                </c:pt>
                <c:pt idx="82">
                  <c:v>YJM975</c:v>
                </c:pt>
                <c:pt idx="83">
                  <c:v>Y6.5</c:v>
                </c:pt>
                <c:pt idx="84">
                  <c:v>DBVPG1373</c:v>
                </c:pt>
                <c:pt idx="85">
                  <c:v>IFO1804</c:v>
                </c:pt>
                <c:pt idx="86">
                  <c:v>YPS606</c:v>
                </c:pt>
                <c:pt idx="87">
                  <c:v>Q89.8</c:v>
                </c:pt>
                <c:pt idx="88">
                  <c:v>YS2</c:v>
                </c:pt>
                <c:pt idx="89">
                  <c:v>UWOPS99-807.1.1</c:v>
                </c:pt>
              </c:strCache>
            </c:strRef>
          </c:xVal>
          <c:yVal>
            <c:numRef>
              <c:f>'lvl acid'!$L$4:$L$93</c:f>
              <c:numCache>
                <c:formatCode>General</c:formatCode>
                <c:ptCount val="90"/>
                <c:pt idx="0">
                  <c:v>66.459627329192557</c:v>
                </c:pt>
                <c:pt idx="1">
                  <c:v>75.396825396825392</c:v>
                </c:pt>
                <c:pt idx="2">
                  <c:v>84.085845089140093</c:v>
                </c:pt>
                <c:pt idx="3">
                  <c:v>85.084033613445399</c:v>
                </c:pt>
                <c:pt idx="4">
                  <c:v>87.577369082840121</c:v>
                </c:pt>
                <c:pt idx="5">
                  <c:v>88.048381095362387</c:v>
                </c:pt>
                <c:pt idx="6">
                  <c:v>88.144329896907209</c:v>
                </c:pt>
                <c:pt idx="7">
                  <c:v>88.608734832454445</c:v>
                </c:pt>
                <c:pt idx="8">
                  <c:v>90.08748351579105</c:v>
                </c:pt>
                <c:pt idx="9">
                  <c:v>90.292031466809576</c:v>
                </c:pt>
                <c:pt idx="10">
                  <c:v>90.635021139997818</c:v>
                </c:pt>
                <c:pt idx="11">
                  <c:v>90.798626870963119</c:v>
                </c:pt>
                <c:pt idx="12">
                  <c:v>90.815083537768174</c:v>
                </c:pt>
                <c:pt idx="13">
                  <c:v>91.617598593113854</c:v>
                </c:pt>
                <c:pt idx="14">
                  <c:v>91.70374895707117</c:v>
                </c:pt>
                <c:pt idx="15">
                  <c:v>91.930439173675722</c:v>
                </c:pt>
                <c:pt idx="16">
                  <c:v>92.075760821347615</c:v>
                </c:pt>
                <c:pt idx="17">
                  <c:v>92.449106001838842</c:v>
                </c:pt>
                <c:pt idx="18">
                  <c:v>92.510715635560743</c:v>
                </c:pt>
                <c:pt idx="19">
                  <c:v>92.658767619848163</c:v>
                </c:pt>
                <c:pt idx="20">
                  <c:v>93.000127163439174</c:v>
                </c:pt>
                <c:pt idx="21">
                  <c:v>93.123772102161098</c:v>
                </c:pt>
                <c:pt idx="22">
                  <c:v>94.195140135304996</c:v>
                </c:pt>
                <c:pt idx="23">
                  <c:v>94.277839994949716</c:v>
                </c:pt>
                <c:pt idx="24">
                  <c:v>94.315892077608311</c:v>
                </c:pt>
                <c:pt idx="25">
                  <c:v>95.17446431052764</c:v>
                </c:pt>
                <c:pt idx="26">
                  <c:v>95.373497934516379</c:v>
                </c:pt>
                <c:pt idx="27">
                  <c:v>95.498709758375313</c:v>
                </c:pt>
                <c:pt idx="28">
                  <c:v>95.6232052292779</c:v>
                </c:pt>
                <c:pt idx="29">
                  <c:v>96</c:v>
                </c:pt>
                <c:pt idx="30">
                  <c:v>96.349457697077341</c:v>
                </c:pt>
                <c:pt idx="31">
                  <c:v>96.677219010167519</c:v>
                </c:pt>
                <c:pt idx="32">
                  <c:v>97.278911564625844</c:v>
                </c:pt>
                <c:pt idx="33">
                  <c:v>97.315436241610726</c:v>
                </c:pt>
                <c:pt idx="34">
                  <c:v>97.72727272727272</c:v>
                </c:pt>
                <c:pt idx="35">
                  <c:v>98.089171974522287</c:v>
                </c:pt>
                <c:pt idx="36">
                  <c:v>98.264585153570522</c:v>
                </c:pt>
                <c:pt idx="37">
                  <c:v>98.657718120805399</c:v>
                </c:pt>
                <c:pt idx="38">
                  <c:v>98.780487804878049</c:v>
                </c:pt>
                <c:pt idx="39">
                  <c:v>98.843930635838134</c:v>
                </c:pt>
                <c:pt idx="40">
                  <c:v>98.958333333333343</c:v>
                </c:pt>
                <c:pt idx="41">
                  <c:v>99.324324324324323</c:v>
                </c:pt>
                <c:pt idx="42">
                  <c:v>99.347331971908261</c:v>
                </c:pt>
                <c:pt idx="43">
                  <c:v>99.999999999999986</c:v>
                </c:pt>
                <c:pt idx="44">
                  <c:v>100.10591089643466</c:v>
                </c:pt>
                <c:pt idx="45">
                  <c:v>100.40506131873693</c:v>
                </c:pt>
                <c:pt idx="46">
                  <c:v>100.65889433892474</c:v>
                </c:pt>
                <c:pt idx="47">
                  <c:v>100.71942446043167</c:v>
                </c:pt>
                <c:pt idx="48">
                  <c:v>101.0859217211194</c:v>
                </c:pt>
                <c:pt idx="49">
                  <c:v>101.38339920948613</c:v>
                </c:pt>
                <c:pt idx="50">
                  <c:v>101.61856866488625</c:v>
                </c:pt>
                <c:pt idx="51">
                  <c:v>101.80053461062764</c:v>
                </c:pt>
                <c:pt idx="52">
                  <c:v>101.8987341772152</c:v>
                </c:pt>
                <c:pt idx="53">
                  <c:v>101.98675496688743</c:v>
                </c:pt>
                <c:pt idx="54">
                  <c:v>102.36004855496607</c:v>
                </c:pt>
                <c:pt idx="55">
                  <c:v>102.54088805173069</c:v>
                </c:pt>
                <c:pt idx="56">
                  <c:v>103.01236137139462</c:v>
                </c:pt>
                <c:pt idx="57">
                  <c:v>103.60962566844911</c:v>
                </c:pt>
                <c:pt idx="58">
                  <c:v>103.84615384615384</c:v>
                </c:pt>
                <c:pt idx="59">
                  <c:v>103.87096774193544</c:v>
                </c:pt>
                <c:pt idx="60">
                  <c:v>103.93700787401573</c:v>
                </c:pt>
                <c:pt idx="61">
                  <c:v>104.01869497411033</c:v>
                </c:pt>
                <c:pt idx="62">
                  <c:v>104.04624277456647</c:v>
                </c:pt>
                <c:pt idx="63">
                  <c:v>104.16666666666667</c:v>
                </c:pt>
                <c:pt idx="64">
                  <c:v>104.61925847874791</c:v>
                </c:pt>
                <c:pt idx="65">
                  <c:v>105.44217687074833</c:v>
                </c:pt>
                <c:pt idx="66">
                  <c:v>106.26963374282938</c:v>
                </c:pt>
                <c:pt idx="67">
                  <c:v>106.36228760645356</c:v>
                </c:pt>
                <c:pt idx="68">
                  <c:v>106.53817893542097</c:v>
                </c:pt>
                <c:pt idx="69">
                  <c:v>107.6456010132864</c:v>
                </c:pt>
                <c:pt idx="70">
                  <c:v>108.38709677419354</c:v>
                </c:pt>
                <c:pt idx="71">
                  <c:v>108.40336134453779</c:v>
                </c:pt>
                <c:pt idx="72">
                  <c:v>108.9217966850053</c:v>
                </c:pt>
                <c:pt idx="73">
                  <c:v>109.75170286368603</c:v>
                </c:pt>
                <c:pt idx="74">
                  <c:v>110.13744173729332</c:v>
                </c:pt>
                <c:pt idx="75">
                  <c:v>110.74380165289257</c:v>
                </c:pt>
                <c:pt idx="76">
                  <c:v>110.78904251516749</c:v>
                </c:pt>
                <c:pt idx="77">
                  <c:v>111.94029850746267</c:v>
                </c:pt>
                <c:pt idx="78">
                  <c:v>114.50381679389312</c:v>
                </c:pt>
                <c:pt idx="79">
                  <c:v>114.62360061048365</c:v>
                </c:pt>
                <c:pt idx="80">
                  <c:v>115.09433962264151</c:v>
                </c:pt>
                <c:pt idx="81">
                  <c:v>116.36363636363637</c:v>
                </c:pt>
                <c:pt idx="82">
                  <c:v>116.79389312977098</c:v>
                </c:pt>
                <c:pt idx="83">
                  <c:v>118.10344827586205</c:v>
                </c:pt>
                <c:pt idx="84">
                  <c:v>118.24324324324324</c:v>
                </c:pt>
                <c:pt idx="85">
                  <c:v>118.75808294098888</c:v>
                </c:pt>
                <c:pt idx="86">
                  <c:v>119.18243728975982</c:v>
                </c:pt>
                <c:pt idx="87">
                  <c:v>121.25984251968505</c:v>
                </c:pt>
                <c:pt idx="88">
                  <c:v>121.9983970013095</c:v>
                </c:pt>
                <c:pt idx="89">
                  <c:v>134.6297681376215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4187456"/>
        <c:axId val="94188032"/>
      </c:scatterChart>
      <c:valAx>
        <c:axId val="94187456"/>
        <c:scaling>
          <c:orientation val="minMax"/>
          <c:max val="100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4188032"/>
        <c:crosses val="autoZero"/>
        <c:crossBetween val="midCat"/>
        <c:majorUnit val="50"/>
      </c:valAx>
      <c:valAx>
        <c:axId val="941880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4187456"/>
        <c:crosses val="autoZero"/>
        <c:crossBetween val="midCat"/>
        <c:majorUnit val="40"/>
      </c:valAx>
    </c:plotArea>
    <c:legend>
      <c:legendPos val="r"/>
      <c:layout>
        <c:manualLayout>
          <c:xMode val="edge"/>
          <c:yMode val="edge"/>
          <c:x val="0.40817532752779434"/>
          <c:y val="0.79287684069611764"/>
          <c:w val="0.56638739078794731"/>
          <c:h val="8.3717191601049873E-2"/>
        </c:manualLayout>
      </c:layout>
      <c:overlay val="0"/>
      <c:txPr>
        <a:bodyPr/>
        <a:lstStyle/>
        <a:p>
          <a:pPr>
            <a:defRPr sz="12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156845871862936"/>
          <c:y val="5.1400554097404488E-2"/>
          <c:w val="0.66990339643923269"/>
          <c:h val="0.81601830065359482"/>
        </c:manualLayout>
      </c:layout>
      <c:scatterChart>
        <c:scatterStyle val="lineMarker"/>
        <c:varyColors val="0"/>
        <c:ser>
          <c:idx val="0"/>
          <c:order val="0"/>
          <c:tx>
            <c:strRef>
              <c:f>HMF!$M$3</c:f>
              <c:strCache>
                <c:ptCount val="1"/>
                <c:pt idx="0">
                  <c:v>HMF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HMF!$B$4:$B$93</c:f>
              <c:strCache>
                <c:ptCount val="90"/>
                <c:pt idx="0">
                  <c:v>L-1764</c:v>
                </c:pt>
                <c:pt idx="1">
                  <c:v>IFO1803</c:v>
                </c:pt>
                <c:pt idx="2">
                  <c:v>CBS5829</c:v>
                </c:pt>
                <c:pt idx="3">
                  <c:v>UFRJ50816</c:v>
                </c:pt>
                <c:pt idx="4">
                  <c:v>DBVPG1853</c:v>
                </c:pt>
                <c:pt idx="5">
                  <c:v>GL379</c:v>
                </c:pt>
                <c:pt idx="6">
                  <c:v>UWOPS99-807.1.1</c:v>
                </c:pt>
                <c:pt idx="7">
                  <c:v>UWOPS83-787.3</c:v>
                </c:pt>
                <c:pt idx="8">
                  <c:v>DBVPG6040</c:v>
                </c:pt>
                <c:pt idx="9">
                  <c:v>SK1</c:v>
                </c:pt>
                <c:pt idx="10">
                  <c:v>Z1.1</c:v>
                </c:pt>
                <c:pt idx="11">
                  <c:v>L-1528</c:v>
                </c:pt>
                <c:pt idx="12">
                  <c:v>2.3319</c:v>
                </c:pt>
                <c:pt idx="13">
                  <c:v>322134S</c:v>
                </c:pt>
                <c:pt idx="14">
                  <c:v>IFO1802</c:v>
                </c:pt>
                <c:pt idx="15">
                  <c:v>BC187</c:v>
                </c:pt>
                <c:pt idx="16">
                  <c:v>IFO1816</c:v>
                </c:pt>
                <c:pt idx="17">
                  <c:v>DBVPG6044</c:v>
                </c:pt>
                <c:pt idx="18">
                  <c:v>ZP594</c:v>
                </c:pt>
                <c:pt idx="19">
                  <c:v>N-17</c:v>
                </c:pt>
                <c:pt idx="20">
                  <c:v>W303</c:v>
                </c:pt>
                <c:pt idx="21">
                  <c:v>A4</c:v>
                </c:pt>
                <c:pt idx="22">
                  <c:v>DBVPG1373</c:v>
                </c:pt>
                <c:pt idx="23">
                  <c:v>RM11</c:v>
                </c:pt>
                <c:pt idx="24">
                  <c:v>Q96.8</c:v>
                </c:pt>
                <c:pt idx="25">
                  <c:v>KPN3829</c:v>
                </c:pt>
                <c:pt idx="26">
                  <c:v>S36.7</c:v>
                </c:pt>
                <c:pt idx="27">
                  <c:v>UWOPS05-227.2</c:v>
                </c:pt>
                <c:pt idx="28">
                  <c:v>ZP452</c:v>
                </c:pt>
                <c:pt idx="29">
                  <c:v>CBS432</c:v>
                </c:pt>
                <c:pt idx="30">
                  <c:v>UFRJ50791</c:v>
                </c:pt>
                <c:pt idx="31">
                  <c:v>NCYC361</c:v>
                </c:pt>
                <c:pt idx="32">
                  <c:v>Y55</c:v>
                </c:pt>
                <c:pt idx="33">
                  <c:v>LD7</c:v>
                </c:pt>
                <c:pt idx="34">
                  <c:v>2.3317</c:v>
                </c:pt>
                <c:pt idx="35">
                  <c:v>CBS4309</c:v>
                </c:pt>
                <c:pt idx="36">
                  <c:v>NCYC110</c:v>
                </c:pt>
                <c:pt idx="37">
                  <c:v>273614N</c:v>
                </c:pt>
                <c:pt idx="38">
                  <c:v>YS4</c:v>
                </c:pt>
                <c:pt idx="39">
                  <c:v>YPS128</c:v>
                </c:pt>
                <c:pt idx="40">
                  <c:v>L-1374</c:v>
                </c:pt>
                <c:pt idx="41">
                  <c:v>Q95.3</c:v>
                </c:pt>
                <c:pt idx="42">
                  <c:v>YS2</c:v>
                </c:pt>
                <c:pt idx="43">
                  <c:v>Q32.3</c:v>
                </c:pt>
                <c:pt idx="44">
                  <c:v>Y8.1</c:v>
                </c:pt>
                <c:pt idx="45">
                  <c:v>Z1</c:v>
                </c:pt>
                <c:pt idx="46">
                  <c:v>DBVP1106</c:v>
                </c:pt>
                <c:pt idx="47">
                  <c:v>N-44</c:v>
                </c:pt>
                <c:pt idx="48">
                  <c:v>YS9</c:v>
                </c:pt>
                <c:pt idx="49">
                  <c:v>378604X</c:v>
                </c:pt>
                <c:pt idx="50">
                  <c:v>Y8.5</c:v>
                </c:pt>
                <c:pt idx="51">
                  <c:v>DBVPG6765</c:v>
                </c:pt>
                <c:pt idx="52">
                  <c:v>A12</c:v>
                </c:pt>
                <c:pt idx="53">
                  <c:v>S288C</c:v>
                </c:pt>
                <c:pt idx="54">
                  <c:v>YPS138</c:v>
                </c:pt>
                <c:pt idx="55">
                  <c:v>N-43</c:v>
                </c:pt>
                <c:pt idx="56">
                  <c:v>Q89.8</c:v>
                </c:pt>
                <c:pt idx="57">
                  <c:v>YPS606</c:v>
                </c:pt>
                <c:pt idx="58">
                  <c:v>N-45</c:v>
                </c:pt>
                <c:pt idx="59">
                  <c:v>Q31.4</c:v>
                </c:pt>
                <c:pt idx="60">
                  <c:v>IFO1804</c:v>
                </c:pt>
                <c:pt idx="61">
                  <c:v>T21.4</c:v>
                </c:pt>
                <c:pt idx="62">
                  <c:v>YIIc17_E5</c:v>
                </c:pt>
                <c:pt idx="63">
                  <c:v>UWOPS87-2421</c:v>
                </c:pt>
                <c:pt idx="64">
                  <c:v>DBVPG6304</c:v>
                </c:pt>
                <c:pt idx="65">
                  <c:v>DBVPG1788</c:v>
                </c:pt>
                <c:pt idx="66">
                  <c:v>Y6.5</c:v>
                </c:pt>
                <c:pt idx="67">
                  <c:v>YJM981</c:v>
                </c:pt>
                <c:pt idx="68">
                  <c:v>DBVPG6045</c:v>
                </c:pt>
                <c:pt idx="69">
                  <c:v>KPN3828</c:v>
                </c:pt>
                <c:pt idx="70">
                  <c:v>Y12</c:v>
                </c:pt>
                <c:pt idx="71">
                  <c:v>IFO1815</c:v>
                </c:pt>
                <c:pt idx="72">
                  <c:v>Y9</c:v>
                </c:pt>
                <c:pt idx="73">
                  <c:v>YJM978</c:v>
                </c:pt>
                <c:pt idx="74">
                  <c:v>YJM789</c:v>
                </c:pt>
                <c:pt idx="75">
                  <c:v>Q59.1</c:v>
                </c:pt>
                <c:pt idx="76">
                  <c:v>UWOPS03-461.4</c:v>
                </c:pt>
                <c:pt idx="77">
                  <c:v>K11</c:v>
                </c:pt>
                <c:pt idx="78">
                  <c:v>NBRC10990</c:v>
                </c:pt>
                <c:pt idx="79">
                  <c:v>UWOPS91-917.1</c:v>
                </c:pt>
                <c:pt idx="80">
                  <c:v>322134S</c:v>
                </c:pt>
                <c:pt idx="81">
                  <c:v>Q62.5</c:v>
                </c:pt>
                <c:pt idx="82">
                  <c:v>ZP555</c:v>
                </c:pt>
                <c:pt idx="83">
                  <c:v>UWOPS05-217.3</c:v>
                </c:pt>
                <c:pt idx="84">
                  <c:v>DBVPG4650</c:v>
                </c:pt>
                <c:pt idx="85">
                  <c:v>Y7</c:v>
                </c:pt>
                <c:pt idx="86">
                  <c:v>Y9.6</c:v>
                </c:pt>
                <c:pt idx="87">
                  <c:v>2.3318</c:v>
                </c:pt>
                <c:pt idx="88">
                  <c:v>YJM975</c:v>
                </c:pt>
                <c:pt idx="89">
                  <c:v>Q74.4</c:v>
                </c:pt>
              </c:strCache>
            </c:strRef>
          </c:xVal>
          <c:yVal>
            <c:numRef>
              <c:f>HMF!$M$4:$M$93</c:f>
              <c:numCache>
                <c:formatCode>General</c:formatCode>
                <c:ptCount val="90"/>
                <c:pt idx="0">
                  <c:v>37.729672057502135</c:v>
                </c:pt>
                <c:pt idx="1">
                  <c:v>50.902890222899359</c:v>
                </c:pt>
                <c:pt idx="2">
                  <c:v>62.73291925465837</c:v>
                </c:pt>
                <c:pt idx="3">
                  <c:v>66.734785127155178</c:v>
                </c:pt>
                <c:pt idx="4">
                  <c:v>67.286132907907884</c:v>
                </c:pt>
                <c:pt idx="5">
                  <c:v>67.538571867032175</c:v>
                </c:pt>
                <c:pt idx="6">
                  <c:v>71.503277543359474</c:v>
                </c:pt>
                <c:pt idx="7">
                  <c:v>74.135898515568869</c:v>
                </c:pt>
                <c:pt idx="8">
                  <c:v>74.666666666666643</c:v>
                </c:pt>
                <c:pt idx="9">
                  <c:v>74.831830717437782</c:v>
                </c:pt>
                <c:pt idx="10">
                  <c:v>75.207907234884587</c:v>
                </c:pt>
                <c:pt idx="11">
                  <c:v>76.079396884071031</c:v>
                </c:pt>
                <c:pt idx="12">
                  <c:v>76.190476190476218</c:v>
                </c:pt>
                <c:pt idx="13">
                  <c:v>77.099236641221353</c:v>
                </c:pt>
                <c:pt idx="14">
                  <c:v>77.103363492073015</c:v>
                </c:pt>
                <c:pt idx="15">
                  <c:v>77.84212619093087</c:v>
                </c:pt>
                <c:pt idx="16">
                  <c:v>78.079713297058646</c:v>
                </c:pt>
                <c:pt idx="17">
                  <c:v>78.449086858955496</c:v>
                </c:pt>
                <c:pt idx="18">
                  <c:v>78.695976196041116</c:v>
                </c:pt>
                <c:pt idx="19">
                  <c:v>78.709677419354847</c:v>
                </c:pt>
                <c:pt idx="20">
                  <c:v>78.773294942237186</c:v>
                </c:pt>
                <c:pt idx="21">
                  <c:v>79.312053592106338</c:v>
                </c:pt>
                <c:pt idx="22">
                  <c:v>79.729729729729726</c:v>
                </c:pt>
                <c:pt idx="23">
                  <c:v>79.76878612716763</c:v>
                </c:pt>
                <c:pt idx="24">
                  <c:v>79.89955028538121</c:v>
                </c:pt>
                <c:pt idx="25">
                  <c:v>79.977005775258974</c:v>
                </c:pt>
                <c:pt idx="26">
                  <c:v>80.405405405405403</c:v>
                </c:pt>
                <c:pt idx="27">
                  <c:v>80.681818181818187</c:v>
                </c:pt>
                <c:pt idx="28">
                  <c:v>81.790555266859684</c:v>
                </c:pt>
                <c:pt idx="29">
                  <c:v>81.879194630872504</c:v>
                </c:pt>
                <c:pt idx="30">
                  <c:v>82.109633983358478</c:v>
                </c:pt>
                <c:pt idx="31">
                  <c:v>82.620159512113332</c:v>
                </c:pt>
                <c:pt idx="32">
                  <c:v>82.999036837290447</c:v>
                </c:pt>
                <c:pt idx="33">
                  <c:v>83.749130635881357</c:v>
                </c:pt>
                <c:pt idx="34">
                  <c:v>84.020618556701038</c:v>
                </c:pt>
                <c:pt idx="35">
                  <c:v>84.033613445378279</c:v>
                </c:pt>
                <c:pt idx="36">
                  <c:v>84.438705331924865</c:v>
                </c:pt>
                <c:pt idx="37">
                  <c:v>85.161290322580641</c:v>
                </c:pt>
                <c:pt idx="38">
                  <c:v>85.344590055477724</c:v>
                </c:pt>
                <c:pt idx="39">
                  <c:v>85.564096230361031</c:v>
                </c:pt>
                <c:pt idx="40">
                  <c:v>85.657017879474864</c:v>
                </c:pt>
                <c:pt idx="41">
                  <c:v>86.363636363636346</c:v>
                </c:pt>
                <c:pt idx="42">
                  <c:v>86.60380034043574</c:v>
                </c:pt>
                <c:pt idx="43">
                  <c:v>87.037037037037038</c:v>
                </c:pt>
                <c:pt idx="44">
                  <c:v>87.24832214765101</c:v>
                </c:pt>
                <c:pt idx="45">
                  <c:v>87.2611464968153</c:v>
                </c:pt>
                <c:pt idx="46">
                  <c:v>87.329529701489179</c:v>
                </c:pt>
                <c:pt idx="47">
                  <c:v>87.471281981584355</c:v>
                </c:pt>
                <c:pt idx="48">
                  <c:v>87.954332535246181</c:v>
                </c:pt>
                <c:pt idx="49">
                  <c:v>88.18897637795277</c:v>
                </c:pt>
                <c:pt idx="50">
                  <c:v>88.529089684413449</c:v>
                </c:pt>
                <c:pt idx="51">
                  <c:v>88.671861158876681</c:v>
                </c:pt>
                <c:pt idx="52">
                  <c:v>88.828966142115888</c:v>
                </c:pt>
                <c:pt idx="53">
                  <c:v>88.866785907175981</c:v>
                </c:pt>
                <c:pt idx="54">
                  <c:v>88.882847717815679</c:v>
                </c:pt>
                <c:pt idx="55">
                  <c:v>89.279826984807997</c:v>
                </c:pt>
                <c:pt idx="56">
                  <c:v>89.763779527559052</c:v>
                </c:pt>
                <c:pt idx="57">
                  <c:v>90.029898672120737</c:v>
                </c:pt>
                <c:pt idx="58">
                  <c:v>90.135816199970293</c:v>
                </c:pt>
                <c:pt idx="59">
                  <c:v>90.139586462500205</c:v>
                </c:pt>
                <c:pt idx="60">
                  <c:v>90.59110173062615</c:v>
                </c:pt>
                <c:pt idx="61">
                  <c:v>90.756302521008394</c:v>
                </c:pt>
                <c:pt idx="62">
                  <c:v>90.962671905697405</c:v>
                </c:pt>
                <c:pt idx="63">
                  <c:v>91.094069458296048</c:v>
                </c:pt>
                <c:pt idx="64">
                  <c:v>91.176595258273736</c:v>
                </c:pt>
                <c:pt idx="65">
                  <c:v>91.772151898734194</c:v>
                </c:pt>
                <c:pt idx="66">
                  <c:v>92.241379310344797</c:v>
                </c:pt>
                <c:pt idx="67">
                  <c:v>92.307692307692307</c:v>
                </c:pt>
                <c:pt idx="68">
                  <c:v>92.914438502673733</c:v>
                </c:pt>
                <c:pt idx="69">
                  <c:v>93.346462247628409</c:v>
                </c:pt>
                <c:pt idx="70">
                  <c:v>93.440698148285705</c:v>
                </c:pt>
                <c:pt idx="71">
                  <c:v>93.636180780395094</c:v>
                </c:pt>
                <c:pt idx="72">
                  <c:v>93.710691823899353</c:v>
                </c:pt>
                <c:pt idx="73">
                  <c:v>93.902439024390233</c:v>
                </c:pt>
                <c:pt idx="74">
                  <c:v>94.195140135304982</c:v>
                </c:pt>
                <c:pt idx="75">
                  <c:v>94.701986754966896</c:v>
                </c:pt>
                <c:pt idx="76">
                  <c:v>94.791666666666686</c:v>
                </c:pt>
                <c:pt idx="77">
                  <c:v>95.059288537549406</c:v>
                </c:pt>
                <c:pt idx="78">
                  <c:v>95.568997063048158</c:v>
                </c:pt>
                <c:pt idx="79">
                  <c:v>97.180095650552929</c:v>
                </c:pt>
                <c:pt idx="80">
                  <c:v>97.222222222222243</c:v>
                </c:pt>
                <c:pt idx="81">
                  <c:v>97.761194029850756</c:v>
                </c:pt>
                <c:pt idx="82">
                  <c:v>99.23834544247002</c:v>
                </c:pt>
                <c:pt idx="83">
                  <c:v>99.999999999999986</c:v>
                </c:pt>
                <c:pt idx="84">
                  <c:v>101.58730158730161</c:v>
                </c:pt>
                <c:pt idx="85">
                  <c:v>101.65289256198349</c:v>
                </c:pt>
                <c:pt idx="86">
                  <c:v>103.17929009998423</c:v>
                </c:pt>
                <c:pt idx="87">
                  <c:v>103.35731414868108</c:v>
                </c:pt>
                <c:pt idx="88">
                  <c:v>106.10687022900763</c:v>
                </c:pt>
                <c:pt idx="89">
                  <c:v>108.3119538349707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4189760"/>
        <c:axId val="94190336"/>
      </c:scatterChart>
      <c:valAx>
        <c:axId val="94189760"/>
        <c:scaling>
          <c:orientation val="minMax"/>
          <c:max val="100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4190336"/>
        <c:crosses val="autoZero"/>
        <c:crossBetween val="midCat"/>
        <c:majorUnit val="50"/>
      </c:valAx>
      <c:valAx>
        <c:axId val="94190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418976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1037414635253084"/>
          <c:y val="0.76954509803921567"/>
          <c:w val="0.29748390713064538"/>
          <c:h val="8.3717191601049873E-2"/>
        </c:manualLayout>
      </c:layout>
      <c:overlay val="0"/>
      <c:txPr>
        <a:bodyPr/>
        <a:lstStyle/>
        <a:p>
          <a:pPr>
            <a:defRPr sz="12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29201456377125"/>
          <c:y val="5.1400554097404488E-2"/>
          <c:w val="0.61174768676941615"/>
          <c:h val="0.82071820615796509"/>
        </c:manualLayout>
      </c:layout>
      <c:scatterChart>
        <c:scatterStyle val="lineMarker"/>
        <c:varyColors val="0"/>
        <c:ser>
          <c:idx val="0"/>
          <c:order val="0"/>
          <c:tx>
            <c:strRef>
              <c:f>furfural!$N$3</c:f>
              <c:strCache>
                <c:ptCount val="1"/>
                <c:pt idx="0">
                  <c:v>Furfural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furfural!$B$4:$B$93</c:f>
              <c:strCache>
                <c:ptCount val="90"/>
                <c:pt idx="0">
                  <c:v>IFO1803</c:v>
                </c:pt>
                <c:pt idx="1">
                  <c:v>L-1764</c:v>
                </c:pt>
                <c:pt idx="2">
                  <c:v>GL379</c:v>
                </c:pt>
                <c:pt idx="3">
                  <c:v>UWOPS99-807.1.1</c:v>
                </c:pt>
                <c:pt idx="4">
                  <c:v>DBVPG1853</c:v>
                </c:pt>
                <c:pt idx="5">
                  <c:v>DBVPG4650</c:v>
                </c:pt>
                <c:pt idx="6">
                  <c:v>Y9.6</c:v>
                </c:pt>
                <c:pt idx="7">
                  <c:v>CBS4309</c:v>
                </c:pt>
                <c:pt idx="8">
                  <c:v>Y12</c:v>
                </c:pt>
                <c:pt idx="9">
                  <c:v>A4</c:v>
                </c:pt>
                <c:pt idx="10">
                  <c:v>Z1.1</c:v>
                </c:pt>
                <c:pt idx="11">
                  <c:v>CBS5829</c:v>
                </c:pt>
                <c:pt idx="12">
                  <c:v>YIIc17_E5</c:v>
                </c:pt>
                <c:pt idx="13">
                  <c:v>K11</c:v>
                </c:pt>
                <c:pt idx="14">
                  <c:v>UWOPS83-787.3</c:v>
                </c:pt>
                <c:pt idx="15">
                  <c:v>S288C</c:v>
                </c:pt>
                <c:pt idx="16">
                  <c:v>ZP452</c:v>
                </c:pt>
                <c:pt idx="17">
                  <c:v>DBVPG1373</c:v>
                </c:pt>
                <c:pt idx="18">
                  <c:v>2.3318</c:v>
                </c:pt>
                <c:pt idx="19">
                  <c:v>A12</c:v>
                </c:pt>
                <c:pt idx="20">
                  <c:v>Q74.4</c:v>
                </c:pt>
                <c:pt idx="21">
                  <c:v>IFO1816</c:v>
                </c:pt>
                <c:pt idx="22">
                  <c:v>S36.7</c:v>
                </c:pt>
                <c:pt idx="23">
                  <c:v>2.3319</c:v>
                </c:pt>
                <c:pt idx="24">
                  <c:v>UWOPS05-227.2</c:v>
                </c:pt>
                <c:pt idx="25">
                  <c:v>Q32.3</c:v>
                </c:pt>
                <c:pt idx="26">
                  <c:v>YS4</c:v>
                </c:pt>
                <c:pt idx="27">
                  <c:v>IFO1802</c:v>
                </c:pt>
                <c:pt idx="28">
                  <c:v>ZP594</c:v>
                </c:pt>
                <c:pt idx="29">
                  <c:v>273614N</c:v>
                </c:pt>
                <c:pt idx="30">
                  <c:v>NCYC361</c:v>
                </c:pt>
                <c:pt idx="31">
                  <c:v>CBS432</c:v>
                </c:pt>
                <c:pt idx="32">
                  <c:v>LD7</c:v>
                </c:pt>
                <c:pt idx="33">
                  <c:v>YPS138</c:v>
                </c:pt>
                <c:pt idx="34">
                  <c:v>Q95.3</c:v>
                </c:pt>
                <c:pt idx="35">
                  <c:v>ZP555</c:v>
                </c:pt>
                <c:pt idx="36">
                  <c:v>KPN3829</c:v>
                </c:pt>
                <c:pt idx="37">
                  <c:v>YJM981</c:v>
                </c:pt>
                <c:pt idx="38">
                  <c:v>UFRJ50816</c:v>
                </c:pt>
                <c:pt idx="39">
                  <c:v>2.3317</c:v>
                </c:pt>
                <c:pt idx="40">
                  <c:v>N-17</c:v>
                </c:pt>
                <c:pt idx="41">
                  <c:v>IFO1804</c:v>
                </c:pt>
                <c:pt idx="42">
                  <c:v>Z1</c:v>
                </c:pt>
                <c:pt idx="43">
                  <c:v>UWOPS87-2421</c:v>
                </c:pt>
                <c:pt idx="44">
                  <c:v>YS2</c:v>
                </c:pt>
                <c:pt idx="45">
                  <c:v>DBVPG6040</c:v>
                </c:pt>
                <c:pt idx="46">
                  <c:v>SK1</c:v>
                </c:pt>
                <c:pt idx="47">
                  <c:v>UWOPS03-461.4</c:v>
                </c:pt>
                <c:pt idx="48">
                  <c:v>L-1374</c:v>
                </c:pt>
                <c:pt idx="49">
                  <c:v>IFO1815</c:v>
                </c:pt>
                <c:pt idx="50">
                  <c:v>BC187</c:v>
                </c:pt>
                <c:pt idx="51">
                  <c:v>L-1528</c:v>
                </c:pt>
                <c:pt idx="52">
                  <c:v>W303</c:v>
                </c:pt>
                <c:pt idx="53">
                  <c:v>Q31.4</c:v>
                </c:pt>
                <c:pt idx="54">
                  <c:v>DBVPG6044</c:v>
                </c:pt>
                <c:pt idx="55">
                  <c:v>UFRJ50791</c:v>
                </c:pt>
                <c:pt idx="56">
                  <c:v>Y8.5</c:v>
                </c:pt>
                <c:pt idx="57">
                  <c:v>RM11</c:v>
                </c:pt>
                <c:pt idx="58">
                  <c:v>Y8.1</c:v>
                </c:pt>
                <c:pt idx="59">
                  <c:v>Q59.1</c:v>
                </c:pt>
                <c:pt idx="60">
                  <c:v>DBVP1106</c:v>
                </c:pt>
                <c:pt idx="61">
                  <c:v>Y9</c:v>
                </c:pt>
                <c:pt idx="62">
                  <c:v>322134S</c:v>
                </c:pt>
                <c:pt idx="63">
                  <c:v>NCYC110</c:v>
                </c:pt>
                <c:pt idx="64">
                  <c:v>Q96.8</c:v>
                </c:pt>
                <c:pt idx="65">
                  <c:v>DBVPG6304</c:v>
                </c:pt>
                <c:pt idx="66">
                  <c:v>YPS606</c:v>
                </c:pt>
                <c:pt idx="67">
                  <c:v>YJM789</c:v>
                </c:pt>
                <c:pt idx="68">
                  <c:v>YJM975</c:v>
                </c:pt>
                <c:pt idx="69">
                  <c:v>KPN3828</c:v>
                </c:pt>
                <c:pt idx="70">
                  <c:v>N-45</c:v>
                </c:pt>
                <c:pt idx="71">
                  <c:v>Q89.8</c:v>
                </c:pt>
                <c:pt idx="72">
                  <c:v>UWOPS05-217.3</c:v>
                </c:pt>
                <c:pt idx="73">
                  <c:v>N-43</c:v>
                </c:pt>
                <c:pt idx="74">
                  <c:v>DBVPG6765</c:v>
                </c:pt>
                <c:pt idx="75">
                  <c:v>YS9</c:v>
                </c:pt>
                <c:pt idx="76">
                  <c:v>322134S</c:v>
                </c:pt>
                <c:pt idx="77">
                  <c:v>Y55</c:v>
                </c:pt>
                <c:pt idx="78">
                  <c:v>T21.4</c:v>
                </c:pt>
                <c:pt idx="79">
                  <c:v>Y7</c:v>
                </c:pt>
                <c:pt idx="80">
                  <c:v>DBVPG6045</c:v>
                </c:pt>
                <c:pt idx="81">
                  <c:v>Q62.5</c:v>
                </c:pt>
                <c:pt idx="82">
                  <c:v>DBVPG1788</c:v>
                </c:pt>
                <c:pt idx="83">
                  <c:v>YJM978</c:v>
                </c:pt>
                <c:pt idx="84">
                  <c:v>N-44</c:v>
                </c:pt>
                <c:pt idx="85">
                  <c:v>NBRC10990</c:v>
                </c:pt>
                <c:pt idx="86">
                  <c:v>Y6.5</c:v>
                </c:pt>
                <c:pt idx="87">
                  <c:v>UWOPS91-917.1</c:v>
                </c:pt>
                <c:pt idx="88">
                  <c:v>YPS128</c:v>
                </c:pt>
                <c:pt idx="89">
                  <c:v>378604X</c:v>
                </c:pt>
              </c:strCache>
            </c:strRef>
          </c:xVal>
          <c:yVal>
            <c:numRef>
              <c:f>furfural!$N$4:$N$93</c:f>
              <c:numCache>
                <c:formatCode>General</c:formatCode>
                <c:ptCount val="90"/>
                <c:pt idx="0">
                  <c:v>17.596060817792374</c:v>
                </c:pt>
                <c:pt idx="1">
                  <c:v>33.333333333333343</c:v>
                </c:pt>
                <c:pt idx="2">
                  <c:v>57.005033135476666</c:v>
                </c:pt>
                <c:pt idx="3">
                  <c:v>58.339566192969329</c:v>
                </c:pt>
                <c:pt idx="4">
                  <c:v>58.875366294419393</c:v>
                </c:pt>
                <c:pt idx="5">
                  <c:v>63.718820861677997</c:v>
                </c:pt>
                <c:pt idx="6">
                  <c:v>63.787630539035845</c:v>
                </c:pt>
                <c:pt idx="7">
                  <c:v>65.126050420168184</c:v>
                </c:pt>
                <c:pt idx="8">
                  <c:v>65.291199124534359</c:v>
                </c:pt>
                <c:pt idx="9">
                  <c:v>65.637561593467325</c:v>
                </c:pt>
                <c:pt idx="10">
                  <c:v>66.131090844467494</c:v>
                </c:pt>
                <c:pt idx="11">
                  <c:v>66.459627329192557</c:v>
                </c:pt>
                <c:pt idx="12">
                  <c:v>66.601178781925327</c:v>
                </c:pt>
                <c:pt idx="13">
                  <c:v>67.984189723320171</c:v>
                </c:pt>
                <c:pt idx="14">
                  <c:v>68.625797950222548</c:v>
                </c:pt>
                <c:pt idx="15">
                  <c:v>70.312182256227146</c:v>
                </c:pt>
                <c:pt idx="16">
                  <c:v>71.380848232895715</c:v>
                </c:pt>
                <c:pt idx="17">
                  <c:v>71.621621621621628</c:v>
                </c:pt>
                <c:pt idx="18">
                  <c:v>71.942446043165461</c:v>
                </c:pt>
                <c:pt idx="19">
                  <c:v>72.317228906287312</c:v>
                </c:pt>
                <c:pt idx="20">
                  <c:v>73.075532624333277</c:v>
                </c:pt>
                <c:pt idx="21">
                  <c:v>73.274807863393505</c:v>
                </c:pt>
                <c:pt idx="22">
                  <c:v>73.648648648648646</c:v>
                </c:pt>
                <c:pt idx="23">
                  <c:v>74.829931972789126</c:v>
                </c:pt>
                <c:pt idx="24">
                  <c:v>75</c:v>
                </c:pt>
                <c:pt idx="25">
                  <c:v>75.308641975308632</c:v>
                </c:pt>
                <c:pt idx="26">
                  <c:v>75.791091168670505</c:v>
                </c:pt>
                <c:pt idx="27">
                  <c:v>76.500993464791208</c:v>
                </c:pt>
                <c:pt idx="28">
                  <c:v>76.96003554465787</c:v>
                </c:pt>
                <c:pt idx="29">
                  <c:v>77.41935483870968</c:v>
                </c:pt>
                <c:pt idx="30">
                  <c:v>77.662949941386515</c:v>
                </c:pt>
                <c:pt idx="31">
                  <c:v>77.852348993288572</c:v>
                </c:pt>
                <c:pt idx="32">
                  <c:v>77.933218786167345</c:v>
                </c:pt>
                <c:pt idx="33">
                  <c:v>77.933511404751414</c:v>
                </c:pt>
                <c:pt idx="34">
                  <c:v>78.181818181818201</c:v>
                </c:pt>
                <c:pt idx="35">
                  <c:v>78.630382578408714</c:v>
                </c:pt>
                <c:pt idx="36">
                  <c:v>79.380162448577934</c:v>
                </c:pt>
                <c:pt idx="37">
                  <c:v>79.487179487179489</c:v>
                </c:pt>
                <c:pt idx="38">
                  <c:v>79.59194556449701</c:v>
                </c:pt>
                <c:pt idx="39">
                  <c:v>79.896907216494853</c:v>
                </c:pt>
                <c:pt idx="40">
                  <c:v>79.999999999999986</c:v>
                </c:pt>
                <c:pt idx="41">
                  <c:v>80.694594818877079</c:v>
                </c:pt>
                <c:pt idx="42">
                  <c:v>80.891719745222929</c:v>
                </c:pt>
                <c:pt idx="43">
                  <c:v>81.147015896757992</c:v>
                </c:pt>
                <c:pt idx="44">
                  <c:v>81.332264667539661</c:v>
                </c:pt>
                <c:pt idx="45">
                  <c:v>81.3333333333333</c:v>
                </c:pt>
                <c:pt idx="46">
                  <c:v>81.370534372359486</c:v>
                </c:pt>
                <c:pt idx="47">
                  <c:v>81.770833333333343</c:v>
                </c:pt>
                <c:pt idx="48">
                  <c:v>83.277656271711678</c:v>
                </c:pt>
                <c:pt idx="49">
                  <c:v>83.311278717157606</c:v>
                </c:pt>
                <c:pt idx="50">
                  <c:v>83.48285997288238</c:v>
                </c:pt>
                <c:pt idx="51">
                  <c:v>83.687336572478131</c:v>
                </c:pt>
                <c:pt idx="52">
                  <c:v>83.975304985592459</c:v>
                </c:pt>
                <c:pt idx="53">
                  <c:v>84.767028328973694</c:v>
                </c:pt>
                <c:pt idx="54">
                  <c:v>84.775626121774508</c:v>
                </c:pt>
                <c:pt idx="55">
                  <c:v>85.267696828872275</c:v>
                </c:pt>
                <c:pt idx="56">
                  <c:v>85.344590055477724</c:v>
                </c:pt>
                <c:pt idx="57">
                  <c:v>85.549132947976858</c:v>
                </c:pt>
                <c:pt idx="58">
                  <c:v>85.90604026845638</c:v>
                </c:pt>
                <c:pt idx="59">
                  <c:v>86.092715231788063</c:v>
                </c:pt>
                <c:pt idx="60">
                  <c:v>86.747332836812575</c:v>
                </c:pt>
                <c:pt idx="61">
                  <c:v>86.79245283018868</c:v>
                </c:pt>
                <c:pt idx="62">
                  <c:v>86.805555555555586</c:v>
                </c:pt>
                <c:pt idx="63">
                  <c:v>87.498078713516364</c:v>
                </c:pt>
                <c:pt idx="64">
                  <c:v>87.537007297954418</c:v>
                </c:pt>
                <c:pt idx="65">
                  <c:v>88.075350521597755</c:v>
                </c:pt>
                <c:pt idx="66">
                  <c:v>88.315043459318417</c:v>
                </c:pt>
                <c:pt idx="67">
                  <c:v>88.571549679465875</c:v>
                </c:pt>
                <c:pt idx="68">
                  <c:v>89.312977099236647</c:v>
                </c:pt>
                <c:pt idx="69">
                  <c:v>89.362162029741839</c:v>
                </c:pt>
                <c:pt idx="70">
                  <c:v>89.575966409908347</c:v>
                </c:pt>
                <c:pt idx="71">
                  <c:v>89.763779527559052</c:v>
                </c:pt>
                <c:pt idx="72">
                  <c:v>90.173410404624249</c:v>
                </c:pt>
                <c:pt idx="73">
                  <c:v>91.126995818976425</c:v>
                </c:pt>
                <c:pt idx="74">
                  <c:v>91.627589864172577</c:v>
                </c:pt>
                <c:pt idx="75">
                  <c:v>91.892586230854235</c:v>
                </c:pt>
                <c:pt idx="76">
                  <c:v>92.36641221374046</c:v>
                </c:pt>
                <c:pt idx="77">
                  <c:v>92.430745568800731</c:v>
                </c:pt>
                <c:pt idx="78">
                  <c:v>93.277310924369743</c:v>
                </c:pt>
                <c:pt idx="79">
                  <c:v>93.388429752066145</c:v>
                </c:pt>
                <c:pt idx="80">
                  <c:v>94.25133689839565</c:v>
                </c:pt>
                <c:pt idx="81">
                  <c:v>94.776119402985088</c:v>
                </c:pt>
                <c:pt idx="82">
                  <c:v>94.936708860759524</c:v>
                </c:pt>
                <c:pt idx="83">
                  <c:v>96.34146341463412</c:v>
                </c:pt>
                <c:pt idx="84">
                  <c:v>96.548490489107238</c:v>
                </c:pt>
                <c:pt idx="85">
                  <c:v>96.734472636987761</c:v>
                </c:pt>
                <c:pt idx="86">
                  <c:v>97.41379310344827</c:v>
                </c:pt>
                <c:pt idx="87">
                  <c:v>97.899948210927377</c:v>
                </c:pt>
                <c:pt idx="88">
                  <c:v>98.479431510415509</c:v>
                </c:pt>
                <c:pt idx="89">
                  <c:v>101.574803149606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4233152"/>
        <c:axId val="94233728"/>
      </c:scatterChart>
      <c:valAx>
        <c:axId val="94233152"/>
        <c:scaling>
          <c:orientation val="minMax"/>
          <c:max val="100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4233728"/>
        <c:crosses val="autoZero"/>
        <c:crossBetween val="midCat"/>
        <c:majorUnit val="50"/>
      </c:valAx>
      <c:valAx>
        <c:axId val="94233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423315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3985309630407408"/>
          <c:y val="0.76434586471601063"/>
          <c:w val="0.4206399206661709"/>
          <c:h val="8.3717191601049873E-2"/>
        </c:manualLayout>
      </c:layout>
      <c:overlay val="0"/>
      <c:txPr>
        <a:bodyPr/>
        <a:lstStyle/>
        <a:p>
          <a:pPr>
            <a:defRPr sz="12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665870340288946"/>
          <c:y val="5.1400554097404488E-2"/>
          <c:w val="0.68112026251561142"/>
          <c:h val="0.81490963855421705"/>
        </c:manualLayout>
      </c:layout>
      <c:scatterChart>
        <c:scatterStyle val="lineMarker"/>
        <c:varyColors val="0"/>
        <c:ser>
          <c:idx val="0"/>
          <c:order val="0"/>
          <c:tx>
            <c:strRef>
              <c:f>vanillin!$O$3</c:f>
              <c:strCache>
                <c:ptCount val="1"/>
                <c:pt idx="0">
                  <c:v>Vanillin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vanillin!$B$4:$B$93</c:f>
              <c:strCache>
                <c:ptCount val="90"/>
                <c:pt idx="0">
                  <c:v>IFO1803</c:v>
                </c:pt>
                <c:pt idx="1">
                  <c:v>L-1764</c:v>
                </c:pt>
                <c:pt idx="2">
                  <c:v>DBVPG6045</c:v>
                </c:pt>
                <c:pt idx="3">
                  <c:v>UWOPS99-807.1.1</c:v>
                </c:pt>
                <c:pt idx="4">
                  <c:v>DBVPG1853</c:v>
                </c:pt>
                <c:pt idx="5">
                  <c:v>GL379</c:v>
                </c:pt>
                <c:pt idx="6">
                  <c:v>A4</c:v>
                </c:pt>
                <c:pt idx="7">
                  <c:v>UWOPS83-787.3</c:v>
                </c:pt>
                <c:pt idx="8">
                  <c:v>CBS5829</c:v>
                </c:pt>
                <c:pt idx="9">
                  <c:v>UFRJ50816</c:v>
                </c:pt>
                <c:pt idx="10">
                  <c:v>ZP452</c:v>
                </c:pt>
                <c:pt idx="11">
                  <c:v>IFO1816</c:v>
                </c:pt>
                <c:pt idx="12">
                  <c:v>Z1.1</c:v>
                </c:pt>
                <c:pt idx="13">
                  <c:v>CBS4309</c:v>
                </c:pt>
                <c:pt idx="14">
                  <c:v>BC187</c:v>
                </c:pt>
                <c:pt idx="15">
                  <c:v>UWOPS05-227.2</c:v>
                </c:pt>
                <c:pt idx="16">
                  <c:v>IFO1802</c:v>
                </c:pt>
                <c:pt idx="17">
                  <c:v>KPN3829</c:v>
                </c:pt>
                <c:pt idx="18">
                  <c:v>DBVPG6765</c:v>
                </c:pt>
                <c:pt idx="19">
                  <c:v>273614N</c:v>
                </c:pt>
                <c:pt idx="20">
                  <c:v>LD7</c:v>
                </c:pt>
                <c:pt idx="21">
                  <c:v>Q31.4</c:v>
                </c:pt>
                <c:pt idx="22">
                  <c:v>UFRJ50791</c:v>
                </c:pt>
                <c:pt idx="23">
                  <c:v>DBVP1106</c:v>
                </c:pt>
                <c:pt idx="24">
                  <c:v>NCYC361</c:v>
                </c:pt>
                <c:pt idx="25">
                  <c:v>S36.7</c:v>
                </c:pt>
                <c:pt idx="26">
                  <c:v>YPS138</c:v>
                </c:pt>
                <c:pt idx="27">
                  <c:v>2.3317</c:v>
                </c:pt>
                <c:pt idx="28">
                  <c:v>Q32.3</c:v>
                </c:pt>
                <c:pt idx="29">
                  <c:v>A12</c:v>
                </c:pt>
                <c:pt idx="30">
                  <c:v>N-45</c:v>
                </c:pt>
                <c:pt idx="31">
                  <c:v>ZP594</c:v>
                </c:pt>
                <c:pt idx="32">
                  <c:v>YS4</c:v>
                </c:pt>
                <c:pt idx="33">
                  <c:v>Y8.1</c:v>
                </c:pt>
                <c:pt idx="34">
                  <c:v>DBVPG4650</c:v>
                </c:pt>
                <c:pt idx="35">
                  <c:v>N-17</c:v>
                </c:pt>
                <c:pt idx="36">
                  <c:v>Y8.5</c:v>
                </c:pt>
                <c:pt idx="37">
                  <c:v>N-43</c:v>
                </c:pt>
                <c:pt idx="38">
                  <c:v>RM11</c:v>
                </c:pt>
                <c:pt idx="39">
                  <c:v>CBS432</c:v>
                </c:pt>
                <c:pt idx="40">
                  <c:v>L-1374</c:v>
                </c:pt>
                <c:pt idx="41">
                  <c:v>DBVPG1373</c:v>
                </c:pt>
                <c:pt idx="42">
                  <c:v>Y12</c:v>
                </c:pt>
                <c:pt idx="43">
                  <c:v>SK1</c:v>
                </c:pt>
                <c:pt idx="44">
                  <c:v>S288C</c:v>
                </c:pt>
                <c:pt idx="45">
                  <c:v>YJM789</c:v>
                </c:pt>
                <c:pt idx="46">
                  <c:v>2.3319</c:v>
                </c:pt>
                <c:pt idx="47">
                  <c:v>YS9</c:v>
                </c:pt>
                <c:pt idx="48">
                  <c:v>Q96.8</c:v>
                </c:pt>
                <c:pt idx="49">
                  <c:v>Z1</c:v>
                </c:pt>
                <c:pt idx="50">
                  <c:v>Q59.1</c:v>
                </c:pt>
                <c:pt idx="51">
                  <c:v>DBVPG6044</c:v>
                </c:pt>
                <c:pt idx="52">
                  <c:v>UWOPS05-217.3</c:v>
                </c:pt>
                <c:pt idx="53">
                  <c:v>K11</c:v>
                </c:pt>
                <c:pt idx="54">
                  <c:v>Y9.6</c:v>
                </c:pt>
                <c:pt idx="55">
                  <c:v>IFO1815</c:v>
                </c:pt>
                <c:pt idx="56">
                  <c:v>YIIc17_E5</c:v>
                </c:pt>
                <c:pt idx="57">
                  <c:v>UWOPS03-461.4</c:v>
                </c:pt>
                <c:pt idx="58">
                  <c:v>NBRC10990</c:v>
                </c:pt>
                <c:pt idx="59">
                  <c:v>N-44</c:v>
                </c:pt>
                <c:pt idx="60">
                  <c:v>UWOPS87-2421</c:v>
                </c:pt>
                <c:pt idx="61">
                  <c:v>ZP555</c:v>
                </c:pt>
                <c:pt idx="62">
                  <c:v>NCYC110</c:v>
                </c:pt>
                <c:pt idx="63">
                  <c:v>YJM978</c:v>
                </c:pt>
                <c:pt idx="64">
                  <c:v>L-1528</c:v>
                </c:pt>
                <c:pt idx="65">
                  <c:v>IFO1804</c:v>
                </c:pt>
                <c:pt idx="66">
                  <c:v>T21.4</c:v>
                </c:pt>
                <c:pt idx="67">
                  <c:v>YJM981</c:v>
                </c:pt>
                <c:pt idx="68">
                  <c:v>DBVPG6304</c:v>
                </c:pt>
                <c:pt idx="69">
                  <c:v>YS2</c:v>
                </c:pt>
                <c:pt idx="70">
                  <c:v>Y55</c:v>
                </c:pt>
                <c:pt idx="71">
                  <c:v>W303</c:v>
                </c:pt>
                <c:pt idx="72">
                  <c:v>2.3318</c:v>
                </c:pt>
                <c:pt idx="73">
                  <c:v>Y6.5</c:v>
                </c:pt>
                <c:pt idx="74">
                  <c:v>DBVPG1788</c:v>
                </c:pt>
                <c:pt idx="75">
                  <c:v>YPS128</c:v>
                </c:pt>
                <c:pt idx="76">
                  <c:v>Q62.5</c:v>
                </c:pt>
                <c:pt idx="77">
                  <c:v>DBVPG6040</c:v>
                </c:pt>
                <c:pt idx="78">
                  <c:v>Y7</c:v>
                </c:pt>
                <c:pt idx="79">
                  <c:v>KPN3828</c:v>
                </c:pt>
                <c:pt idx="80">
                  <c:v>Y9</c:v>
                </c:pt>
                <c:pt idx="81">
                  <c:v>Q89.8</c:v>
                </c:pt>
                <c:pt idx="82">
                  <c:v>322134S</c:v>
                </c:pt>
                <c:pt idx="83">
                  <c:v>Q74.4</c:v>
                </c:pt>
                <c:pt idx="84">
                  <c:v>UWOPS91-917.1</c:v>
                </c:pt>
                <c:pt idx="85">
                  <c:v>378604X</c:v>
                </c:pt>
                <c:pt idx="86">
                  <c:v>YJM975</c:v>
                </c:pt>
                <c:pt idx="87">
                  <c:v>322134S</c:v>
                </c:pt>
                <c:pt idx="88">
                  <c:v>YPS606</c:v>
                </c:pt>
                <c:pt idx="89">
                  <c:v>Q95.3</c:v>
                </c:pt>
              </c:strCache>
            </c:strRef>
          </c:xVal>
          <c:yVal>
            <c:numRef>
              <c:f>vanillin!$O$4:$O$93</c:f>
              <c:numCache>
                <c:formatCode>General</c:formatCode>
                <c:ptCount val="90"/>
                <c:pt idx="0">
                  <c:v>13.197045613344278</c:v>
                </c:pt>
                <c:pt idx="1">
                  <c:v>27.777777777777786</c:v>
                </c:pt>
                <c:pt idx="2">
                  <c:v>46.791443850267349</c:v>
                </c:pt>
                <c:pt idx="3">
                  <c:v>51.608077786088245</c:v>
                </c:pt>
                <c:pt idx="4">
                  <c:v>66.843460980882156</c:v>
                </c:pt>
                <c:pt idx="5">
                  <c:v>68.158191792417753</c:v>
                </c:pt>
                <c:pt idx="6">
                  <c:v>70.560378712977382</c:v>
                </c:pt>
                <c:pt idx="7">
                  <c:v>73.134062049142273</c:v>
                </c:pt>
                <c:pt idx="8">
                  <c:v>73.91304347826086</c:v>
                </c:pt>
                <c:pt idx="9">
                  <c:v>75.918471153827923</c:v>
                </c:pt>
                <c:pt idx="10">
                  <c:v>78.320652922205028</c:v>
                </c:pt>
                <c:pt idx="11">
                  <c:v>80.482166013891245</c:v>
                </c:pt>
                <c:pt idx="12">
                  <c:v>81.043003485867033</c:v>
                </c:pt>
                <c:pt idx="13">
                  <c:v>82.983193277310846</c:v>
                </c:pt>
                <c:pt idx="14">
                  <c:v>83.482859972882395</c:v>
                </c:pt>
                <c:pt idx="15">
                  <c:v>85.795454545454547</c:v>
                </c:pt>
                <c:pt idx="16">
                  <c:v>86.741283928582135</c:v>
                </c:pt>
                <c:pt idx="17">
                  <c:v>87.139125695431403</c:v>
                </c:pt>
                <c:pt idx="18">
                  <c:v>87.489569676758322</c:v>
                </c:pt>
                <c:pt idx="19">
                  <c:v>87.741935483870975</c:v>
                </c:pt>
                <c:pt idx="20">
                  <c:v>87.820268930681124</c:v>
                </c:pt>
                <c:pt idx="21">
                  <c:v>88.348733751324687</c:v>
                </c:pt>
                <c:pt idx="22">
                  <c:v>88.425759674386043</c:v>
                </c:pt>
                <c:pt idx="23">
                  <c:v>89.658317160195551</c:v>
                </c:pt>
                <c:pt idx="24">
                  <c:v>89.780573336496488</c:v>
                </c:pt>
                <c:pt idx="25">
                  <c:v>89.86486486486487</c:v>
                </c:pt>
                <c:pt idx="26">
                  <c:v>90.171004931117324</c:v>
                </c:pt>
                <c:pt idx="27">
                  <c:v>90.206185567010309</c:v>
                </c:pt>
                <c:pt idx="28">
                  <c:v>91.358024691358025</c:v>
                </c:pt>
                <c:pt idx="29">
                  <c:v>91.546087459404148</c:v>
                </c:pt>
                <c:pt idx="30">
                  <c:v>91.815365570156075</c:v>
                </c:pt>
                <c:pt idx="31">
                  <c:v>92.583501407107221</c:v>
                </c:pt>
                <c:pt idx="32">
                  <c:v>93.624289090710619</c:v>
                </c:pt>
                <c:pt idx="33">
                  <c:v>93.959731543624173</c:v>
                </c:pt>
                <c:pt idx="34">
                  <c:v>94.557823129251688</c:v>
                </c:pt>
                <c:pt idx="35">
                  <c:v>94.838709677419331</c:v>
                </c:pt>
                <c:pt idx="36">
                  <c:v>94.898088942284929</c:v>
                </c:pt>
                <c:pt idx="37">
                  <c:v>95.43705643203613</c:v>
                </c:pt>
                <c:pt idx="38">
                  <c:v>95.95375722543352</c:v>
                </c:pt>
                <c:pt idx="39">
                  <c:v>95.973154362416096</c:v>
                </c:pt>
                <c:pt idx="40">
                  <c:v>96.364145114409226</c:v>
                </c:pt>
                <c:pt idx="41">
                  <c:v>97.297297297297291</c:v>
                </c:pt>
                <c:pt idx="42">
                  <c:v>97.350350790473399</c:v>
                </c:pt>
                <c:pt idx="43">
                  <c:v>97.354032195501546</c:v>
                </c:pt>
                <c:pt idx="44">
                  <c:v>97.411669167481364</c:v>
                </c:pt>
                <c:pt idx="45">
                  <c:v>97.709884170204433</c:v>
                </c:pt>
                <c:pt idx="46">
                  <c:v>97.959183673469425</c:v>
                </c:pt>
                <c:pt idx="47">
                  <c:v>98.456342390200973</c:v>
                </c:pt>
                <c:pt idx="48">
                  <c:v>98.6994444701768</c:v>
                </c:pt>
                <c:pt idx="49">
                  <c:v>98.726114649681534</c:v>
                </c:pt>
                <c:pt idx="50">
                  <c:v>99.337748344370851</c:v>
                </c:pt>
                <c:pt idx="51">
                  <c:v>99.959320352540075</c:v>
                </c:pt>
                <c:pt idx="52">
                  <c:v>100.57803468208091</c:v>
                </c:pt>
                <c:pt idx="53">
                  <c:v>101.97628458498025</c:v>
                </c:pt>
                <c:pt idx="54">
                  <c:v>102.06020886245733</c:v>
                </c:pt>
                <c:pt idx="55">
                  <c:v>103.07100507956039</c:v>
                </c:pt>
                <c:pt idx="56">
                  <c:v>103.14341846758349</c:v>
                </c:pt>
                <c:pt idx="57">
                  <c:v>103.64583333333334</c:v>
                </c:pt>
                <c:pt idx="58">
                  <c:v>103.72732608062545</c:v>
                </c:pt>
                <c:pt idx="59">
                  <c:v>103.9752974498078</c:v>
                </c:pt>
                <c:pt idx="60">
                  <c:v>104.70582696355871</c:v>
                </c:pt>
                <c:pt idx="61">
                  <c:v>105.04058741390475</c:v>
                </c:pt>
                <c:pt idx="62">
                  <c:v>105.24244432674695</c:v>
                </c:pt>
                <c:pt idx="63">
                  <c:v>105.48780487804879</c:v>
                </c:pt>
                <c:pt idx="64">
                  <c:v>106.51115563769942</c:v>
                </c:pt>
                <c:pt idx="65">
                  <c:v>107.33903650435535</c:v>
                </c:pt>
                <c:pt idx="66">
                  <c:v>107.56302521008404</c:v>
                </c:pt>
                <c:pt idx="67">
                  <c:v>107.69230769230769</c:v>
                </c:pt>
                <c:pt idx="68">
                  <c:v>107.92331683632403</c:v>
                </c:pt>
                <c:pt idx="69">
                  <c:v>109.196096081419</c:v>
                </c:pt>
                <c:pt idx="70">
                  <c:v>111.29416303182128</c:v>
                </c:pt>
                <c:pt idx="71">
                  <c:v>112.21478807809258</c:v>
                </c:pt>
                <c:pt idx="72">
                  <c:v>113.66906474820146</c:v>
                </c:pt>
                <c:pt idx="73">
                  <c:v>113.79310344827584</c:v>
                </c:pt>
                <c:pt idx="74">
                  <c:v>114.55696202531649</c:v>
                </c:pt>
                <c:pt idx="75">
                  <c:v>114.62360061048365</c:v>
                </c:pt>
                <c:pt idx="76">
                  <c:v>117.91044776119404</c:v>
                </c:pt>
                <c:pt idx="77">
                  <c:v>117.99999999999997</c:v>
                </c:pt>
                <c:pt idx="78">
                  <c:v>118.18181818181822</c:v>
                </c:pt>
                <c:pt idx="79">
                  <c:v>118.39063504577265</c:v>
                </c:pt>
                <c:pt idx="80">
                  <c:v>118.86792452830186</c:v>
                </c:pt>
                <c:pt idx="81">
                  <c:v>118.89763779527559</c:v>
                </c:pt>
                <c:pt idx="82">
                  <c:v>119.08396946564885</c:v>
                </c:pt>
                <c:pt idx="83">
                  <c:v>121.32540485026296</c:v>
                </c:pt>
                <c:pt idx="84">
                  <c:v>122.37493526365921</c:v>
                </c:pt>
                <c:pt idx="85">
                  <c:v>122.83464566929135</c:v>
                </c:pt>
                <c:pt idx="86">
                  <c:v>125.95419847328246</c:v>
                </c:pt>
                <c:pt idx="87">
                  <c:v>126.3888888888889</c:v>
                </c:pt>
                <c:pt idx="88">
                  <c:v>131.18642377937593</c:v>
                </c:pt>
                <c:pt idx="89">
                  <c:v>143.6363636363636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4235456"/>
        <c:axId val="94236032"/>
      </c:scatterChart>
      <c:valAx>
        <c:axId val="94235456"/>
        <c:scaling>
          <c:orientation val="minMax"/>
          <c:max val="100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4236032"/>
        <c:crosses val="autoZero"/>
        <c:crossBetween val="midCat"/>
        <c:majorUnit val="50"/>
      </c:valAx>
      <c:valAx>
        <c:axId val="942360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4235456"/>
        <c:crosses val="autoZero"/>
        <c:crossBetween val="midCat"/>
        <c:majorUnit val="40"/>
      </c:valAx>
    </c:plotArea>
    <c:legend>
      <c:legendPos val="r"/>
      <c:layout>
        <c:manualLayout>
          <c:xMode val="edge"/>
          <c:yMode val="edge"/>
          <c:x val="0.60443847653149974"/>
          <c:y val="0.77105354752342703"/>
          <c:w val="0.34045742302556442"/>
          <c:h val="8.3717191601049873E-2"/>
        </c:manualLayout>
      </c:layout>
      <c:overlay val="0"/>
      <c:txPr>
        <a:bodyPr/>
        <a:lstStyle/>
        <a:p>
          <a:pPr>
            <a:defRPr sz="12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0356</cdr:x>
      <cdr:y>0.2767</cdr:y>
    </cdr:from>
    <cdr:to>
      <cdr:x>0.75771</cdr:x>
      <cdr:y>0.36723</cdr:y>
    </cdr:to>
    <cdr:sp macro="" textlink="">
      <cdr:nvSpPr>
        <cdr:cNvPr id="4" name="TextBox 2"/>
        <cdr:cNvSpPr txBox="1"/>
      </cdr:nvSpPr>
      <cdr:spPr>
        <a:xfrm xmlns:a="http://schemas.openxmlformats.org/drawingml/2006/main">
          <a:off x="1293355" y="846649"/>
          <a:ext cx="652743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200" dirty="0">
              <a:latin typeface="Arial" panose="020B0604020202020204" pitchFamily="34" charset="0"/>
              <a:cs typeface="Arial" panose="020B0604020202020204" pitchFamily="34" charset="0"/>
            </a:rPr>
            <a:t>2.3317</a:t>
          </a:r>
        </a:p>
      </cdr:txBody>
    </cdr:sp>
  </cdr:relSizeAnchor>
  <cdr:relSizeAnchor xmlns:cdr="http://schemas.openxmlformats.org/drawingml/2006/chartDrawing">
    <cdr:from>
      <cdr:x>0.70647</cdr:x>
      <cdr:y>0.33612</cdr:y>
    </cdr:from>
    <cdr:to>
      <cdr:x>0.79814</cdr:x>
      <cdr:y>0.39977</cdr:y>
    </cdr:to>
    <cdr:cxnSp macro="">
      <cdr:nvCxnSpPr>
        <cdr:cNvPr id="6" name="Straight Arrow Connector 5"/>
        <cdr:cNvCxnSpPr/>
      </cdr:nvCxnSpPr>
      <cdr:spPr>
        <a:xfrm xmlns:a="http://schemas.openxmlformats.org/drawingml/2006/main">
          <a:off x="1814495" y="1028460"/>
          <a:ext cx="235445" cy="194758"/>
        </a:xfrm>
        <a:prstGeom xmlns:a="http://schemas.openxmlformats.org/drawingml/2006/main" prst="straightConnector1">
          <a:avLst/>
        </a:prstGeom>
        <a:ln xmlns:a="http://schemas.openxmlformats.org/drawingml/2006/main">
          <a:solidFill>
            <a:schemeClr val="tx1"/>
          </a:solidFill>
          <a:tailEnd type="arrow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0541</cdr:x>
      <cdr:y>0.10136</cdr:y>
    </cdr:from>
    <cdr:to>
      <cdr:x>0.71933</cdr:x>
      <cdr:y>0.19189</cdr:y>
    </cdr:to>
    <cdr:sp macro="" textlink="">
      <cdr:nvSpPr>
        <cdr:cNvPr id="7" name="TextBox 2"/>
        <cdr:cNvSpPr txBox="1"/>
      </cdr:nvSpPr>
      <cdr:spPr>
        <a:xfrm xmlns:a="http://schemas.openxmlformats.org/drawingml/2006/main">
          <a:off x="784412" y="310156"/>
          <a:ext cx="1063112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200" dirty="0" smtClean="0">
              <a:latin typeface="Arial" panose="020B0604020202020204" pitchFamily="34" charset="0"/>
              <a:cs typeface="Arial" panose="020B0604020202020204" pitchFamily="34" charset="0"/>
            </a:rPr>
            <a:t>DBVPG6299</a:t>
          </a:r>
          <a:endParaRPr lang="en-GB" sz="12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0116</cdr:x>
      <cdr:y>0.00744</cdr:y>
    </cdr:from>
    <cdr:to>
      <cdr:x>0.13042</cdr:x>
      <cdr:y>0.14085</cdr:y>
    </cdr:to>
    <cdr:sp macro="" textlink="">
      <cdr:nvSpPr>
        <cdr:cNvPr id="2" name="TextBox 18"/>
        <cdr:cNvSpPr txBox="1"/>
      </cdr:nvSpPr>
      <cdr:spPr>
        <a:xfrm xmlns:a="http://schemas.openxmlformats.org/drawingml/2006/main">
          <a:off x="2923" y="20597"/>
          <a:ext cx="325730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1pPr>
          <a:lvl2pPr marL="4572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2pPr>
          <a:lvl3pPr marL="9144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3pPr>
          <a:lvl4pPr marL="13716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4pPr>
          <a:lvl5pPr marL="18288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5pPr>
          <a:lvl6pPr marL="22860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6pPr>
          <a:lvl7pPr marL="27432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7pPr>
          <a:lvl8pPr marL="32004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8pPr>
          <a:lvl9pPr marL="36576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9pPr>
        </a:lstStyle>
        <a:p xmlns:a="http://schemas.openxmlformats.org/drawingml/2006/main">
          <a:r>
            <a:rPr lang="en-GB" sz="1800" b="1" dirty="0" smtClean="0"/>
            <a:t>F</a:t>
          </a:r>
          <a:endParaRPr lang="en-GB" sz="1800" b="1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</cdr:x>
      <cdr:y>0.00127</cdr:y>
    </cdr:from>
    <cdr:to>
      <cdr:x>0.14342</cdr:x>
      <cdr:y>0.13278</cdr:y>
    </cdr:to>
    <cdr:sp macro="" textlink="">
      <cdr:nvSpPr>
        <cdr:cNvPr id="2" name="TextBox 15"/>
        <cdr:cNvSpPr txBox="1"/>
      </cdr:nvSpPr>
      <cdr:spPr>
        <a:xfrm xmlns:a="http://schemas.openxmlformats.org/drawingml/2006/main">
          <a:off x="0" y="3567"/>
          <a:ext cx="338554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1pPr>
          <a:lvl2pPr marL="4572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2pPr>
          <a:lvl3pPr marL="9144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3pPr>
          <a:lvl4pPr marL="13716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4pPr>
          <a:lvl5pPr marL="18288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5pPr>
          <a:lvl6pPr marL="22860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6pPr>
          <a:lvl7pPr marL="27432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7pPr>
          <a:lvl8pPr marL="32004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8pPr>
          <a:lvl9pPr marL="36576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9pPr>
        </a:lstStyle>
        <a:p xmlns:a="http://schemas.openxmlformats.org/drawingml/2006/main">
          <a:r>
            <a:rPr lang="en-GB" sz="1800" b="1" dirty="0" smtClean="0"/>
            <a:t>E</a:t>
          </a:r>
          <a:endParaRPr lang="en-GB" sz="1800" b="1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5042</cdr:x>
      <cdr:y>0.12214</cdr:y>
    </cdr:to>
    <cdr:sp macro="" textlink="">
      <cdr:nvSpPr>
        <cdr:cNvPr id="2" name="TextBox 11"/>
        <cdr:cNvSpPr txBox="1"/>
      </cdr:nvSpPr>
      <cdr:spPr>
        <a:xfrm xmlns:a="http://schemas.openxmlformats.org/drawingml/2006/main">
          <a:off x="0" y="0"/>
          <a:ext cx="332142" cy="33855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1pPr>
          <a:lvl2pPr marL="4572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2pPr>
          <a:lvl3pPr marL="9144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3pPr>
          <a:lvl4pPr marL="13716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4pPr>
          <a:lvl5pPr marL="18288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5pPr>
          <a:lvl6pPr marL="22860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6pPr>
          <a:lvl7pPr marL="27432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7pPr>
          <a:lvl8pPr marL="32004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8pPr>
          <a:lvl9pPr marL="36576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9pPr>
        </a:lstStyle>
        <a:p xmlns:a="http://schemas.openxmlformats.org/drawingml/2006/main">
          <a:r>
            <a:rPr lang="en-GB" sz="1600" b="1" dirty="0" smtClean="0"/>
            <a:t>A</a:t>
          </a:r>
          <a:endParaRPr lang="en-GB" sz="1600" b="1" dirty="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</cdr:x>
      <cdr:y>0.00349</cdr:y>
    </cdr:from>
    <cdr:to>
      <cdr:x>0.15368</cdr:x>
      <cdr:y>0.13608</cdr:y>
    </cdr:to>
    <cdr:sp macro="" textlink="">
      <cdr:nvSpPr>
        <cdr:cNvPr id="2" name="TextBox 12"/>
        <cdr:cNvSpPr txBox="1"/>
      </cdr:nvSpPr>
      <cdr:spPr>
        <a:xfrm xmlns:a="http://schemas.openxmlformats.org/drawingml/2006/main">
          <a:off x="0" y="9727"/>
          <a:ext cx="351378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1pPr>
          <a:lvl2pPr marL="4572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2pPr>
          <a:lvl3pPr marL="9144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3pPr>
          <a:lvl4pPr marL="13716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4pPr>
          <a:lvl5pPr marL="18288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5pPr>
          <a:lvl6pPr marL="22860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6pPr>
          <a:lvl7pPr marL="27432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7pPr>
          <a:lvl8pPr marL="32004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8pPr>
          <a:lvl9pPr marL="36576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9pPr>
        </a:lstStyle>
        <a:p xmlns:a="http://schemas.openxmlformats.org/drawingml/2006/main">
          <a:r>
            <a:rPr lang="en-GB" sz="1800" b="1" dirty="0" smtClean="0"/>
            <a:t>B</a:t>
          </a:r>
          <a:endParaRPr lang="en-GB" sz="1800" b="1" dirty="0"/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01416</cdr:x>
      <cdr:y>0</cdr:y>
    </cdr:from>
    <cdr:to>
      <cdr:x>0.15358</cdr:x>
      <cdr:y>0.13336</cdr:y>
    </cdr:to>
    <cdr:sp macro="" textlink="">
      <cdr:nvSpPr>
        <cdr:cNvPr id="2" name="TextBox 13"/>
        <cdr:cNvSpPr txBox="1"/>
      </cdr:nvSpPr>
      <cdr:spPr>
        <a:xfrm xmlns:a="http://schemas.openxmlformats.org/drawingml/2006/main">
          <a:off x="35689" y="0"/>
          <a:ext cx="351378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1pPr>
          <a:lvl2pPr marL="4572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2pPr>
          <a:lvl3pPr marL="9144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3pPr>
          <a:lvl4pPr marL="13716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4pPr>
          <a:lvl5pPr marL="18288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5pPr>
          <a:lvl6pPr marL="22860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6pPr>
          <a:lvl7pPr marL="27432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7pPr>
          <a:lvl8pPr marL="32004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8pPr>
          <a:lvl9pPr marL="36576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9pPr>
        </a:lstStyle>
        <a:p xmlns:a="http://schemas.openxmlformats.org/drawingml/2006/main">
          <a:r>
            <a:rPr lang="en-GB" sz="1800" b="1" dirty="0" smtClean="0"/>
            <a:t>C</a:t>
          </a:r>
          <a:endParaRPr lang="en-GB" sz="1800" b="1" dirty="0"/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4452</cdr:x>
      <cdr:y>0.13341</cdr:y>
    </cdr:to>
    <cdr:sp macro="" textlink="">
      <cdr:nvSpPr>
        <cdr:cNvPr id="2" name="TextBox 21"/>
        <cdr:cNvSpPr txBox="1"/>
      </cdr:nvSpPr>
      <cdr:spPr>
        <a:xfrm xmlns:a="http://schemas.openxmlformats.org/drawingml/2006/main">
          <a:off x="0" y="0"/>
          <a:ext cx="364202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1pPr>
          <a:lvl2pPr marL="4572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2pPr>
          <a:lvl3pPr marL="9144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3pPr>
          <a:lvl4pPr marL="13716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4pPr>
          <a:lvl5pPr marL="18288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5pPr>
          <a:lvl6pPr marL="22860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6pPr>
          <a:lvl7pPr marL="27432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7pPr>
          <a:lvl8pPr marL="32004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8pPr>
          <a:lvl9pPr marL="36576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9pPr>
        </a:lstStyle>
        <a:p xmlns:a="http://schemas.openxmlformats.org/drawingml/2006/main">
          <a:r>
            <a:rPr lang="en-GB" sz="1800" b="1" dirty="0" smtClean="0"/>
            <a:t>G</a:t>
          </a:r>
          <a:endParaRPr lang="en-GB" sz="1800" b="1" dirty="0"/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5257</cdr:x>
      <cdr:y>0.1314</cdr:y>
    </cdr:to>
    <cdr:sp macro="" textlink="">
      <cdr:nvSpPr>
        <cdr:cNvPr id="2" name="TextBox 14"/>
        <cdr:cNvSpPr txBox="1"/>
      </cdr:nvSpPr>
      <cdr:spPr>
        <a:xfrm xmlns:a="http://schemas.openxmlformats.org/drawingml/2006/main">
          <a:off x="0" y="0"/>
          <a:ext cx="351378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1pPr>
          <a:lvl2pPr marL="4572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2pPr>
          <a:lvl3pPr marL="9144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3pPr>
          <a:lvl4pPr marL="13716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4pPr>
          <a:lvl5pPr marL="18288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5pPr>
          <a:lvl6pPr marL="22860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6pPr>
          <a:lvl7pPr marL="27432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7pPr>
          <a:lvl8pPr marL="32004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8pPr>
          <a:lvl9pPr marL="36576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9pPr>
        </a:lstStyle>
        <a:p xmlns:a="http://schemas.openxmlformats.org/drawingml/2006/main">
          <a:r>
            <a:rPr lang="en-GB" sz="1800" b="1" dirty="0" smtClean="0"/>
            <a:t>D</a:t>
          </a:r>
          <a:endParaRPr lang="en-GB" sz="1800" b="1" dirty="0"/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7283</cdr:x>
      <cdr:y>0.13341</cdr:y>
    </cdr:to>
    <cdr:sp macro="" textlink="">
      <cdr:nvSpPr>
        <cdr:cNvPr id="2" name="TextBox 23"/>
        <cdr:cNvSpPr txBox="1"/>
      </cdr:nvSpPr>
      <cdr:spPr>
        <a:xfrm xmlns:a="http://schemas.openxmlformats.org/drawingml/2006/main">
          <a:off x="0" y="0"/>
          <a:ext cx="183532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1pPr>
          <a:lvl2pPr marL="4572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2pPr>
          <a:lvl3pPr marL="9144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3pPr>
          <a:lvl4pPr marL="13716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4pPr>
          <a:lvl5pPr marL="1828800" algn="l" rtl="0" fontAlgn="base">
            <a:spcBef>
              <a:spcPct val="0"/>
            </a:spcBef>
            <a:spcAft>
              <a:spcPct val="0"/>
            </a:spcAft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5pPr>
          <a:lvl6pPr marL="22860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6pPr>
          <a:lvl7pPr marL="27432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7pPr>
          <a:lvl8pPr marL="32004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8pPr>
          <a:lvl9pPr marL="3657600" algn="l" defTabSz="914400" rtl="0" eaLnBrk="1" latinLnBrk="0" hangingPunct="1">
            <a:defRPr kern="1200">
              <a:solidFill>
                <a:schemeClr val="tx1"/>
              </a:solidFill>
              <a:latin typeface="Arial" charset="0"/>
              <a:ea typeface="+mn-ea"/>
              <a:cs typeface="Arial" charset="0"/>
            </a:defRPr>
          </a:lvl9pPr>
        </a:lstStyle>
        <a:p xmlns:a="http://schemas.openxmlformats.org/drawingml/2006/main">
          <a:r>
            <a:rPr lang="en-GB" sz="1800" b="1" dirty="0" smtClean="0"/>
            <a:t>H</a:t>
          </a:r>
          <a:endParaRPr lang="en-GB" sz="1800" b="1" dirty="0"/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1163" cy="49712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7636" y="0"/>
            <a:ext cx="2951163" cy="49712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C2C900-297C-41CA-A444-DE01C455DCD3}" type="datetimeFigureOut">
              <a:rPr lang="en-GB" smtClean="0"/>
              <a:pPr/>
              <a:t>24/02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43662"/>
            <a:ext cx="2951163" cy="4971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7636" y="9443662"/>
            <a:ext cx="2951163" cy="4971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317CD0-051C-4E96-BF63-80D04E199B4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530604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1163" cy="49712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7636" y="0"/>
            <a:ext cx="2951163" cy="49712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123E2B-2973-4574-95B1-28D98266AADD}" type="datetimeFigureOut">
              <a:rPr lang="en-GB" smtClean="0"/>
              <a:t>24/02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8188" y="746125"/>
            <a:ext cx="2794000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1038" y="4722694"/>
            <a:ext cx="5448300" cy="447413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3662"/>
            <a:ext cx="2951163" cy="4971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7636" y="9443662"/>
            <a:ext cx="2951163" cy="4971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20A812-9CA6-4ECA-B1B9-D788B4222B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5094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420A812-9CA6-4ECA-B1B9-D788B4222B06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65273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420A812-9CA6-4ECA-B1B9-D788B4222B06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55114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AD04-0057-4726-8712-5618473EEF1B}" type="datetimeFigureOut">
              <a:rPr lang="en-GB"/>
              <a:pPr>
                <a:defRPr/>
              </a:pPr>
              <a:t>24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BDC2E8-2A99-4CA0-B168-C0CB3768A5A1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CEDFE1-F507-4655-A653-92361939E60D}" type="datetimeFigureOut">
              <a:rPr lang="en-GB"/>
              <a:pPr>
                <a:defRPr/>
              </a:pPr>
              <a:t>24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6FF219-7459-478C-8B2D-15A9FA061F8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F62FC1-87DE-4A6A-BFC6-BA65BFDF3CBB}" type="datetimeFigureOut">
              <a:rPr lang="en-GB"/>
              <a:pPr>
                <a:defRPr/>
              </a:pPr>
              <a:t>24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B96722-32B2-445B-B3EB-DADCEECAB98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550B1B-50F0-407A-9496-DB17392B005C}" type="datetimeFigureOut">
              <a:rPr lang="en-GB"/>
              <a:pPr>
                <a:defRPr/>
              </a:pPr>
              <a:t>24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2B8B16-10CE-43E4-85B1-AC44AB28CA8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0FA18B-17B7-45FA-A2D0-98A663131800}" type="datetimeFigureOut">
              <a:rPr lang="en-GB"/>
              <a:pPr>
                <a:defRPr/>
              </a:pPr>
              <a:t>24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90C55B-C0D5-4931-86ED-788BC3FD07E8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3B326C-E28D-4258-B802-D6CCCD172C9E}" type="datetimeFigureOut">
              <a:rPr lang="en-GB"/>
              <a:pPr>
                <a:defRPr/>
              </a:pPr>
              <a:t>24/02/2014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2535B7-3F0A-4221-B826-696422EB5B2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64606E-9BA5-4660-AF5E-4A9D0EAC1292}" type="datetimeFigureOut">
              <a:rPr lang="en-GB"/>
              <a:pPr>
                <a:defRPr/>
              </a:pPr>
              <a:t>24/02/2014</a:t>
            </a:fld>
            <a:endParaRPr lang="en-GB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87EABA-4F4A-4326-A571-E546341D4B2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3F3331-20FF-4282-A5D6-CEE1773FF8BA}" type="datetimeFigureOut">
              <a:rPr lang="en-GB"/>
              <a:pPr>
                <a:defRPr/>
              </a:pPr>
              <a:t>24/02/2014</a:t>
            </a:fld>
            <a:endParaRPr lang="en-GB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0B85C2-A9F7-40FD-8245-A81196C3221A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564965-4992-4C96-8231-ED929C58ADAF}" type="datetimeFigureOut">
              <a:rPr lang="en-GB"/>
              <a:pPr>
                <a:defRPr/>
              </a:pPr>
              <a:t>24/02/2014</a:t>
            </a:fld>
            <a:endParaRPr lang="en-GB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5498A6-BBCD-42A1-B962-CD85B5F0CE6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02C7A4D-1A5D-493F-81AB-4E32BDE39560}" type="datetimeFigureOut">
              <a:rPr lang="en-GB"/>
              <a:pPr>
                <a:defRPr/>
              </a:pPr>
              <a:t>24/02/2014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D26EA4-85A7-43F6-AA31-8D32E0FDBAA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32A2E4-8347-4C50-93B9-9AD09452A1E1}" type="datetimeFigureOut">
              <a:rPr lang="en-GB"/>
              <a:pPr>
                <a:defRPr/>
              </a:pPr>
              <a:t>24/02/2014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E92EAB-CEF0-43C2-939B-9D84F445EFE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57F0DC30-9D80-42DA-ABED-772998C3D48D}" type="datetimeFigureOut">
              <a:rPr lang="en-GB"/>
              <a:pPr>
                <a:defRPr/>
              </a:pPr>
              <a:t>24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74A0BAC-3C55-47CB-AAF6-CA0D6D57E39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8.xml"/><Relationship Id="rId3" Type="http://schemas.openxmlformats.org/officeDocument/2006/relationships/chart" Target="../charts/chart13.xml"/><Relationship Id="rId7" Type="http://schemas.openxmlformats.org/officeDocument/2006/relationships/chart" Target="../charts/chart17.xml"/><Relationship Id="rId2" Type="http://schemas.openxmlformats.org/officeDocument/2006/relationships/chart" Target="../charts/chart1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6.xml"/><Relationship Id="rId5" Type="http://schemas.openxmlformats.org/officeDocument/2006/relationships/chart" Target="../charts/chart15.xml"/><Relationship Id="rId4" Type="http://schemas.openxmlformats.org/officeDocument/2006/relationships/chart" Target="../charts/chart14.xml"/><Relationship Id="rId9" Type="http://schemas.openxmlformats.org/officeDocument/2006/relationships/chart" Target="../charts/chart1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1693948"/>
              </p:ext>
            </p:extLst>
          </p:nvPr>
        </p:nvGraphicFramePr>
        <p:xfrm>
          <a:off x="-19708" y="0"/>
          <a:ext cx="2568402" cy="30598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2"/>
          <p:cNvSpPr txBox="1"/>
          <p:nvPr/>
        </p:nvSpPr>
        <p:spPr>
          <a:xfrm>
            <a:off x="1879885" y="1918973"/>
            <a:ext cx="652743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2.3317</a:t>
            </a:r>
          </a:p>
        </p:txBody>
      </p:sp>
      <p:cxnSp>
        <p:nvCxnSpPr>
          <p:cNvPr id="8" name="Straight Arrow Connector 7"/>
          <p:cNvCxnSpPr/>
          <p:nvPr/>
        </p:nvCxnSpPr>
        <p:spPr>
          <a:xfrm flipH="1" flipV="1">
            <a:off x="2138536" y="1655000"/>
            <a:ext cx="117717" cy="26397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1903102" y="486441"/>
            <a:ext cx="242382" cy="19476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7580530"/>
              </p:ext>
            </p:extLst>
          </p:nvPr>
        </p:nvGraphicFramePr>
        <p:xfrm>
          <a:off x="2420889" y="143093"/>
          <a:ext cx="2448272" cy="30238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9" name="TextBox 2"/>
          <p:cNvSpPr txBox="1"/>
          <p:nvPr/>
        </p:nvSpPr>
        <p:spPr>
          <a:xfrm>
            <a:off x="3402639" y="2437342"/>
            <a:ext cx="652743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.3318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Arrow Connector 20"/>
          <p:cNvCxnSpPr>
            <a:stCxn id="19" idx="1"/>
          </p:cNvCxnSpPr>
          <p:nvPr/>
        </p:nvCxnSpPr>
        <p:spPr>
          <a:xfrm flipH="1" flipV="1">
            <a:off x="3059125" y="2506557"/>
            <a:ext cx="343514" cy="6928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"/>
          <p:cNvSpPr txBox="1"/>
          <p:nvPr/>
        </p:nvSpPr>
        <p:spPr>
          <a:xfrm>
            <a:off x="3417356" y="2301737"/>
            <a:ext cx="652743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2.3317</a:t>
            </a:r>
          </a:p>
        </p:txBody>
      </p:sp>
      <p:cxnSp>
        <p:nvCxnSpPr>
          <p:cNvPr id="23" name="Straight Arrow Connector 22"/>
          <p:cNvCxnSpPr/>
          <p:nvPr/>
        </p:nvCxnSpPr>
        <p:spPr>
          <a:xfrm flipH="1" flipV="1">
            <a:off x="3147909" y="2340155"/>
            <a:ext cx="343514" cy="6159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>
            <a:stCxn id="22" idx="0"/>
          </p:cNvCxnSpPr>
          <p:nvPr/>
        </p:nvCxnSpPr>
        <p:spPr>
          <a:xfrm flipH="1" flipV="1">
            <a:off x="3147909" y="1786987"/>
            <a:ext cx="595819" cy="51475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9" name="Chart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3897135"/>
              </p:ext>
            </p:extLst>
          </p:nvPr>
        </p:nvGraphicFramePr>
        <p:xfrm>
          <a:off x="4522534" y="184666"/>
          <a:ext cx="2372993" cy="30911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0" name="TextBox 29"/>
          <p:cNvSpPr txBox="1"/>
          <p:nvPr/>
        </p:nvSpPr>
        <p:spPr bwMode="auto">
          <a:xfrm>
            <a:off x="-58934" y="699018"/>
            <a:ext cx="369332" cy="1315344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200" b="1" dirty="0">
                <a:latin typeface="Arial" panose="020B0604020202020204" pitchFamily="34" charset="0"/>
                <a:cs typeface="Arial" pitchFamily="34" charset="0"/>
              </a:rPr>
              <a:t>% RSI of control</a:t>
            </a:r>
          </a:p>
        </p:txBody>
      </p:sp>
      <p:sp>
        <p:nvSpPr>
          <p:cNvPr id="31" name="TextBox 30"/>
          <p:cNvSpPr txBox="1"/>
          <p:nvPr/>
        </p:nvSpPr>
        <p:spPr bwMode="auto">
          <a:xfrm>
            <a:off x="2348880" y="699018"/>
            <a:ext cx="369332" cy="1315344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200" b="1" dirty="0">
                <a:latin typeface="Arial" panose="020B0604020202020204" pitchFamily="34" charset="0"/>
                <a:cs typeface="Arial" pitchFamily="34" charset="0"/>
              </a:rPr>
              <a:t>% RSI of control</a:t>
            </a:r>
          </a:p>
        </p:txBody>
      </p:sp>
      <p:sp>
        <p:nvSpPr>
          <p:cNvPr id="32" name="TextBox 31"/>
          <p:cNvSpPr txBox="1"/>
          <p:nvPr/>
        </p:nvSpPr>
        <p:spPr bwMode="auto">
          <a:xfrm>
            <a:off x="4435050" y="634294"/>
            <a:ext cx="369332" cy="1315344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200" b="1" dirty="0">
                <a:latin typeface="Arial" panose="020B0604020202020204" pitchFamily="34" charset="0"/>
                <a:cs typeface="Arial" pitchFamily="34" charset="0"/>
              </a:rPr>
              <a:t>% RSI of control</a:t>
            </a:r>
          </a:p>
        </p:txBody>
      </p:sp>
      <p:sp>
        <p:nvSpPr>
          <p:cNvPr id="33" name="TextBox 12"/>
          <p:cNvSpPr txBox="1">
            <a:spLocks noChangeArrowheads="1"/>
          </p:cNvSpPr>
          <p:nvPr/>
        </p:nvSpPr>
        <p:spPr bwMode="auto">
          <a:xfrm>
            <a:off x="-46593" y="33157"/>
            <a:ext cx="42962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34" name="TextBox 12"/>
          <p:cNvSpPr txBox="1">
            <a:spLocks noChangeArrowheads="1"/>
          </p:cNvSpPr>
          <p:nvPr/>
        </p:nvSpPr>
        <p:spPr bwMode="auto">
          <a:xfrm>
            <a:off x="2276872" y="33157"/>
            <a:ext cx="42962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12"/>
          <p:cNvSpPr txBox="1">
            <a:spLocks noChangeArrowheads="1"/>
          </p:cNvSpPr>
          <p:nvPr/>
        </p:nvSpPr>
        <p:spPr bwMode="auto">
          <a:xfrm>
            <a:off x="4435050" y="35631"/>
            <a:ext cx="42962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12"/>
          <p:cNvSpPr txBox="1">
            <a:spLocks noChangeArrowheads="1"/>
          </p:cNvSpPr>
          <p:nvPr/>
        </p:nvSpPr>
        <p:spPr bwMode="auto">
          <a:xfrm>
            <a:off x="-74089" y="2952153"/>
            <a:ext cx="4849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12"/>
          <p:cNvSpPr txBox="1">
            <a:spLocks noChangeArrowheads="1"/>
          </p:cNvSpPr>
          <p:nvPr/>
        </p:nvSpPr>
        <p:spPr bwMode="auto">
          <a:xfrm>
            <a:off x="2304884" y="2972023"/>
            <a:ext cx="39548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12"/>
          <p:cNvSpPr txBox="1">
            <a:spLocks noChangeArrowheads="1"/>
          </p:cNvSpPr>
          <p:nvPr/>
        </p:nvSpPr>
        <p:spPr bwMode="auto">
          <a:xfrm>
            <a:off x="4520452" y="3001860"/>
            <a:ext cx="39548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12"/>
          <p:cNvSpPr txBox="1">
            <a:spLocks noChangeArrowheads="1"/>
          </p:cNvSpPr>
          <p:nvPr/>
        </p:nvSpPr>
        <p:spPr bwMode="auto">
          <a:xfrm>
            <a:off x="-71483" y="5996638"/>
            <a:ext cx="39548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.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12"/>
          <p:cNvSpPr txBox="1">
            <a:spLocks noChangeArrowheads="1"/>
          </p:cNvSpPr>
          <p:nvPr/>
        </p:nvSpPr>
        <p:spPr bwMode="auto">
          <a:xfrm>
            <a:off x="2334883" y="6035650"/>
            <a:ext cx="39548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.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12"/>
          <p:cNvSpPr txBox="1">
            <a:spLocks noChangeArrowheads="1"/>
          </p:cNvSpPr>
          <p:nvPr/>
        </p:nvSpPr>
        <p:spPr bwMode="auto">
          <a:xfrm>
            <a:off x="4564957" y="6039507"/>
            <a:ext cx="34637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.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 bwMode="auto">
          <a:xfrm>
            <a:off x="-74089" y="3321485"/>
            <a:ext cx="369332" cy="1524207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200" b="1" dirty="0">
                <a:latin typeface="Arial" panose="020B0604020202020204" pitchFamily="34" charset="0"/>
                <a:cs typeface="Arial" pitchFamily="34" charset="0"/>
              </a:rPr>
              <a:t>% RSI of control</a:t>
            </a:r>
          </a:p>
        </p:txBody>
      </p:sp>
      <p:sp>
        <p:nvSpPr>
          <p:cNvPr id="56" name="TextBox 55"/>
          <p:cNvSpPr txBox="1"/>
          <p:nvPr/>
        </p:nvSpPr>
        <p:spPr bwMode="auto">
          <a:xfrm>
            <a:off x="2333199" y="2952153"/>
            <a:ext cx="369332" cy="1873669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200" b="1" dirty="0">
                <a:latin typeface="Arial" panose="020B0604020202020204" pitchFamily="34" charset="0"/>
                <a:cs typeface="Arial" pitchFamily="34" charset="0"/>
              </a:rPr>
              <a:t>% RSI of control</a:t>
            </a:r>
          </a:p>
        </p:txBody>
      </p:sp>
      <p:sp>
        <p:nvSpPr>
          <p:cNvPr id="57" name="TextBox 56"/>
          <p:cNvSpPr txBox="1"/>
          <p:nvPr/>
        </p:nvSpPr>
        <p:spPr bwMode="auto">
          <a:xfrm>
            <a:off x="4529654" y="3176559"/>
            <a:ext cx="369332" cy="1669133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200" b="1" dirty="0">
                <a:latin typeface="Arial" panose="020B0604020202020204" pitchFamily="34" charset="0"/>
                <a:cs typeface="Arial" pitchFamily="34" charset="0"/>
              </a:rPr>
              <a:t>% RSI of control</a:t>
            </a:r>
          </a:p>
        </p:txBody>
      </p:sp>
      <p:sp>
        <p:nvSpPr>
          <p:cNvPr id="58" name="TextBox 57"/>
          <p:cNvSpPr txBox="1"/>
          <p:nvPr/>
        </p:nvSpPr>
        <p:spPr bwMode="auto">
          <a:xfrm>
            <a:off x="-45766" y="6455715"/>
            <a:ext cx="369332" cy="1636165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200" b="1" dirty="0">
                <a:latin typeface="Arial" panose="020B0604020202020204" pitchFamily="34" charset="0"/>
                <a:cs typeface="Arial" pitchFamily="34" charset="0"/>
              </a:rPr>
              <a:t>% RSI of control</a:t>
            </a:r>
          </a:p>
        </p:txBody>
      </p:sp>
      <p:sp>
        <p:nvSpPr>
          <p:cNvPr id="59" name="TextBox 58"/>
          <p:cNvSpPr txBox="1"/>
          <p:nvPr/>
        </p:nvSpPr>
        <p:spPr bwMode="auto">
          <a:xfrm>
            <a:off x="2336730" y="6455714"/>
            <a:ext cx="369332" cy="1636165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200" b="1" dirty="0">
                <a:latin typeface="Arial" panose="020B0604020202020204" pitchFamily="34" charset="0"/>
                <a:cs typeface="Arial" pitchFamily="34" charset="0"/>
              </a:rPr>
              <a:t>% RSI of control</a:t>
            </a:r>
          </a:p>
        </p:txBody>
      </p:sp>
      <p:sp>
        <p:nvSpPr>
          <p:cNvPr id="60" name="TextBox 59"/>
          <p:cNvSpPr txBox="1"/>
          <p:nvPr/>
        </p:nvSpPr>
        <p:spPr bwMode="auto">
          <a:xfrm>
            <a:off x="4545887" y="6427490"/>
            <a:ext cx="369332" cy="1636165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200" b="1" dirty="0">
                <a:latin typeface="Arial" panose="020B0604020202020204" pitchFamily="34" charset="0"/>
                <a:cs typeface="Arial" pitchFamily="34" charset="0"/>
              </a:rPr>
              <a:t>% RSI of control</a:t>
            </a:r>
          </a:p>
        </p:txBody>
      </p:sp>
      <p:graphicFrame>
        <p:nvGraphicFramePr>
          <p:cNvPr id="61" name="Chart 6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3228413"/>
              </p:ext>
            </p:extLst>
          </p:nvPr>
        </p:nvGraphicFramePr>
        <p:xfrm>
          <a:off x="168986" y="3131716"/>
          <a:ext cx="2302967" cy="298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2" name="Chart 6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1203476"/>
              </p:ext>
            </p:extLst>
          </p:nvPr>
        </p:nvGraphicFramePr>
        <p:xfrm>
          <a:off x="2637406" y="3051817"/>
          <a:ext cx="2166976" cy="298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63" name="Chart 6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4827283"/>
              </p:ext>
            </p:extLst>
          </p:nvPr>
        </p:nvGraphicFramePr>
        <p:xfrm>
          <a:off x="4604035" y="2972022"/>
          <a:ext cx="2275811" cy="298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64" name="Chart 6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4011478"/>
              </p:ext>
            </p:extLst>
          </p:nvPr>
        </p:nvGraphicFramePr>
        <p:xfrm>
          <a:off x="23453" y="6099605"/>
          <a:ext cx="2468232" cy="30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65" name="Chart 6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1765895"/>
              </p:ext>
            </p:extLst>
          </p:nvPr>
        </p:nvGraphicFramePr>
        <p:xfrm>
          <a:off x="2396020" y="6148399"/>
          <a:ext cx="2337856" cy="298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66" name="Chart 6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801980"/>
              </p:ext>
            </p:extLst>
          </p:nvPr>
        </p:nvGraphicFramePr>
        <p:xfrm>
          <a:off x="4690401" y="6156000"/>
          <a:ext cx="2205126" cy="298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67" name="TextBox 66"/>
          <p:cNvSpPr txBox="1"/>
          <p:nvPr/>
        </p:nvSpPr>
        <p:spPr>
          <a:xfrm>
            <a:off x="1087216" y="5793468"/>
            <a:ext cx="7694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itchFamily="34" charset="0"/>
              </a:rPr>
              <a:t>Strains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491423" y="5795168"/>
            <a:ext cx="7079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itchFamily="34" charset="0"/>
              </a:rPr>
              <a:t>Strains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588250" y="5795168"/>
            <a:ext cx="713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itchFamily="34" charset="0"/>
              </a:rPr>
              <a:t>Strains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087216" y="8902114"/>
            <a:ext cx="8364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itchFamily="34" charset="0"/>
              </a:rPr>
              <a:t>Strains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3415920" y="8895788"/>
            <a:ext cx="8048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itchFamily="34" charset="0"/>
              </a:rPr>
              <a:t>Strains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5588249" y="8867001"/>
            <a:ext cx="713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itchFamily="34" charset="0"/>
              </a:rPr>
              <a:t>Strains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911719" y="4779655"/>
            <a:ext cx="1063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BVPG6299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911718" y="4457871"/>
            <a:ext cx="13452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WOPPS99-807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Straight Arrow Connector 78"/>
          <p:cNvCxnSpPr>
            <a:stCxn id="73" idx="1"/>
          </p:cNvCxnSpPr>
          <p:nvPr/>
        </p:nvCxnSpPr>
        <p:spPr>
          <a:xfrm flipH="1" flipV="1">
            <a:off x="749025" y="4734870"/>
            <a:ext cx="162694" cy="18328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>
            <a:stCxn id="75" idx="1"/>
          </p:cNvCxnSpPr>
          <p:nvPr/>
        </p:nvCxnSpPr>
        <p:spPr>
          <a:xfrm flipH="1" flipV="1">
            <a:off x="749024" y="4349637"/>
            <a:ext cx="162694" cy="24673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/>
          <p:cNvSpPr txBox="1"/>
          <p:nvPr/>
        </p:nvSpPr>
        <p:spPr>
          <a:xfrm>
            <a:off x="1308728" y="7427577"/>
            <a:ext cx="1063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BVPG6299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975038" y="7729243"/>
            <a:ext cx="13452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WOPPS99-807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Straight Arrow Connector 87"/>
          <p:cNvCxnSpPr/>
          <p:nvPr/>
        </p:nvCxnSpPr>
        <p:spPr>
          <a:xfrm flipH="1" flipV="1">
            <a:off x="1837357" y="6921690"/>
            <a:ext cx="249409" cy="40532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/>
          <p:cNvCxnSpPr/>
          <p:nvPr/>
        </p:nvCxnSpPr>
        <p:spPr>
          <a:xfrm flipH="1" flipV="1">
            <a:off x="860066" y="7380337"/>
            <a:ext cx="162694" cy="35930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5550288" y="8102868"/>
            <a:ext cx="1063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BVPG6299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5550287" y="7781084"/>
            <a:ext cx="13452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WOPPS99-807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Straight Arrow Connector 94"/>
          <p:cNvCxnSpPr/>
          <p:nvPr/>
        </p:nvCxnSpPr>
        <p:spPr>
          <a:xfrm flipH="1" flipV="1">
            <a:off x="5301299" y="8006242"/>
            <a:ext cx="239912" cy="29701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/>
          <p:cNvCxnSpPr>
            <a:stCxn id="94" idx="1"/>
          </p:cNvCxnSpPr>
          <p:nvPr/>
        </p:nvCxnSpPr>
        <p:spPr>
          <a:xfrm flipH="1" flipV="1">
            <a:off x="5301299" y="7713630"/>
            <a:ext cx="248988" cy="20595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/>
          <p:cNvSpPr txBox="1"/>
          <p:nvPr/>
        </p:nvSpPr>
        <p:spPr>
          <a:xfrm>
            <a:off x="3022781" y="3647460"/>
            <a:ext cx="1063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BVPG6299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3258886" y="3229152"/>
            <a:ext cx="13452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WOPPS99-807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Straight Arrow Connector 107"/>
          <p:cNvCxnSpPr/>
          <p:nvPr/>
        </p:nvCxnSpPr>
        <p:spPr>
          <a:xfrm>
            <a:off x="3910807" y="3532774"/>
            <a:ext cx="299461" cy="16879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5749619" y="4634581"/>
            <a:ext cx="1063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BVPG6299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5143544" y="3190228"/>
            <a:ext cx="13452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WOPPS99-807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Straight Arrow Connector 112"/>
          <p:cNvCxnSpPr/>
          <p:nvPr/>
        </p:nvCxnSpPr>
        <p:spPr>
          <a:xfrm flipH="1" flipV="1">
            <a:off x="5936598" y="4270182"/>
            <a:ext cx="300743" cy="37537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/>
          <p:cNvCxnSpPr/>
          <p:nvPr/>
        </p:nvCxnSpPr>
        <p:spPr>
          <a:xfrm>
            <a:off x="5936598" y="3440441"/>
            <a:ext cx="481604" cy="17672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/>
          <p:cNvSpPr txBox="1"/>
          <p:nvPr/>
        </p:nvSpPr>
        <p:spPr>
          <a:xfrm>
            <a:off x="3382762" y="7751267"/>
            <a:ext cx="13452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WOPPS99-807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Straight Arrow Connector 118"/>
          <p:cNvCxnSpPr/>
          <p:nvPr/>
        </p:nvCxnSpPr>
        <p:spPr>
          <a:xfrm flipH="1" flipV="1">
            <a:off x="3209544" y="7493066"/>
            <a:ext cx="281879" cy="28801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/>
          <p:cNvSpPr txBox="1"/>
          <p:nvPr/>
        </p:nvSpPr>
        <p:spPr>
          <a:xfrm>
            <a:off x="3655319" y="7273796"/>
            <a:ext cx="1063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BVPG6299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3" name="Straight Arrow Connector 122"/>
          <p:cNvCxnSpPr/>
          <p:nvPr/>
        </p:nvCxnSpPr>
        <p:spPr>
          <a:xfrm flipH="1" flipV="1">
            <a:off x="4101573" y="7029039"/>
            <a:ext cx="107471" cy="28394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23"/>
          <p:cNvSpPr txBox="1"/>
          <p:nvPr/>
        </p:nvSpPr>
        <p:spPr>
          <a:xfrm>
            <a:off x="5561767" y="2275725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-1764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5" name="Straight Arrow Connector 124"/>
          <p:cNvCxnSpPr/>
          <p:nvPr/>
        </p:nvCxnSpPr>
        <p:spPr>
          <a:xfrm flipH="1" flipV="1">
            <a:off x="5301299" y="2195972"/>
            <a:ext cx="314022" cy="10576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125"/>
          <p:cNvSpPr txBox="1"/>
          <p:nvPr/>
        </p:nvSpPr>
        <p:spPr>
          <a:xfrm>
            <a:off x="5088152" y="1126881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-1764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7" name="Straight Arrow Connector 126"/>
          <p:cNvCxnSpPr/>
          <p:nvPr/>
        </p:nvCxnSpPr>
        <p:spPr>
          <a:xfrm>
            <a:off x="5488518" y="1348210"/>
            <a:ext cx="260934" cy="6667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/>
          <p:cNvSpPr txBox="1"/>
          <p:nvPr/>
        </p:nvSpPr>
        <p:spPr>
          <a:xfrm>
            <a:off x="5072374" y="496310"/>
            <a:ext cx="1063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BVPG6299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5370770" y="2440164"/>
            <a:ext cx="1063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BVPG6299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3" name="Straight Arrow Connector 132"/>
          <p:cNvCxnSpPr>
            <a:stCxn id="131" idx="3"/>
          </p:cNvCxnSpPr>
          <p:nvPr/>
        </p:nvCxnSpPr>
        <p:spPr>
          <a:xfrm flipV="1">
            <a:off x="6135486" y="609315"/>
            <a:ext cx="298396" cy="2549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Arrow Connector 134"/>
          <p:cNvCxnSpPr/>
          <p:nvPr/>
        </p:nvCxnSpPr>
        <p:spPr>
          <a:xfrm flipH="1" flipV="1">
            <a:off x="5193822" y="2537636"/>
            <a:ext cx="214954" cy="4102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/>
          <p:cNvCxnSpPr>
            <a:stCxn id="101" idx="3"/>
          </p:cNvCxnSpPr>
          <p:nvPr/>
        </p:nvCxnSpPr>
        <p:spPr>
          <a:xfrm flipV="1">
            <a:off x="4085893" y="3785959"/>
            <a:ext cx="124375" cy="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/>
          <p:cNvCxnSpPr/>
          <p:nvPr/>
        </p:nvCxnSpPr>
        <p:spPr>
          <a:xfrm>
            <a:off x="1843582" y="407192"/>
            <a:ext cx="260934" cy="6667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805620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2420888" cy="9144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4261" y="0"/>
            <a:ext cx="2088232" cy="9144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323527"/>
            <a:ext cx="2286000" cy="880533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2338412" y="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668208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</a:t>
            </a:r>
            <a:endParaRPr lang="en-GB" dirty="0"/>
          </a:p>
        </p:txBody>
      </p:sp>
      <p:sp>
        <p:nvSpPr>
          <p:cNvPr id="2" name="TextBox 1"/>
          <p:cNvSpPr txBox="1"/>
          <p:nvPr/>
        </p:nvSpPr>
        <p:spPr>
          <a:xfrm>
            <a:off x="2115641" y="3685736"/>
            <a:ext cx="2393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 smtClean="0"/>
              <a:t>*</a:t>
            </a:r>
            <a:endParaRPr lang="en-GB" sz="2000" dirty="0"/>
          </a:p>
        </p:txBody>
      </p:sp>
      <p:sp>
        <p:nvSpPr>
          <p:cNvPr id="9" name="TextBox 8"/>
          <p:cNvSpPr txBox="1"/>
          <p:nvPr/>
        </p:nvSpPr>
        <p:spPr>
          <a:xfrm>
            <a:off x="2105890" y="2805014"/>
            <a:ext cx="2393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 smtClean="0"/>
              <a:t>*</a:t>
            </a:r>
            <a:endParaRPr lang="en-GB" sz="2000" dirty="0"/>
          </a:p>
        </p:txBody>
      </p:sp>
      <p:sp>
        <p:nvSpPr>
          <p:cNvPr id="10" name="TextBox 9"/>
          <p:cNvSpPr txBox="1"/>
          <p:nvPr/>
        </p:nvSpPr>
        <p:spPr>
          <a:xfrm>
            <a:off x="4293096" y="3768866"/>
            <a:ext cx="2393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 smtClean="0"/>
              <a:t>*</a:t>
            </a:r>
            <a:endParaRPr lang="en-GB" sz="2000" dirty="0"/>
          </a:p>
        </p:txBody>
      </p:sp>
      <p:sp>
        <p:nvSpPr>
          <p:cNvPr id="11" name="TextBox 10"/>
          <p:cNvSpPr txBox="1"/>
          <p:nvPr/>
        </p:nvSpPr>
        <p:spPr>
          <a:xfrm>
            <a:off x="4357713" y="8408560"/>
            <a:ext cx="2393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 smtClean="0"/>
              <a:t>*</a:t>
            </a:r>
            <a:endParaRPr lang="en-GB" sz="2000" dirty="0"/>
          </a:p>
        </p:txBody>
      </p:sp>
      <p:sp>
        <p:nvSpPr>
          <p:cNvPr id="12" name="TextBox 11"/>
          <p:cNvSpPr txBox="1"/>
          <p:nvPr/>
        </p:nvSpPr>
        <p:spPr>
          <a:xfrm>
            <a:off x="6597352" y="3569788"/>
            <a:ext cx="2393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 smtClean="0"/>
              <a:t>*</a:t>
            </a:r>
            <a:endParaRPr lang="en-GB" sz="2000" dirty="0"/>
          </a:p>
        </p:txBody>
      </p:sp>
      <p:sp>
        <p:nvSpPr>
          <p:cNvPr id="13" name="TextBox 12"/>
          <p:cNvSpPr txBox="1"/>
          <p:nvPr/>
        </p:nvSpPr>
        <p:spPr>
          <a:xfrm>
            <a:off x="6597352" y="5004048"/>
            <a:ext cx="2393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 smtClean="0"/>
              <a:t>*</a:t>
            </a:r>
            <a:endParaRPr lang="en-GB" sz="2000" dirty="0"/>
          </a:p>
        </p:txBody>
      </p:sp>
    </p:spTree>
    <p:extLst>
      <p:ext uri="{BB962C8B-B14F-4D97-AF65-F5344CB8AC3E}">
        <p14:creationId xmlns:p14="http://schemas.microsoft.com/office/powerpoint/2010/main" val="15730761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85269"/>
              </p:ext>
            </p:extLst>
          </p:nvPr>
        </p:nvGraphicFramePr>
        <p:xfrm>
          <a:off x="-30495" y="0"/>
          <a:ext cx="3466668" cy="30659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7603695"/>
              </p:ext>
            </p:extLst>
          </p:nvPr>
        </p:nvGraphicFramePr>
        <p:xfrm>
          <a:off x="3398505" y="1"/>
          <a:ext cx="3429000" cy="30659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12"/>
          <p:cNvSpPr txBox="1">
            <a:spLocks noChangeArrowheads="1"/>
          </p:cNvSpPr>
          <p:nvPr/>
        </p:nvSpPr>
        <p:spPr bwMode="auto">
          <a:xfrm>
            <a:off x="71269" y="0"/>
            <a:ext cx="4296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b="1" dirty="0" smtClean="0"/>
              <a:t>A.</a:t>
            </a:r>
            <a:endParaRPr lang="en-GB" b="1" dirty="0"/>
          </a:p>
        </p:txBody>
      </p:sp>
      <p:sp>
        <p:nvSpPr>
          <p:cNvPr id="8" name="TextBox 12"/>
          <p:cNvSpPr txBox="1">
            <a:spLocks noChangeArrowheads="1"/>
          </p:cNvSpPr>
          <p:nvPr/>
        </p:nvSpPr>
        <p:spPr bwMode="auto">
          <a:xfrm>
            <a:off x="3356992" y="0"/>
            <a:ext cx="4296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b="1" dirty="0" smtClean="0"/>
              <a:t>B.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0805620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2872683"/>
              </p:ext>
            </p:extLst>
          </p:nvPr>
        </p:nvGraphicFramePr>
        <p:xfrm>
          <a:off x="4221088" y="2915816"/>
          <a:ext cx="2520000" cy="2768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6109492"/>
              </p:ext>
            </p:extLst>
          </p:nvPr>
        </p:nvGraphicFramePr>
        <p:xfrm>
          <a:off x="2204864" y="2915816"/>
          <a:ext cx="2360510" cy="28083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3114446"/>
              </p:ext>
            </p:extLst>
          </p:nvPr>
        </p:nvGraphicFramePr>
        <p:xfrm>
          <a:off x="0" y="0"/>
          <a:ext cx="2208040" cy="2771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3114540"/>
              </p:ext>
            </p:extLst>
          </p:nvPr>
        </p:nvGraphicFramePr>
        <p:xfrm>
          <a:off x="2204864" y="0"/>
          <a:ext cx="2286395" cy="27854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0729407"/>
              </p:ext>
            </p:extLst>
          </p:nvPr>
        </p:nvGraphicFramePr>
        <p:xfrm>
          <a:off x="4337720" y="-26714"/>
          <a:ext cx="2520280" cy="27694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1" name="Chart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2186415"/>
              </p:ext>
            </p:extLst>
          </p:nvPr>
        </p:nvGraphicFramePr>
        <p:xfrm>
          <a:off x="-891" y="5652120"/>
          <a:ext cx="2520000" cy="2768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5439734"/>
              </p:ext>
            </p:extLst>
          </p:nvPr>
        </p:nvGraphicFramePr>
        <p:xfrm>
          <a:off x="0" y="2915816"/>
          <a:ext cx="2303079" cy="28106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6185720"/>
              </p:ext>
            </p:extLst>
          </p:nvPr>
        </p:nvGraphicFramePr>
        <p:xfrm>
          <a:off x="2132856" y="5652120"/>
          <a:ext cx="2592008" cy="28404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620688" y="51674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Control</a:t>
            </a:r>
            <a:endParaRPr lang="en-GB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2780928" y="65248"/>
            <a:ext cx="11705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10% sorbitol</a:t>
            </a:r>
            <a:endParaRPr lang="en-GB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5085184" y="50308"/>
            <a:ext cx="1627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25 mM acetic acid</a:t>
            </a:r>
            <a:endParaRPr lang="en-GB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620687" y="2987824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35°C</a:t>
            </a:r>
            <a:endParaRPr lang="en-GB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2852936" y="2987824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Control</a:t>
            </a:r>
            <a:endParaRPr lang="en-GB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5137121" y="2975800"/>
            <a:ext cx="11705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10% sorbitol</a:t>
            </a:r>
            <a:endParaRPr lang="en-GB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692696" y="5796136"/>
            <a:ext cx="1627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25 mM acetic acid</a:t>
            </a:r>
            <a:endParaRPr lang="en-GB" sz="1400" dirty="0"/>
          </a:p>
        </p:txBody>
      </p:sp>
      <p:sp>
        <p:nvSpPr>
          <p:cNvPr id="19" name="TextBox 18"/>
          <p:cNvSpPr txBox="1"/>
          <p:nvPr/>
        </p:nvSpPr>
        <p:spPr>
          <a:xfrm>
            <a:off x="2909081" y="5796087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35°C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35909832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27</TotalTime>
  <Words>195</Words>
  <Application>Microsoft Office PowerPoint</Application>
  <PresentationFormat>On-screen Show (4:3)</PresentationFormat>
  <Paragraphs>97</Paragraphs>
  <Slides>4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The University of Nottingh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Greetham Darren</cp:lastModifiedBy>
  <cp:revision>356</cp:revision>
  <cp:lastPrinted>2014-02-18T10:11:31Z</cp:lastPrinted>
  <dcterms:created xsi:type="dcterms:W3CDTF">2012-01-04T10:53:23Z</dcterms:created>
  <dcterms:modified xsi:type="dcterms:W3CDTF">2014-02-24T09:26:41Z</dcterms:modified>
</cp:coreProperties>
</file>